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>
        <p:scale>
          <a:sx n="81" d="100"/>
          <a:sy n="81" d="100"/>
        </p:scale>
        <p:origin x="-300" y="-3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B30FD47-AFC0-4021-A808-E4E01908A20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FE122017-E93E-4526-BD38-B3EEF16ADC7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7AF46D97-D042-431D-8A7B-5F3B3EA2FF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AE1FC-C05A-4F4D-88AB-B7D04DDF52BF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072FCF1D-BA8C-4A3D-9E0E-9B4D324906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A1EFAB5C-D418-4E1E-A1BC-15D64799AC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90B59-DBA4-4B74-A9A8-E723EEB6A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6401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E58A6B7-5209-432E-AE1D-F913972A72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95F782E2-AAFE-4BC3-9BD2-354B5D66DB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08D0D2CC-B455-4B17-9C87-532AB18E96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AE1FC-C05A-4F4D-88AB-B7D04DDF52BF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87B48477-4D78-4A41-8C18-764CFDB9AC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3B307293-7882-4AEC-A665-D1A9888AB9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90B59-DBA4-4B74-A9A8-E723EEB6A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01570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C40C1983-538D-4FB0-8B18-108097B26E2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6F9BD8BF-5C5D-4EA4-B5CC-6D7BB683074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F76B07FB-88CA-4298-A905-DF38B42197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AE1FC-C05A-4F4D-88AB-B7D04DDF52BF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B0566C7A-2E70-4A27-8C70-9FD62F7D31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E559922F-DF82-4899-B2FF-2FAC99823C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90B59-DBA4-4B74-A9A8-E723EEB6A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34867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07EC761-6182-4DA1-B8CD-F1A6F86B70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539041C7-E8F8-4683-841A-4C107C46B93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798C2C96-F356-454A-976B-5B1E0B7DFB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AE1FC-C05A-4F4D-88AB-B7D04DDF52BF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1DEF46C7-AB81-4565-8223-EFA350BB3D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52ACB52F-11F0-44BC-886A-0260AD03D3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90B59-DBA4-4B74-A9A8-E723EEB6A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14251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E3F74EA-DAC7-41E6-9AE8-AEE49C2699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2B3BF27D-88FC-40AA-820A-4B9BD16909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702904A4-D246-4764-8865-8A1A3C1891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AE1FC-C05A-4F4D-88AB-B7D04DDF52BF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B85BFE3D-628C-4165-92F5-54571650F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48384F4C-BEE5-466B-B9D1-B35C35787B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90B59-DBA4-4B74-A9A8-E723EEB6A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66433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E4FA6CE-7C1B-45EB-A8F5-EAED7C2149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BABE9584-22FE-4B53-90F3-4CFF898680F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9ECB3C76-B576-418A-95FF-48A935DC847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85239273-C3D4-41A0-A672-4883F4B73B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AE1FC-C05A-4F4D-88AB-B7D04DDF52BF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E4F97D67-3BFB-4B93-A7AE-AA8C50E4B6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F4456C9F-19C9-4446-8282-F18CD0D9C5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90B59-DBA4-4B74-A9A8-E723EEB6A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29298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F50AE61-D99F-4912-97FB-E57D107ED3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4579251F-5D75-4414-8E11-846DAA2ECD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F5A4B476-FCDA-4B5C-A148-16DD03D28EB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9B1593DA-9788-4DD8-B49A-52304398EE6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C4FFA7E0-F655-4AF0-98E6-CFBD8811DFB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8991A450-04E7-4066-B5B9-925539E582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AE1FC-C05A-4F4D-88AB-B7D04DDF52BF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27DF1CD3-9F77-4D68-8BEB-470FFE9CDA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80C76B12-5465-498C-927C-06250597B6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90B59-DBA4-4B74-A9A8-E723EEB6A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34963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6CA93A8-8499-45EC-9BF5-AEEE379E0E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6CD626A8-2686-4232-9AA3-AA814D3461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AE1FC-C05A-4F4D-88AB-B7D04DDF52BF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6BDFA245-415D-454F-9FB4-F1ED0A449F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B4EE32CD-8A01-4793-8ED7-05EFCDE5B7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90B59-DBA4-4B74-A9A8-E723EEB6A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40052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DCF7DA0D-1E4C-4641-BD45-C9286B0EE4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AE1FC-C05A-4F4D-88AB-B7D04DDF52BF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E83E4CBC-A36F-40D1-AE00-0B853B07AD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8066B0E6-EFE5-4250-9DEE-6AA05DD55F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90B59-DBA4-4B74-A9A8-E723EEB6A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69514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8D134B4-B8D2-458C-BF37-7CF799E9A9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1B98A4C7-6CC1-4614-BD5C-D018643FC84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1F314069-3287-4ACB-B077-342536B917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B48CB33E-F246-4C6F-ADF6-382D494032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AE1FC-C05A-4F4D-88AB-B7D04DDF52BF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F6F1B798-F0EA-4A2E-8431-EC3EDBC6A1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4B761BA9-F245-4E89-9E24-DCDB1487AF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90B59-DBA4-4B74-A9A8-E723EEB6A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76316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3A334E9-9149-47F0-B02F-CC2864F3BC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8CD02B36-2FAE-4003-A545-105BD259CA4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D05F0F54-594C-4995-9743-857B993ADDE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E66B08EC-0E6D-44B9-BB7A-0BA4036F68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AE1FC-C05A-4F4D-88AB-B7D04DDF52BF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7F0898E4-FEAB-4C1B-93F1-53F6A3F7B2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15F5BEF0-6311-464D-8B66-0D3F4FBCAD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90B59-DBA4-4B74-A9A8-E723EEB6A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32990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5B1E2D8F-BF52-45B0-A3D4-1E5CDDFEB1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9B5D082C-5621-470A-BDFA-22101F401D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EA809B26-366A-49CF-B2E7-56A575A85F2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BAE1FC-C05A-4F4D-88AB-B7D04DDF52BF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19F9AEDB-064D-4334-8502-340F2133364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C5DAF390-77A8-42DA-A361-F03A8C7FCF9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890B59-DBA4-4B74-A9A8-E723EEB6A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59683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57" name="Group 556">
            <a:extLst>
              <a:ext uri="{FF2B5EF4-FFF2-40B4-BE49-F238E27FC236}">
                <a16:creationId xmlns:a16="http://schemas.microsoft.com/office/drawing/2014/main" xmlns="" id="{C03415DD-A540-4E57-8A8B-3EBA0979DDF4}"/>
              </a:ext>
            </a:extLst>
          </p:cNvPr>
          <p:cNvGrpSpPr/>
          <p:nvPr/>
        </p:nvGrpSpPr>
        <p:grpSpPr>
          <a:xfrm>
            <a:off x="1676400" y="333375"/>
            <a:ext cx="7914584" cy="5244991"/>
            <a:chOff x="3661543" y="916301"/>
            <a:chExt cx="6339016" cy="4843040"/>
          </a:xfrm>
        </p:grpSpPr>
        <p:grpSp>
          <p:nvGrpSpPr>
            <p:cNvPr id="4" name="Group 4">
              <a:extLst>
                <a:ext uri="{FF2B5EF4-FFF2-40B4-BE49-F238E27FC236}">
                  <a16:creationId xmlns:a16="http://schemas.microsoft.com/office/drawing/2014/main" xmlns="" id="{D05A8B49-9FA6-4837-AC8A-126D5F1621E7}"/>
                </a:ext>
              </a:extLst>
            </p:cNvPr>
            <p:cNvGrpSpPr>
              <a:grpSpLocks noChangeAspect="1"/>
            </p:cNvGrpSpPr>
            <p:nvPr/>
          </p:nvGrpSpPr>
          <p:grpSpPr bwMode="auto">
            <a:xfrm>
              <a:off x="3661543" y="916301"/>
              <a:ext cx="5721147" cy="2638798"/>
              <a:chOff x="1550" y="125"/>
              <a:chExt cx="3066" cy="1796"/>
            </a:xfrm>
          </p:grpSpPr>
          <p:sp>
            <p:nvSpPr>
              <p:cNvPr id="5" name="AutoShape 3">
                <a:extLst>
                  <a:ext uri="{FF2B5EF4-FFF2-40B4-BE49-F238E27FC236}">
                    <a16:creationId xmlns:a16="http://schemas.microsoft.com/office/drawing/2014/main" xmlns="" id="{579F1545-5934-48B9-9122-42CBACEFBEEA}"/>
                  </a:ext>
                </a:extLst>
              </p:cNvPr>
              <p:cNvSpPr>
                <a:spLocks noChangeAspect="1" noChangeArrowheads="1" noTextEdit="1"/>
              </p:cNvSpPr>
              <p:nvPr/>
            </p:nvSpPr>
            <p:spPr bwMode="auto">
              <a:xfrm>
                <a:off x="1550" y="125"/>
                <a:ext cx="3066" cy="17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grpSp>
            <p:nvGrpSpPr>
              <p:cNvPr id="6" name="Group 205">
                <a:extLst>
                  <a:ext uri="{FF2B5EF4-FFF2-40B4-BE49-F238E27FC236}">
                    <a16:creationId xmlns:a16="http://schemas.microsoft.com/office/drawing/2014/main" xmlns="" id="{A2D92670-F162-4463-9512-B8725BDBB23A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554" y="129"/>
                <a:ext cx="2841" cy="1777"/>
                <a:chOff x="1554" y="129"/>
                <a:chExt cx="2841" cy="1777"/>
              </a:xfrm>
            </p:grpSpPr>
            <p:sp>
              <p:nvSpPr>
                <p:cNvPr id="104" name="Rectangle 5">
                  <a:extLst>
                    <a:ext uri="{FF2B5EF4-FFF2-40B4-BE49-F238E27FC236}">
                      <a16:creationId xmlns:a16="http://schemas.microsoft.com/office/drawing/2014/main" xmlns="" id="{C2BD60D2-E73A-4618-912F-E684F980950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554" y="129"/>
                  <a:ext cx="65" cy="4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RT:</a:t>
                  </a:r>
                  <a:endPara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05" name="Rectangle 6">
                  <a:extLst>
                    <a:ext uri="{FF2B5EF4-FFF2-40B4-BE49-F238E27FC236}">
                      <a16:creationId xmlns:a16="http://schemas.microsoft.com/office/drawing/2014/main" xmlns="" id="{C13B2A3F-828E-44E2-AB28-CC87E57D1D4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635" y="129"/>
                  <a:ext cx="213" cy="4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>
                      <a:ln>
                        <a:noFill/>
                      </a:ln>
                      <a:solidFill>
                        <a:srgbClr val="000096"/>
                      </a:solidFill>
                      <a:effectLst/>
                      <a:latin typeface="Arial" panose="020B0604020202020204" pitchFamily="34" charset="0"/>
                    </a:rPr>
                    <a:t>0.00 - 15.01</a:t>
                  </a:r>
                  <a:endPara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06" name="Line 7">
                  <a:extLst>
                    <a:ext uri="{FF2B5EF4-FFF2-40B4-BE49-F238E27FC236}">
                      <a16:creationId xmlns:a16="http://schemas.microsoft.com/office/drawing/2014/main" xmlns="" id="{BDCACABF-1D3D-461A-A3C7-21BCFA7FA63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718" y="1777"/>
                  <a:ext cx="2668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07" name="Line 8">
                  <a:extLst>
                    <a:ext uri="{FF2B5EF4-FFF2-40B4-BE49-F238E27FC236}">
                      <a16:creationId xmlns:a16="http://schemas.microsoft.com/office/drawing/2014/main" xmlns="" id="{FB8D85B0-C242-48FE-91CA-C1244C28B42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752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08" name="Line 9">
                  <a:extLst>
                    <a:ext uri="{FF2B5EF4-FFF2-40B4-BE49-F238E27FC236}">
                      <a16:creationId xmlns:a16="http://schemas.microsoft.com/office/drawing/2014/main" xmlns="" id="{E7D04914-202C-499B-B92A-49B6F9D6A75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788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09" name="Line 10">
                  <a:extLst>
                    <a:ext uri="{FF2B5EF4-FFF2-40B4-BE49-F238E27FC236}">
                      <a16:creationId xmlns:a16="http://schemas.microsoft.com/office/drawing/2014/main" xmlns="" id="{AFB51E4E-D859-4814-8635-81C1B0E4646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823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10" name="Line 11">
                  <a:extLst>
                    <a:ext uri="{FF2B5EF4-FFF2-40B4-BE49-F238E27FC236}">
                      <a16:creationId xmlns:a16="http://schemas.microsoft.com/office/drawing/2014/main" xmlns="" id="{0434BC20-EC7D-451A-8867-CCD143021BE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859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11" name="Line 12">
                  <a:extLst>
                    <a:ext uri="{FF2B5EF4-FFF2-40B4-BE49-F238E27FC236}">
                      <a16:creationId xmlns:a16="http://schemas.microsoft.com/office/drawing/2014/main" xmlns="" id="{6BF430C0-5BB5-4B26-9FA0-85611E07622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930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12" name="Line 13">
                  <a:extLst>
                    <a:ext uri="{FF2B5EF4-FFF2-40B4-BE49-F238E27FC236}">
                      <a16:creationId xmlns:a16="http://schemas.microsoft.com/office/drawing/2014/main" xmlns="" id="{149E608D-D503-4445-8D83-114F2C8B89B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966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13" name="Line 14">
                  <a:extLst>
                    <a:ext uri="{FF2B5EF4-FFF2-40B4-BE49-F238E27FC236}">
                      <a16:creationId xmlns:a16="http://schemas.microsoft.com/office/drawing/2014/main" xmlns="" id="{31D85727-2969-4BCA-A860-9B988476F13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000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14" name="Line 15">
                  <a:extLst>
                    <a:ext uri="{FF2B5EF4-FFF2-40B4-BE49-F238E27FC236}">
                      <a16:creationId xmlns:a16="http://schemas.microsoft.com/office/drawing/2014/main" xmlns="" id="{96EF8C3E-EF99-4DA3-8C58-950EC754596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037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15" name="Line 16">
                  <a:extLst>
                    <a:ext uri="{FF2B5EF4-FFF2-40B4-BE49-F238E27FC236}">
                      <a16:creationId xmlns:a16="http://schemas.microsoft.com/office/drawing/2014/main" xmlns="" id="{830FEAC9-6A83-44DA-A740-BA1310089F8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107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16" name="Line 17">
                  <a:extLst>
                    <a:ext uri="{FF2B5EF4-FFF2-40B4-BE49-F238E27FC236}">
                      <a16:creationId xmlns:a16="http://schemas.microsoft.com/office/drawing/2014/main" xmlns="" id="{A0032768-918F-4C57-A12F-5890B5ED65B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144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17" name="Line 18">
                  <a:extLst>
                    <a:ext uri="{FF2B5EF4-FFF2-40B4-BE49-F238E27FC236}">
                      <a16:creationId xmlns:a16="http://schemas.microsoft.com/office/drawing/2014/main" xmlns="" id="{0679DE56-1526-4F14-ADA6-7A3DC2A0AFA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178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18" name="Line 19">
                  <a:extLst>
                    <a:ext uri="{FF2B5EF4-FFF2-40B4-BE49-F238E27FC236}">
                      <a16:creationId xmlns:a16="http://schemas.microsoft.com/office/drawing/2014/main" xmlns="" id="{48936CF2-2F3A-41C9-8438-C070B790DF4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215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19" name="Line 20">
                  <a:extLst>
                    <a:ext uri="{FF2B5EF4-FFF2-40B4-BE49-F238E27FC236}">
                      <a16:creationId xmlns:a16="http://schemas.microsoft.com/office/drawing/2014/main" xmlns="" id="{7ADB7E7B-9EA9-47FD-8FDE-12CA9A7F4BD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285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20" name="Line 21">
                  <a:extLst>
                    <a:ext uri="{FF2B5EF4-FFF2-40B4-BE49-F238E27FC236}">
                      <a16:creationId xmlns:a16="http://schemas.microsoft.com/office/drawing/2014/main" xmlns="" id="{B63051FF-1404-484D-AB40-FF8D2A21950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322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21" name="Line 22">
                  <a:extLst>
                    <a:ext uri="{FF2B5EF4-FFF2-40B4-BE49-F238E27FC236}">
                      <a16:creationId xmlns:a16="http://schemas.microsoft.com/office/drawing/2014/main" xmlns="" id="{15AFDB04-945C-40F2-B93B-79B75DDFE6B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356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22" name="Line 23">
                  <a:extLst>
                    <a:ext uri="{FF2B5EF4-FFF2-40B4-BE49-F238E27FC236}">
                      <a16:creationId xmlns:a16="http://schemas.microsoft.com/office/drawing/2014/main" xmlns="" id="{6F22C93B-BC40-4B4D-949E-8AE6D4B5D5E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392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23" name="Line 24">
                  <a:extLst>
                    <a:ext uri="{FF2B5EF4-FFF2-40B4-BE49-F238E27FC236}">
                      <a16:creationId xmlns:a16="http://schemas.microsoft.com/office/drawing/2014/main" xmlns="" id="{91135E56-FC26-4043-A60C-0F8CC21F76C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463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24" name="Line 25">
                  <a:extLst>
                    <a:ext uri="{FF2B5EF4-FFF2-40B4-BE49-F238E27FC236}">
                      <a16:creationId xmlns:a16="http://schemas.microsoft.com/office/drawing/2014/main" xmlns="" id="{1C92CCCB-A327-4268-99AE-4A7B7489CAF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499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25" name="Line 26">
                  <a:extLst>
                    <a:ext uri="{FF2B5EF4-FFF2-40B4-BE49-F238E27FC236}">
                      <a16:creationId xmlns:a16="http://schemas.microsoft.com/office/drawing/2014/main" xmlns="" id="{26817324-E03C-40EF-9172-5A730199618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534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26" name="Line 27">
                  <a:extLst>
                    <a:ext uri="{FF2B5EF4-FFF2-40B4-BE49-F238E27FC236}">
                      <a16:creationId xmlns:a16="http://schemas.microsoft.com/office/drawing/2014/main" xmlns="" id="{837FC2DC-38B6-453C-B41E-8E31A93E2BC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570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27" name="Line 28">
                  <a:extLst>
                    <a:ext uri="{FF2B5EF4-FFF2-40B4-BE49-F238E27FC236}">
                      <a16:creationId xmlns:a16="http://schemas.microsoft.com/office/drawing/2014/main" xmlns="" id="{E25F6BC2-B700-46F9-9389-C12D32A481E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641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28" name="Line 29">
                  <a:extLst>
                    <a:ext uri="{FF2B5EF4-FFF2-40B4-BE49-F238E27FC236}">
                      <a16:creationId xmlns:a16="http://schemas.microsoft.com/office/drawing/2014/main" xmlns="" id="{3CC9EDC4-A666-4DB7-BE99-2BA671F60BA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677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29" name="Line 30">
                  <a:extLst>
                    <a:ext uri="{FF2B5EF4-FFF2-40B4-BE49-F238E27FC236}">
                      <a16:creationId xmlns:a16="http://schemas.microsoft.com/office/drawing/2014/main" xmlns="" id="{85C7840B-B7BF-4053-8525-D02EAFB2C4B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711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30" name="Line 31">
                  <a:extLst>
                    <a:ext uri="{FF2B5EF4-FFF2-40B4-BE49-F238E27FC236}">
                      <a16:creationId xmlns:a16="http://schemas.microsoft.com/office/drawing/2014/main" xmlns="" id="{39FE3D95-550B-4257-90CF-C6A43ABF22C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748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31" name="Line 32">
                  <a:extLst>
                    <a:ext uri="{FF2B5EF4-FFF2-40B4-BE49-F238E27FC236}">
                      <a16:creationId xmlns:a16="http://schemas.microsoft.com/office/drawing/2014/main" xmlns="" id="{09932ECA-2F97-4E1F-A6C4-39E10C277F5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818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32" name="Line 33">
                  <a:extLst>
                    <a:ext uri="{FF2B5EF4-FFF2-40B4-BE49-F238E27FC236}">
                      <a16:creationId xmlns:a16="http://schemas.microsoft.com/office/drawing/2014/main" xmlns="" id="{702FC0ED-197B-4746-83B0-B90FC423A34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855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33" name="Line 34">
                  <a:extLst>
                    <a:ext uri="{FF2B5EF4-FFF2-40B4-BE49-F238E27FC236}">
                      <a16:creationId xmlns:a16="http://schemas.microsoft.com/office/drawing/2014/main" xmlns="" id="{A6D8355F-523D-44FF-AA9D-7E18523E17B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889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34" name="Line 35">
                  <a:extLst>
                    <a:ext uri="{FF2B5EF4-FFF2-40B4-BE49-F238E27FC236}">
                      <a16:creationId xmlns:a16="http://schemas.microsoft.com/office/drawing/2014/main" xmlns="" id="{47D00100-FC75-4C3C-A686-BF4D6370A29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925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35" name="Line 36">
                  <a:extLst>
                    <a:ext uri="{FF2B5EF4-FFF2-40B4-BE49-F238E27FC236}">
                      <a16:creationId xmlns:a16="http://schemas.microsoft.com/office/drawing/2014/main" xmlns="" id="{38E7BEF5-6592-4857-B7F2-5CC0170B6A1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996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36" name="Line 37">
                  <a:extLst>
                    <a:ext uri="{FF2B5EF4-FFF2-40B4-BE49-F238E27FC236}">
                      <a16:creationId xmlns:a16="http://schemas.microsoft.com/office/drawing/2014/main" xmlns="" id="{AA07EDF9-55BC-41A5-BDC6-D4D346C342A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033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37" name="Line 38">
                  <a:extLst>
                    <a:ext uri="{FF2B5EF4-FFF2-40B4-BE49-F238E27FC236}">
                      <a16:creationId xmlns:a16="http://schemas.microsoft.com/office/drawing/2014/main" xmlns="" id="{A8584091-1728-4193-A4A8-2EF50D0B49D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067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38" name="Line 39">
                  <a:extLst>
                    <a:ext uri="{FF2B5EF4-FFF2-40B4-BE49-F238E27FC236}">
                      <a16:creationId xmlns:a16="http://schemas.microsoft.com/office/drawing/2014/main" xmlns="" id="{C797D2BF-2FA6-4D21-BD67-EA2FC964BDF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03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39" name="Line 40">
                  <a:extLst>
                    <a:ext uri="{FF2B5EF4-FFF2-40B4-BE49-F238E27FC236}">
                      <a16:creationId xmlns:a16="http://schemas.microsoft.com/office/drawing/2014/main" xmlns="" id="{BD968125-06CE-4452-8E25-2E4C906B903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74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40" name="Line 41">
                  <a:extLst>
                    <a:ext uri="{FF2B5EF4-FFF2-40B4-BE49-F238E27FC236}">
                      <a16:creationId xmlns:a16="http://schemas.microsoft.com/office/drawing/2014/main" xmlns="" id="{DBA10FFA-C230-4A66-A103-086EE658825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210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41" name="Line 42">
                  <a:extLst>
                    <a:ext uri="{FF2B5EF4-FFF2-40B4-BE49-F238E27FC236}">
                      <a16:creationId xmlns:a16="http://schemas.microsoft.com/office/drawing/2014/main" xmlns="" id="{DCD6149E-5E9C-4CC4-84ED-2F40694D779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245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42" name="Line 43">
                  <a:extLst>
                    <a:ext uri="{FF2B5EF4-FFF2-40B4-BE49-F238E27FC236}">
                      <a16:creationId xmlns:a16="http://schemas.microsoft.com/office/drawing/2014/main" xmlns="" id="{9BA1EB30-DEF8-4ADA-9631-99A0E08A1CD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281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43" name="Line 44">
                  <a:extLst>
                    <a:ext uri="{FF2B5EF4-FFF2-40B4-BE49-F238E27FC236}">
                      <a16:creationId xmlns:a16="http://schemas.microsoft.com/office/drawing/2014/main" xmlns="" id="{2C30E5A0-EA48-431D-99E2-59C426CEFA2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352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44" name="Line 45">
                  <a:extLst>
                    <a:ext uri="{FF2B5EF4-FFF2-40B4-BE49-F238E27FC236}">
                      <a16:creationId xmlns:a16="http://schemas.microsoft.com/office/drawing/2014/main" xmlns="" id="{460F485A-5CB5-4972-80E8-133BF1058D5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388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45" name="Line 46">
                  <a:extLst>
                    <a:ext uri="{FF2B5EF4-FFF2-40B4-BE49-F238E27FC236}">
                      <a16:creationId xmlns:a16="http://schemas.microsoft.com/office/drawing/2014/main" xmlns="" id="{41971C46-79F3-447B-92FE-3DF139FF5CB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422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46" name="Line 47">
                  <a:extLst>
                    <a:ext uri="{FF2B5EF4-FFF2-40B4-BE49-F238E27FC236}">
                      <a16:creationId xmlns:a16="http://schemas.microsoft.com/office/drawing/2014/main" xmlns="" id="{0113A65D-AD09-4178-8CEA-A1A84865B00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459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47" name="Line 48">
                  <a:extLst>
                    <a:ext uri="{FF2B5EF4-FFF2-40B4-BE49-F238E27FC236}">
                      <a16:creationId xmlns:a16="http://schemas.microsoft.com/office/drawing/2014/main" xmlns="" id="{04D2D87E-4FA6-46E1-B6BF-95661E17A0C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529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48" name="Line 49">
                  <a:extLst>
                    <a:ext uri="{FF2B5EF4-FFF2-40B4-BE49-F238E27FC236}">
                      <a16:creationId xmlns:a16="http://schemas.microsoft.com/office/drawing/2014/main" xmlns="" id="{ABC3ADF5-861C-4A08-9A30-0C12A04EC8E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566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49" name="Line 50">
                  <a:extLst>
                    <a:ext uri="{FF2B5EF4-FFF2-40B4-BE49-F238E27FC236}">
                      <a16:creationId xmlns:a16="http://schemas.microsoft.com/office/drawing/2014/main" xmlns="" id="{071F6D09-6C31-4BED-B94A-0BB71A3D999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600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50" name="Line 51">
                  <a:extLst>
                    <a:ext uri="{FF2B5EF4-FFF2-40B4-BE49-F238E27FC236}">
                      <a16:creationId xmlns:a16="http://schemas.microsoft.com/office/drawing/2014/main" xmlns="" id="{A564B039-1AE8-4CE8-804D-05C0E95F303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636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51" name="Line 52">
                  <a:extLst>
                    <a:ext uri="{FF2B5EF4-FFF2-40B4-BE49-F238E27FC236}">
                      <a16:creationId xmlns:a16="http://schemas.microsoft.com/office/drawing/2014/main" xmlns="" id="{0722F83F-6A84-4FBE-AAF7-BAEC155910D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707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52" name="Line 53">
                  <a:extLst>
                    <a:ext uri="{FF2B5EF4-FFF2-40B4-BE49-F238E27FC236}">
                      <a16:creationId xmlns:a16="http://schemas.microsoft.com/office/drawing/2014/main" xmlns="" id="{BEE092F5-47A6-4E1A-AC63-4EC0BC718F4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743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53" name="Line 54">
                  <a:extLst>
                    <a:ext uri="{FF2B5EF4-FFF2-40B4-BE49-F238E27FC236}">
                      <a16:creationId xmlns:a16="http://schemas.microsoft.com/office/drawing/2014/main" xmlns="" id="{516DB10F-4F71-48A3-8295-6D83038071C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778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54" name="Line 55">
                  <a:extLst>
                    <a:ext uri="{FF2B5EF4-FFF2-40B4-BE49-F238E27FC236}">
                      <a16:creationId xmlns:a16="http://schemas.microsoft.com/office/drawing/2014/main" xmlns="" id="{1B951834-FDA2-47CC-B856-E2C5F70FB15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814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55" name="Line 56">
                  <a:extLst>
                    <a:ext uri="{FF2B5EF4-FFF2-40B4-BE49-F238E27FC236}">
                      <a16:creationId xmlns:a16="http://schemas.microsoft.com/office/drawing/2014/main" xmlns="" id="{7546EE49-2104-489B-BD9E-7B9C6441B5F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885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56" name="Line 57">
                  <a:extLst>
                    <a:ext uri="{FF2B5EF4-FFF2-40B4-BE49-F238E27FC236}">
                      <a16:creationId xmlns:a16="http://schemas.microsoft.com/office/drawing/2014/main" xmlns="" id="{ACB62749-E610-49A9-B24B-C8FDE351E4A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921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57" name="Line 58">
                  <a:extLst>
                    <a:ext uri="{FF2B5EF4-FFF2-40B4-BE49-F238E27FC236}">
                      <a16:creationId xmlns:a16="http://schemas.microsoft.com/office/drawing/2014/main" xmlns="" id="{0D42FC9F-B542-46A7-8112-BEAF0ABD1D7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956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58" name="Line 59">
                  <a:extLst>
                    <a:ext uri="{FF2B5EF4-FFF2-40B4-BE49-F238E27FC236}">
                      <a16:creationId xmlns:a16="http://schemas.microsoft.com/office/drawing/2014/main" xmlns="" id="{0DBA7BFB-7192-46EE-BAD1-C1A1B1DAB31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992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59" name="Line 60">
                  <a:extLst>
                    <a:ext uri="{FF2B5EF4-FFF2-40B4-BE49-F238E27FC236}">
                      <a16:creationId xmlns:a16="http://schemas.microsoft.com/office/drawing/2014/main" xmlns="" id="{EEB5BFF5-011A-4A80-8D0F-D0CEAB869C7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063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60" name="Line 61">
                  <a:extLst>
                    <a:ext uri="{FF2B5EF4-FFF2-40B4-BE49-F238E27FC236}">
                      <a16:creationId xmlns:a16="http://schemas.microsoft.com/office/drawing/2014/main" xmlns="" id="{FAAE781D-A6F1-44B6-8595-B09D8E629D4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099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61" name="Line 62">
                  <a:extLst>
                    <a:ext uri="{FF2B5EF4-FFF2-40B4-BE49-F238E27FC236}">
                      <a16:creationId xmlns:a16="http://schemas.microsoft.com/office/drawing/2014/main" xmlns="" id="{3824BB54-60CC-44E1-A274-97B109CEA13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133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62" name="Line 63">
                  <a:extLst>
                    <a:ext uri="{FF2B5EF4-FFF2-40B4-BE49-F238E27FC236}">
                      <a16:creationId xmlns:a16="http://schemas.microsoft.com/office/drawing/2014/main" xmlns="" id="{777B4656-FAFA-4BF3-8DC2-05C9A0C44F4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170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63" name="Line 64">
                  <a:extLst>
                    <a:ext uri="{FF2B5EF4-FFF2-40B4-BE49-F238E27FC236}">
                      <a16:creationId xmlns:a16="http://schemas.microsoft.com/office/drawing/2014/main" xmlns="" id="{4C9CE0F5-C208-47AA-98FA-4F73511889F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240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64" name="Line 65">
                  <a:extLst>
                    <a:ext uri="{FF2B5EF4-FFF2-40B4-BE49-F238E27FC236}">
                      <a16:creationId xmlns:a16="http://schemas.microsoft.com/office/drawing/2014/main" xmlns="" id="{F09CE73D-E346-4F2A-B980-032ECABF552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277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65" name="Line 66">
                  <a:extLst>
                    <a:ext uri="{FF2B5EF4-FFF2-40B4-BE49-F238E27FC236}">
                      <a16:creationId xmlns:a16="http://schemas.microsoft.com/office/drawing/2014/main" xmlns="" id="{EAD2ED7C-4C3A-4F4A-BFCD-88D5EB9D5E4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311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66" name="Line 67">
                  <a:extLst>
                    <a:ext uri="{FF2B5EF4-FFF2-40B4-BE49-F238E27FC236}">
                      <a16:creationId xmlns:a16="http://schemas.microsoft.com/office/drawing/2014/main" xmlns="" id="{814B4447-E93F-4661-92C2-1DDBDEF1BDD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347" y="1777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67" name="Line 68">
                  <a:extLst>
                    <a:ext uri="{FF2B5EF4-FFF2-40B4-BE49-F238E27FC236}">
                      <a16:creationId xmlns:a16="http://schemas.microsoft.com/office/drawing/2014/main" xmlns="" id="{F74A72C7-A7AC-4324-AC86-E864C37BE97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718" y="1777"/>
                  <a:ext cx="0" cy="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68" name="Rectangle 69">
                  <a:extLst>
                    <a:ext uri="{FF2B5EF4-FFF2-40B4-BE49-F238E27FC236}">
                      <a16:creationId xmlns:a16="http://schemas.microsoft.com/office/drawing/2014/main" xmlns="" id="{866CBA91-2BC7-4251-904C-C90201B3859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698" y="1804"/>
                  <a:ext cx="22" cy="4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</a:t>
                  </a:r>
                  <a:endPara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69" name="Line 70">
                  <a:extLst>
                    <a:ext uri="{FF2B5EF4-FFF2-40B4-BE49-F238E27FC236}">
                      <a16:creationId xmlns:a16="http://schemas.microsoft.com/office/drawing/2014/main" xmlns="" id="{2C1BD183-3298-44A3-9E94-2542D18ECDC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893" y="1777"/>
                  <a:ext cx="0" cy="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70" name="Rectangle 71">
                  <a:extLst>
                    <a:ext uri="{FF2B5EF4-FFF2-40B4-BE49-F238E27FC236}">
                      <a16:creationId xmlns:a16="http://schemas.microsoft.com/office/drawing/2014/main" xmlns="" id="{A96E3CBC-07AB-42EB-B361-5ED5C748BF0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873" y="1804"/>
                  <a:ext cx="22" cy="4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</a:t>
                  </a:r>
                  <a:endPara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71" name="Line 72">
                  <a:extLst>
                    <a:ext uri="{FF2B5EF4-FFF2-40B4-BE49-F238E27FC236}">
                      <a16:creationId xmlns:a16="http://schemas.microsoft.com/office/drawing/2014/main" xmlns="" id="{C7C7DFF3-061B-4EF1-8FD2-392F5C270D1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071" y="1777"/>
                  <a:ext cx="0" cy="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72" name="Rectangle 73">
                  <a:extLst>
                    <a:ext uri="{FF2B5EF4-FFF2-40B4-BE49-F238E27FC236}">
                      <a16:creationId xmlns:a16="http://schemas.microsoft.com/office/drawing/2014/main" xmlns="" id="{B460DB08-A2C9-4575-B0F6-E0DB48DA596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051" y="1804"/>
                  <a:ext cx="22" cy="4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2</a:t>
                  </a:r>
                  <a:endPara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73" name="Line 74">
                  <a:extLst>
                    <a:ext uri="{FF2B5EF4-FFF2-40B4-BE49-F238E27FC236}">
                      <a16:creationId xmlns:a16="http://schemas.microsoft.com/office/drawing/2014/main" xmlns="" id="{F4ABEB65-ECF5-4F98-B61D-269ADA3A528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249" y="1777"/>
                  <a:ext cx="0" cy="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74" name="Rectangle 75">
                  <a:extLst>
                    <a:ext uri="{FF2B5EF4-FFF2-40B4-BE49-F238E27FC236}">
                      <a16:creationId xmlns:a16="http://schemas.microsoft.com/office/drawing/2014/main" xmlns="" id="{9443F968-8E7B-4063-B72C-1C3DF861926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229" y="1804"/>
                  <a:ext cx="22" cy="4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3</a:t>
                  </a:r>
                  <a:endPara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75" name="Line 76">
                  <a:extLst>
                    <a:ext uri="{FF2B5EF4-FFF2-40B4-BE49-F238E27FC236}">
                      <a16:creationId xmlns:a16="http://schemas.microsoft.com/office/drawing/2014/main" xmlns="" id="{47444D77-812D-4080-A561-7991AEE6879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427" y="1777"/>
                  <a:ext cx="0" cy="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76" name="Rectangle 77">
                  <a:extLst>
                    <a:ext uri="{FF2B5EF4-FFF2-40B4-BE49-F238E27FC236}">
                      <a16:creationId xmlns:a16="http://schemas.microsoft.com/office/drawing/2014/main" xmlns="" id="{D5FFF5B2-92BF-4590-9C0C-998026A547D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407" y="1804"/>
                  <a:ext cx="22" cy="4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4</a:t>
                  </a:r>
                  <a:endPara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77" name="Line 78">
                  <a:extLst>
                    <a:ext uri="{FF2B5EF4-FFF2-40B4-BE49-F238E27FC236}">
                      <a16:creationId xmlns:a16="http://schemas.microsoft.com/office/drawing/2014/main" xmlns="" id="{1BB07377-21C9-4607-952D-7E81FE9BC7C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604" y="1777"/>
                  <a:ext cx="0" cy="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78" name="Rectangle 79">
                  <a:extLst>
                    <a:ext uri="{FF2B5EF4-FFF2-40B4-BE49-F238E27FC236}">
                      <a16:creationId xmlns:a16="http://schemas.microsoft.com/office/drawing/2014/main" xmlns="" id="{051B1BE7-6FCD-4815-8FA4-CB0747E0FDA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84" y="1804"/>
                  <a:ext cx="22" cy="4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5</a:t>
                  </a:r>
                  <a:endPara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79" name="Line 80">
                  <a:extLst>
                    <a:ext uri="{FF2B5EF4-FFF2-40B4-BE49-F238E27FC236}">
                      <a16:creationId xmlns:a16="http://schemas.microsoft.com/office/drawing/2014/main" xmlns="" id="{587C0585-2170-43E4-8976-CECD32544BC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782" y="1777"/>
                  <a:ext cx="0" cy="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80" name="Rectangle 81">
                  <a:extLst>
                    <a:ext uri="{FF2B5EF4-FFF2-40B4-BE49-F238E27FC236}">
                      <a16:creationId xmlns:a16="http://schemas.microsoft.com/office/drawing/2014/main" xmlns="" id="{027A56CA-5AC3-48DD-8380-9FA979BBB4B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62" y="1804"/>
                  <a:ext cx="22" cy="4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6</a:t>
                  </a:r>
                  <a:endPara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81" name="Line 82">
                  <a:extLst>
                    <a:ext uri="{FF2B5EF4-FFF2-40B4-BE49-F238E27FC236}">
                      <a16:creationId xmlns:a16="http://schemas.microsoft.com/office/drawing/2014/main" xmlns="" id="{9E37082F-F260-4C6A-B53B-9797059ACBE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960" y="1777"/>
                  <a:ext cx="0" cy="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82" name="Rectangle 83">
                  <a:extLst>
                    <a:ext uri="{FF2B5EF4-FFF2-40B4-BE49-F238E27FC236}">
                      <a16:creationId xmlns:a16="http://schemas.microsoft.com/office/drawing/2014/main" xmlns="" id="{7A3C5765-E12C-4A22-AC81-5F09EC2AA8E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940" y="1804"/>
                  <a:ext cx="22" cy="4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7</a:t>
                  </a:r>
                  <a:endPara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83" name="Line 84">
                  <a:extLst>
                    <a:ext uri="{FF2B5EF4-FFF2-40B4-BE49-F238E27FC236}">
                      <a16:creationId xmlns:a16="http://schemas.microsoft.com/office/drawing/2014/main" xmlns="" id="{F40D30FF-9B8A-4484-9DF3-310C865CE69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38" y="1777"/>
                  <a:ext cx="0" cy="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84" name="Rectangle 85">
                  <a:extLst>
                    <a:ext uri="{FF2B5EF4-FFF2-40B4-BE49-F238E27FC236}">
                      <a16:creationId xmlns:a16="http://schemas.microsoft.com/office/drawing/2014/main" xmlns="" id="{A3010963-77A3-442A-808C-3BA476AADD5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18" y="1804"/>
                  <a:ext cx="22" cy="4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8</a:t>
                  </a:r>
                  <a:endPara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85" name="Line 86">
                  <a:extLst>
                    <a:ext uri="{FF2B5EF4-FFF2-40B4-BE49-F238E27FC236}">
                      <a16:creationId xmlns:a16="http://schemas.microsoft.com/office/drawing/2014/main" xmlns="" id="{AEE57152-93CC-456C-9D16-C8E3F5DAB1C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315" y="1777"/>
                  <a:ext cx="0" cy="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86" name="Rectangle 87">
                  <a:extLst>
                    <a:ext uri="{FF2B5EF4-FFF2-40B4-BE49-F238E27FC236}">
                      <a16:creationId xmlns:a16="http://schemas.microsoft.com/office/drawing/2014/main" xmlns="" id="{81FBC119-AFFA-4989-AA13-09A2D95F587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95" y="1804"/>
                  <a:ext cx="22" cy="4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9</a:t>
                  </a:r>
                  <a:endPara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87" name="Line 88">
                  <a:extLst>
                    <a:ext uri="{FF2B5EF4-FFF2-40B4-BE49-F238E27FC236}">
                      <a16:creationId xmlns:a16="http://schemas.microsoft.com/office/drawing/2014/main" xmlns="" id="{6B4D591A-15A8-4FFF-AB74-2502027FFB4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493" y="1777"/>
                  <a:ext cx="0" cy="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88" name="Rectangle 89">
                  <a:extLst>
                    <a:ext uri="{FF2B5EF4-FFF2-40B4-BE49-F238E27FC236}">
                      <a16:creationId xmlns:a16="http://schemas.microsoft.com/office/drawing/2014/main" xmlns="" id="{E3CDD23A-4DC1-4159-A290-2CD9ACB9A3F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62" y="1804"/>
                  <a:ext cx="44" cy="4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0</a:t>
                  </a:r>
                  <a:endPara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89" name="Line 90">
                  <a:extLst>
                    <a:ext uri="{FF2B5EF4-FFF2-40B4-BE49-F238E27FC236}">
                      <a16:creationId xmlns:a16="http://schemas.microsoft.com/office/drawing/2014/main" xmlns="" id="{A7579C30-A1C5-4200-B2FF-94FDE645D12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671" y="1777"/>
                  <a:ext cx="0" cy="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90" name="Rectangle 91">
                  <a:extLst>
                    <a:ext uri="{FF2B5EF4-FFF2-40B4-BE49-F238E27FC236}">
                      <a16:creationId xmlns:a16="http://schemas.microsoft.com/office/drawing/2014/main" xmlns="" id="{8EEA62BC-CA65-4051-99EE-CA8D448CAAD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640" y="1804"/>
                  <a:ext cx="44" cy="4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1</a:t>
                  </a:r>
                  <a:endPara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91" name="Line 92">
                  <a:extLst>
                    <a:ext uri="{FF2B5EF4-FFF2-40B4-BE49-F238E27FC236}">
                      <a16:creationId xmlns:a16="http://schemas.microsoft.com/office/drawing/2014/main" xmlns="" id="{E4D11089-94F5-450F-8ADE-86ECFA6F58F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849" y="1777"/>
                  <a:ext cx="0" cy="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92" name="Rectangle 93">
                  <a:extLst>
                    <a:ext uri="{FF2B5EF4-FFF2-40B4-BE49-F238E27FC236}">
                      <a16:creationId xmlns:a16="http://schemas.microsoft.com/office/drawing/2014/main" xmlns="" id="{F4037A4A-9B3C-4995-9E18-9089A9F44CC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818" y="1804"/>
                  <a:ext cx="44" cy="4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2</a:t>
                  </a:r>
                  <a:endPara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93" name="Line 94">
                  <a:extLst>
                    <a:ext uri="{FF2B5EF4-FFF2-40B4-BE49-F238E27FC236}">
                      <a16:creationId xmlns:a16="http://schemas.microsoft.com/office/drawing/2014/main" xmlns="" id="{85624994-4257-47C5-AC76-6ED314B9533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026" y="1777"/>
                  <a:ext cx="0" cy="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94" name="Rectangle 95">
                  <a:extLst>
                    <a:ext uri="{FF2B5EF4-FFF2-40B4-BE49-F238E27FC236}">
                      <a16:creationId xmlns:a16="http://schemas.microsoft.com/office/drawing/2014/main" xmlns="" id="{724159F8-FA74-410C-BDE4-9C6319E12AD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995" y="1804"/>
                  <a:ext cx="44" cy="4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3</a:t>
                  </a:r>
                  <a:endPara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95" name="Line 96">
                  <a:extLst>
                    <a:ext uri="{FF2B5EF4-FFF2-40B4-BE49-F238E27FC236}">
                      <a16:creationId xmlns:a16="http://schemas.microsoft.com/office/drawing/2014/main" xmlns="" id="{2D85538B-1935-4DC5-984A-D6D764454D3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204" y="1777"/>
                  <a:ext cx="0" cy="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96" name="Rectangle 97">
                  <a:extLst>
                    <a:ext uri="{FF2B5EF4-FFF2-40B4-BE49-F238E27FC236}">
                      <a16:creationId xmlns:a16="http://schemas.microsoft.com/office/drawing/2014/main" xmlns="" id="{236FF26A-9D68-4B49-980D-8DBC8D3FE2F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173" y="1804"/>
                  <a:ext cx="44" cy="4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4</a:t>
                  </a:r>
                  <a:endPara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97" name="Line 98">
                  <a:extLst>
                    <a:ext uri="{FF2B5EF4-FFF2-40B4-BE49-F238E27FC236}">
                      <a16:creationId xmlns:a16="http://schemas.microsoft.com/office/drawing/2014/main" xmlns="" id="{11017A26-38A2-4522-93BA-824005B1E03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382" y="1777"/>
                  <a:ext cx="0" cy="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198" name="Rectangle 99">
                  <a:extLst>
                    <a:ext uri="{FF2B5EF4-FFF2-40B4-BE49-F238E27FC236}">
                      <a16:creationId xmlns:a16="http://schemas.microsoft.com/office/drawing/2014/main" xmlns="" id="{89DE7FD6-3A56-4E21-9C71-BBA1B950E6E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351" y="1804"/>
                  <a:ext cx="44" cy="4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5</a:t>
                  </a:r>
                  <a:endPara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99" name="Rectangle 100">
                  <a:extLst>
                    <a:ext uri="{FF2B5EF4-FFF2-40B4-BE49-F238E27FC236}">
                      <a16:creationId xmlns:a16="http://schemas.microsoft.com/office/drawing/2014/main" xmlns="" id="{FA14F769-5250-4CEC-BAD0-094C7884D84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948" y="1858"/>
                  <a:ext cx="191" cy="4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Time (min)</a:t>
                  </a:r>
                  <a:endPara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00" name="Line 101">
                  <a:extLst>
                    <a:ext uri="{FF2B5EF4-FFF2-40B4-BE49-F238E27FC236}">
                      <a16:creationId xmlns:a16="http://schemas.microsoft.com/office/drawing/2014/main" xmlns="" id="{1ECFFF42-4C93-4952-B975-CF76E1FAD8F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1718" y="226"/>
                  <a:ext cx="0" cy="154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01" name="Line 102">
                  <a:extLst>
                    <a:ext uri="{FF2B5EF4-FFF2-40B4-BE49-F238E27FC236}">
                      <a16:creationId xmlns:a16="http://schemas.microsoft.com/office/drawing/2014/main" xmlns="" id="{704B0B95-45F2-48DF-A60B-3E56F6D3238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1761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02" name="Line 103">
                  <a:extLst>
                    <a:ext uri="{FF2B5EF4-FFF2-40B4-BE49-F238E27FC236}">
                      <a16:creationId xmlns:a16="http://schemas.microsoft.com/office/drawing/2014/main" xmlns="" id="{1DA72CF8-8097-4485-A338-6928D73D85D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1745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03" name="Line 104">
                  <a:extLst>
                    <a:ext uri="{FF2B5EF4-FFF2-40B4-BE49-F238E27FC236}">
                      <a16:creationId xmlns:a16="http://schemas.microsoft.com/office/drawing/2014/main" xmlns="" id="{11F0D158-5643-47A5-99D8-9F76B07DCF4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1731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04" name="Line 105">
                  <a:extLst>
                    <a:ext uri="{FF2B5EF4-FFF2-40B4-BE49-F238E27FC236}">
                      <a16:creationId xmlns:a16="http://schemas.microsoft.com/office/drawing/2014/main" xmlns="" id="{B76FCE5A-6D6F-4434-A27E-CE6ECD66EE7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1715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05" name="Line 106">
                  <a:extLst>
                    <a:ext uri="{FF2B5EF4-FFF2-40B4-BE49-F238E27FC236}">
                      <a16:creationId xmlns:a16="http://schemas.microsoft.com/office/drawing/2014/main" xmlns="" id="{9C85E17F-CAB6-4659-A82D-EE090220F79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1684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06" name="Line 107">
                  <a:extLst>
                    <a:ext uri="{FF2B5EF4-FFF2-40B4-BE49-F238E27FC236}">
                      <a16:creationId xmlns:a16="http://schemas.microsoft.com/office/drawing/2014/main" xmlns="" id="{C25BEA9C-7951-46AC-96DA-9C696E4192D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1668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07" name="Line 108">
                  <a:extLst>
                    <a:ext uri="{FF2B5EF4-FFF2-40B4-BE49-F238E27FC236}">
                      <a16:creationId xmlns:a16="http://schemas.microsoft.com/office/drawing/2014/main" xmlns="" id="{FBD19358-4494-4719-8E69-A0E5A51BA1F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1652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08" name="Line 109">
                  <a:extLst>
                    <a:ext uri="{FF2B5EF4-FFF2-40B4-BE49-F238E27FC236}">
                      <a16:creationId xmlns:a16="http://schemas.microsoft.com/office/drawing/2014/main" xmlns="" id="{E1C5F26A-D6D8-446F-9F66-18A6ACA8E4A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1638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09" name="Line 110">
                  <a:extLst>
                    <a:ext uri="{FF2B5EF4-FFF2-40B4-BE49-F238E27FC236}">
                      <a16:creationId xmlns:a16="http://schemas.microsoft.com/office/drawing/2014/main" xmlns="" id="{AFE86320-50D5-45D9-9333-271B45A460B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1606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10" name="Line 111">
                  <a:extLst>
                    <a:ext uri="{FF2B5EF4-FFF2-40B4-BE49-F238E27FC236}">
                      <a16:creationId xmlns:a16="http://schemas.microsoft.com/office/drawing/2014/main" xmlns="" id="{948630F4-354E-484F-89D9-87EB798DFA8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1591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11" name="Line 112">
                  <a:extLst>
                    <a:ext uri="{FF2B5EF4-FFF2-40B4-BE49-F238E27FC236}">
                      <a16:creationId xmlns:a16="http://schemas.microsoft.com/office/drawing/2014/main" xmlns="" id="{A30E671F-48D9-47A2-B209-350D76B61A9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1575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12" name="Line 113">
                  <a:extLst>
                    <a:ext uri="{FF2B5EF4-FFF2-40B4-BE49-F238E27FC236}">
                      <a16:creationId xmlns:a16="http://schemas.microsoft.com/office/drawing/2014/main" xmlns="" id="{7AE0FCFF-787B-4CE1-B77C-B5262A838D8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1559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13" name="Line 114">
                  <a:extLst>
                    <a:ext uri="{FF2B5EF4-FFF2-40B4-BE49-F238E27FC236}">
                      <a16:creationId xmlns:a16="http://schemas.microsoft.com/office/drawing/2014/main" xmlns="" id="{DE4A8CB2-744B-49FF-9EF7-654FC7CE94F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1529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14" name="Line 115">
                  <a:extLst>
                    <a:ext uri="{FF2B5EF4-FFF2-40B4-BE49-F238E27FC236}">
                      <a16:creationId xmlns:a16="http://schemas.microsoft.com/office/drawing/2014/main" xmlns="" id="{8A672F91-3B39-4E83-86CA-A4DE44F7BCF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1512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15" name="Line 116">
                  <a:extLst>
                    <a:ext uri="{FF2B5EF4-FFF2-40B4-BE49-F238E27FC236}">
                      <a16:creationId xmlns:a16="http://schemas.microsoft.com/office/drawing/2014/main" xmlns="" id="{C605D7DA-3233-4971-8D1F-202765023DE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1498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16" name="Line 117">
                  <a:extLst>
                    <a:ext uri="{FF2B5EF4-FFF2-40B4-BE49-F238E27FC236}">
                      <a16:creationId xmlns:a16="http://schemas.microsoft.com/office/drawing/2014/main" xmlns="" id="{DB42C076-EDFE-4010-AE23-1F8F20CF78E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1482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17" name="Line 118">
                  <a:extLst>
                    <a:ext uri="{FF2B5EF4-FFF2-40B4-BE49-F238E27FC236}">
                      <a16:creationId xmlns:a16="http://schemas.microsoft.com/office/drawing/2014/main" xmlns="" id="{94EF2F7C-FA92-447E-80C2-B6C78A78124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1452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18" name="Line 119">
                  <a:extLst>
                    <a:ext uri="{FF2B5EF4-FFF2-40B4-BE49-F238E27FC236}">
                      <a16:creationId xmlns:a16="http://schemas.microsoft.com/office/drawing/2014/main" xmlns="" id="{EA914CBF-CE37-4116-BD8A-62114151200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1436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19" name="Line 120">
                  <a:extLst>
                    <a:ext uri="{FF2B5EF4-FFF2-40B4-BE49-F238E27FC236}">
                      <a16:creationId xmlns:a16="http://schemas.microsoft.com/office/drawing/2014/main" xmlns="" id="{A84A42BF-031A-47AF-91CA-5DC152CA43D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1419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20" name="Line 121">
                  <a:extLst>
                    <a:ext uri="{FF2B5EF4-FFF2-40B4-BE49-F238E27FC236}">
                      <a16:creationId xmlns:a16="http://schemas.microsoft.com/office/drawing/2014/main" xmlns="" id="{141C8D64-0145-4B60-A511-A479988C87A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1405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21" name="Line 122">
                  <a:extLst>
                    <a:ext uri="{FF2B5EF4-FFF2-40B4-BE49-F238E27FC236}">
                      <a16:creationId xmlns:a16="http://schemas.microsoft.com/office/drawing/2014/main" xmlns="" id="{93C7EF8B-57D4-41BD-8BD3-4E8D768EF0B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1373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22" name="Line 123">
                  <a:extLst>
                    <a:ext uri="{FF2B5EF4-FFF2-40B4-BE49-F238E27FC236}">
                      <a16:creationId xmlns:a16="http://schemas.microsoft.com/office/drawing/2014/main" xmlns="" id="{EC2F4F2E-3033-47B4-8D53-3BB22E225A1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1359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23" name="Line 124">
                  <a:extLst>
                    <a:ext uri="{FF2B5EF4-FFF2-40B4-BE49-F238E27FC236}">
                      <a16:creationId xmlns:a16="http://schemas.microsoft.com/office/drawing/2014/main" xmlns="" id="{0C9228D9-9E94-453E-B8A7-61189A34EFD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1343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24" name="Line 125">
                  <a:extLst>
                    <a:ext uri="{FF2B5EF4-FFF2-40B4-BE49-F238E27FC236}">
                      <a16:creationId xmlns:a16="http://schemas.microsoft.com/office/drawing/2014/main" xmlns="" id="{B1D03A3C-BA15-4215-914B-FA430DB6DBD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1326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25" name="Line 126">
                  <a:extLst>
                    <a:ext uri="{FF2B5EF4-FFF2-40B4-BE49-F238E27FC236}">
                      <a16:creationId xmlns:a16="http://schemas.microsoft.com/office/drawing/2014/main" xmlns="" id="{506F7767-C3A8-48D8-9137-5E05B7F99BE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1296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26" name="Line 127">
                  <a:extLst>
                    <a:ext uri="{FF2B5EF4-FFF2-40B4-BE49-F238E27FC236}">
                      <a16:creationId xmlns:a16="http://schemas.microsoft.com/office/drawing/2014/main" xmlns="" id="{4BF7F4C2-C895-4EFF-B8A8-E75D716D39B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1280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27" name="Line 128">
                  <a:extLst>
                    <a:ext uri="{FF2B5EF4-FFF2-40B4-BE49-F238E27FC236}">
                      <a16:creationId xmlns:a16="http://schemas.microsoft.com/office/drawing/2014/main" xmlns="" id="{CE94B2BB-9266-4577-A8E8-91C94EF12B1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1266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28" name="Line 129">
                  <a:extLst>
                    <a:ext uri="{FF2B5EF4-FFF2-40B4-BE49-F238E27FC236}">
                      <a16:creationId xmlns:a16="http://schemas.microsoft.com/office/drawing/2014/main" xmlns="" id="{13A7CFA9-0DE4-4CFD-999E-675AAA9DB82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1250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29" name="Line 130">
                  <a:extLst>
                    <a:ext uri="{FF2B5EF4-FFF2-40B4-BE49-F238E27FC236}">
                      <a16:creationId xmlns:a16="http://schemas.microsoft.com/office/drawing/2014/main" xmlns="" id="{908E7897-06C0-4845-95C8-81F5B9C1FD2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1219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30" name="Line 131">
                  <a:extLst>
                    <a:ext uri="{FF2B5EF4-FFF2-40B4-BE49-F238E27FC236}">
                      <a16:creationId xmlns:a16="http://schemas.microsoft.com/office/drawing/2014/main" xmlns="" id="{6E03FD61-EB66-492A-9F97-D2E40868EED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1203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31" name="Line 132">
                  <a:extLst>
                    <a:ext uri="{FF2B5EF4-FFF2-40B4-BE49-F238E27FC236}">
                      <a16:creationId xmlns:a16="http://schemas.microsoft.com/office/drawing/2014/main" xmlns="" id="{C1C8D026-3949-4CE3-8E3E-236773D28B2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1187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32" name="Line 133">
                  <a:extLst>
                    <a:ext uri="{FF2B5EF4-FFF2-40B4-BE49-F238E27FC236}">
                      <a16:creationId xmlns:a16="http://schemas.microsoft.com/office/drawing/2014/main" xmlns="" id="{9258EDEE-3237-4ACB-96C9-2A9D17E290D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1173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33" name="Line 134">
                  <a:extLst>
                    <a:ext uri="{FF2B5EF4-FFF2-40B4-BE49-F238E27FC236}">
                      <a16:creationId xmlns:a16="http://schemas.microsoft.com/office/drawing/2014/main" xmlns="" id="{81131E87-B417-40FD-B4D0-02B7EBFD4E6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1140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34" name="Line 135">
                  <a:extLst>
                    <a:ext uri="{FF2B5EF4-FFF2-40B4-BE49-F238E27FC236}">
                      <a16:creationId xmlns:a16="http://schemas.microsoft.com/office/drawing/2014/main" xmlns="" id="{A0CA70DF-5219-4D7D-8726-043E22AC245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1126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35" name="Line 136">
                  <a:extLst>
                    <a:ext uri="{FF2B5EF4-FFF2-40B4-BE49-F238E27FC236}">
                      <a16:creationId xmlns:a16="http://schemas.microsoft.com/office/drawing/2014/main" xmlns="" id="{78B40852-366D-410C-87B7-3EFB5FFF68E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1110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36" name="Line 137">
                  <a:extLst>
                    <a:ext uri="{FF2B5EF4-FFF2-40B4-BE49-F238E27FC236}">
                      <a16:creationId xmlns:a16="http://schemas.microsoft.com/office/drawing/2014/main" xmlns="" id="{F7150ADA-8563-426E-ACA7-DE993A9FAAF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1094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37" name="Line 138">
                  <a:extLst>
                    <a:ext uri="{FF2B5EF4-FFF2-40B4-BE49-F238E27FC236}">
                      <a16:creationId xmlns:a16="http://schemas.microsoft.com/office/drawing/2014/main" xmlns="" id="{76BB8502-21D3-4CC9-B848-EA08888EC58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1063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38" name="Line 139">
                  <a:extLst>
                    <a:ext uri="{FF2B5EF4-FFF2-40B4-BE49-F238E27FC236}">
                      <a16:creationId xmlns:a16="http://schemas.microsoft.com/office/drawing/2014/main" xmlns="" id="{5F79C036-5953-4F16-91AC-42A674CD031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1047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39" name="Line 140">
                  <a:extLst>
                    <a:ext uri="{FF2B5EF4-FFF2-40B4-BE49-F238E27FC236}">
                      <a16:creationId xmlns:a16="http://schemas.microsoft.com/office/drawing/2014/main" xmlns="" id="{4DBD2A21-8790-4903-972E-F48A82CA35A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1033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40" name="Line 141">
                  <a:extLst>
                    <a:ext uri="{FF2B5EF4-FFF2-40B4-BE49-F238E27FC236}">
                      <a16:creationId xmlns:a16="http://schemas.microsoft.com/office/drawing/2014/main" xmlns="" id="{65552774-36EC-4551-810C-90CD9E1FC32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1017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41" name="Line 142">
                  <a:extLst>
                    <a:ext uri="{FF2B5EF4-FFF2-40B4-BE49-F238E27FC236}">
                      <a16:creationId xmlns:a16="http://schemas.microsoft.com/office/drawing/2014/main" xmlns="" id="{325994FD-3971-4852-A719-0454CABB8E3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987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42" name="Line 143">
                  <a:extLst>
                    <a:ext uri="{FF2B5EF4-FFF2-40B4-BE49-F238E27FC236}">
                      <a16:creationId xmlns:a16="http://schemas.microsoft.com/office/drawing/2014/main" xmlns="" id="{6237931C-3B54-4D77-8942-3951D2E7B09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970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43" name="Line 144">
                  <a:extLst>
                    <a:ext uri="{FF2B5EF4-FFF2-40B4-BE49-F238E27FC236}">
                      <a16:creationId xmlns:a16="http://schemas.microsoft.com/office/drawing/2014/main" xmlns="" id="{78D323DA-4D1A-4974-BADD-D7E7738BD8C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956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44" name="Line 145">
                  <a:extLst>
                    <a:ext uri="{FF2B5EF4-FFF2-40B4-BE49-F238E27FC236}">
                      <a16:creationId xmlns:a16="http://schemas.microsoft.com/office/drawing/2014/main" xmlns="" id="{B7EBA0A5-2700-48AA-96A3-300AD21C5C8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940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45" name="Line 146">
                  <a:extLst>
                    <a:ext uri="{FF2B5EF4-FFF2-40B4-BE49-F238E27FC236}">
                      <a16:creationId xmlns:a16="http://schemas.microsoft.com/office/drawing/2014/main" xmlns="" id="{99E09428-4835-4D4F-98DF-8CDCBEAB4C6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910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46" name="Line 147">
                  <a:extLst>
                    <a:ext uri="{FF2B5EF4-FFF2-40B4-BE49-F238E27FC236}">
                      <a16:creationId xmlns:a16="http://schemas.microsoft.com/office/drawing/2014/main" xmlns="" id="{7E4FEA71-6AEB-476A-A31C-C1C64AFE909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894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47" name="Line 148">
                  <a:extLst>
                    <a:ext uri="{FF2B5EF4-FFF2-40B4-BE49-F238E27FC236}">
                      <a16:creationId xmlns:a16="http://schemas.microsoft.com/office/drawing/2014/main" xmlns="" id="{C2EAF7BB-14F8-4AD6-A40F-2D24E3F3906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877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48" name="Line 149">
                  <a:extLst>
                    <a:ext uri="{FF2B5EF4-FFF2-40B4-BE49-F238E27FC236}">
                      <a16:creationId xmlns:a16="http://schemas.microsoft.com/office/drawing/2014/main" xmlns="" id="{89EDA325-F3FE-4D0D-A1E3-5DCB2586AB1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863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49" name="Line 150">
                  <a:extLst>
                    <a:ext uri="{FF2B5EF4-FFF2-40B4-BE49-F238E27FC236}">
                      <a16:creationId xmlns:a16="http://schemas.microsoft.com/office/drawing/2014/main" xmlns="" id="{0C83F67D-9786-4E7B-B907-F47EAEE078C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831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50" name="Line 151">
                  <a:extLst>
                    <a:ext uri="{FF2B5EF4-FFF2-40B4-BE49-F238E27FC236}">
                      <a16:creationId xmlns:a16="http://schemas.microsoft.com/office/drawing/2014/main" xmlns="" id="{051D2F36-5AE2-4FE6-86B3-8D13E15C68D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817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51" name="Line 152">
                  <a:extLst>
                    <a:ext uri="{FF2B5EF4-FFF2-40B4-BE49-F238E27FC236}">
                      <a16:creationId xmlns:a16="http://schemas.microsoft.com/office/drawing/2014/main" xmlns="" id="{9FF9F703-2D58-4051-A0F1-D53F688EFF2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801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52" name="Line 153">
                  <a:extLst>
                    <a:ext uri="{FF2B5EF4-FFF2-40B4-BE49-F238E27FC236}">
                      <a16:creationId xmlns:a16="http://schemas.microsoft.com/office/drawing/2014/main" xmlns="" id="{975119CE-5F37-4B9C-81C5-640A316BBB1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784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53" name="Line 154">
                  <a:extLst>
                    <a:ext uri="{FF2B5EF4-FFF2-40B4-BE49-F238E27FC236}">
                      <a16:creationId xmlns:a16="http://schemas.microsoft.com/office/drawing/2014/main" xmlns="" id="{A5195EAF-430C-4E98-B2BE-8285CEBBF0E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754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54" name="Line 155">
                  <a:extLst>
                    <a:ext uri="{FF2B5EF4-FFF2-40B4-BE49-F238E27FC236}">
                      <a16:creationId xmlns:a16="http://schemas.microsoft.com/office/drawing/2014/main" xmlns="" id="{CBBFE5AF-0EA0-4929-A607-6B83F91EC5E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738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55" name="Line 156">
                  <a:extLst>
                    <a:ext uri="{FF2B5EF4-FFF2-40B4-BE49-F238E27FC236}">
                      <a16:creationId xmlns:a16="http://schemas.microsoft.com/office/drawing/2014/main" xmlns="" id="{DD186DF4-3B2B-494E-99F5-5E8D9ACD933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724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56" name="Line 157">
                  <a:extLst>
                    <a:ext uri="{FF2B5EF4-FFF2-40B4-BE49-F238E27FC236}">
                      <a16:creationId xmlns:a16="http://schemas.microsoft.com/office/drawing/2014/main" xmlns="" id="{9F69E0A2-8E35-47DF-ABDE-A06743406C4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707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57" name="Line 158">
                  <a:extLst>
                    <a:ext uri="{FF2B5EF4-FFF2-40B4-BE49-F238E27FC236}">
                      <a16:creationId xmlns:a16="http://schemas.microsoft.com/office/drawing/2014/main" xmlns="" id="{CD502E14-68B5-4618-B7C4-8A6B688F90B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677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58" name="Line 159">
                  <a:extLst>
                    <a:ext uri="{FF2B5EF4-FFF2-40B4-BE49-F238E27FC236}">
                      <a16:creationId xmlns:a16="http://schemas.microsoft.com/office/drawing/2014/main" xmlns="" id="{9871347F-8063-4AE7-B34C-B4BBE95BBC3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661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59" name="Line 160">
                  <a:extLst>
                    <a:ext uri="{FF2B5EF4-FFF2-40B4-BE49-F238E27FC236}">
                      <a16:creationId xmlns:a16="http://schemas.microsoft.com/office/drawing/2014/main" xmlns="" id="{2E620312-1610-4411-8BBF-BE54883F557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645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60" name="Line 161">
                  <a:extLst>
                    <a:ext uri="{FF2B5EF4-FFF2-40B4-BE49-F238E27FC236}">
                      <a16:creationId xmlns:a16="http://schemas.microsoft.com/office/drawing/2014/main" xmlns="" id="{F2886B56-4983-4063-9425-00EAA4B6396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631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61" name="Line 162">
                  <a:extLst>
                    <a:ext uri="{FF2B5EF4-FFF2-40B4-BE49-F238E27FC236}">
                      <a16:creationId xmlns:a16="http://schemas.microsoft.com/office/drawing/2014/main" xmlns="" id="{4BE52C4D-3189-49F7-AF5F-4F48A0C0DB3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598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62" name="Line 163">
                  <a:extLst>
                    <a:ext uri="{FF2B5EF4-FFF2-40B4-BE49-F238E27FC236}">
                      <a16:creationId xmlns:a16="http://schemas.microsoft.com/office/drawing/2014/main" xmlns="" id="{C1ED341B-E18B-45B0-9EBC-7605428537F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584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63" name="Line 164">
                  <a:extLst>
                    <a:ext uri="{FF2B5EF4-FFF2-40B4-BE49-F238E27FC236}">
                      <a16:creationId xmlns:a16="http://schemas.microsoft.com/office/drawing/2014/main" xmlns="" id="{D885BCFC-63B4-4EB0-96CF-B3D490AA039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568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64" name="Line 165">
                  <a:extLst>
                    <a:ext uri="{FF2B5EF4-FFF2-40B4-BE49-F238E27FC236}">
                      <a16:creationId xmlns:a16="http://schemas.microsoft.com/office/drawing/2014/main" xmlns="" id="{39623AB7-362E-4E98-8B3A-BB8A81D9B7B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552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65" name="Line 166">
                  <a:extLst>
                    <a:ext uri="{FF2B5EF4-FFF2-40B4-BE49-F238E27FC236}">
                      <a16:creationId xmlns:a16="http://schemas.microsoft.com/office/drawing/2014/main" xmlns="" id="{C6FBBBDF-FE20-43D4-8778-CB3A9D72610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521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66" name="Line 167">
                  <a:extLst>
                    <a:ext uri="{FF2B5EF4-FFF2-40B4-BE49-F238E27FC236}">
                      <a16:creationId xmlns:a16="http://schemas.microsoft.com/office/drawing/2014/main" xmlns="" id="{34C5CFCF-6920-4E03-B3B7-F6932F6401D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505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67" name="Line 168">
                  <a:extLst>
                    <a:ext uri="{FF2B5EF4-FFF2-40B4-BE49-F238E27FC236}">
                      <a16:creationId xmlns:a16="http://schemas.microsoft.com/office/drawing/2014/main" xmlns="" id="{1F3BD9DF-450A-4F71-946B-7AE4E51C160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491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68" name="Line 169">
                  <a:extLst>
                    <a:ext uri="{FF2B5EF4-FFF2-40B4-BE49-F238E27FC236}">
                      <a16:creationId xmlns:a16="http://schemas.microsoft.com/office/drawing/2014/main" xmlns="" id="{06B2B62F-8411-4F29-B462-3197A27C3D7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475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69" name="Line 170">
                  <a:extLst>
                    <a:ext uri="{FF2B5EF4-FFF2-40B4-BE49-F238E27FC236}">
                      <a16:creationId xmlns:a16="http://schemas.microsoft.com/office/drawing/2014/main" xmlns="" id="{5DAF8632-F5BE-49F5-B023-402C973E655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445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70" name="Line 171">
                  <a:extLst>
                    <a:ext uri="{FF2B5EF4-FFF2-40B4-BE49-F238E27FC236}">
                      <a16:creationId xmlns:a16="http://schemas.microsoft.com/office/drawing/2014/main" xmlns="" id="{E910B973-BF83-488D-BD3E-8F709FA394D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428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71" name="Line 172">
                  <a:extLst>
                    <a:ext uri="{FF2B5EF4-FFF2-40B4-BE49-F238E27FC236}">
                      <a16:creationId xmlns:a16="http://schemas.microsoft.com/office/drawing/2014/main" xmlns="" id="{B2E05B95-153B-402B-9C49-87A77A79B51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412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72" name="Line 173">
                  <a:extLst>
                    <a:ext uri="{FF2B5EF4-FFF2-40B4-BE49-F238E27FC236}">
                      <a16:creationId xmlns:a16="http://schemas.microsoft.com/office/drawing/2014/main" xmlns="" id="{588EC5DF-D958-4831-BC77-AF9B936F508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398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73" name="Line 174">
                  <a:extLst>
                    <a:ext uri="{FF2B5EF4-FFF2-40B4-BE49-F238E27FC236}">
                      <a16:creationId xmlns:a16="http://schemas.microsoft.com/office/drawing/2014/main" xmlns="" id="{C9D7E107-947B-4698-95E0-66AFBE332BA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366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74" name="Line 175">
                  <a:extLst>
                    <a:ext uri="{FF2B5EF4-FFF2-40B4-BE49-F238E27FC236}">
                      <a16:creationId xmlns:a16="http://schemas.microsoft.com/office/drawing/2014/main" xmlns="" id="{8862D31E-EB3D-4D5E-AD1F-6924A1B4200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352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75" name="Line 176">
                  <a:extLst>
                    <a:ext uri="{FF2B5EF4-FFF2-40B4-BE49-F238E27FC236}">
                      <a16:creationId xmlns:a16="http://schemas.microsoft.com/office/drawing/2014/main" xmlns="" id="{F8F8883A-963A-46D8-9220-A3BCC4450A9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335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76" name="Line 177">
                  <a:extLst>
                    <a:ext uri="{FF2B5EF4-FFF2-40B4-BE49-F238E27FC236}">
                      <a16:creationId xmlns:a16="http://schemas.microsoft.com/office/drawing/2014/main" xmlns="" id="{7BB02A9C-1401-4389-9BF5-2E94C021812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319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77" name="Line 178">
                  <a:extLst>
                    <a:ext uri="{FF2B5EF4-FFF2-40B4-BE49-F238E27FC236}">
                      <a16:creationId xmlns:a16="http://schemas.microsoft.com/office/drawing/2014/main" xmlns="" id="{34A401B9-C0F5-4028-887D-F12428E1B71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289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78" name="Line 179">
                  <a:extLst>
                    <a:ext uri="{FF2B5EF4-FFF2-40B4-BE49-F238E27FC236}">
                      <a16:creationId xmlns:a16="http://schemas.microsoft.com/office/drawing/2014/main" xmlns="" id="{C14C8F14-BA39-4F08-ADEC-CA953999495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273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79" name="Line 180">
                  <a:extLst>
                    <a:ext uri="{FF2B5EF4-FFF2-40B4-BE49-F238E27FC236}">
                      <a16:creationId xmlns:a16="http://schemas.microsoft.com/office/drawing/2014/main" xmlns="" id="{26D75698-460B-438A-AE4A-B7EF5D6223A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258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80" name="Line 181">
                  <a:extLst>
                    <a:ext uri="{FF2B5EF4-FFF2-40B4-BE49-F238E27FC236}">
                      <a16:creationId xmlns:a16="http://schemas.microsoft.com/office/drawing/2014/main" xmlns="" id="{770A9099-EC48-45C4-8405-E674BDB4624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9" y="242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81" name="Line 182">
                  <a:extLst>
                    <a:ext uri="{FF2B5EF4-FFF2-40B4-BE49-F238E27FC236}">
                      <a16:creationId xmlns:a16="http://schemas.microsoft.com/office/drawing/2014/main" xmlns="" id="{250BEDC5-3C7C-48E3-9B08-1A05FF8557B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1" y="1775"/>
                  <a:ext cx="27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82" name="Rectangle 183">
                  <a:extLst>
                    <a:ext uri="{FF2B5EF4-FFF2-40B4-BE49-F238E27FC236}">
                      <a16:creationId xmlns:a16="http://schemas.microsoft.com/office/drawing/2014/main" xmlns="" id="{1011D958-6304-4FF1-8B2E-68C6081A152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651" y="1754"/>
                  <a:ext cx="22" cy="4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</a:t>
                  </a:r>
                  <a:endPara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83" name="Line 184">
                  <a:extLst>
                    <a:ext uri="{FF2B5EF4-FFF2-40B4-BE49-F238E27FC236}">
                      <a16:creationId xmlns:a16="http://schemas.microsoft.com/office/drawing/2014/main" xmlns="" id="{618AB288-22CD-4C16-AEEB-5DD169BA608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1" y="1699"/>
                  <a:ext cx="27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84" name="Rectangle 185">
                  <a:extLst>
                    <a:ext uri="{FF2B5EF4-FFF2-40B4-BE49-F238E27FC236}">
                      <a16:creationId xmlns:a16="http://schemas.microsoft.com/office/drawing/2014/main" xmlns="" id="{C68923F7-DDA5-4E79-AB5A-4A2F8D2E271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651" y="1677"/>
                  <a:ext cx="22" cy="4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5</a:t>
                  </a:r>
                  <a:endPara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85" name="Line 186">
                  <a:extLst>
                    <a:ext uri="{FF2B5EF4-FFF2-40B4-BE49-F238E27FC236}">
                      <a16:creationId xmlns:a16="http://schemas.microsoft.com/office/drawing/2014/main" xmlns="" id="{DC59D9CB-6FBB-4374-A4F3-A4FB4E7107B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1" y="1622"/>
                  <a:ext cx="27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86" name="Rectangle 187">
                  <a:extLst>
                    <a:ext uri="{FF2B5EF4-FFF2-40B4-BE49-F238E27FC236}">
                      <a16:creationId xmlns:a16="http://schemas.microsoft.com/office/drawing/2014/main" xmlns="" id="{B7E23AA6-449F-4E86-A65B-77221B9A323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628" y="1600"/>
                  <a:ext cx="44" cy="4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0</a:t>
                  </a:r>
                  <a:endPara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87" name="Line 188">
                  <a:extLst>
                    <a:ext uri="{FF2B5EF4-FFF2-40B4-BE49-F238E27FC236}">
                      <a16:creationId xmlns:a16="http://schemas.microsoft.com/office/drawing/2014/main" xmlns="" id="{9B186043-9BDF-4332-A775-F931577B1DE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1" y="1545"/>
                  <a:ext cx="27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88" name="Rectangle 189">
                  <a:extLst>
                    <a:ext uri="{FF2B5EF4-FFF2-40B4-BE49-F238E27FC236}">
                      <a16:creationId xmlns:a16="http://schemas.microsoft.com/office/drawing/2014/main" xmlns="" id="{55FC09C0-84C5-47CC-A82F-5699E6C859B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628" y="1523"/>
                  <a:ext cx="44" cy="4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5</a:t>
                  </a:r>
                  <a:endPara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89" name="Line 190">
                  <a:extLst>
                    <a:ext uri="{FF2B5EF4-FFF2-40B4-BE49-F238E27FC236}">
                      <a16:creationId xmlns:a16="http://schemas.microsoft.com/office/drawing/2014/main" xmlns="" id="{527C206E-F47D-4F4E-9B47-78B0B21ADD8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1" y="1466"/>
                  <a:ext cx="27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90" name="Rectangle 191">
                  <a:extLst>
                    <a:ext uri="{FF2B5EF4-FFF2-40B4-BE49-F238E27FC236}">
                      <a16:creationId xmlns:a16="http://schemas.microsoft.com/office/drawing/2014/main" xmlns="" id="{51115CF1-29FD-458C-967E-7CA24C8B44F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628" y="1444"/>
                  <a:ext cx="44" cy="4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20</a:t>
                  </a:r>
                  <a:endPara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91" name="Line 192">
                  <a:extLst>
                    <a:ext uri="{FF2B5EF4-FFF2-40B4-BE49-F238E27FC236}">
                      <a16:creationId xmlns:a16="http://schemas.microsoft.com/office/drawing/2014/main" xmlns="" id="{4DB2E9C5-35D5-4DA9-82D7-C7C38B38D7D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1" y="1389"/>
                  <a:ext cx="27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92" name="Rectangle 193">
                  <a:extLst>
                    <a:ext uri="{FF2B5EF4-FFF2-40B4-BE49-F238E27FC236}">
                      <a16:creationId xmlns:a16="http://schemas.microsoft.com/office/drawing/2014/main" xmlns="" id="{0446F625-D882-40D8-A245-A95633CD16A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628" y="1367"/>
                  <a:ext cx="44" cy="4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25</a:t>
                  </a:r>
                  <a:endPara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93" name="Line 194">
                  <a:extLst>
                    <a:ext uri="{FF2B5EF4-FFF2-40B4-BE49-F238E27FC236}">
                      <a16:creationId xmlns:a16="http://schemas.microsoft.com/office/drawing/2014/main" xmlns="" id="{AB0E5C25-3B3B-419E-8056-AF3C201B215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1" y="1312"/>
                  <a:ext cx="27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94" name="Rectangle 195">
                  <a:extLst>
                    <a:ext uri="{FF2B5EF4-FFF2-40B4-BE49-F238E27FC236}">
                      <a16:creationId xmlns:a16="http://schemas.microsoft.com/office/drawing/2014/main" xmlns="" id="{4A88EB4F-26D4-48F4-91DC-9E2012619E3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628" y="1290"/>
                  <a:ext cx="44" cy="4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30</a:t>
                  </a:r>
                  <a:endPara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95" name="Line 196">
                  <a:extLst>
                    <a:ext uri="{FF2B5EF4-FFF2-40B4-BE49-F238E27FC236}">
                      <a16:creationId xmlns:a16="http://schemas.microsoft.com/office/drawing/2014/main" xmlns="" id="{69FA1D34-201B-474B-B57D-5366AF43591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1" y="1233"/>
                  <a:ext cx="27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96" name="Rectangle 197">
                  <a:extLst>
                    <a:ext uri="{FF2B5EF4-FFF2-40B4-BE49-F238E27FC236}">
                      <a16:creationId xmlns:a16="http://schemas.microsoft.com/office/drawing/2014/main" xmlns="" id="{673922E0-D23C-46FE-B2AD-51ED93EDF9A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628" y="1212"/>
                  <a:ext cx="44" cy="4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35</a:t>
                  </a:r>
                  <a:endPara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97" name="Line 198">
                  <a:extLst>
                    <a:ext uri="{FF2B5EF4-FFF2-40B4-BE49-F238E27FC236}">
                      <a16:creationId xmlns:a16="http://schemas.microsoft.com/office/drawing/2014/main" xmlns="" id="{C289B50F-113F-4947-A297-292A16236CD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1" y="1157"/>
                  <a:ext cx="27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298" name="Rectangle 199">
                  <a:extLst>
                    <a:ext uri="{FF2B5EF4-FFF2-40B4-BE49-F238E27FC236}">
                      <a16:creationId xmlns:a16="http://schemas.microsoft.com/office/drawing/2014/main" xmlns="" id="{42521C54-0BDC-4862-99A3-FCE3C6F65D3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628" y="1135"/>
                  <a:ext cx="44" cy="4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40</a:t>
                  </a:r>
                  <a:endPara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99" name="Line 200">
                  <a:extLst>
                    <a:ext uri="{FF2B5EF4-FFF2-40B4-BE49-F238E27FC236}">
                      <a16:creationId xmlns:a16="http://schemas.microsoft.com/office/drawing/2014/main" xmlns="" id="{8F090B33-DC87-4CD8-B6E6-F8B888F6C86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1" y="1080"/>
                  <a:ext cx="27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300" name="Rectangle 201">
                  <a:extLst>
                    <a:ext uri="{FF2B5EF4-FFF2-40B4-BE49-F238E27FC236}">
                      <a16:creationId xmlns:a16="http://schemas.microsoft.com/office/drawing/2014/main" xmlns="" id="{E16411FA-7449-442E-BBBA-9BF132748DF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628" y="1058"/>
                  <a:ext cx="44" cy="4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45</a:t>
                  </a:r>
                  <a:endPara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01" name="Line 202">
                  <a:extLst>
                    <a:ext uri="{FF2B5EF4-FFF2-40B4-BE49-F238E27FC236}">
                      <a16:creationId xmlns:a16="http://schemas.microsoft.com/office/drawing/2014/main" xmlns="" id="{A730270B-C421-4870-BE17-07C2E1C920B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1" y="1001"/>
                  <a:ext cx="27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  <p:sp>
              <p:nvSpPr>
                <p:cNvPr id="302" name="Rectangle 203">
                  <a:extLst>
                    <a:ext uri="{FF2B5EF4-FFF2-40B4-BE49-F238E27FC236}">
                      <a16:creationId xmlns:a16="http://schemas.microsoft.com/office/drawing/2014/main" xmlns="" id="{B9C4C273-5B01-41F9-B2C6-58064635123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628" y="979"/>
                  <a:ext cx="44" cy="4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50</a:t>
                  </a:r>
                  <a:endPara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03" name="Line 204">
                  <a:extLst>
                    <a:ext uri="{FF2B5EF4-FFF2-40B4-BE49-F238E27FC236}">
                      <a16:creationId xmlns:a16="http://schemas.microsoft.com/office/drawing/2014/main" xmlns="" id="{5503A9F7-3C87-4304-BE2C-9CF32787ED5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1" y="924"/>
                  <a:ext cx="27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/>
                </a:p>
              </p:txBody>
            </p:sp>
          </p:grpSp>
          <p:sp>
            <p:nvSpPr>
              <p:cNvPr id="7" name="Rectangle 206">
                <a:extLst>
                  <a:ext uri="{FF2B5EF4-FFF2-40B4-BE49-F238E27FC236}">
                    <a16:creationId xmlns:a16="http://schemas.microsoft.com/office/drawing/2014/main" xmlns="" id="{B3DA58A8-A39B-4FE7-8DDB-ABC4208E437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28" y="902"/>
                <a:ext cx="44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5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" name="Line 207">
                <a:extLst>
                  <a:ext uri="{FF2B5EF4-FFF2-40B4-BE49-F238E27FC236}">
                    <a16:creationId xmlns:a16="http://schemas.microsoft.com/office/drawing/2014/main" xmlns="" id="{8BA006FC-D8EF-4844-906E-02C09597FFC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691" y="847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" name="Rectangle 208">
                <a:extLst>
                  <a:ext uri="{FF2B5EF4-FFF2-40B4-BE49-F238E27FC236}">
                    <a16:creationId xmlns:a16="http://schemas.microsoft.com/office/drawing/2014/main" xmlns="" id="{46119C41-BC97-463A-AFBC-96E7F48280F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28" y="825"/>
                <a:ext cx="44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0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" name="Line 209">
                <a:extLst>
                  <a:ext uri="{FF2B5EF4-FFF2-40B4-BE49-F238E27FC236}">
                    <a16:creationId xmlns:a16="http://schemas.microsoft.com/office/drawing/2014/main" xmlns="" id="{0A1618F0-3C08-46B0-B1FC-821D52A5ECB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691" y="770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11" name="Rectangle 210">
                <a:extLst>
                  <a:ext uri="{FF2B5EF4-FFF2-40B4-BE49-F238E27FC236}">
                    <a16:creationId xmlns:a16="http://schemas.microsoft.com/office/drawing/2014/main" xmlns="" id="{0DBEA252-DE55-405A-AF2B-83537324634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28" y="748"/>
                <a:ext cx="44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5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" name="Line 211">
                <a:extLst>
                  <a:ext uri="{FF2B5EF4-FFF2-40B4-BE49-F238E27FC236}">
                    <a16:creationId xmlns:a16="http://schemas.microsoft.com/office/drawing/2014/main" xmlns="" id="{61D3A4F5-CE09-410F-8D81-485DBF39EC5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691" y="691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13" name="Rectangle 212">
                <a:extLst>
                  <a:ext uri="{FF2B5EF4-FFF2-40B4-BE49-F238E27FC236}">
                    <a16:creationId xmlns:a16="http://schemas.microsoft.com/office/drawing/2014/main" xmlns="" id="{2CCAA8F9-2F93-466E-AAA6-AFDF97410EB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28" y="669"/>
                <a:ext cx="44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70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" name="Line 213">
                <a:extLst>
                  <a:ext uri="{FF2B5EF4-FFF2-40B4-BE49-F238E27FC236}">
                    <a16:creationId xmlns:a16="http://schemas.microsoft.com/office/drawing/2014/main" xmlns="" id="{71B2BB3C-B593-494A-A625-AB61F728B80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691" y="614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15" name="Rectangle 214">
                <a:extLst>
                  <a:ext uri="{FF2B5EF4-FFF2-40B4-BE49-F238E27FC236}">
                    <a16:creationId xmlns:a16="http://schemas.microsoft.com/office/drawing/2014/main" xmlns="" id="{EE6C7D4B-8F7A-4ADC-8231-E99B8B7CF08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28" y="593"/>
                <a:ext cx="44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75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" name="Line 215">
                <a:extLst>
                  <a:ext uri="{FF2B5EF4-FFF2-40B4-BE49-F238E27FC236}">
                    <a16:creationId xmlns:a16="http://schemas.microsoft.com/office/drawing/2014/main" xmlns="" id="{9C51A71A-FBEA-469C-B3CD-FE3E654E234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691" y="538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17" name="Rectangle 216">
                <a:extLst>
                  <a:ext uri="{FF2B5EF4-FFF2-40B4-BE49-F238E27FC236}">
                    <a16:creationId xmlns:a16="http://schemas.microsoft.com/office/drawing/2014/main" xmlns="" id="{5F80AA97-6ADE-4FF3-BF32-5D2AA884F83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28" y="516"/>
                <a:ext cx="44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0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" name="Line 217">
                <a:extLst>
                  <a:ext uri="{FF2B5EF4-FFF2-40B4-BE49-F238E27FC236}">
                    <a16:creationId xmlns:a16="http://schemas.microsoft.com/office/drawing/2014/main" xmlns="" id="{8B8C232A-F48E-45B4-986F-621200EB326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691" y="459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19" name="Rectangle 218">
                <a:extLst>
                  <a:ext uri="{FF2B5EF4-FFF2-40B4-BE49-F238E27FC236}">
                    <a16:creationId xmlns:a16="http://schemas.microsoft.com/office/drawing/2014/main" xmlns="" id="{32BF7F6E-A2A2-4790-A1BD-5C98B443910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28" y="437"/>
                <a:ext cx="44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5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" name="Line 219">
                <a:extLst>
                  <a:ext uri="{FF2B5EF4-FFF2-40B4-BE49-F238E27FC236}">
                    <a16:creationId xmlns:a16="http://schemas.microsoft.com/office/drawing/2014/main" xmlns="" id="{8B90B025-E61E-4689-8605-983A4CC0C31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691" y="382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21" name="Rectangle 220">
                <a:extLst>
                  <a:ext uri="{FF2B5EF4-FFF2-40B4-BE49-F238E27FC236}">
                    <a16:creationId xmlns:a16="http://schemas.microsoft.com/office/drawing/2014/main" xmlns="" id="{34B37B2A-6798-421A-880A-F7B01107F2F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28" y="360"/>
                <a:ext cx="44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90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" name="Line 221">
                <a:extLst>
                  <a:ext uri="{FF2B5EF4-FFF2-40B4-BE49-F238E27FC236}">
                    <a16:creationId xmlns:a16="http://schemas.microsoft.com/office/drawing/2014/main" xmlns="" id="{34C3255B-A918-4BB7-85D1-F928213788F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691" y="305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23" name="Rectangle 222">
                <a:extLst>
                  <a:ext uri="{FF2B5EF4-FFF2-40B4-BE49-F238E27FC236}">
                    <a16:creationId xmlns:a16="http://schemas.microsoft.com/office/drawing/2014/main" xmlns="" id="{44BE99B8-F577-494B-8B67-9FE12F5281B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28" y="283"/>
                <a:ext cx="44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95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" name="Line 223">
                <a:extLst>
                  <a:ext uri="{FF2B5EF4-FFF2-40B4-BE49-F238E27FC236}">
                    <a16:creationId xmlns:a16="http://schemas.microsoft.com/office/drawing/2014/main" xmlns="" id="{9DE7FD45-0FF8-44B3-A0D9-C1297C03AF1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691" y="226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25" name="Rectangle 224">
                <a:extLst>
                  <a:ext uri="{FF2B5EF4-FFF2-40B4-BE49-F238E27FC236}">
                    <a16:creationId xmlns:a16="http://schemas.microsoft.com/office/drawing/2014/main" xmlns="" id="{6C1904C9-C77B-4208-8D3E-F6D48EE09E7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06" y="204"/>
                <a:ext cx="67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0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6" name="Rectangle 225">
                <a:extLst>
                  <a:ext uri="{FF2B5EF4-FFF2-40B4-BE49-F238E27FC236}">
                    <a16:creationId xmlns:a16="http://schemas.microsoft.com/office/drawing/2014/main" xmlns="" id="{15C16F23-3B73-4144-95B8-84BB8E5572B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1421" y="976"/>
                <a:ext cx="359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Relative Abundance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7" name="Freeform 226">
                <a:extLst>
                  <a:ext uri="{FF2B5EF4-FFF2-40B4-BE49-F238E27FC236}">
                    <a16:creationId xmlns:a16="http://schemas.microsoft.com/office/drawing/2014/main" xmlns="" id="{7FF0C96D-CADB-4E4A-836F-BD9DE57E584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718" y="226"/>
                <a:ext cx="2668" cy="1539"/>
              </a:xfrm>
              <a:custGeom>
                <a:avLst/>
                <a:gdLst>
                  <a:gd name="T0" fmla="*/ 20 w 1321"/>
                  <a:gd name="T1" fmla="*/ 758 h 761"/>
                  <a:gd name="T2" fmla="*/ 41 w 1321"/>
                  <a:gd name="T3" fmla="*/ 758 h 761"/>
                  <a:gd name="T4" fmla="*/ 62 w 1321"/>
                  <a:gd name="T5" fmla="*/ 758 h 761"/>
                  <a:gd name="T6" fmla="*/ 83 w 1321"/>
                  <a:gd name="T7" fmla="*/ 757 h 761"/>
                  <a:gd name="T8" fmla="*/ 104 w 1321"/>
                  <a:gd name="T9" fmla="*/ 690 h 761"/>
                  <a:gd name="T10" fmla="*/ 125 w 1321"/>
                  <a:gd name="T11" fmla="*/ 746 h 761"/>
                  <a:gd name="T12" fmla="*/ 146 w 1321"/>
                  <a:gd name="T13" fmla="*/ 486 h 761"/>
                  <a:gd name="T14" fmla="*/ 167 w 1321"/>
                  <a:gd name="T15" fmla="*/ 602 h 761"/>
                  <a:gd name="T16" fmla="*/ 188 w 1321"/>
                  <a:gd name="T17" fmla="*/ 382 h 761"/>
                  <a:gd name="T18" fmla="*/ 209 w 1321"/>
                  <a:gd name="T19" fmla="*/ 710 h 761"/>
                  <a:gd name="T20" fmla="*/ 230 w 1321"/>
                  <a:gd name="T21" fmla="*/ 759 h 761"/>
                  <a:gd name="T22" fmla="*/ 251 w 1321"/>
                  <a:gd name="T23" fmla="*/ 728 h 761"/>
                  <a:gd name="T24" fmla="*/ 272 w 1321"/>
                  <a:gd name="T25" fmla="*/ 132 h 761"/>
                  <a:gd name="T26" fmla="*/ 293 w 1321"/>
                  <a:gd name="T27" fmla="*/ 715 h 761"/>
                  <a:gd name="T28" fmla="*/ 314 w 1321"/>
                  <a:gd name="T29" fmla="*/ 753 h 761"/>
                  <a:gd name="T30" fmla="*/ 335 w 1321"/>
                  <a:gd name="T31" fmla="*/ 760 h 761"/>
                  <a:gd name="T32" fmla="*/ 356 w 1321"/>
                  <a:gd name="T33" fmla="*/ 735 h 761"/>
                  <a:gd name="T34" fmla="*/ 377 w 1321"/>
                  <a:gd name="T35" fmla="*/ 649 h 761"/>
                  <a:gd name="T36" fmla="*/ 398 w 1321"/>
                  <a:gd name="T37" fmla="*/ 617 h 761"/>
                  <a:gd name="T38" fmla="*/ 419 w 1321"/>
                  <a:gd name="T39" fmla="*/ 598 h 761"/>
                  <a:gd name="T40" fmla="*/ 440 w 1321"/>
                  <a:gd name="T41" fmla="*/ 654 h 761"/>
                  <a:gd name="T42" fmla="*/ 461 w 1321"/>
                  <a:gd name="T43" fmla="*/ 327 h 761"/>
                  <a:gd name="T44" fmla="*/ 482 w 1321"/>
                  <a:gd name="T45" fmla="*/ 622 h 761"/>
                  <a:gd name="T46" fmla="*/ 503 w 1321"/>
                  <a:gd name="T47" fmla="*/ 655 h 761"/>
                  <a:gd name="T48" fmla="*/ 524 w 1321"/>
                  <a:gd name="T49" fmla="*/ 558 h 761"/>
                  <a:gd name="T50" fmla="*/ 545 w 1321"/>
                  <a:gd name="T51" fmla="*/ 600 h 761"/>
                  <a:gd name="T52" fmla="*/ 566 w 1321"/>
                  <a:gd name="T53" fmla="*/ 645 h 761"/>
                  <a:gd name="T54" fmla="*/ 587 w 1321"/>
                  <a:gd name="T55" fmla="*/ 747 h 761"/>
                  <a:gd name="T56" fmla="*/ 608 w 1321"/>
                  <a:gd name="T57" fmla="*/ 646 h 761"/>
                  <a:gd name="T58" fmla="*/ 629 w 1321"/>
                  <a:gd name="T59" fmla="*/ 668 h 761"/>
                  <a:gd name="T60" fmla="*/ 650 w 1321"/>
                  <a:gd name="T61" fmla="*/ 553 h 761"/>
                  <a:gd name="T62" fmla="*/ 671 w 1321"/>
                  <a:gd name="T63" fmla="*/ 750 h 761"/>
                  <a:gd name="T64" fmla="*/ 692 w 1321"/>
                  <a:gd name="T65" fmla="*/ 756 h 761"/>
                  <a:gd name="T66" fmla="*/ 713 w 1321"/>
                  <a:gd name="T67" fmla="*/ 757 h 761"/>
                  <a:gd name="T68" fmla="*/ 734 w 1321"/>
                  <a:gd name="T69" fmla="*/ 746 h 761"/>
                  <a:gd name="T70" fmla="*/ 755 w 1321"/>
                  <a:gd name="T71" fmla="*/ 222 h 761"/>
                  <a:gd name="T72" fmla="*/ 776 w 1321"/>
                  <a:gd name="T73" fmla="*/ 739 h 761"/>
                  <a:gd name="T74" fmla="*/ 797 w 1321"/>
                  <a:gd name="T75" fmla="*/ 756 h 761"/>
                  <a:gd name="T76" fmla="*/ 818 w 1321"/>
                  <a:gd name="T77" fmla="*/ 756 h 761"/>
                  <a:gd name="T78" fmla="*/ 839 w 1321"/>
                  <a:gd name="T79" fmla="*/ 756 h 761"/>
                  <a:gd name="T80" fmla="*/ 860 w 1321"/>
                  <a:gd name="T81" fmla="*/ 755 h 761"/>
                  <a:gd name="T82" fmla="*/ 881 w 1321"/>
                  <a:gd name="T83" fmla="*/ 757 h 761"/>
                  <a:gd name="T84" fmla="*/ 902 w 1321"/>
                  <a:gd name="T85" fmla="*/ 757 h 761"/>
                  <a:gd name="T86" fmla="*/ 923 w 1321"/>
                  <a:gd name="T87" fmla="*/ 756 h 761"/>
                  <a:gd name="T88" fmla="*/ 944 w 1321"/>
                  <a:gd name="T89" fmla="*/ 731 h 761"/>
                  <a:gd name="T90" fmla="*/ 965 w 1321"/>
                  <a:gd name="T91" fmla="*/ 743 h 761"/>
                  <a:gd name="T92" fmla="*/ 986 w 1321"/>
                  <a:gd name="T93" fmla="*/ 747 h 761"/>
                  <a:gd name="T94" fmla="*/ 1007 w 1321"/>
                  <a:gd name="T95" fmla="*/ 753 h 761"/>
                  <a:gd name="T96" fmla="*/ 1028 w 1321"/>
                  <a:gd name="T97" fmla="*/ 755 h 761"/>
                  <a:gd name="T98" fmla="*/ 1049 w 1321"/>
                  <a:gd name="T99" fmla="*/ 754 h 761"/>
                  <a:gd name="T100" fmla="*/ 1070 w 1321"/>
                  <a:gd name="T101" fmla="*/ 755 h 761"/>
                  <a:gd name="T102" fmla="*/ 1091 w 1321"/>
                  <a:gd name="T103" fmla="*/ 753 h 761"/>
                  <a:gd name="T104" fmla="*/ 1112 w 1321"/>
                  <a:gd name="T105" fmla="*/ 755 h 761"/>
                  <a:gd name="T106" fmla="*/ 1133 w 1321"/>
                  <a:gd name="T107" fmla="*/ 754 h 761"/>
                  <a:gd name="T108" fmla="*/ 1154 w 1321"/>
                  <a:gd name="T109" fmla="*/ 753 h 761"/>
                  <a:gd name="T110" fmla="*/ 1175 w 1321"/>
                  <a:gd name="T111" fmla="*/ 754 h 761"/>
                  <a:gd name="T112" fmla="*/ 1196 w 1321"/>
                  <a:gd name="T113" fmla="*/ 755 h 761"/>
                  <a:gd name="T114" fmla="*/ 1217 w 1321"/>
                  <a:gd name="T115" fmla="*/ 754 h 761"/>
                  <a:gd name="T116" fmla="*/ 1238 w 1321"/>
                  <a:gd name="T117" fmla="*/ 754 h 761"/>
                  <a:gd name="T118" fmla="*/ 1259 w 1321"/>
                  <a:gd name="T119" fmla="*/ 753 h 761"/>
                  <a:gd name="T120" fmla="*/ 1280 w 1321"/>
                  <a:gd name="T121" fmla="*/ 754 h 761"/>
                  <a:gd name="T122" fmla="*/ 1301 w 1321"/>
                  <a:gd name="T123" fmla="*/ 753 h 76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  <a:cxn ang="0">
                    <a:pos x="T118" y="T119"/>
                  </a:cxn>
                  <a:cxn ang="0">
                    <a:pos x="T120" y="T121"/>
                  </a:cxn>
                  <a:cxn ang="0">
                    <a:pos x="T122" y="T123"/>
                  </a:cxn>
                </a:cxnLst>
                <a:rect l="0" t="0" r="r" b="b"/>
                <a:pathLst>
                  <a:path w="1321" h="761">
                    <a:moveTo>
                      <a:pt x="0" y="760"/>
                    </a:moveTo>
                    <a:lnTo>
                      <a:pt x="0" y="759"/>
                    </a:lnTo>
                    <a:lnTo>
                      <a:pt x="1" y="759"/>
                    </a:lnTo>
                    <a:lnTo>
                      <a:pt x="1" y="759"/>
                    </a:lnTo>
                    <a:lnTo>
                      <a:pt x="2" y="759"/>
                    </a:lnTo>
                    <a:lnTo>
                      <a:pt x="2" y="759"/>
                    </a:lnTo>
                    <a:lnTo>
                      <a:pt x="3" y="759"/>
                    </a:lnTo>
                    <a:lnTo>
                      <a:pt x="3" y="758"/>
                    </a:lnTo>
                    <a:lnTo>
                      <a:pt x="4" y="758"/>
                    </a:lnTo>
                    <a:lnTo>
                      <a:pt x="4" y="759"/>
                    </a:lnTo>
                    <a:lnTo>
                      <a:pt x="5" y="758"/>
                    </a:lnTo>
                    <a:lnTo>
                      <a:pt x="5" y="759"/>
                    </a:lnTo>
                    <a:lnTo>
                      <a:pt x="6" y="758"/>
                    </a:lnTo>
                    <a:lnTo>
                      <a:pt x="6" y="759"/>
                    </a:lnTo>
                    <a:lnTo>
                      <a:pt x="7" y="758"/>
                    </a:lnTo>
                    <a:lnTo>
                      <a:pt x="7" y="758"/>
                    </a:lnTo>
                    <a:lnTo>
                      <a:pt x="8" y="758"/>
                    </a:lnTo>
                    <a:lnTo>
                      <a:pt x="8" y="759"/>
                    </a:lnTo>
                    <a:lnTo>
                      <a:pt x="9" y="759"/>
                    </a:lnTo>
                    <a:lnTo>
                      <a:pt x="9" y="757"/>
                    </a:lnTo>
                    <a:lnTo>
                      <a:pt x="10" y="758"/>
                    </a:lnTo>
                    <a:lnTo>
                      <a:pt x="10" y="759"/>
                    </a:lnTo>
                    <a:lnTo>
                      <a:pt x="11" y="757"/>
                    </a:lnTo>
                    <a:lnTo>
                      <a:pt x="11" y="759"/>
                    </a:lnTo>
                    <a:lnTo>
                      <a:pt x="12" y="759"/>
                    </a:lnTo>
                    <a:lnTo>
                      <a:pt x="12" y="758"/>
                    </a:lnTo>
                    <a:lnTo>
                      <a:pt x="13" y="758"/>
                    </a:lnTo>
                    <a:lnTo>
                      <a:pt x="13" y="758"/>
                    </a:lnTo>
                    <a:lnTo>
                      <a:pt x="14" y="759"/>
                    </a:lnTo>
                    <a:lnTo>
                      <a:pt x="14" y="758"/>
                    </a:lnTo>
                    <a:lnTo>
                      <a:pt x="15" y="758"/>
                    </a:lnTo>
                    <a:lnTo>
                      <a:pt x="15" y="758"/>
                    </a:lnTo>
                    <a:lnTo>
                      <a:pt x="16" y="758"/>
                    </a:lnTo>
                    <a:lnTo>
                      <a:pt x="16" y="758"/>
                    </a:lnTo>
                    <a:lnTo>
                      <a:pt x="17" y="757"/>
                    </a:lnTo>
                    <a:lnTo>
                      <a:pt x="17" y="758"/>
                    </a:lnTo>
                    <a:lnTo>
                      <a:pt x="18" y="758"/>
                    </a:lnTo>
                    <a:lnTo>
                      <a:pt x="18" y="759"/>
                    </a:lnTo>
                    <a:lnTo>
                      <a:pt x="19" y="759"/>
                    </a:lnTo>
                    <a:lnTo>
                      <a:pt x="19" y="758"/>
                    </a:lnTo>
                    <a:lnTo>
                      <a:pt x="20" y="757"/>
                    </a:lnTo>
                    <a:lnTo>
                      <a:pt x="20" y="758"/>
                    </a:lnTo>
                    <a:lnTo>
                      <a:pt x="21" y="758"/>
                    </a:lnTo>
                    <a:lnTo>
                      <a:pt x="21" y="758"/>
                    </a:lnTo>
                    <a:lnTo>
                      <a:pt x="22" y="758"/>
                    </a:lnTo>
                    <a:lnTo>
                      <a:pt x="22" y="758"/>
                    </a:lnTo>
                    <a:lnTo>
                      <a:pt x="23" y="758"/>
                    </a:lnTo>
                    <a:lnTo>
                      <a:pt x="23" y="759"/>
                    </a:lnTo>
                    <a:lnTo>
                      <a:pt x="24" y="759"/>
                    </a:lnTo>
                    <a:lnTo>
                      <a:pt x="24" y="757"/>
                    </a:lnTo>
                    <a:lnTo>
                      <a:pt x="25" y="758"/>
                    </a:lnTo>
                    <a:lnTo>
                      <a:pt x="25" y="759"/>
                    </a:lnTo>
                    <a:lnTo>
                      <a:pt x="26" y="758"/>
                    </a:lnTo>
                    <a:lnTo>
                      <a:pt x="26" y="757"/>
                    </a:lnTo>
                    <a:lnTo>
                      <a:pt x="27" y="758"/>
                    </a:lnTo>
                    <a:lnTo>
                      <a:pt x="27" y="757"/>
                    </a:lnTo>
                    <a:lnTo>
                      <a:pt x="28" y="759"/>
                    </a:lnTo>
                    <a:lnTo>
                      <a:pt x="28" y="757"/>
                    </a:lnTo>
                    <a:lnTo>
                      <a:pt x="29" y="757"/>
                    </a:lnTo>
                    <a:lnTo>
                      <a:pt x="29" y="758"/>
                    </a:lnTo>
                    <a:lnTo>
                      <a:pt x="30" y="757"/>
                    </a:lnTo>
                    <a:lnTo>
                      <a:pt x="30" y="758"/>
                    </a:lnTo>
                    <a:lnTo>
                      <a:pt x="31" y="758"/>
                    </a:lnTo>
                    <a:lnTo>
                      <a:pt x="31" y="757"/>
                    </a:lnTo>
                    <a:lnTo>
                      <a:pt x="32" y="757"/>
                    </a:lnTo>
                    <a:lnTo>
                      <a:pt x="32" y="758"/>
                    </a:lnTo>
                    <a:lnTo>
                      <a:pt x="33" y="759"/>
                    </a:lnTo>
                    <a:lnTo>
                      <a:pt x="33" y="757"/>
                    </a:lnTo>
                    <a:lnTo>
                      <a:pt x="34" y="758"/>
                    </a:lnTo>
                    <a:lnTo>
                      <a:pt x="34" y="757"/>
                    </a:lnTo>
                    <a:lnTo>
                      <a:pt x="35" y="757"/>
                    </a:lnTo>
                    <a:lnTo>
                      <a:pt x="35" y="759"/>
                    </a:lnTo>
                    <a:lnTo>
                      <a:pt x="36" y="759"/>
                    </a:lnTo>
                    <a:lnTo>
                      <a:pt x="36" y="757"/>
                    </a:lnTo>
                    <a:lnTo>
                      <a:pt x="37" y="758"/>
                    </a:lnTo>
                    <a:lnTo>
                      <a:pt x="37" y="757"/>
                    </a:lnTo>
                    <a:lnTo>
                      <a:pt x="38" y="757"/>
                    </a:lnTo>
                    <a:lnTo>
                      <a:pt x="38" y="758"/>
                    </a:lnTo>
                    <a:lnTo>
                      <a:pt x="39" y="758"/>
                    </a:lnTo>
                    <a:lnTo>
                      <a:pt x="39" y="758"/>
                    </a:lnTo>
                    <a:lnTo>
                      <a:pt x="40" y="757"/>
                    </a:lnTo>
                    <a:lnTo>
                      <a:pt x="40" y="758"/>
                    </a:lnTo>
                    <a:lnTo>
                      <a:pt x="41" y="757"/>
                    </a:lnTo>
                    <a:lnTo>
                      <a:pt x="41" y="758"/>
                    </a:lnTo>
                    <a:lnTo>
                      <a:pt x="42" y="759"/>
                    </a:lnTo>
                    <a:lnTo>
                      <a:pt x="42" y="757"/>
                    </a:lnTo>
                    <a:lnTo>
                      <a:pt x="43" y="758"/>
                    </a:lnTo>
                    <a:lnTo>
                      <a:pt x="43" y="757"/>
                    </a:lnTo>
                    <a:lnTo>
                      <a:pt x="44" y="759"/>
                    </a:lnTo>
                    <a:lnTo>
                      <a:pt x="44" y="757"/>
                    </a:lnTo>
                    <a:lnTo>
                      <a:pt x="45" y="758"/>
                    </a:lnTo>
                    <a:lnTo>
                      <a:pt x="45" y="758"/>
                    </a:lnTo>
                    <a:lnTo>
                      <a:pt x="46" y="758"/>
                    </a:lnTo>
                    <a:lnTo>
                      <a:pt x="46" y="757"/>
                    </a:lnTo>
                    <a:lnTo>
                      <a:pt x="47" y="757"/>
                    </a:lnTo>
                    <a:lnTo>
                      <a:pt x="47" y="758"/>
                    </a:lnTo>
                    <a:lnTo>
                      <a:pt x="48" y="758"/>
                    </a:lnTo>
                    <a:lnTo>
                      <a:pt x="48" y="757"/>
                    </a:lnTo>
                    <a:lnTo>
                      <a:pt x="49" y="757"/>
                    </a:lnTo>
                    <a:lnTo>
                      <a:pt x="49" y="758"/>
                    </a:lnTo>
                    <a:lnTo>
                      <a:pt x="50" y="758"/>
                    </a:lnTo>
                    <a:lnTo>
                      <a:pt x="50" y="757"/>
                    </a:lnTo>
                    <a:lnTo>
                      <a:pt x="51" y="758"/>
                    </a:lnTo>
                    <a:lnTo>
                      <a:pt x="51" y="757"/>
                    </a:lnTo>
                    <a:lnTo>
                      <a:pt x="52" y="757"/>
                    </a:lnTo>
                    <a:lnTo>
                      <a:pt x="52" y="758"/>
                    </a:lnTo>
                    <a:lnTo>
                      <a:pt x="53" y="758"/>
                    </a:lnTo>
                    <a:lnTo>
                      <a:pt x="53" y="758"/>
                    </a:lnTo>
                    <a:lnTo>
                      <a:pt x="54" y="758"/>
                    </a:lnTo>
                    <a:lnTo>
                      <a:pt x="54" y="757"/>
                    </a:lnTo>
                    <a:lnTo>
                      <a:pt x="55" y="759"/>
                    </a:lnTo>
                    <a:lnTo>
                      <a:pt x="55" y="758"/>
                    </a:lnTo>
                    <a:lnTo>
                      <a:pt x="56" y="757"/>
                    </a:lnTo>
                    <a:lnTo>
                      <a:pt x="56" y="758"/>
                    </a:lnTo>
                    <a:lnTo>
                      <a:pt x="57" y="757"/>
                    </a:lnTo>
                    <a:lnTo>
                      <a:pt x="57" y="758"/>
                    </a:lnTo>
                    <a:lnTo>
                      <a:pt x="58" y="759"/>
                    </a:lnTo>
                    <a:lnTo>
                      <a:pt x="58" y="757"/>
                    </a:lnTo>
                    <a:lnTo>
                      <a:pt x="59" y="758"/>
                    </a:lnTo>
                    <a:lnTo>
                      <a:pt x="59" y="758"/>
                    </a:lnTo>
                    <a:lnTo>
                      <a:pt x="60" y="758"/>
                    </a:lnTo>
                    <a:lnTo>
                      <a:pt x="60" y="758"/>
                    </a:lnTo>
                    <a:lnTo>
                      <a:pt x="61" y="758"/>
                    </a:lnTo>
                    <a:lnTo>
                      <a:pt x="61" y="757"/>
                    </a:lnTo>
                    <a:lnTo>
                      <a:pt x="62" y="757"/>
                    </a:lnTo>
                    <a:lnTo>
                      <a:pt x="62" y="758"/>
                    </a:lnTo>
                    <a:lnTo>
                      <a:pt x="63" y="758"/>
                    </a:lnTo>
                    <a:lnTo>
                      <a:pt x="63" y="757"/>
                    </a:lnTo>
                    <a:lnTo>
                      <a:pt x="64" y="757"/>
                    </a:lnTo>
                    <a:lnTo>
                      <a:pt x="64" y="758"/>
                    </a:lnTo>
                    <a:lnTo>
                      <a:pt x="65" y="758"/>
                    </a:lnTo>
                    <a:lnTo>
                      <a:pt x="65" y="757"/>
                    </a:lnTo>
                    <a:lnTo>
                      <a:pt x="66" y="758"/>
                    </a:lnTo>
                    <a:lnTo>
                      <a:pt x="66" y="758"/>
                    </a:lnTo>
                    <a:lnTo>
                      <a:pt x="67" y="757"/>
                    </a:lnTo>
                    <a:lnTo>
                      <a:pt x="67" y="759"/>
                    </a:lnTo>
                    <a:lnTo>
                      <a:pt x="68" y="757"/>
                    </a:lnTo>
                    <a:lnTo>
                      <a:pt x="68" y="759"/>
                    </a:lnTo>
                    <a:lnTo>
                      <a:pt x="69" y="757"/>
                    </a:lnTo>
                    <a:lnTo>
                      <a:pt x="69" y="758"/>
                    </a:lnTo>
                    <a:lnTo>
                      <a:pt x="70" y="758"/>
                    </a:lnTo>
                    <a:lnTo>
                      <a:pt x="70" y="757"/>
                    </a:lnTo>
                    <a:lnTo>
                      <a:pt x="71" y="758"/>
                    </a:lnTo>
                    <a:lnTo>
                      <a:pt x="71" y="757"/>
                    </a:lnTo>
                    <a:lnTo>
                      <a:pt x="72" y="758"/>
                    </a:lnTo>
                    <a:lnTo>
                      <a:pt x="72" y="758"/>
                    </a:lnTo>
                    <a:lnTo>
                      <a:pt x="73" y="758"/>
                    </a:lnTo>
                    <a:lnTo>
                      <a:pt x="73" y="758"/>
                    </a:lnTo>
                    <a:lnTo>
                      <a:pt x="74" y="758"/>
                    </a:lnTo>
                    <a:lnTo>
                      <a:pt x="74" y="757"/>
                    </a:lnTo>
                    <a:lnTo>
                      <a:pt x="75" y="757"/>
                    </a:lnTo>
                    <a:lnTo>
                      <a:pt x="75" y="759"/>
                    </a:lnTo>
                    <a:lnTo>
                      <a:pt x="76" y="758"/>
                    </a:lnTo>
                    <a:lnTo>
                      <a:pt x="76" y="759"/>
                    </a:lnTo>
                    <a:lnTo>
                      <a:pt x="77" y="757"/>
                    </a:lnTo>
                    <a:lnTo>
                      <a:pt x="77" y="759"/>
                    </a:lnTo>
                    <a:lnTo>
                      <a:pt x="78" y="757"/>
                    </a:lnTo>
                    <a:lnTo>
                      <a:pt x="78" y="758"/>
                    </a:lnTo>
                    <a:lnTo>
                      <a:pt x="79" y="759"/>
                    </a:lnTo>
                    <a:lnTo>
                      <a:pt x="79" y="758"/>
                    </a:lnTo>
                    <a:lnTo>
                      <a:pt x="80" y="759"/>
                    </a:lnTo>
                    <a:lnTo>
                      <a:pt x="80" y="759"/>
                    </a:lnTo>
                    <a:lnTo>
                      <a:pt x="81" y="759"/>
                    </a:lnTo>
                    <a:lnTo>
                      <a:pt x="81" y="761"/>
                    </a:lnTo>
                    <a:lnTo>
                      <a:pt x="82" y="760"/>
                    </a:lnTo>
                    <a:lnTo>
                      <a:pt x="82" y="761"/>
                    </a:lnTo>
                    <a:lnTo>
                      <a:pt x="83" y="761"/>
                    </a:lnTo>
                    <a:lnTo>
                      <a:pt x="83" y="757"/>
                    </a:lnTo>
                    <a:lnTo>
                      <a:pt x="84" y="760"/>
                    </a:lnTo>
                    <a:lnTo>
                      <a:pt x="84" y="751"/>
                    </a:lnTo>
                    <a:lnTo>
                      <a:pt x="85" y="736"/>
                    </a:lnTo>
                    <a:lnTo>
                      <a:pt x="85" y="751"/>
                    </a:lnTo>
                    <a:lnTo>
                      <a:pt x="86" y="729"/>
                    </a:lnTo>
                    <a:lnTo>
                      <a:pt x="86" y="755"/>
                    </a:lnTo>
                    <a:lnTo>
                      <a:pt x="87" y="749"/>
                    </a:lnTo>
                    <a:lnTo>
                      <a:pt x="87" y="742"/>
                    </a:lnTo>
                    <a:lnTo>
                      <a:pt x="88" y="746"/>
                    </a:lnTo>
                    <a:lnTo>
                      <a:pt x="88" y="750"/>
                    </a:lnTo>
                    <a:lnTo>
                      <a:pt x="89" y="752"/>
                    </a:lnTo>
                    <a:lnTo>
                      <a:pt x="89" y="756"/>
                    </a:lnTo>
                    <a:lnTo>
                      <a:pt x="90" y="757"/>
                    </a:lnTo>
                    <a:lnTo>
                      <a:pt x="90" y="756"/>
                    </a:lnTo>
                    <a:lnTo>
                      <a:pt x="91" y="757"/>
                    </a:lnTo>
                    <a:lnTo>
                      <a:pt x="91" y="752"/>
                    </a:lnTo>
                    <a:lnTo>
                      <a:pt x="92" y="756"/>
                    </a:lnTo>
                    <a:lnTo>
                      <a:pt x="92" y="752"/>
                    </a:lnTo>
                    <a:lnTo>
                      <a:pt x="93" y="750"/>
                    </a:lnTo>
                    <a:lnTo>
                      <a:pt x="93" y="756"/>
                    </a:lnTo>
                    <a:lnTo>
                      <a:pt x="94" y="755"/>
                    </a:lnTo>
                    <a:lnTo>
                      <a:pt x="94" y="752"/>
                    </a:lnTo>
                    <a:lnTo>
                      <a:pt x="95" y="753"/>
                    </a:lnTo>
                    <a:lnTo>
                      <a:pt x="95" y="755"/>
                    </a:lnTo>
                    <a:lnTo>
                      <a:pt x="96" y="756"/>
                    </a:lnTo>
                    <a:lnTo>
                      <a:pt x="96" y="754"/>
                    </a:lnTo>
                    <a:lnTo>
                      <a:pt x="97" y="750"/>
                    </a:lnTo>
                    <a:lnTo>
                      <a:pt x="97" y="755"/>
                    </a:lnTo>
                    <a:lnTo>
                      <a:pt x="98" y="747"/>
                    </a:lnTo>
                    <a:lnTo>
                      <a:pt x="98" y="754"/>
                    </a:lnTo>
                    <a:lnTo>
                      <a:pt x="99" y="744"/>
                    </a:lnTo>
                    <a:lnTo>
                      <a:pt x="99" y="749"/>
                    </a:lnTo>
                    <a:lnTo>
                      <a:pt x="100" y="740"/>
                    </a:lnTo>
                    <a:lnTo>
                      <a:pt x="100" y="720"/>
                    </a:lnTo>
                    <a:lnTo>
                      <a:pt x="101" y="740"/>
                    </a:lnTo>
                    <a:lnTo>
                      <a:pt x="101" y="697"/>
                    </a:lnTo>
                    <a:lnTo>
                      <a:pt x="102" y="700"/>
                    </a:lnTo>
                    <a:lnTo>
                      <a:pt x="102" y="724"/>
                    </a:lnTo>
                    <a:lnTo>
                      <a:pt x="103" y="706"/>
                    </a:lnTo>
                    <a:lnTo>
                      <a:pt x="103" y="692"/>
                    </a:lnTo>
                    <a:lnTo>
                      <a:pt x="104" y="722"/>
                    </a:lnTo>
                    <a:lnTo>
                      <a:pt x="104" y="690"/>
                    </a:lnTo>
                    <a:lnTo>
                      <a:pt x="105" y="669"/>
                    </a:lnTo>
                    <a:lnTo>
                      <a:pt x="105" y="711"/>
                    </a:lnTo>
                    <a:lnTo>
                      <a:pt x="106" y="721"/>
                    </a:lnTo>
                    <a:lnTo>
                      <a:pt x="106" y="643"/>
                    </a:lnTo>
                    <a:lnTo>
                      <a:pt x="107" y="678"/>
                    </a:lnTo>
                    <a:lnTo>
                      <a:pt x="107" y="720"/>
                    </a:lnTo>
                    <a:lnTo>
                      <a:pt x="108" y="708"/>
                    </a:lnTo>
                    <a:lnTo>
                      <a:pt x="108" y="673"/>
                    </a:lnTo>
                    <a:lnTo>
                      <a:pt x="109" y="693"/>
                    </a:lnTo>
                    <a:lnTo>
                      <a:pt x="109" y="710"/>
                    </a:lnTo>
                    <a:lnTo>
                      <a:pt x="110" y="699"/>
                    </a:lnTo>
                    <a:lnTo>
                      <a:pt x="110" y="711"/>
                    </a:lnTo>
                    <a:lnTo>
                      <a:pt x="111" y="685"/>
                    </a:lnTo>
                    <a:lnTo>
                      <a:pt x="111" y="723"/>
                    </a:lnTo>
                    <a:lnTo>
                      <a:pt x="112" y="698"/>
                    </a:lnTo>
                    <a:lnTo>
                      <a:pt x="112" y="713"/>
                    </a:lnTo>
                    <a:lnTo>
                      <a:pt x="113" y="691"/>
                    </a:lnTo>
                    <a:lnTo>
                      <a:pt x="113" y="720"/>
                    </a:lnTo>
                    <a:lnTo>
                      <a:pt x="114" y="691"/>
                    </a:lnTo>
                    <a:lnTo>
                      <a:pt x="114" y="720"/>
                    </a:lnTo>
                    <a:lnTo>
                      <a:pt x="115" y="735"/>
                    </a:lnTo>
                    <a:lnTo>
                      <a:pt x="115" y="725"/>
                    </a:lnTo>
                    <a:lnTo>
                      <a:pt x="116" y="724"/>
                    </a:lnTo>
                    <a:lnTo>
                      <a:pt x="116" y="740"/>
                    </a:lnTo>
                    <a:lnTo>
                      <a:pt x="117" y="736"/>
                    </a:lnTo>
                    <a:lnTo>
                      <a:pt x="117" y="747"/>
                    </a:lnTo>
                    <a:lnTo>
                      <a:pt x="118" y="741"/>
                    </a:lnTo>
                    <a:lnTo>
                      <a:pt x="118" y="753"/>
                    </a:lnTo>
                    <a:lnTo>
                      <a:pt x="119" y="748"/>
                    </a:lnTo>
                    <a:lnTo>
                      <a:pt x="119" y="751"/>
                    </a:lnTo>
                    <a:lnTo>
                      <a:pt x="120" y="750"/>
                    </a:lnTo>
                    <a:lnTo>
                      <a:pt x="120" y="752"/>
                    </a:lnTo>
                    <a:lnTo>
                      <a:pt x="121" y="752"/>
                    </a:lnTo>
                    <a:lnTo>
                      <a:pt x="121" y="752"/>
                    </a:lnTo>
                    <a:lnTo>
                      <a:pt x="122" y="753"/>
                    </a:lnTo>
                    <a:lnTo>
                      <a:pt x="122" y="751"/>
                    </a:lnTo>
                    <a:lnTo>
                      <a:pt x="123" y="751"/>
                    </a:lnTo>
                    <a:lnTo>
                      <a:pt x="123" y="748"/>
                    </a:lnTo>
                    <a:lnTo>
                      <a:pt x="124" y="750"/>
                    </a:lnTo>
                    <a:lnTo>
                      <a:pt x="124" y="748"/>
                    </a:lnTo>
                    <a:lnTo>
                      <a:pt x="125" y="747"/>
                    </a:lnTo>
                    <a:lnTo>
                      <a:pt x="125" y="746"/>
                    </a:lnTo>
                    <a:lnTo>
                      <a:pt x="126" y="746"/>
                    </a:lnTo>
                    <a:lnTo>
                      <a:pt x="126" y="747"/>
                    </a:lnTo>
                    <a:lnTo>
                      <a:pt x="127" y="746"/>
                    </a:lnTo>
                    <a:lnTo>
                      <a:pt x="127" y="748"/>
                    </a:lnTo>
                    <a:lnTo>
                      <a:pt x="128" y="747"/>
                    </a:lnTo>
                    <a:lnTo>
                      <a:pt x="128" y="746"/>
                    </a:lnTo>
                    <a:lnTo>
                      <a:pt x="129" y="748"/>
                    </a:lnTo>
                    <a:lnTo>
                      <a:pt x="129" y="746"/>
                    </a:lnTo>
                    <a:lnTo>
                      <a:pt x="130" y="745"/>
                    </a:lnTo>
                    <a:lnTo>
                      <a:pt x="130" y="748"/>
                    </a:lnTo>
                    <a:lnTo>
                      <a:pt x="131" y="748"/>
                    </a:lnTo>
                    <a:lnTo>
                      <a:pt x="131" y="746"/>
                    </a:lnTo>
                    <a:lnTo>
                      <a:pt x="132" y="747"/>
                    </a:lnTo>
                    <a:lnTo>
                      <a:pt x="132" y="748"/>
                    </a:lnTo>
                    <a:lnTo>
                      <a:pt x="133" y="746"/>
                    </a:lnTo>
                    <a:lnTo>
                      <a:pt x="133" y="749"/>
                    </a:lnTo>
                    <a:lnTo>
                      <a:pt x="134" y="749"/>
                    </a:lnTo>
                    <a:lnTo>
                      <a:pt x="134" y="738"/>
                    </a:lnTo>
                    <a:lnTo>
                      <a:pt x="135" y="733"/>
                    </a:lnTo>
                    <a:lnTo>
                      <a:pt x="135" y="711"/>
                    </a:lnTo>
                    <a:lnTo>
                      <a:pt x="136" y="700"/>
                    </a:lnTo>
                    <a:lnTo>
                      <a:pt x="136" y="667"/>
                    </a:lnTo>
                    <a:lnTo>
                      <a:pt x="137" y="652"/>
                    </a:lnTo>
                    <a:lnTo>
                      <a:pt x="137" y="614"/>
                    </a:lnTo>
                    <a:lnTo>
                      <a:pt x="138" y="608"/>
                    </a:lnTo>
                    <a:lnTo>
                      <a:pt x="138" y="586"/>
                    </a:lnTo>
                    <a:lnTo>
                      <a:pt x="139" y="565"/>
                    </a:lnTo>
                    <a:lnTo>
                      <a:pt x="139" y="548"/>
                    </a:lnTo>
                    <a:lnTo>
                      <a:pt x="140" y="556"/>
                    </a:lnTo>
                    <a:lnTo>
                      <a:pt x="140" y="528"/>
                    </a:lnTo>
                    <a:lnTo>
                      <a:pt x="141" y="512"/>
                    </a:lnTo>
                    <a:lnTo>
                      <a:pt x="141" y="538"/>
                    </a:lnTo>
                    <a:lnTo>
                      <a:pt x="142" y="525"/>
                    </a:lnTo>
                    <a:lnTo>
                      <a:pt x="142" y="488"/>
                    </a:lnTo>
                    <a:lnTo>
                      <a:pt x="143" y="481"/>
                    </a:lnTo>
                    <a:lnTo>
                      <a:pt x="143" y="529"/>
                    </a:lnTo>
                    <a:lnTo>
                      <a:pt x="144" y="524"/>
                    </a:lnTo>
                    <a:lnTo>
                      <a:pt x="144" y="483"/>
                    </a:lnTo>
                    <a:lnTo>
                      <a:pt x="145" y="489"/>
                    </a:lnTo>
                    <a:lnTo>
                      <a:pt x="145" y="522"/>
                    </a:lnTo>
                    <a:lnTo>
                      <a:pt x="146" y="521"/>
                    </a:lnTo>
                    <a:lnTo>
                      <a:pt x="146" y="486"/>
                    </a:lnTo>
                    <a:lnTo>
                      <a:pt x="147" y="533"/>
                    </a:lnTo>
                    <a:lnTo>
                      <a:pt x="147" y="487"/>
                    </a:lnTo>
                    <a:lnTo>
                      <a:pt x="148" y="486"/>
                    </a:lnTo>
                    <a:lnTo>
                      <a:pt x="148" y="519"/>
                    </a:lnTo>
                    <a:lnTo>
                      <a:pt x="149" y="492"/>
                    </a:lnTo>
                    <a:lnTo>
                      <a:pt x="149" y="528"/>
                    </a:lnTo>
                    <a:lnTo>
                      <a:pt x="150" y="517"/>
                    </a:lnTo>
                    <a:lnTo>
                      <a:pt x="150" y="546"/>
                    </a:lnTo>
                    <a:lnTo>
                      <a:pt x="151" y="552"/>
                    </a:lnTo>
                    <a:lnTo>
                      <a:pt x="151" y="505"/>
                    </a:lnTo>
                    <a:lnTo>
                      <a:pt x="152" y="542"/>
                    </a:lnTo>
                    <a:lnTo>
                      <a:pt x="152" y="480"/>
                    </a:lnTo>
                    <a:lnTo>
                      <a:pt x="153" y="520"/>
                    </a:lnTo>
                    <a:lnTo>
                      <a:pt x="153" y="545"/>
                    </a:lnTo>
                    <a:lnTo>
                      <a:pt x="154" y="523"/>
                    </a:lnTo>
                    <a:lnTo>
                      <a:pt x="154" y="540"/>
                    </a:lnTo>
                    <a:lnTo>
                      <a:pt x="155" y="535"/>
                    </a:lnTo>
                    <a:lnTo>
                      <a:pt x="155" y="567"/>
                    </a:lnTo>
                    <a:lnTo>
                      <a:pt x="156" y="533"/>
                    </a:lnTo>
                    <a:lnTo>
                      <a:pt x="156" y="559"/>
                    </a:lnTo>
                    <a:lnTo>
                      <a:pt x="157" y="567"/>
                    </a:lnTo>
                    <a:lnTo>
                      <a:pt x="157" y="532"/>
                    </a:lnTo>
                    <a:lnTo>
                      <a:pt x="158" y="553"/>
                    </a:lnTo>
                    <a:lnTo>
                      <a:pt x="158" y="587"/>
                    </a:lnTo>
                    <a:lnTo>
                      <a:pt x="159" y="561"/>
                    </a:lnTo>
                    <a:lnTo>
                      <a:pt x="159" y="595"/>
                    </a:lnTo>
                    <a:lnTo>
                      <a:pt x="160" y="590"/>
                    </a:lnTo>
                    <a:lnTo>
                      <a:pt x="160" y="576"/>
                    </a:lnTo>
                    <a:lnTo>
                      <a:pt x="161" y="598"/>
                    </a:lnTo>
                    <a:lnTo>
                      <a:pt x="161" y="586"/>
                    </a:lnTo>
                    <a:lnTo>
                      <a:pt x="162" y="605"/>
                    </a:lnTo>
                    <a:lnTo>
                      <a:pt x="162" y="634"/>
                    </a:lnTo>
                    <a:lnTo>
                      <a:pt x="163" y="622"/>
                    </a:lnTo>
                    <a:lnTo>
                      <a:pt x="163" y="638"/>
                    </a:lnTo>
                    <a:lnTo>
                      <a:pt x="164" y="637"/>
                    </a:lnTo>
                    <a:lnTo>
                      <a:pt x="164" y="619"/>
                    </a:lnTo>
                    <a:lnTo>
                      <a:pt x="165" y="631"/>
                    </a:lnTo>
                    <a:lnTo>
                      <a:pt x="165" y="602"/>
                    </a:lnTo>
                    <a:lnTo>
                      <a:pt x="166" y="603"/>
                    </a:lnTo>
                    <a:lnTo>
                      <a:pt x="166" y="617"/>
                    </a:lnTo>
                    <a:lnTo>
                      <a:pt x="167" y="619"/>
                    </a:lnTo>
                    <a:lnTo>
                      <a:pt x="167" y="602"/>
                    </a:lnTo>
                    <a:lnTo>
                      <a:pt x="168" y="600"/>
                    </a:lnTo>
                    <a:lnTo>
                      <a:pt x="168" y="615"/>
                    </a:lnTo>
                    <a:lnTo>
                      <a:pt x="169" y="619"/>
                    </a:lnTo>
                    <a:lnTo>
                      <a:pt x="169" y="599"/>
                    </a:lnTo>
                    <a:lnTo>
                      <a:pt x="170" y="610"/>
                    </a:lnTo>
                    <a:lnTo>
                      <a:pt x="170" y="627"/>
                    </a:lnTo>
                    <a:lnTo>
                      <a:pt x="171" y="615"/>
                    </a:lnTo>
                    <a:lnTo>
                      <a:pt x="171" y="633"/>
                    </a:lnTo>
                    <a:lnTo>
                      <a:pt x="172" y="612"/>
                    </a:lnTo>
                    <a:lnTo>
                      <a:pt x="172" y="622"/>
                    </a:lnTo>
                    <a:lnTo>
                      <a:pt x="173" y="633"/>
                    </a:lnTo>
                    <a:lnTo>
                      <a:pt x="173" y="611"/>
                    </a:lnTo>
                    <a:lnTo>
                      <a:pt x="174" y="614"/>
                    </a:lnTo>
                    <a:lnTo>
                      <a:pt x="174" y="633"/>
                    </a:lnTo>
                    <a:lnTo>
                      <a:pt x="175" y="633"/>
                    </a:lnTo>
                    <a:lnTo>
                      <a:pt x="175" y="623"/>
                    </a:lnTo>
                    <a:lnTo>
                      <a:pt x="176" y="621"/>
                    </a:lnTo>
                    <a:lnTo>
                      <a:pt x="176" y="639"/>
                    </a:lnTo>
                    <a:lnTo>
                      <a:pt x="177" y="631"/>
                    </a:lnTo>
                    <a:lnTo>
                      <a:pt x="177" y="636"/>
                    </a:lnTo>
                    <a:lnTo>
                      <a:pt x="178" y="643"/>
                    </a:lnTo>
                    <a:lnTo>
                      <a:pt x="178" y="631"/>
                    </a:lnTo>
                    <a:lnTo>
                      <a:pt x="179" y="638"/>
                    </a:lnTo>
                    <a:lnTo>
                      <a:pt x="179" y="640"/>
                    </a:lnTo>
                    <a:lnTo>
                      <a:pt x="180" y="658"/>
                    </a:lnTo>
                    <a:lnTo>
                      <a:pt x="180" y="639"/>
                    </a:lnTo>
                    <a:lnTo>
                      <a:pt x="181" y="638"/>
                    </a:lnTo>
                    <a:lnTo>
                      <a:pt x="181" y="656"/>
                    </a:lnTo>
                    <a:lnTo>
                      <a:pt x="182" y="657"/>
                    </a:lnTo>
                    <a:lnTo>
                      <a:pt x="182" y="628"/>
                    </a:lnTo>
                    <a:lnTo>
                      <a:pt x="183" y="595"/>
                    </a:lnTo>
                    <a:lnTo>
                      <a:pt x="183" y="554"/>
                    </a:lnTo>
                    <a:lnTo>
                      <a:pt x="184" y="512"/>
                    </a:lnTo>
                    <a:lnTo>
                      <a:pt x="184" y="478"/>
                    </a:lnTo>
                    <a:lnTo>
                      <a:pt x="185" y="488"/>
                    </a:lnTo>
                    <a:lnTo>
                      <a:pt x="185" y="408"/>
                    </a:lnTo>
                    <a:lnTo>
                      <a:pt x="186" y="435"/>
                    </a:lnTo>
                    <a:lnTo>
                      <a:pt x="186" y="399"/>
                    </a:lnTo>
                    <a:lnTo>
                      <a:pt x="187" y="379"/>
                    </a:lnTo>
                    <a:lnTo>
                      <a:pt x="187" y="416"/>
                    </a:lnTo>
                    <a:lnTo>
                      <a:pt x="188" y="453"/>
                    </a:lnTo>
                    <a:lnTo>
                      <a:pt x="188" y="382"/>
                    </a:lnTo>
                    <a:lnTo>
                      <a:pt x="189" y="457"/>
                    </a:lnTo>
                    <a:lnTo>
                      <a:pt x="189" y="381"/>
                    </a:lnTo>
                    <a:lnTo>
                      <a:pt x="190" y="454"/>
                    </a:lnTo>
                    <a:lnTo>
                      <a:pt x="190" y="407"/>
                    </a:lnTo>
                    <a:lnTo>
                      <a:pt x="191" y="405"/>
                    </a:lnTo>
                    <a:lnTo>
                      <a:pt x="191" y="470"/>
                    </a:lnTo>
                    <a:lnTo>
                      <a:pt x="192" y="412"/>
                    </a:lnTo>
                    <a:lnTo>
                      <a:pt x="192" y="485"/>
                    </a:lnTo>
                    <a:lnTo>
                      <a:pt x="193" y="437"/>
                    </a:lnTo>
                    <a:lnTo>
                      <a:pt x="193" y="508"/>
                    </a:lnTo>
                    <a:lnTo>
                      <a:pt x="194" y="429"/>
                    </a:lnTo>
                    <a:lnTo>
                      <a:pt x="194" y="492"/>
                    </a:lnTo>
                    <a:lnTo>
                      <a:pt x="195" y="487"/>
                    </a:lnTo>
                    <a:lnTo>
                      <a:pt x="195" y="538"/>
                    </a:lnTo>
                    <a:lnTo>
                      <a:pt x="196" y="518"/>
                    </a:lnTo>
                    <a:lnTo>
                      <a:pt x="196" y="557"/>
                    </a:lnTo>
                    <a:lnTo>
                      <a:pt x="197" y="537"/>
                    </a:lnTo>
                    <a:lnTo>
                      <a:pt x="197" y="566"/>
                    </a:lnTo>
                    <a:lnTo>
                      <a:pt x="198" y="571"/>
                    </a:lnTo>
                    <a:lnTo>
                      <a:pt x="198" y="612"/>
                    </a:lnTo>
                    <a:lnTo>
                      <a:pt x="199" y="608"/>
                    </a:lnTo>
                    <a:lnTo>
                      <a:pt x="199" y="622"/>
                    </a:lnTo>
                    <a:lnTo>
                      <a:pt x="200" y="652"/>
                    </a:lnTo>
                    <a:lnTo>
                      <a:pt x="200" y="635"/>
                    </a:lnTo>
                    <a:lnTo>
                      <a:pt x="201" y="657"/>
                    </a:lnTo>
                    <a:lnTo>
                      <a:pt x="201" y="666"/>
                    </a:lnTo>
                    <a:lnTo>
                      <a:pt x="202" y="673"/>
                    </a:lnTo>
                    <a:lnTo>
                      <a:pt x="202" y="659"/>
                    </a:lnTo>
                    <a:lnTo>
                      <a:pt x="203" y="673"/>
                    </a:lnTo>
                    <a:lnTo>
                      <a:pt x="203" y="661"/>
                    </a:lnTo>
                    <a:lnTo>
                      <a:pt x="204" y="675"/>
                    </a:lnTo>
                    <a:lnTo>
                      <a:pt x="204" y="665"/>
                    </a:lnTo>
                    <a:lnTo>
                      <a:pt x="205" y="671"/>
                    </a:lnTo>
                    <a:lnTo>
                      <a:pt x="205" y="677"/>
                    </a:lnTo>
                    <a:lnTo>
                      <a:pt x="206" y="672"/>
                    </a:lnTo>
                    <a:lnTo>
                      <a:pt x="206" y="682"/>
                    </a:lnTo>
                    <a:lnTo>
                      <a:pt x="207" y="674"/>
                    </a:lnTo>
                    <a:lnTo>
                      <a:pt x="207" y="685"/>
                    </a:lnTo>
                    <a:lnTo>
                      <a:pt x="208" y="701"/>
                    </a:lnTo>
                    <a:lnTo>
                      <a:pt x="208" y="687"/>
                    </a:lnTo>
                    <a:lnTo>
                      <a:pt x="209" y="704"/>
                    </a:lnTo>
                    <a:lnTo>
                      <a:pt x="209" y="710"/>
                    </a:lnTo>
                    <a:lnTo>
                      <a:pt x="210" y="712"/>
                    </a:lnTo>
                    <a:lnTo>
                      <a:pt x="210" y="722"/>
                    </a:lnTo>
                    <a:lnTo>
                      <a:pt x="211" y="725"/>
                    </a:lnTo>
                    <a:lnTo>
                      <a:pt x="211" y="731"/>
                    </a:lnTo>
                    <a:lnTo>
                      <a:pt x="212" y="733"/>
                    </a:lnTo>
                    <a:lnTo>
                      <a:pt x="212" y="740"/>
                    </a:lnTo>
                    <a:lnTo>
                      <a:pt x="213" y="742"/>
                    </a:lnTo>
                    <a:lnTo>
                      <a:pt x="213" y="741"/>
                    </a:lnTo>
                    <a:lnTo>
                      <a:pt x="214" y="746"/>
                    </a:lnTo>
                    <a:lnTo>
                      <a:pt x="214" y="743"/>
                    </a:lnTo>
                    <a:lnTo>
                      <a:pt x="215" y="746"/>
                    </a:lnTo>
                    <a:lnTo>
                      <a:pt x="215" y="745"/>
                    </a:lnTo>
                    <a:lnTo>
                      <a:pt x="216" y="744"/>
                    </a:lnTo>
                    <a:lnTo>
                      <a:pt x="216" y="748"/>
                    </a:lnTo>
                    <a:lnTo>
                      <a:pt x="217" y="744"/>
                    </a:lnTo>
                    <a:lnTo>
                      <a:pt x="217" y="749"/>
                    </a:lnTo>
                    <a:lnTo>
                      <a:pt x="218" y="748"/>
                    </a:lnTo>
                    <a:lnTo>
                      <a:pt x="218" y="750"/>
                    </a:lnTo>
                    <a:lnTo>
                      <a:pt x="219" y="749"/>
                    </a:lnTo>
                    <a:lnTo>
                      <a:pt x="219" y="751"/>
                    </a:lnTo>
                    <a:lnTo>
                      <a:pt x="220" y="750"/>
                    </a:lnTo>
                    <a:lnTo>
                      <a:pt x="220" y="753"/>
                    </a:lnTo>
                    <a:lnTo>
                      <a:pt x="221" y="751"/>
                    </a:lnTo>
                    <a:lnTo>
                      <a:pt x="221" y="753"/>
                    </a:lnTo>
                    <a:lnTo>
                      <a:pt x="222" y="753"/>
                    </a:lnTo>
                    <a:lnTo>
                      <a:pt x="222" y="753"/>
                    </a:lnTo>
                    <a:lnTo>
                      <a:pt x="223" y="754"/>
                    </a:lnTo>
                    <a:lnTo>
                      <a:pt x="223" y="753"/>
                    </a:lnTo>
                    <a:lnTo>
                      <a:pt x="224" y="753"/>
                    </a:lnTo>
                    <a:lnTo>
                      <a:pt x="224" y="755"/>
                    </a:lnTo>
                    <a:lnTo>
                      <a:pt x="225" y="754"/>
                    </a:lnTo>
                    <a:lnTo>
                      <a:pt x="225" y="756"/>
                    </a:lnTo>
                    <a:lnTo>
                      <a:pt x="226" y="756"/>
                    </a:lnTo>
                    <a:lnTo>
                      <a:pt x="226" y="755"/>
                    </a:lnTo>
                    <a:lnTo>
                      <a:pt x="227" y="756"/>
                    </a:lnTo>
                    <a:lnTo>
                      <a:pt x="227" y="757"/>
                    </a:lnTo>
                    <a:lnTo>
                      <a:pt x="228" y="758"/>
                    </a:lnTo>
                    <a:lnTo>
                      <a:pt x="228" y="757"/>
                    </a:lnTo>
                    <a:lnTo>
                      <a:pt x="229" y="758"/>
                    </a:lnTo>
                    <a:lnTo>
                      <a:pt x="229" y="757"/>
                    </a:lnTo>
                    <a:lnTo>
                      <a:pt x="230" y="757"/>
                    </a:lnTo>
                    <a:lnTo>
                      <a:pt x="230" y="759"/>
                    </a:lnTo>
                    <a:lnTo>
                      <a:pt x="231" y="759"/>
                    </a:lnTo>
                    <a:lnTo>
                      <a:pt x="231" y="757"/>
                    </a:lnTo>
                    <a:lnTo>
                      <a:pt x="232" y="759"/>
                    </a:lnTo>
                    <a:lnTo>
                      <a:pt x="232" y="757"/>
                    </a:lnTo>
                    <a:lnTo>
                      <a:pt x="233" y="758"/>
                    </a:lnTo>
                    <a:lnTo>
                      <a:pt x="233" y="757"/>
                    </a:lnTo>
                    <a:lnTo>
                      <a:pt x="234" y="758"/>
                    </a:lnTo>
                    <a:lnTo>
                      <a:pt x="234" y="758"/>
                    </a:lnTo>
                    <a:lnTo>
                      <a:pt x="235" y="757"/>
                    </a:lnTo>
                    <a:lnTo>
                      <a:pt x="235" y="759"/>
                    </a:lnTo>
                    <a:lnTo>
                      <a:pt x="236" y="758"/>
                    </a:lnTo>
                    <a:lnTo>
                      <a:pt x="236" y="759"/>
                    </a:lnTo>
                    <a:lnTo>
                      <a:pt x="237" y="759"/>
                    </a:lnTo>
                    <a:lnTo>
                      <a:pt x="237" y="757"/>
                    </a:lnTo>
                    <a:lnTo>
                      <a:pt x="238" y="757"/>
                    </a:lnTo>
                    <a:lnTo>
                      <a:pt x="238" y="754"/>
                    </a:lnTo>
                    <a:lnTo>
                      <a:pt x="239" y="753"/>
                    </a:lnTo>
                    <a:lnTo>
                      <a:pt x="239" y="748"/>
                    </a:lnTo>
                    <a:lnTo>
                      <a:pt x="240" y="748"/>
                    </a:lnTo>
                    <a:lnTo>
                      <a:pt x="240" y="743"/>
                    </a:lnTo>
                    <a:lnTo>
                      <a:pt x="241" y="742"/>
                    </a:lnTo>
                    <a:lnTo>
                      <a:pt x="241" y="738"/>
                    </a:lnTo>
                    <a:lnTo>
                      <a:pt x="242" y="736"/>
                    </a:lnTo>
                    <a:lnTo>
                      <a:pt x="242" y="729"/>
                    </a:lnTo>
                    <a:lnTo>
                      <a:pt x="243" y="735"/>
                    </a:lnTo>
                    <a:lnTo>
                      <a:pt x="243" y="726"/>
                    </a:lnTo>
                    <a:lnTo>
                      <a:pt x="244" y="730"/>
                    </a:lnTo>
                    <a:lnTo>
                      <a:pt x="244" y="718"/>
                    </a:lnTo>
                    <a:lnTo>
                      <a:pt x="245" y="721"/>
                    </a:lnTo>
                    <a:lnTo>
                      <a:pt x="245" y="732"/>
                    </a:lnTo>
                    <a:lnTo>
                      <a:pt x="246" y="714"/>
                    </a:lnTo>
                    <a:lnTo>
                      <a:pt x="246" y="722"/>
                    </a:lnTo>
                    <a:lnTo>
                      <a:pt x="247" y="720"/>
                    </a:lnTo>
                    <a:lnTo>
                      <a:pt x="247" y="726"/>
                    </a:lnTo>
                    <a:lnTo>
                      <a:pt x="248" y="717"/>
                    </a:lnTo>
                    <a:lnTo>
                      <a:pt x="248" y="728"/>
                    </a:lnTo>
                    <a:lnTo>
                      <a:pt x="249" y="727"/>
                    </a:lnTo>
                    <a:lnTo>
                      <a:pt x="249" y="722"/>
                    </a:lnTo>
                    <a:lnTo>
                      <a:pt x="250" y="718"/>
                    </a:lnTo>
                    <a:lnTo>
                      <a:pt x="250" y="724"/>
                    </a:lnTo>
                    <a:lnTo>
                      <a:pt x="251" y="723"/>
                    </a:lnTo>
                    <a:lnTo>
                      <a:pt x="251" y="728"/>
                    </a:lnTo>
                    <a:lnTo>
                      <a:pt x="252" y="724"/>
                    </a:lnTo>
                    <a:lnTo>
                      <a:pt x="252" y="732"/>
                    </a:lnTo>
                    <a:lnTo>
                      <a:pt x="253" y="722"/>
                    </a:lnTo>
                    <a:lnTo>
                      <a:pt x="253" y="731"/>
                    </a:lnTo>
                    <a:lnTo>
                      <a:pt x="254" y="726"/>
                    </a:lnTo>
                    <a:lnTo>
                      <a:pt x="254" y="725"/>
                    </a:lnTo>
                    <a:lnTo>
                      <a:pt x="255" y="735"/>
                    </a:lnTo>
                    <a:lnTo>
                      <a:pt x="255" y="723"/>
                    </a:lnTo>
                    <a:lnTo>
                      <a:pt x="256" y="733"/>
                    </a:lnTo>
                    <a:lnTo>
                      <a:pt x="256" y="729"/>
                    </a:lnTo>
                    <a:lnTo>
                      <a:pt x="257" y="733"/>
                    </a:lnTo>
                    <a:lnTo>
                      <a:pt x="257" y="702"/>
                    </a:lnTo>
                    <a:lnTo>
                      <a:pt x="258" y="694"/>
                    </a:lnTo>
                    <a:lnTo>
                      <a:pt x="258" y="638"/>
                    </a:lnTo>
                    <a:lnTo>
                      <a:pt x="259" y="624"/>
                    </a:lnTo>
                    <a:lnTo>
                      <a:pt x="259" y="569"/>
                    </a:lnTo>
                    <a:lnTo>
                      <a:pt x="260" y="555"/>
                    </a:lnTo>
                    <a:lnTo>
                      <a:pt x="260" y="501"/>
                    </a:lnTo>
                    <a:lnTo>
                      <a:pt x="261" y="490"/>
                    </a:lnTo>
                    <a:lnTo>
                      <a:pt x="261" y="419"/>
                    </a:lnTo>
                    <a:lnTo>
                      <a:pt x="262" y="444"/>
                    </a:lnTo>
                    <a:lnTo>
                      <a:pt x="262" y="334"/>
                    </a:lnTo>
                    <a:lnTo>
                      <a:pt x="263" y="336"/>
                    </a:lnTo>
                    <a:lnTo>
                      <a:pt x="263" y="195"/>
                    </a:lnTo>
                    <a:lnTo>
                      <a:pt x="264" y="230"/>
                    </a:lnTo>
                    <a:lnTo>
                      <a:pt x="264" y="209"/>
                    </a:lnTo>
                    <a:lnTo>
                      <a:pt x="265" y="247"/>
                    </a:lnTo>
                    <a:lnTo>
                      <a:pt x="265" y="95"/>
                    </a:lnTo>
                    <a:lnTo>
                      <a:pt x="266" y="184"/>
                    </a:lnTo>
                    <a:lnTo>
                      <a:pt x="266" y="35"/>
                    </a:lnTo>
                    <a:lnTo>
                      <a:pt x="267" y="0"/>
                    </a:lnTo>
                    <a:lnTo>
                      <a:pt x="267" y="151"/>
                    </a:lnTo>
                    <a:lnTo>
                      <a:pt x="268" y="76"/>
                    </a:lnTo>
                    <a:lnTo>
                      <a:pt x="268" y="188"/>
                    </a:lnTo>
                    <a:lnTo>
                      <a:pt x="269" y="233"/>
                    </a:lnTo>
                    <a:lnTo>
                      <a:pt x="269" y="111"/>
                    </a:lnTo>
                    <a:lnTo>
                      <a:pt x="270" y="91"/>
                    </a:lnTo>
                    <a:lnTo>
                      <a:pt x="270" y="233"/>
                    </a:lnTo>
                    <a:lnTo>
                      <a:pt x="271" y="180"/>
                    </a:lnTo>
                    <a:lnTo>
                      <a:pt x="271" y="266"/>
                    </a:lnTo>
                    <a:lnTo>
                      <a:pt x="272" y="273"/>
                    </a:lnTo>
                    <a:lnTo>
                      <a:pt x="272" y="132"/>
                    </a:lnTo>
                    <a:lnTo>
                      <a:pt x="273" y="332"/>
                    </a:lnTo>
                    <a:lnTo>
                      <a:pt x="273" y="249"/>
                    </a:lnTo>
                    <a:lnTo>
                      <a:pt x="274" y="273"/>
                    </a:lnTo>
                    <a:lnTo>
                      <a:pt x="274" y="358"/>
                    </a:lnTo>
                    <a:lnTo>
                      <a:pt x="275" y="405"/>
                    </a:lnTo>
                    <a:lnTo>
                      <a:pt x="275" y="265"/>
                    </a:lnTo>
                    <a:lnTo>
                      <a:pt x="276" y="339"/>
                    </a:lnTo>
                    <a:lnTo>
                      <a:pt x="276" y="425"/>
                    </a:lnTo>
                    <a:lnTo>
                      <a:pt x="277" y="380"/>
                    </a:lnTo>
                    <a:lnTo>
                      <a:pt x="277" y="451"/>
                    </a:lnTo>
                    <a:lnTo>
                      <a:pt x="278" y="503"/>
                    </a:lnTo>
                    <a:lnTo>
                      <a:pt x="278" y="432"/>
                    </a:lnTo>
                    <a:lnTo>
                      <a:pt x="279" y="494"/>
                    </a:lnTo>
                    <a:lnTo>
                      <a:pt x="279" y="541"/>
                    </a:lnTo>
                    <a:lnTo>
                      <a:pt x="280" y="519"/>
                    </a:lnTo>
                    <a:lnTo>
                      <a:pt x="280" y="554"/>
                    </a:lnTo>
                    <a:lnTo>
                      <a:pt x="281" y="553"/>
                    </a:lnTo>
                    <a:lnTo>
                      <a:pt x="281" y="601"/>
                    </a:lnTo>
                    <a:lnTo>
                      <a:pt x="282" y="592"/>
                    </a:lnTo>
                    <a:lnTo>
                      <a:pt x="282" y="615"/>
                    </a:lnTo>
                    <a:lnTo>
                      <a:pt x="283" y="617"/>
                    </a:lnTo>
                    <a:lnTo>
                      <a:pt x="283" y="631"/>
                    </a:lnTo>
                    <a:lnTo>
                      <a:pt x="284" y="633"/>
                    </a:lnTo>
                    <a:lnTo>
                      <a:pt x="284" y="650"/>
                    </a:lnTo>
                    <a:lnTo>
                      <a:pt x="285" y="641"/>
                    </a:lnTo>
                    <a:lnTo>
                      <a:pt x="285" y="668"/>
                    </a:lnTo>
                    <a:lnTo>
                      <a:pt x="286" y="659"/>
                    </a:lnTo>
                    <a:lnTo>
                      <a:pt x="286" y="673"/>
                    </a:lnTo>
                    <a:lnTo>
                      <a:pt x="287" y="668"/>
                    </a:lnTo>
                    <a:lnTo>
                      <a:pt x="287" y="683"/>
                    </a:lnTo>
                    <a:lnTo>
                      <a:pt x="288" y="675"/>
                    </a:lnTo>
                    <a:lnTo>
                      <a:pt x="288" y="697"/>
                    </a:lnTo>
                    <a:lnTo>
                      <a:pt x="289" y="701"/>
                    </a:lnTo>
                    <a:lnTo>
                      <a:pt x="289" y="683"/>
                    </a:lnTo>
                    <a:lnTo>
                      <a:pt x="290" y="696"/>
                    </a:lnTo>
                    <a:lnTo>
                      <a:pt x="290" y="705"/>
                    </a:lnTo>
                    <a:lnTo>
                      <a:pt x="291" y="706"/>
                    </a:lnTo>
                    <a:lnTo>
                      <a:pt x="291" y="714"/>
                    </a:lnTo>
                    <a:lnTo>
                      <a:pt x="292" y="715"/>
                    </a:lnTo>
                    <a:lnTo>
                      <a:pt x="292" y="708"/>
                    </a:lnTo>
                    <a:lnTo>
                      <a:pt x="293" y="718"/>
                    </a:lnTo>
                    <a:lnTo>
                      <a:pt x="293" y="715"/>
                    </a:lnTo>
                    <a:lnTo>
                      <a:pt x="294" y="721"/>
                    </a:lnTo>
                    <a:lnTo>
                      <a:pt x="294" y="726"/>
                    </a:lnTo>
                    <a:lnTo>
                      <a:pt x="295" y="713"/>
                    </a:lnTo>
                    <a:lnTo>
                      <a:pt x="295" y="729"/>
                    </a:lnTo>
                    <a:lnTo>
                      <a:pt x="296" y="726"/>
                    </a:lnTo>
                    <a:lnTo>
                      <a:pt x="296" y="731"/>
                    </a:lnTo>
                    <a:lnTo>
                      <a:pt x="297" y="728"/>
                    </a:lnTo>
                    <a:lnTo>
                      <a:pt x="297" y="734"/>
                    </a:lnTo>
                    <a:lnTo>
                      <a:pt x="298" y="733"/>
                    </a:lnTo>
                    <a:lnTo>
                      <a:pt x="298" y="737"/>
                    </a:lnTo>
                    <a:lnTo>
                      <a:pt x="299" y="733"/>
                    </a:lnTo>
                    <a:lnTo>
                      <a:pt x="299" y="739"/>
                    </a:lnTo>
                    <a:lnTo>
                      <a:pt x="300" y="741"/>
                    </a:lnTo>
                    <a:lnTo>
                      <a:pt x="300" y="740"/>
                    </a:lnTo>
                    <a:lnTo>
                      <a:pt x="301" y="737"/>
                    </a:lnTo>
                    <a:lnTo>
                      <a:pt x="301" y="742"/>
                    </a:lnTo>
                    <a:lnTo>
                      <a:pt x="302" y="743"/>
                    </a:lnTo>
                    <a:lnTo>
                      <a:pt x="302" y="744"/>
                    </a:lnTo>
                    <a:lnTo>
                      <a:pt x="303" y="743"/>
                    </a:lnTo>
                    <a:lnTo>
                      <a:pt x="303" y="746"/>
                    </a:lnTo>
                    <a:lnTo>
                      <a:pt x="304" y="743"/>
                    </a:lnTo>
                    <a:lnTo>
                      <a:pt x="304" y="747"/>
                    </a:lnTo>
                    <a:lnTo>
                      <a:pt x="305" y="747"/>
                    </a:lnTo>
                    <a:lnTo>
                      <a:pt x="305" y="746"/>
                    </a:lnTo>
                    <a:lnTo>
                      <a:pt x="306" y="748"/>
                    </a:lnTo>
                    <a:lnTo>
                      <a:pt x="306" y="746"/>
                    </a:lnTo>
                    <a:lnTo>
                      <a:pt x="307" y="746"/>
                    </a:lnTo>
                    <a:lnTo>
                      <a:pt x="307" y="748"/>
                    </a:lnTo>
                    <a:lnTo>
                      <a:pt x="308" y="747"/>
                    </a:lnTo>
                    <a:lnTo>
                      <a:pt x="308" y="749"/>
                    </a:lnTo>
                    <a:lnTo>
                      <a:pt x="309" y="748"/>
                    </a:lnTo>
                    <a:lnTo>
                      <a:pt x="309" y="750"/>
                    </a:lnTo>
                    <a:lnTo>
                      <a:pt x="310" y="749"/>
                    </a:lnTo>
                    <a:lnTo>
                      <a:pt x="310" y="750"/>
                    </a:lnTo>
                    <a:lnTo>
                      <a:pt x="311" y="749"/>
                    </a:lnTo>
                    <a:lnTo>
                      <a:pt x="311" y="750"/>
                    </a:lnTo>
                    <a:lnTo>
                      <a:pt x="312" y="750"/>
                    </a:lnTo>
                    <a:lnTo>
                      <a:pt x="312" y="752"/>
                    </a:lnTo>
                    <a:lnTo>
                      <a:pt x="313" y="752"/>
                    </a:lnTo>
                    <a:lnTo>
                      <a:pt x="313" y="750"/>
                    </a:lnTo>
                    <a:lnTo>
                      <a:pt x="314" y="751"/>
                    </a:lnTo>
                    <a:lnTo>
                      <a:pt x="314" y="753"/>
                    </a:lnTo>
                    <a:lnTo>
                      <a:pt x="315" y="752"/>
                    </a:lnTo>
                    <a:lnTo>
                      <a:pt x="315" y="752"/>
                    </a:lnTo>
                    <a:lnTo>
                      <a:pt x="316" y="752"/>
                    </a:lnTo>
                    <a:lnTo>
                      <a:pt x="316" y="753"/>
                    </a:lnTo>
                    <a:lnTo>
                      <a:pt x="317" y="750"/>
                    </a:lnTo>
                    <a:lnTo>
                      <a:pt x="317" y="753"/>
                    </a:lnTo>
                    <a:lnTo>
                      <a:pt x="318" y="753"/>
                    </a:lnTo>
                    <a:lnTo>
                      <a:pt x="318" y="752"/>
                    </a:lnTo>
                    <a:lnTo>
                      <a:pt x="319" y="752"/>
                    </a:lnTo>
                    <a:lnTo>
                      <a:pt x="319" y="754"/>
                    </a:lnTo>
                    <a:lnTo>
                      <a:pt x="320" y="753"/>
                    </a:lnTo>
                    <a:lnTo>
                      <a:pt x="320" y="754"/>
                    </a:lnTo>
                    <a:lnTo>
                      <a:pt x="321" y="752"/>
                    </a:lnTo>
                    <a:lnTo>
                      <a:pt x="321" y="754"/>
                    </a:lnTo>
                    <a:lnTo>
                      <a:pt x="322" y="753"/>
                    </a:lnTo>
                    <a:lnTo>
                      <a:pt x="322" y="754"/>
                    </a:lnTo>
                    <a:lnTo>
                      <a:pt x="323" y="752"/>
                    </a:lnTo>
                    <a:lnTo>
                      <a:pt x="323" y="755"/>
                    </a:lnTo>
                    <a:lnTo>
                      <a:pt x="324" y="754"/>
                    </a:lnTo>
                    <a:lnTo>
                      <a:pt x="324" y="755"/>
                    </a:lnTo>
                    <a:lnTo>
                      <a:pt x="325" y="755"/>
                    </a:lnTo>
                    <a:lnTo>
                      <a:pt x="325" y="754"/>
                    </a:lnTo>
                    <a:lnTo>
                      <a:pt x="326" y="755"/>
                    </a:lnTo>
                    <a:lnTo>
                      <a:pt x="326" y="757"/>
                    </a:lnTo>
                    <a:lnTo>
                      <a:pt x="327" y="756"/>
                    </a:lnTo>
                    <a:lnTo>
                      <a:pt x="327" y="757"/>
                    </a:lnTo>
                    <a:lnTo>
                      <a:pt x="328" y="756"/>
                    </a:lnTo>
                    <a:lnTo>
                      <a:pt x="328" y="757"/>
                    </a:lnTo>
                    <a:lnTo>
                      <a:pt x="329" y="758"/>
                    </a:lnTo>
                    <a:lnTo>
                      <a:pt x="329" y="754"/>
                    </a:lnTo>
                    <a:lnTo>
                      <a:pt x="330" y="757"/>
                    </a:lnTo>
                    <a:lnTo>
                      <a:pt x="330" y="758"/>
                    </a:lnTo>
                    <a:lnTo>
                      <a:pt x="331" y="758"/>
                    </a:lnTo>
                    <a:lnTo>
                      <a:pt x="331" y="758"/>
                    </a:lnTo>
                    <a:lnTo>
                      <a:pt x="332" y="758"/>
                    </a:lnTo>
                    <a:lnTo>
                      <a:pt x="332" y="759"/>
                    </a:lnTo>
                    <a:lnTo>
                      <a:pt x="333" y="759"/>
                    </a:lnTo>
                    <a:lnTo>
                      <a:pt x="333" y="758"/>
                    </a:lnTo>
                    <a:lnTo>
                      <a:pt x="334" y="759"/>
                    </a:lnTo>
                    <a:lnTo>
                      <a:pt x="334" y="758"/>
                    </a:lnTo>
                    <a:lnTo>
                      <a:pt x="335" y="759"/>
                    </a:lnTo>
                    <a:lnTo>
                      <a:pt x="335" y="760"/>
                    </a:lnTo>
                    <a:lnTo>
                      <a:pt x="336" y="759"/>
                    </a:lnTo>
                    <a:lnTo>
                      <a:pt x="336" y="760"/>
                    </a:lnTo>
                    <a:lnTo>
                      <a:pt x="337" y="760"/>
                    </a:lnTo>
                    <a:lnTo>
                      <a:pt x="337" y="759"/>
                    </a:lnTo>
                    <a:lnTo>
                      <a:pt x="338" y="760"/>
                    </a:lnTo>
                    <a:lnTo>
                      <a:pt x="338" y="759"/>
                    </a:lnTo>
                    <a:lnTo>
                      <a:pt x="339" y="758"/>
                    </a:lnTo>
                    <a:lnTo>
                      <a:pt x="339" y="760"/>
                    </a:lnTo>
                    <a:lnTo>
                      <a:pt x="340" y="758"/>
                    </a:lnTo>
                    <a:lnTo>
                      <a:pt x="340" y="761"/>
                    </a:lnTo>
                    <a:lnTo>
                      <a:pt x="341" y="759"/>
                    </a:lnTo>
                    <a:lnTo>
                      <a:pt x="341" y="761"/>
                    </a:lnTo>
                    <a:lnTo>
                      <a:pt x="342" y="758"/>
                    </a:lnTo>
                    <a:lnTo>
                      <a:pt x="342" y="761"/>
                    </a:lnTo>
                    <a:lnTo>
                      <a:pt x="343" y="760"/>
                    </a:lnTo>
                    <a:lnTo>
                      <a:pt x="343" y="758"/>
                    </a:lnTo>
                    <a:lnTo>
                      <a:pt x="344" y="759"/>
                    </a:lnTo>
                    <a:lnTo>
                      <a:pt x="344" y="757"/>
                    </a:lnTo>
                    <a:lnTo>
                      <a:pt x="345" y="758"/>
                    </a:lnTo>
                    <a:lnTo>
                      <a:pt x="345" y="753"/>
                    </a:lnTo>
                    <a:lnTo>
                      <a:pt x="346" y="754"/>
                    </a:lnTo>
                    <a:lnTo>
                      <a:pt x="346" y="749"/>
                    </a:lnTo>
                    <a:lnTo>
                      <a:pt x="347" y="751"/>
                    </a:lnTo>
                    <a:lnTo>
                      <a:pt x="347" y="749"/>
                    </a:lnTo>
                    <a:lnTo>
                      <a:pt x="348" y="745"/>
                    </a:lnTo>
                    <a:lnTo>
                      <a:pt x="348" y="747"/>
                    </a:lnTo>
                    <a:lnTo>
                      <a:pt x="349" y="745"/>
                    </a:lnTo>
                    <a:lnTo>
                      <a:pt x="349" y="741"/>
                    </a:lnTo>
                    <a:lnTo>
                      <a:pt x="350" y="740"/>
                    </a:lnTo>
                    <a:lnTo>
                      <a:pt x="350" y="744"/>
                    </a:lnTo>
                    <a:lnTo>
                      <a:pt x="351" y="743"/>
                    </a:lnTo>
                    <a:lnTo>
                      <a:pt x="351" y="737"/>
                    </a:lnTo>
                    <a:lnTo>
                      <a:pt x="352" y="741"/>
                    </a:lnTo>
                    <a:lnTo>
                      <a:pt x="352" y="737"/>
                    </a:lnTo>
                    <a:lnTo>
                      <a:pt x="353" y="732"/>
                    </a:lnTo>
                    <a:lnTo>
                      <a:pt x="353" y="739"/>
                    </a:lnTo>
                    <a:lnTo>
                      <a:pt x="354" y="734"/>
                    </a:lnTo>
                    <a:lnTo>
                      <a:pt x="354" y="725"/>
                    </a:lnTo>
                    <a:lnTo>
                      <a:pt x="355" y="736"/>
                    </a:lnTo>
                    <a:lnTo>
                      <a:pt x="355" y="725"/>
                    </a:lnTo>
                    <a:lnTo>
                      <a:pt x="356" y="727"/>
                    </a:lnTo>
                    <a:lnTo>
                      <a:pt x="356" y="735"/>
                    </a:lnTo>
                    <a:lnTo>
                      <a:pt x="357" y="725"/>
                    </a:lnTo>
                    <a:lnTo>
                      <a:pt x="357" y="729"/>
                    </a:lnTo>
                    <a:lnTo>
                      <a:pt x="358" y="720"/>
                    </a:lnTo>
                    <a:lnTo>
                      <a:pt x="358" y="726"/>
                    </a:lnTo>
                    <a:lnTo>
                      <a:pt x="359" y="727"/>
                    </a:lnTo>
                    <a:lnTo>
                      <a:pt x="359" y="719"/>
                    </a:lnTo>
                    <a:lnTo>
                      <a:pt x="360" y="722"/>
                    </a:lnTo>
                    <a:lnTo>
                      <a:pt x="360" y="712"/>
                    </a:lnTo>
                    <a:lnTo>
                      <a:pt x="361" y="714"/>
                    </a:lnTo>
                    <a:lnTo>
                      <a:pt x="361" y="707"/>
                    </a:lnTo>
                    <a:lnTo>
                      <a:pt x="362" y="704"/>
                    </a:lnTo>
                    <a:lnTo>
                      <a:pt x="362" y="712"/>
                    </a:lnTo>
                    <a:lnTo>
                      <a:pt x="363" y="712"/>
                    </a:lnTo>
                    <a:lnTo>
                      <a:pt x="363" y="700"/>
                    </a:lnTo>
                    <a:lnTo>
                      <a:pt x="364" y="705"/>
                    </a:lnTo>
                    <a:lnTo>
                      <a:pt x="364" y="690"/>
                    </a:lnTo>
                    <a:lnTo>
                      <a:pt x="365" y="686"/>
                    </a:lnTo>
                    <a:lnTo>
                      <a:pt x="365" y="700"/>
                    </a:lnTo>
                    <a:lnTo>
                      <a:pt x="366" y="690"/>
                    </a:lnTo>
                    <a:lnTo>
                      <a:pt x="366" y="669"/>
                    </a:lnTo>
                    <a:lnTo>
                      <a:pt x="367" y="690"/>
                    </a:lnTo>
                    <a:lnTo>
                      <a:pt x="367" y="674"/>
                    </a:lnTo>
                    <a:lnTo>
                      <a:pt x="368" y="684"/>
                    </a:lnTo>
                    <a:lnTo>
                      <a:pt x="368" y="663"/>
                    </a:lnTo>
                    <a:lnTo>
                      <a:pt x="369" y="681"/>
                    </a:lnTo>
                    <a:lnTo>
                      <a:pt x="369" y="667"/>
                    </a:lnTo>
                    <a:lnTo>
                      <a:pt x="370" y="673"/>
                    </a:lnTo>
                    <a:lnTo>
                      <a:pt x="370" y="651"/>
                    </a:lnTo>
                    <a:lnTo>
                      <a:pt x="371" y="679"/>
                    </a:lnTo>
                    <a:lnTo>
                      <a:pt x="371" y="649"/>
                    </a:lnTo>
                    <a:lnTo>
                      <a:pt x="372" y="651"/>
                    </a:lnTo>
                    <a:lnTo>
                      <a:pt x="372" y="674"/>
                    </a:lnTo>
                    <a:lnTo>
                      <a:pt x="373" y="653"/>
                    </a:lnTo>
                    <a:lnTo>
                      <a:pt x="373" y="641"/>
                    </a:lnTo>
                    <a:lnTo>
                      <a:pt x="374" y="638"/>
                    </a:lnTo>
                    <a:lnTo>
                      <a:pt x="374" y="659"/>
                    </a:lnTo>
                    <a:lnTo>
                      <a:pt x="375" y="641"/>
                    </a:lnTo>
                    <a:lnTo>
                      <a:pt x="375" y="669"/>
                    </a:lnTo>
                    <a:lnTo>
                      <a:pt x="376" y="665"/>
                    </a:lnTo>
                    <a:lnTo>
                      <a:pt x="376" y="644"/>
                    </a:lnTo>
                    <a:lnTo>
                      <a:pt x="377" y="658"/>
                    </a:lnTo>
                    <a:lnTo>
                      <a:pt x="377" y="649"/>
                    </a:lnTo>
                    <a:lnTo>
                      <a:pt x="378" y="635"/>
                    </a:lnTo>
                    <a:lnTo>
                      <a:pt x="378" y="672"/>
                    </a:lnTo>
                    <a:lnTo>
                      <a:pt x="379" y="663"/>
                    </a:lnTo>
                    <a:lnTo>
                      <a:pt x="379" y="621"/>
                    </a:lnTo>
                    <a:lnTo>
                      <a:pt x="380" y="660"/>
                    </a:lnTo>
                    <a:lnTo>
                      <a:pt x="380" y="618"/>
                    </a:lnTo>
                    <a:lnTo>
                      <a:pt x="381" y="668"/>
                    </a:lnTo>
                    <a:lnTo>
                      <a:pt x="381" y="630"/>
                    </a:lnTo>
                    <a:lnTo>
                      <a:pt x="382" y="618"/>
                    </a:lnTo>
                    <a:lnTo>
                      <a:pt x="382" y="665"/>
                    </a:lnTo>
                    <a:lnTo>
                      <a:pt x="383" y="662"/>
                    </a:lnTo>
                    <a:lnTo>
                      <a:pt x="383" y="650"/>
                    </a:lnTo>
                    <a:lnTo>
                      <a:pt x="384" y="659"/>
                    </a:lnTo>
                    <a:lnTo>
                      <a:pt x="384" y="637"/>
                    </a:lnTo>
                    <a:lnTo>
                      <a:pt x="385" y="661"/>
                    </a:lnTo>
                    <a:lnTo>
                      <a:pt x="385" y="627"/>
                    </a:lnTo>
                    <a:lnTo>
                      <a:pt x="386" y="639"/>
                    </a:lnTo>
                    <a:lnTo>
                      <a:pt x="386" y="655"/>
                    </a:lnTo>
                    <a:lnTo>
                      <a:pt x="387" y="631"/>
                    </a:lnTo>
                    <a:lnTo>
                      <a:pt x="387" y="657"/>
                    </a:lnTo>
                    <a:lnTo>
                      <a:pt x="388" y="659"/>
                    </a:lnTo>
                    <a:lnTo>
                      <a:pt x="388" y="641"/>
                    </a:lnTo>
                    <a:lnTo>
                      <a:pt x="389" y="646"/>
                    </a:lnTo>
                    <a:lnTo>
                      <a:pt x="389" y="622"/>
                    </a:lnTo>
                    <a:lnTo>
                      <a:pt x="390" y="662"/>
                    </a:lnTo>
                    <a:lnTo>
                      <a:pt x="390" y="607"/>
                    </a:lnTo>
                    <a:lnTo>
                      <a:pt x="391" y="652"/>
                    </a:lnTo>
                    <a:lnTo>
                      <a:pt x="391" y="616"/>
                    </a:lnTo>
                    <a:lnTo>
                      <a:pt x="392" y="651"/>
                    </a:lnTo>
                    <a:lnTo>
                      <a:pt x="392" y="618"/>
                    </a:lnTo>
                    <a:lnTo>
                      <a:pt x="393" y="654"/>
                    </a:lnTo>
                    <a:lnTo>
                      <a:pt x="393" y="616"/>
                    </a:lnTo>
                    <a:lnTo>
                      <a:pt x="394" y="601"/>
                    </a:lnTo>
                    <a:lnTo>
                      <a:pt x="394" y="629"/>
                    </a:lnTo>
                    <a:lnTo>
                      <a:pt x="395" y="605"/>
                    </a:lnTo>
                    <a:lnTo>
                      <a:pt x="395" y="622"/>
                    </a:lnTo>
                    <a:lnTo>
                      <a:pt x="396" y="644"/>
                    </a:lnTo>
                    <a:lnTo>
                      <a:pt x="396" y="576"/>
                    </a:lnTo>
                    <a:lnTo>
                      <a:pt x="397" y="579"/>
                    </a:lnTo>
                    <a:lnTo>
                      <a:pt x="397" y="635"/>
                    </a:lnTo>
                    <a:lnTo>
                      <a:pt x="398" y="621"/>
                    </a:lnTo>
                    <a:lnTo>
                      <a:pt x="398" y="617"/>
                    </a:lnTo>
                    <a:lnTo>
                      <a:pt x="399" y="628"/>
                    </a:lnTo>
                    <a:lnTo>
                      <a:pt x="399" y="594"/>
                    </a:lnTo>
                    <a:lnTo>
                      <a:pt x="400" y="563"/>
                    </a:lnTo>
                    <a:lnTo>
                      <a:pt x="400" y="631"/>
                    </a:lnTo>
                    <a:lnTo>
                      <a:pt x="401" y="577"/>
                    </a:lnTo>
                    <a:lnTo>
                      <a:pt x="401" y="606"/>
                    </a:lnTo>
                    <a:lnTo>
                      <a:pt x="402" y="622"/>
                    </a:lnTo>
                    <a:lnTo>
                      <a:pt x="402" y="586"/>
                    </a:lnTo>
                    <a:lnTo>
                      <a:pt x="403" y="616"/>
                    </a:lnTo>
                    <a:lnTo>
                      <a:pt x="403" y="583"/>
                    </a:lnTo>
                    <a:lnTo>
                      <a:pt x="404" y="623"/>
                    </a:lnTo>
                    <a:lnTo>
                      <a:pt x="404" y="591"/>
                    </a:lnTo>
                    <a:lnTo>
                      <a:pt x="405" y="635"/>
                    </a:lnTo>
                    <a:lnTo>
                      <a:pt x="405" y="587"/>
                    </a:lnTo>
                    <a:lnTo>
                      <a:pt x="406" y="607"/>
                    </a:lnTo>
                    <a:lnTo>
                      <a:pt x="406" y="638"/>
                    </a:lnTo>
                    <a:lnTo>
                      <a:pt x="407" y="610"/>
                    </a:lnTo>
                    <a:lnTo>
                      <a:pt x="407" y="634"/>
                    </a:lnTo>
                    <a:lnTo>
                      <a:pt x="408" y="626"/>
                    </a:lnTo>
                    <a:lnTo>
                      <a:pt x="408" y="642"/>
                    </a:lnTo>
                    <a:lnTo>
                      <a:pt x="409" y="616"/>
                    </a:lnTo>
                    <a:lnTo>
                      <a:pt x="409" y="661"/>
                    </a:lnTo>
                    <a:lnTo>
                      <a:pt x="410" y="645"/>
                    </a:lnTo>
                    <a:lnTo>
                      <a:pt x="410" y="624"/>
                    </a:lnTo>
                    <a:lnTo>
                      <a:pt x="411" y="643"/>
                    </a:lnTo>
                    <a:lnTo>
                      <a:pt x="411" y="608"/>
                    </a:lnTo>
                    <a:lnTo>
                      <a:pt x="412" y="662"/>
                    </a:lnTo>
                    <a:lnTo>
                      <a:pt x="412" y="618"/>
                    </a:lnTo>
                    <a:lnTo>
                      <a:pt x="413" y="645"/>
                    </a:lnTo>
                    <a:lnTo>
                      <a:pt x="413" y="624"/>
                    </a:lnTo>
                    <a:lnTo>
                      <a:pt x="414" y="601"/>
                    </a:lnTo>
                    <a:lnTo>
                      <a:pt x="414" y="646"/>
                    </a:lnTo>
                    <a:lnTo>
                      <a:pt x="415" y="610"/>
                    </a:lnTo>
                    <a:lnTo>
                      <a:pt x="415" y="648"/>
                    </a:lnTo>
                    <a:lnTo>
                      <a:pt x="416" y="623"/>
                    </a:lnTo>
                    <a:lnTo>
                      <a:pt x="416" y="600"/>
                    </a:lnTo>
                    <a:lnTo>
                      <a:pt x="417" y="613"/>
                    </a:lnTo>
                    <a:lnTo>
                      <a:pt x="417" y="638"/>
                    </a:lnTo>
                    <a:lnTo>
                      <a:pt x="418" y="618"/>
                    </a:lnTo>
                    <a:lnTo>
                      <a:pt x="418" y="584"/>
                    </a:lnTo>
                    <a:lnTo>
                      <a:pt x="419" y="568"/>
                    </a:lnTo>
                    <a:lnTo>
                      <a:pt x="419" y="598"/>
                    </a:lnTo>
                    <a:lnTo>
                      <a:pt x="420" y="606"/>
                    </a:lnTo>
                    <a:lnTo>
                      <a:pt x="420" y="571"/>
                    </a:lnTo>
                    <a:lnTo>
                      <a:pt x="421" y="606"/>
                    </a:lnTo>
                    <a:lnTo>
                      <a:pt x="421" y="531"/>
                    </a:lnTo>
                    <a:lnTo>
                      <a:pt x="422" y="538"/>
                    </a:lnTo>
                    <a:lnTo>
                      <a:pt x="422" y="600"/>
                    </a:lnTo>
                    <a:lnTo>
                      <a:pt x="423" y="611"/>
                    </a:lnTo>
                    <a:lnTo>
                      <a:pt x="423" y="506"/>
                    </a:lnTo>
                    <a:lnTo>
                      <a:pt x="424" y="525"/>
                    </a:lnTo>
                    <a:lnTo>
                      <a:pt x="424" y="571"/>
                    </a:lnTo>
                    <a:lnTo>
                      <a:pt x="425" y="597"/>
                    </a:lnTo>
                    <a:lnTo>
                      <a:pt x="425" y="486"/>
                    </a:lnTo>
                    <a:lnTo>
                      <a:pt x="426" y="556"/>
                    </a:lnTo>
                    <a:lnTo>
                      <a:pt x="426" y="491"/>
                    </a:lnTo>
                    <a:lnTo>
                      <a:pt x="427" y="585"/>
                    </a:lnTo>
                    <a:lnTo>
                      <a:pt x="427" y="513"/>
                    </a:lnTo>
                    <a:lnTo>
                      <a:pt x="428" y="610"/>
                    </a:lnTo>
                    <a:lnTo>
                      <a:pt x="428" y="528"/>
                    </a:lnTo>
                    <a:lnTo>
                      <a:pt x="429" y="554"/>
                    </a:lnTo>
                    <a:lnTo>
                      <a:pt x="429" y="491"/>
                    </a:lnTo>
                    <a:lnTo>
                      <a:pt x="430" y="576"/>
                    </a:lnTo>
                    <a:lnTo>
                      <a:pt x="430" y="492"/>
                    </a:lnTo>
                    <a:lnTo>
                      <a:pt x="431" y="503"/>
                    </a:lnTo>
                    <a:lnTo>
                      <a:pt x="431" y="470"/>
                    </a:lnTo>
                    <a:lnTo>
                      <a:pt x="432" y="522"/>
                    </a:lnTo>
                    <a:lnTo>
                      <a:pt x="432" y="459"/>
                    </a:lnTo>
                    <a:lnTo>
                      <a:pt x="433" y="464"/>
                    </a:lnTo>
                    <a:lnTo>
                      <a:pt x="433" y="409"/>
                    </a:lnTo>
                    <a:lnTo>
                      <a:pt x="434" y="373"/>
                    </a:lnTo>
                    <a:lnTo>
                      <a:pt x="434" y="440"/>
                    </a:lnTo>
                    <a:lnTo>
                      <a:pt x="435" y="348"/>
                    </a:lnTo>
                    <a:lnTo>
                      <a:pt x="435" y="483"/>
                    </a:lnTo>
                    <a:lnTo>
                      <a:pt x="436" y="334"/>
                    </a:lnTo>
                    <a:lnTo>
                      <a:pt x="436" y="521"/>
                    </a:lnTo>
                    <a:lnTo>
                      <a:pt x="437" y="414"/>
                    </a:lnTo>
                    <a:lnTo>
                      <a:pt x="437" y="501"/>
                    </a:lnTo>
                    <a:lnTo>
                      <a:pt x="438" y="462"/>
                    </a:lnTo>
                    <a:lnTo>
                      <a:pt x="438" y="558"/>
                    </a:lnTo>
                    <a:lnTo>
                      <a:pt x="439" y="546"/>
                    </a:lnTo>
                    <a:lnTo>
                      <a:pt x="439" y="589"/>
                    </a:lnTo>
                    <a:lnTo>
                      <a:pt x="440" y="590"/>
                    </a:lnTo>
                    <a:lnTo>
                      <a:pt x="440" y="654"/>
                    </a:lnTo>
                    <a:lnTo>
                      <a:pt x="441" y="653"/>
                    </a:lnTo>
                    <a:lnTo>
                      <a:pt x="441" y="676"/>
                    </a:lnTo>
                    <a:lnTo>
                      <a:pt x="442" y="693"/>
                    </a:lnTo>
                    <a:lnTo>
                      <a:pt x="442" y="706"/>
                    </a:lnTo>
                    <a:lnTo>
                      <a:pt x="443" y="704"/>
                    </a:lnTo>
                    <a:lnTo>
                      <a:pt x="443" y="690"/>
                    </a:lnTo>
                    <a:lnTo>
                      <a:pt x="444" y="691"/>
                    </a:lnTo>
                    <a:lnTo>
                      <a:pt x="444" y="670"/>
                    </a:lnTo>
                    <a:lnTo>
                      <a:pt x="445" y="667"/>
                    </a:lnTo>
                    <a:lnTo>
                      <a:pt x="445" y="649"/>
                    </a:lnTo>
                    <a:lnTo>
                      <a:pt x="446" y="658"/>
                    </a:lnTo>
                    <a:lnTo>
                      <a:pt x="446" y="631"/>
                    </a:lnTo>
                    <a:lnTo>
                      <a:pt x="447" y="624"/>
                    </a:lnTo>
                    <a:lnTo>
                      <a:pt x="447" y="637"/>
                    </a:lnTo>
                    <a:lnTo>
                      <a:pt x="448" y="605"/>
                    </a:lnTo>
                    <a:lnTo>
                      <a:pt x="448" y="643"/>
                    </a:lnTo>
                    <a:lnTo>
                      <a:pt x="449" y="630"/>
                    </a:lnTo>
                    <a:lnTo>
                      <a:pt x="449" y="607"/>
                    </a:lnTo>
                    <a:lnTo>
                      <a:pt x="450" y="626"/>
                    </a:lnTo>
                    <a:lnTo>
                      <a:pt x="450" y="604"/>
                    </a:lnTo>
                    <a:lnTo>
                      <a:pt x="451" y="626"/>
                    </a:lnTo>
                    <a:lnTo>
                      <a:pt x="451" y="604"/>
                    </a:lnTo>
                    <a:lnTo>
                      <a:pt x="452" y="602"/>
                    </a:lnTo>
                    <a:lnTo>
                      <a:pt x="452" y="553"/>
                    </a:lnTo>
                    <a:lnTo>
                      <a:pt x="453" y="537"/>
                    </a:lnTo>
                    <a:lnTo>
                      <a:pt x="453" y="520"/>
                    </a:lnTo>
                    <a:lnTo>
                      <a:pt x="454" y="497"/>
                    </a:lnTo>
                    <a:lnTo>
                      <a:pt x="454" y="453"/>
                    </a:lnTo>
                    <a:lnTo>
                      <a:pt x="455" y="449"/>
                    </a:lnTo>
                    <a:lnTo>
                      <a:pt x="455" y="411"/>
                    </a:lnTo>
                    <a:lnTo>
                      <a:pt x="456" y="342"/>
                    </a:lnTo>
                    <a:lnTo>
                      <a:pt x="456" y="418"/>
                    </a:lnTo>
                    <a:lnTo>
                      <a:pt x="457" y="395"/>
                    </a:lnTo>
                    <a:lnTo>
                      <a:pt x="457" y="363"/>
                    </a:lnTo>
                    <a:lnTo>
                      <a:pt x="458" y="325"/>
                    </a:lnTo>
                    <a:lnTo>
                      <a:pt x="458" y="374"/>
                    </a:lnTo>
                    <a:lnTo>
                      <a:pt x="459" y="374"/>
                    </a:lnTo>
                    <a:lnTo>
                      <a:pt x="459" y="290"/>
                    </a:lnTo>
                    <a:lnTo>
                      <a:pt x="460" y="259"/>
                    </a:lnTo>
                    <a:lnTo>
                      <a:pt x="460" y="326"/>
                    </a:lnTo>
                    <a:lnTo>
                      <a:pt x="461" y="288"/>
                    </a:lnTo>
                    <a:lnTo>
                      <a:pt x="461" y="327"/>
                    </a:lnTo>
                    <a:lnTo>
                      <a:pt x="462" y="349"/>
                    </a:lnTo>
                    <a:lnTo>
                      <a:pt x="462" y="273"/>
                    </a:lnTo>
                    <a:lnTo>
                      <a:pt x="463" y="273"/>
                    </a:lnTo>
                    <a:lnTo>
                      <a:pt x="463" y="321"/>
                    </a:lnTo>
                    <a:lnTo>
                      <a:pt x="464" y="287"/>
                    </a:lnTo>
                    <a:lnTo>
                      <a:pt x="464" y="345"/>
                    </a:lnTo>
                    <a:lnTo>
                      <a:pt x="465" y="236"/>
                    </a:lnTo>
                    <a:lnTo>
                      <a:pt x="465" y="282"/>
                    </a:lnTo>
                    <a:lnTo>
                      <a:pt x="466" y="269"/>
                    </a:lnTo>
                    <a:lnTo>
                      <a:pt x="466" y="203"/>
                    </a:lnTo>
                    <a:lnTo>
                      <a:pt x="467" y="251"/>
                    </a:lnTo>
                    <a:lnTo>
                      <a:pt x="467" y="278"/>
                    </a:lnTo>
                    <a:lnTo>
                      <a:pt x="468" y="284"/>
                    </a:lnTo>
                    <a:lnTo>
                      <a:pt x="468" y="212"/>
                    </a:lnTo>
                    <a:lnTo>
                      <a:pt x="469" y="203"/>
                    </a:lnTo>
                    <a:lnTo>
                      <a:pt x="469" y="273"/>
                    </a:lnTo>
                    <a:lnTo>
                      <a:pt x="470" y="271"/>
                    </a:lnTo>
                    <a:lnTo>
                      <a:pt x="470" y="211"/>
                    </a:lnTo>
                    <a:lnTo>
                      <a:pt x="471" y="274"/>
                    </a:lnTo>
                    <a:lnTo>
                      <a:pt x="471" y="170"/>
                    </a:lnTo>
                    <a:lnTo>
                      <a:pt x="472" y="154"/>
                    </a:lnTo>
                    <a:lnTo>
                      <a:pt x="472" y="273"/>
                    </a:lnTo>
                    <a:lnTo>
                      <a:pt x="473" y="206"/>
                    </a:lnTo>
                    <a:lnTo>
                      <a:pt x="473" y="253"/>
                    </a:lnTo>
                    <a:lnTo>
                      <a:pt x="474" y="214"/>
                    </a:lnTo>
                    <a:lnTo>
                      <a:pt x="474" y="283"/>
                    </a:lnTo>
                    <a:lnTo>
                      <a:pt x="475" y="254"/>
                    </a:lnTo>
                    <a:lnTo>
                      <a:pt x="475" y="336"/>
                    </a:lnTo>
                    <a:lnTo>
                      <a:pt x="476" y="270"/>
                    </a:lnTo>
                    <a:lnTo>
                      <a:pt x="476" y="331"/>
                    </a:lnTo>
                    <a:lnTo>
                      <a:pt x="477" y="325"/>
                    </a:lnTo>
                    <a:lnTo>
                      <a:pt x="477" y="391"/>
                    </a:lnTo>
                    <a:lnTo>
                      <a:pt x="478" y="369"/>
                    </a:lnTo>
                    <a:lnTo>
                      <a:pt x="478" y="427"/>
                    </a:lnTo>
                    <a:lnTo>
                      <a:pt x="479" y="443"/>
                    </a:lnTo>
                    <a:lnTo>
                      <a:pt x="479" y="483"/>
                    </a:lnTo>
                    <a:lnTo>
                      <a:pt x="480" y="479"/>
                    </a:lnTo>
                    <a:lnTo>
                      <a:pt x="480" y="517"/>
                    </a:lnTo>
                    <a:lnTo>
                      <a:pt x="481" y="525"/>
                    </a:lnTo>
                    <a:lnTo>
                      <a:pt x="481" y="577"/>
                    </a:lnTo>
                    <a:lnTo>
                      <a:pt x="482" y="581"/>
                    </a:lnTo>
                    <a:lnTo>
                      <a:pt x="482" y="622"/>
                    </a:lnTo>
                    <a:lnTo>
                      <a:pt x="483" y="624"/>
                    </a:lnTo>
                    <a:lnTo>
                      <a:pt x="483" y="653"/>
                    </a:lnTo>
                    <a:lnTo>
                      <a:pt x="484" y="646"/>
                    </a:lnTo>
                    <a:lnTo>
                      <a:pt x="484" y="631"/>
                    </a:lnTo>
                    <a:lnTo>
                      <a:pt x="485" y="623"/>
                    </a:lnTo>
                    <a:lnTo>
                      <a:pt x="485" y="632"/>
                    </a:lnTo>
                    <a:lnTo>
                      <a:pt x="486" y="647"/>
                    </a:lnTo>
                    <a:lnTo>
                      <a:pt x="486" y="635"/>
                    </a:lnTo>
                    <a:lnTo>
                      <a:pt x="487" y="650"/>
                    </a:lnTo>
                    <a:lnTo>
                      <a:pt x="487" y="635"/>
                    </a:lnTo>
                    <a:lnTo>
                      <a:pt x="488" y="638"/>
                    </a:lnTo>
                    <a:lnTo>
                      <a:pt x="488" y="644"/>
                    </a:lnTo>
                    <a:lnTo>
                      <a:pt x="489" y="660"/>
                    </a:lnTo>
                    <a:lnTo>
                      <a:pt x="489" y="626"/>
                    </a:lnTo>
                    <a:lnTo>
                      <a:pt x="490" y="645"/>
                    </a:lnTo>
                    <a:lnTo>
                      <a:pt x="490" y="630"/>
                    </a:lnTo>
                    <a:lnTo>
                      <a:pt x="491" y="618"/>
                    </a:lnTo>
                    <a:lnTo>
                      <a:pt x="491" y="610"/>
                    </a:lnTo>
                    <a:lnTo>
                      <a:pt x="492" y="622"/>
                    </a:lnTo>
                    <a:lnTo>
                      <a:pt x="492" y="582"/>
                    </a:lnTo>
                    <a:lnTo>
                      <a:pt x="493" y="605"/>
                    </a:lnTo>
                    <a:lnTo>
                      <a:pt x="493" y="576"/>
                    </a:lnTo>
                    <a:lnTo>
                      <a:pt x="494" y="568"/>
                    </a:lnTo>
                    <a:lnTo>
                      <a:pt x="494" y="606"/>
                    </a:lnTo>
                    <a:lnTo>
                      <a:pt x="495" y="598"/>
                    </a:lnTo>
                    <a:lnTo>
                      <a:pt x="495" y="572"/>
                    </a:lnTo>
                    <a:lnTo>
                      <a:pt x="496" y="577"/>
                    </a:lnTo>
                    <a:lnTo>
                      <a:pt x="496" y="595"/>
                    </a:lnTo>
                    <a:lnTo>
                      <a:pt x="497" y="570"/>
                    </a:lnTo>
                    <a:lnTo>
                      <a:pt x="497" y="605"/>
                    </a:lnTo>
                    <a:lnTo>
                      <a:pt x="498" y="600"/>
                    </a:lnTo>
                    <a:lnTo>
                      <a:pt x="498" y="595"/>
                    </a:lnTo>
                    <a:lnTo>
                      <a:pt x="499" y="588"/>
                    </a:lnTo>
                    <a:lnTo>
                      <a:pt x="499" y="611"/>
                    </a:lnTo>
                    <a:lnTo>
                      <a:pt x="500" y="619"/>
                    </a:lnTo>
                    <a:lnTo>
                      <a:pt x="500" y="637"/>
                    </a:lnTo>
                    <a:lnTo>
                      <a:pt x="501" y="631"/>
                    </a:lnTo>
                    <a:lnTo>
                      <a:pt x="501" y="624"/>
                    </a:lnTo>
                    <a:lnTo>
                      <a:pt x="502" y="645"/>
                    </a:lnTo>
                    <a:lnTo>
                      <a:pt x="502" y="634"/>
                    </a:lnTo>
                    <a:lnTo>
                      <a:pt x="503" y="633"/>
                    </a:lnTo>
                    <a:lnTo>
                      <a:pt x="503" y="655"/>
                    </a:lnTo>
                    <a:lnTo>
                      <a:pt x="504" y="650"/>
                    </a:lnTo>
                    <a:lnTo>
                      <a:pt x="504" y="640"/>
                    </a:lnTo>
                    <a:lnTo>
                      <a:pt x="505" y="639"/>
                    </a:lnTo>
                    <a:lnTo>
                      <a:pt x="505" y="660"/>
                    </a:lnTo>
                    <a:lnTo>
                      <a:pt x="506" y="655"/>
                    </a:lnTo>
                    <a:lnTo>
                      <a:pt x="506" y="674"/>
                    </a:lnTo>
                    <a:lnTo>
                      <a:pt x="507" y="674"/>
                    </a:lnTo>
                    <a:lnTo>
                      <a:pt x="507" y="694"/>
                    </a:lnTo>
                    <a:lnTo>
                      <a:pt x="508" y="699"/>
                    </a:lnTo>
                    <a:lnTo>
                      <a:pt x="508" y="716"/>
                    </a:lnTo>
                    <a:lnTo>
                      <a:pt x="509" y="717"/>
                    </a:lnTo>
                    <a:lnTo>
                      <a:pt x="509" y="731"/>
                    </a:lnTo>
                    <a:lnTo>
                      <a:pt x="510" y="733"/>
                    </a:lnTo>
                    <a:lnTo>
                      <a:pt x="510" y="738"/>
                    </a:lnTo>
                    <a:lnTo>
                      <a:pt x="511" y="741"/>
                    </a:lnTo>
                    <a:lnTo>
                      <a:pt x="511" y="746"/>
                    </a:lnTo>
                    <a:lnTo>
                      <a:pt x="512" y="748"/>
                    </a:lnTo>
                    <a:lnTo>
                      <a:pt x="512" y="747"/>
                    </a:lnTo>
                    <a:lnTo>
                      <a:pt x="513" y="747"/>
                    </a:lnTo>
                    <a:lnTo>
                      <a:pt x="513" y="748"/>
                    </a:lnTo>
                    <a:lnTo>
                      <a:pt x="514" y="751"/>
                    </a:lnTo>
                    <a:lnTo>
                      <a:pt x="514" y="746"/>
                    </a:lnTo>
                    <a:lnTo>
                      <a:pt x="515" y="745"/>
                    </a:lnTo>
                    <a:lnTo>
                      <a:pt x="515" y="734"/>
                    </a:lnTo>
                    <a:lnTo>
                      <a:pt x="516" y="731"/>
                    </a:lnTo>
                    <a:lnTo>
                      <a:pt x="516" y="720"/>
                    </a:lnTo>
                    <a:lnTo>
                      <a:pt x="517" y="718"/>
                    </a:lnTo>
                    <a:lnTo>
                      <a:pt x="517" y="710"/>
                    </a:lnTo>
                    <a:lnTo>
                      <a:pt x="518" y="704"/>
                    </a:lnTo>
                    <a:lnTo>
                      <a:pt x="518" y="709"/>
                    </a:lnTo>
                    <a:lnTo>
                      <a:pt x="519" y="707"/>
                    </a:lnTo>
                    <a:lnTo>
                      <a:pt x="519" y="703"/>
                    </a:lnTo>
                    <a:lnTo>
                      <a:pt x="520" y="704"/>
                    </a:lnTo>
                    <a:lnTo>
                      <a:pt x="520" y="687"/>
                    </a:lnTo>
                    <a:lnTo>
                      <a:pt x="521" y="689"/>
                    </a:lnTo>
                    <a:lnTo>
                      <a:pt x="521" y="670"/>
                    </a:lnTo>
                    <a:lnTo>
                      <a:pt x="522" y="667"/>
                    </a:lnTo>
                    <a:lnTo>
                      <a:pt x="522" y="683"/>
                    </a:lnTo>
                    <a:lnTo>
                      <a:pt x="523" y="679"/>
                    </a:lnTo>
                    <a:lnTo>
                      <a:pt x="523" y="637"/>
                    </a:lnTo>
                    <a:lnTo>
                      <a:pt x="524" y="623"/>
                    </a:lnTo>
                    <a:lnTo>
                      <a:pt x="524" y="558"/>
                    </a:lnTo>
                    <a:lnTo>
                      <a:pt x="525" y="542"/>
                    </a:lnTo>
                    <a:lnTo>
                      <a:pt x="525" y="514"/>
                    </a:lnTo>
                    <a:lnTo>
                      <a:pt x="526" y="520"/>
                    </a:lnTo>
                    <a:lnTo>
                      <a:pt x="526" y="575"/>
                    </a:lnTo>
                    <a:lnTo>
                      <a:pt x="527" y="579"/>
                    </a:lnTo>
                    <a:lnTo>
                      <a:pt x="527" y="614"/>
                    </a:lnTo>
                    <a:lnTo>
                      <a:pt x="528" y="633"/>
                    </a:lnTo>
                    <a:lnTo>
                      <a:pt x="528" y="596"/>
                    </a:lnTo>
                    <a:lnTo>
                      <a:pt x="529" y="605"/>
                    </a:lnTo>
                    <a:lnTo>
                      <a:pt x="529" y="552"/>
                    </a:lnTo>
                    <a:lnTo>
                      <a:pt x="530" y="568"/>
                    </a:lnTo>
                    <a:lnTo>
                      <a:pt x="530" y="521"/>
                    </a:lnTo>
                    <a:lnTo>
                      <a:pt x="531" y="511"/>
                    </a:lnTo>
                    <a:lnTo>
                      <a:pt x="531" y="556"/>
                    </a:lnTo>
                    <a:lnTo>
                      <a:pt x="532" y="553"/>
                    </a:lnTo>
                    <a:lnTo>
                      <a:pt x="532" y="536"/>
                    </a:lnTo>
                    <a:lnTo>
                      <a:pt x="533" y="510"/>
                    </a:lnTo>
                    <a:lnTo>
                      <a:pt x="533" y="550"/>
                    </a:lnTo>
                    <a:lnTo>
                      <a:pt x="534" y="501"/>
                    </a:lnTo>
                    <a:lnTo>
                      <a:pt x="534" y="537"/>
                    </a:lnTo>
                    <a:lnTo>
                      <a:pt x="535" y="514"/>
                    </a:lnTo>
                    <a:lnTo>
                      <a:pt x="535" y="561"/>
                    </a:lnTo>
                    <a:lnTo>
                      <a:pt x="536" y="556"/>
                    </a:lnTo>
                    <a:lnTo>
                      <a:pt x="536" y="528"/>
                    </a:lnTo>
                    <a:lnTo>
                      <a:pt x="537" y="555"/>
                    </a:lnTo>
                    <a:lnTo>
                      <a:pt x="537" y="542"/>
                    </a:lnTo>
                    <a:lnTo>
                      <a:pt x="538" y="573"/>
                    </a:lnTo>
                    <a:lnTo>
                      <a:pt x="538" y="553"/>
                    </a:lnTo>
                    <a:lnTo>
                      <a:pt x="539" y="552"/>
                    </a:lnTo>
                    <a:lnTo>
                      <a:pt x="539" y="572"/>
                    </a:lnTo>
                    <a:lnTo>
                      <a:pt x="540" y="529"/>
                    </a:lnTo>
                    <a:lnTo>
                      <a:pt x="540" y="576"/>
                    </a:lnTo>
                    <a:lnTo>
                      <a:pt x="541" y="550"/>
                    </a:lnTo>
                    <a:lnTo>
                      <a:pt x="541" y="591"/>
                    </a:lnTo>
                    <a:lnTo>
                      <a:pt x="542" y="595"/>
                    </a:lnTo>
                    <a:lnTo>
                      <a:pt x="542" y="572"/>
                    </a:lnTo>
                    <a:lnTo>
                      <a:pt x="543" y="578"/>
                    </a:lnTo>
                    <a:lnTo>
                      <a:pt x="543" y="584"/>
                    </a:lnTo>
                    <a:lnTo>
                      <a:pt x="544" y="598"/>
                    </a:lnTo>
                    <a:lnTo>
                      <a:pt x="544" y="582"/>
                    </a:lnTo>
                    <a:lnTo>
                      <a:pt x="545" y="578"/>
                    </a:lnTo>
                    <a:lnTo>
                      <a:pt x="545" y="600"/>
                    </a:lnTo>
                    <a:lnTo>
                      <a:pt x="546" y="602"/>
                    </a:lnTo>
                    <a:lnTo>
                      <a:pt x="546" y="580"/>
                    </a:lnTo>
                    <a:lnTo>
                      <a:pt x="547" y="572"/>
                    </a:lnTo>
                    <a:lnTo>
                      <a:pt x="547" y="618"/>
                    </a:lnTo>
                    <a:lnTo>
                      <a:pt x="548" y="603"/>
                    </a:lnTo>
                    <a:lnTo>
                      <a:pt x="548" y="567"/>
                    </a:lnTo>
                    <a:lnTo>
                      <a:pt x="549" y="591"/>
                    </a:lnTo>
                    <a:lnTo>
                      <a:pt x="549" y="619"/>
                    </a:lnTo>
                    <a:lnTo>
                      <a:pt x="550" y="619"/>
                    </a:lnTo>
                    <a:lnTo>
                      <a:pt x="550" y="590"/>
                    </a:lnTo>
                    <a:lnTo>
                      <a:pt x="551" y="584"/>
                    </a:lnTo>
                    <a:lnTo>
                      <a:pt x="551" y="625"/>
                    </a:lnTo>
                    <a:lnTo>
                      <a:pt x="552" y="577"/>
                    </a:lnTo>
                    <a:lnTo>
                      <a:pt x="552" y="611"/>
                    </a:lnTo>
                    <a:lnTo>
                      <a:pt x="553" y="588"/>
                    </a:lnTo>
                    <a:lnTo>
                      <a:pt x="553" y="616"/>
                    </a:lnTo>
                    <a:lnTo>
                      <a:pt x="554" y="583"/>
                    </a:lnTo>
                    <a:lnTo>
                      <a:pt x="554" y="620"/>
                    </a:lnTo>
                    <a:lnTo>
                      <a:pt x="555" y="620"/>
                    </a:lnTo>
                    <a:lnTo>
                      <a:pt x="555" y="599"/>
                    </a:lnTo>
                    <a:lnTo>
                      <a:pt x="556" y="637"/>
                    </a:lnTo>
                    <a:lnTo>
                      <a:pt x="556" y="599"/>
                    </a:lnTo>
                    <a:lnTo>
                      <a:pt x="557" y="594"/>
                    </a:lnTo>
                    <a:lnTo>
                      <a:pt x="557" y="617"/>
                    </a:lnTo>
                    <a:lnTo>
                      <a:pt x="558" y="624"/>
                    </a:lnTo>
                    <a:lnTo>
                      <a:pt x="558" y="605"/>
                    </a:lnTo>
                    <a:lnTo>
                      <a:pt x="559" y="620"/>
                    </a:lnTo>
                    <a:lnTo>
                      <a:pt x="559" y="614"/>
                    </a:lnTo>
                    <a:lnTo>
                      <a:pt x="560" y="628"/>
                    </a:lnTo>
                    <a:lnTo>
                      <a:pt x="560" y="613"/>
                    </a:lnTo>
                    <a:lnTo>
                      <a:pt x="561" y="614"/>
                    </a:lnTo>
                    <a:lnTo>
                      <a:pt x="561" y="629"/>
                    </a:lnTo>
                    <a:lnTo>
                      <a:pt x="562" y="617"/>
                    </a:lnTo>
                    <a:lnTo>
                      <a:pt x="562" y="650"/>
                    </a:lnTo>
                    <a:lnTo>
                      <a:pt x="563" y="629"/>
                    </a:lnTo>
                    <a:lnTo>
                      <a:pt x="563" y="645"/>
                    </a:lnTo>
                    <a:lnTo>
                      <a:pt x="564" y="651"/>
                    </a:lnTo>
                    <a:lnTo>
                      <a:pt x="564" y="622"/>
                    </a:lnTo>
                    <a:lnTo>
                      <a:pt x="565" y="632"/>
                    </a:lnTo>
                    <a:lnTo>
                      <a:pt x="565" y="643"/>
                    </a:lnTo>
                    <a:lnTo>
                      <a:pt x="566" y="625"/>
                    </a:lnTo>
                    <a:lnTo>
                      <a:pt x="566" y="645"/>
                    </a:lnTo>
                    <a:lnTo>
                      <a:pt x="567" y="616"/>
                    </a:lnTo>
                    <a:lnTo>
                      <a:pt x="567" y="646"/>
                    </a:lnTo>
                    <a:lnTo>
                      <a:pt x="568" y="641"/>
                    </a:lnTo>
                    <a:lnTo>
                      <a:pt x="568" y="603"/>
                    </a:lnTo>
                    <a:lnTo>
                      <a:pt x="569" y="622"/>
                    </a:lnTo>
                    <a:lnTo>
                      <a:pt x="569" y="642"/>
                    </a:lnTo>
                    <a:lnTo>
                      <a:pt x="570" y="625"/>
                    </a:lnTo>
                    <a:lnTo>
                      <a:pt x="570" y="641"/>
                    </a:lnTo>
                    <a:lnTo>
                      <a:pt x="571" y="640"/>
                    </a:lnTo>
                    <a:lnTo>
                      <a:pt x="571" y="625"/>
                    </a:lnTo>
                    <a:lnTo>
                      <a:pt x="572" y="630"/>
                    </a:lnTo>
                    <a:lnTo>
                      <a:pt x="572" y="616"/>
                    </a:lnTo>
                    <a:lnTo>
                      <a:pt x="573" y="640"/>
                    </a:lnTo>
                    <a:lnTo>
                      <a:pt x="573" y="611"/>
                    </a:lnTo>
                    <a:lnTo>
                      <a:pt x="574" y="612"/>
                    </a:lnTo>
                    <a:lnTo>
                      <a:pt x="574" y="632"/>
                    </a:lnTo>
                    <a:lnTo>
                      <a:pt x="575" y="619"/>
                    </a:lnTo>
                    <a:lnTo>
                      <a:pt x="575" y="630"/>
                    </a:lnTo>
                    <a:lnTo>
                      <a:pt x="576" y="606"/>
                    </a:lnTo>
                    <a:lnTo>
                      <a:pt x="576" y="641"/>
                    </a:lnTo>
                    <a:lnTo>
                      <a:pt x="577" y="620"/>
                    </a:lnTo>
                    <a:lnTo>
                      <a:pt x="577" y="649"/>
                    </a:lnTo>
                    <a:lnTo>
                      <a:pt x="578" y="636"/>
                    </a:lnTo>
                    <a:lnTo>
                      <a:pt x="578" y="668"/>
                    </a:lnTo>
                    <a:lnTo>
                      <a:pt x="579" y="663"/>
                    </a:lnTo>
                    <a:lnTo>
                      <a:pt x="579" y="689"/>
                    </a:lnTo>
                    <a:lnTo>
                      <a:pt x="580" y="694"/>
                    </a:lnTo>
                    <a:lnTo>
                      <a:pt x="580" y="714"/>
                    </a:lnTo>
                    <a:lnTo>
                      <a:pt x="581" y="719"/>
                    </a:lnTo>
                    <a:lnTo>
                      <a:pt x="581" y="727"/>
                    </a:lnTo>
                    <a:lnTo>
                      <a:pt x="582" y="729"/>
                    </a:lnTo>
                    <a:lnTo>
                      <a:pt x="582" y="735"/>
                    </a:lnTo>
                    <a:lnTo>
                      <a:pt x="583" y="738"/>
                    </a:lnTo>
                    <a:lnTo>
                      <a:pt x="583" y="743"/>
                    </a:lnTo>
                    <a:lnTo>
                      <a:pt x="584" y="744"/>
                    </a:lnTo>
                    <a:lnTo>
                      <a:pt x="584" y="748"/>
                    </a:lnTo>
                    <a:lnTo>
                      <a:pt x="585" y="745"/>
                    </a:lnTo>
                    <a:lnTo>
                      <a:pt x="585" y="749"/>
                    </a:lnTo>
                    <a:lnTo>
                      <a:pt x="586" y="748"/>
                    </a:lnTo>
                    <a:lnTo>
                      <a:pt x="586" y="750"/>
                    </a:lnTo>
                    <a:lnTo>
                      <a:pt x="587" y="750"/>
                    </a:lnTo>
                    <a:lnTo>
                      <a:pt x="587" y="747"/>
                    </a:lnTo>
                    <a:lnTo>
                      <a:pt x="588" y="753"/>
                    </a:lnTo>
                    <a:lnTo>
                      <a:pt x="588" y="750"/>
                    </a:lnTo>
                    <a:lnTo>
                      <a:pt x="589" y="752"/>
                    </a:lnTo>
                    <a:lnTo>
                      <a:pt x="589" y="751"/>
                    </a:lnTo>
                    <a:lnTo>
                      <a:pt x="590" y="752"/>
                    </a:lnTo>
                    <a:lnTo>
                      <a:pt x="590" y="753"/>
                    </a:lnTo>
                    <a:lnTo>
                      <a:pt x="591" y="752"/>
                    </a:lnTo>
                    <a:lnTo>
                      <a:pt x="591" y="753"/>
                    </a:lnTo>
                    <a:lnTo>
                      <a:pt x="592" y="751"/>
                    </a:lnTo>
                    <a:lnTo>
                      <a:pt x="592" y="754"/>
                    </a:lnTo>
                    <a:lnTo>
                      <a:pt x="593" y="755"/>
                    </a:lnTo>
                    <a:lnTo>
                      <a:pt x="593" y="746"/>
                    </a:lnTo>
                    <a:lnTo>
                      <a:pt x="594" y="742"/>
                    </a:lnTo>
                    <a:lnTo>
                      <a:pt x="594" y="726"/>
                    </a:lnTo>
                    <a:lnTo>
                      <a:pt x="595" y="718"/>
                    </a:lnTo>
                    <a:lnTo>
                      <a:pt x="595" y="700"/>
                    </a:lnTo>
                    <a:lnTo>
                      <a:pt x="596" y="691"/>
                    </a:lnTo>
                    <a:lnTo>
                      <a:pt x="596" y="663"/>
                    </a:lnTo>
                    <a:lnTo>
                      <a:pt x="597" y="648"/>
                    </a:lnTo>
                    <a:lnTo>
                      <a:pt x="597" y="599"/>
                    </a:lnTo>
                    <a:lnTo>
                      <a:pt x="598" y="598"/>
                    </a:lnTo>
                    <a:lnTo>
                      <a:pt x="598" y="552"/>
                    </a:lnTo>
                    <a:lnTo>
                      <a:pt x="599" y="522"/>
                    </a:lnTo>
                    <a:lnTo>
                      <a:pt x="599" y="478"/>
                    </a:lnTo>
                    <a:lnTo>
                      <a:pt x="600" y="493"/>
                    </a:lnTo>
                    <a:lnTo>
                      <a:pt x="600" y="466"/>
                    </a:lnTo>
                    <a:lnTo>
                      <a:pt x="601" y="461"/>
                    </a:lnTo>
                    <a:lnTo>
                      <a:pt x="601" y="412"/>
                    </a:lnTo>
                    <a:lnTo>
                      <a:pt x="602" y="456"/>
                    </a:lnTo>
                    <a:lnTo>
                      <a:pt x="602" y="433"/>
                    </a:lnTo>
                    <a:lnTo>
                      <a:pt x="603" y="404"/>
                    </a:lnTo>
                    <a:lnTo>
                      <a:pt x="603" y="423"/>
                    </a:lnTo>
                    <a:lnTo>
                      <a:pt x="604" y="381"/>
                    </a:lnTo>
                    <a:lnTo>
                      <a:pt x="604" y="413"/>
                    </a:lnTo>
                    <a:lnTo>
                      <a:pt x="605" y="400"/>
                    </a:lnTo>
                    <a:lnTo>
                      <a:pt x="605" y="501"/>
                    </a:lnTo>
                    <a:lnTo>
                      <a:pt x="606" y="501"/>
                    </a:lnTo>
                    <a:lnTo>
                      <a:pt x="606" y="554"/>
                    </a:lnTo>
                    <a:lnTo>
                      <a:pt x="607" y="577"/>
                    </a:lnTo>
                    <a:lnTo>
                      <a:pt x="607" y="615"/>
                    </a:lnTo>
                    <a:lnTo>
                      <a:pt x="608" y="631"/>
                    </a:lnTo>
                    <a:lnTo>
                      <a:pt x="608" y="646"/>
                    </a:lnTo>
                    <a:lnTo>
                      <a:pt x="609" y="635"/>
                    </a:lnTo>
                    <a:lnTo>
                      <a:pt x="609" y="647"/>
                    </a:lnTo>
                    <a:lnTo>
                      <a:pt x="610" y="642"/>
                    </a:lnTo>
                    <a:lnTo>
                      <a:pt x="610" y="650"/>
                    </a:lnTo>
                    <a:lnTo>
                      <a:pt x="611" y="669"/>
                    </a:lnTo>
                    <a:lnTo>
                      <a:pt x="611" y="655"/>
                    </a:lnTo>
                    <a:lnTo>
                      <a:pt x="612" y="643"/>
                    </a:lnTo>
                    <a:lnTo>
                      <a:pt x="612" y="664"/>
                    </a:lnTo>
                    <a:lnTo>
                      <a:pt x="613" y="650"/>
                    </a:lnTo>
                    <a:lnTo>
                      <a:pt x="613" y="673"/>
                    </a:lnTo>
                    <a:lnTo>
                      <a:pt x="614" y="660"/>
                    </a:lnTo>
                    <a:lnTo>
                      <a:pt x="614" y="688"/>
                    </a:lnTo>
                    <a:lnTo>
                      <a:pt x="615" y="696"/>
                    </a:lnTo>
                    <a:lnTo>
                      <a:pt x="615" y="718"/>
                    </a:lnTo>
                    <a:lnTo>
                      <a:pt x="616" y="719"/>
                    </a:lnTo>
                    <a:lnTo>
                      <a:pt x="616" y="735"/>
                    </a:lnTo>
                    <a:lnTo>
                      <a:pt x="617" y="737"/>
                    </a:lnTo>
                    <a:lnTo>
                      <a:pt x="617" y="743"/>
                    </a:lnTo>
                    <a:lnTo>
                      <a:pt x="618" y="745"/>
                    </a:lnTo>
                    <a:lnTo>
                      <a:pt x="618" y="751"/>
                    </a:lnTo>
                    <a:lnTo>
                      <a:pt x="619" y="753"/>
                    </a:lnTo>
                    <a:lnTo>
                      <a:pt x="619" y="754"/>
                    </a:lnTo>
                    <a:lnTo>
                      <a:pt x="620" y="754"/>
                    </a:lnTo>
                    <a:lnTo>
                      <a:pt x="620" y="755"/>
                    </a:lnTo>
                    <a:lnTo>
                      <a:pt x="621" y="754"/>
                    </a:lnTo>
                    <a:lnTo>
                      <a:pt x="621" y="755"/>
                    </a:lnTo>
                    <a:lnTo>
                      <a:pt x="622" y="755"/>
                    </a:lnTo>
                    <a:lnTo>
                      <a:pt x="622" y="748"/>
                    </a:lnTo>
                    <a:lnTo>
                      <a:pt x="623" y="743"/>
                    </a:lnTo>
                    <a:lnTo>
                      <a:pt x="623" y="724"/>
                    </a:lnTo>
                    <a:lnTo>
                      <a:pt x="624" y="712"/>
                    </a:lnTo>
                    <a:lnTo>
                      <a:pt x="624" y="672"/>
                    </a:lnTo>
                    <a:lnTo>
                      <a:pt x="625" y="672"/>
                    </a:lnTo>
                    <a:lnTo>
                      <a:pt x="625" y="614"/>
                    </a:lnTo>
                    <a:lnTo>
                      <a:pt x="626" y="610"/>
                    </a:lnTo>
                    <a:lnTo>
                      <a:pt x="626" y="590"/>
                    </a:lnTo>
                    <a:lnTo>
                      <a:pt x="627" y="578"/>
                    </a:lnTo>
                    <a:lnTo>
                      <a:pt x="627" y="601"/>
                    </a:lnTo>
                    <a:lnTo>
                      <a:pt x="628" y="587"/>
                    </a:lnTo>
                    <a:lnTo>
                      <a:pt x="628" y="626"/>
                    </a:lnTo>
                    <a:lnTo>
                      <a:pt x="629" y="647"/>
                    </a:lnTo>
                    <a:lnTo>
                      <a:pt x="629" y="668"/>
                    </a:lnTo>
                    <a:lnTo>
                      <a:pt x="630" y="682"/>
                    </a:lnTo>
                    <a:lnTo>
                      <a:pt x="630" y="701"/>
                    </a:lnTo>
                    <a:lnTo>
                      <a:pt x="631" y="709"/>
                    </a:lnTo>
                    <a:lnTo>
                      <a:pt x="631" y="722"/>
                    </a:lnTo>
                    <a:lnTo>
                      <a:pt x="632" y="725"/>
                    </a:lnTo>
                    <a:lnTo>
                      <a:pt x="632" y="732"/>
                    </a:lnTo>
                    <a:lnTo>
                      <a:pt x="633" y="736"/>
                    </a:lnTo>
                    <a:lnTo>
                      <a:pt x="633" y="742"/>
                    </a:lnTo>
                    <a:lnTo>
                      <a:pt x="634" y="743"/>
                    </a:lnTo>
                    <a:lnTo>
                      <a:pt x="634" y="746"/>
                    </a:lnTo>
                    <a:lnTo>
                      <a:pt x="635" y="747"/>
                    </a:lnTo>
                    <a:lnTo>
                      <a:pt x="635" y="750"/>
                    </a:lnTo>
                    <a:lnTo>
                      <a:pt x="636" y="750"/>
                    </a:lnTo>
                    <a:lnTo>
                      <a:pt x="636" y="752"/>
                    </a:lnTo>
                    <a:lnTo>
                      <a:pt x="637" y="752"/>
                    </a:lnTo>
                    <a:lnTo>
                      <a:pt x="637" y="754"/>
                    </a:lnTo>
                    <a:lnTo>
                      <a:pt x="638" y="755"/>
                    </a:lnTo>
                    <a:lnTo>
                      <a:pt x="638" y="746"/>
                    </a:lnTo>
                    <a:lnTo>
                      <a:pt x="639" y="743"/>
                    </a:lnTo>
                    <a:lnTo>
                      <a:pt x="639" y="736"/>
                    </a:lnTo>
                    <a:lnTo>
                      <a:pt x="640" y="731"/>
                    </a:lnTo>
                    <a:lnTo>
                      <a:pt x="640" y="728"/>
                    </a:lnTo>
                    <a:lnTo>
                      <a:pt x="641" y="727"/>
                    </a:lnTo>
                    <a:lnTo>
                      <a:pt x="641" y="696"/>
                    </a:lnTo>
                    <a:lnTo>
                      <a:pt x="642" y="685"/>
                    </a:lnTo>
                    <a:lnTo>
                      <a:pt x="642" y="607"/>
                    </a:lnTo>
                    <a:lnTo>
                      <a:pt x="643" y="593"/>
                    </a:lnTo>
                    <a:lnTo>
                      <a:pt x="643" y="489"/>
                    </a:lnTo>
                    <a:lnTo>
                      <a:pt x="644" y="483"/>
                    </a:lnTo>
                    <a:lnTo>
                      <a:pt x="644" y="362"/>
                    </a:lnTo>
                    <a:lnTo>
                      <a:pt x="645" y="377"/>
                    </a:lnTo>
                    <a:lnTo>
                      <a:pt x="645" y="294"/>
                    </a:lnTo>
                    <a:lnTo>
                      <a:pt x="646" y="330"/>
                    </a:lnTo>
                    <a:lnTo>
                      <a:pt x="646" y="227"/>
                    </a:lnTo>
                    <a:lnTo>
                      <a:pt x="647" y="307"/>
                    </a:lnTo>
                    <a:lnTo>
                      <a:pt x="647" y="253"/>
                    </a:lnTo>
                    <a:lnTo>
                      <a:pt x="648" y="267"/>
                    </a:lnTo>
                    <a:lnTo>
                      <a:pt x="648" y="366"/>
                    </a:lnTo>
                    <a:lnTo>
                      <a:pt x="649" y="343"/>
                    </a:lnTo>
                    <a:lnTo>
                      <a:pt x="649" y="436"/>
                    </a:lnTo>
                    <a:lnTo>
                      <a:pt x="650" y="471"/>
                    </a:lnTo>
                    <a:lnTo>
                      <a:pt x="650" y="553"/>
                    </a:lnTo>
                    <a:lnTo>
                      <a:pt x="651" y="577"/>
                    </a:lnTo>
                    <a:lnTo>
                      <a:pt x="651" y="632"/>
                    </a:lnTo>
                    <a:lnTo>
                      <a:pt x="652" y="641"/>
                    </a:lnTo>
                    <a:lnTo>
                      <a:pt x="652" y="683"/>
                    </a:lnTo>
                    <a:lnTo>
                      <a:pt x="653" y="688"/>
                    </a:lnTo>
                    <a:lnTo>
                      <a:pt x="653" y="710"/>
                    </a:lnTo>
                    <a:lnTo>
                      <a:pt x="654" y="707"/>
                    </a:lnTo>
                    <a:lnTo>
                      <a:pt x="654" y="727"/>
                    </a:lnTo>
                    <a:lnTo>
                      <a:pt x="655" y="728"/>
                    </a:lnTo>
                    <a:lnTo>
                      <a:pt x="655" y="735"/>
                    </a:lnTo>
                    <a:lnTo>
                      <a:pt x="656" y="731"/>
                    </a:lnTo>
                    <a:lnTo>
                      <a:pt x="656" y="691"/>
                    </a:lnTo>
                    <a:lnTo>
                      <a:pt x="657" y="682"/>
                    </a:lnTo>
                    <a:lnTo>
                      <a:pt x="657" y="616"/>
                    </a:lnTo>
                    <a:lnTo>
                      <a:pt x="658" y="610"/>
                    </a:lnTo>
                    <a:lnTo>
                      <a:pt x="658" y="508"/>
                    </a:lnTo>
                    <a:lnTo>
                      <a:pt x="659" y="514"/>
                    </a:lnTo>
                    <a:lnTo>
                      <a:pt x="659" y="404"/>
                    </a:lnTo>
                    <a:lnTo>
                      <a:pt x="660" y="316"/>
                    </a:lnTo>
                    <a:lnTo>
                      <a:pt x="660" y="425"/>
                    </a:lnTo>
                    <a:lnTo>
                      <a:pt x="661" y="334"/>
                    </a:lnTo>
                    <a:lnTo>
                      <a:pt x="661" y="388"/>
                    </a:lnTo>
                    <a:lnTo>
                      <a:pt x="662" y="357"/>
                    </a:lnTo>
                    <a:lnTo>
                      <a:pt x="662" y="398"/>
                    </a:lnTo>
                    <a:lnTo>
                      <a:pt x="663" y="378"/>
                    </a:lnTo>
                    <a:lnTo>
                      <a:pt x="663" y="459"/>
                    </a:lnTo>
                    <a:lnTo>
                      <a:pt x="664" y="467"/>
                    </a:lnTo>
                    <a:lnTo>
                      <a:pt x="664" y="531"/>
                    </a:lnTo>
                    <a:lnTo>
                      <a:pt x="665" y="523"/>
                    </a:lnTo>
                    <a:lnTo>
                      <a:pt x="665" y="626"/>
                    </a:lnTo>
                    <a:lnTo>
                      <a:pt x="666" y="634"/>
                    </a:lnTo>
                    <a:lnTo>
                      <a:pt x="666" y="680"/>
                    </a:lnTo>
                    <a:lnTo>
                      <a:pt x="667" y="692"/>
                    </a:lnTo>
                    <a:lnTo>
                      <a:pt x="667" y="714"/>
                    </a:lnTo>
                    <a:lnTo>
                      <a:pt x="668" y="712"/>
                    </a:lnTo>
                    <a:lnTo>
                      <a:pt x="668" y="728"/>
                    </a:lnTo>
                    <a:lnTo>
                      <a:pt x="669" y="733"/>
                    </a:lnTo>
                    <a:lnTo>
                      <a:pt x="669" y="740"/>
                    </a:lnTo>
                    <a:lnTo>
                      <a:pt x="670" y="742"/>
                    </a:lnTo>
                    <a:lnTo>
                      <a:pt x="670" y="747"/>
                    </a:lnTo>
                    <a:lnTo>
                      <a:pt x="671" y="746"/>
                    </a:lnTo>
                    <a:lnTo>
                      <a:pt x="671" y="750"/>
                    </a:lnTo>
                    <a:lnTo>
                      <a:pt x="672" y="750"/>
                    </a:lnTo>
                    <a:lnTo>
                      <a:pt x="672" y="752"/>
                    </a:lnTo>
                    <a:lnTo>
                      <a:pt x="673" y="752"/>
                    </a:lnTo>
                    <a:lnTo>
                      <a:pt x="673" y="755"/>
                    </a:lnTo>
                    <a:lnTo>
                      <a:pt x="674" y="754"/>
                    </a:lnTo>
                    <a:lnTo>
                      <a:pt x="674" y="755"/>
                    </a:lnTo>
                    <a:lnTo>
                      <a:pt x="675" y="756"/>
                    </a:lnTo>
                    <a:lnTo>
                      <a:pt x="675" y="757"/>
                    </a:lnTo>
                    <a:lnTo>
                      <a:pt x="676" y="757"/>
                    </a:lnTo>
                    <a:lnTo>
                      <a:pt x="676" y="757"/>
                    </a:lnTo>
                    <a:lnTo>
                      <a:pt x="677" y="758"/>
                    </a:lnTo>
                    <a:lnTo>
                      <a:pt x="677" y="757"/>
                    </a:lnTo>
                    <a:lnTo>
                      <a:pt x="678" y="757"/>
                    </a:lnTo>
                    <a:lnTo>
                      <a:pt x="678" y="756"/>
                    </a:lnTo>
                    <a:lnTo>
                      <a:pt x="679" y="755"/>
                    </a:lnTo>
                    <a:lnTo>
                      <a:pt x="679" y="740"/>
                    </a:lnTo>
                    <a:lnTo>
                      <a:pt x="680" y="740"/>
                    </a:lnTo>
                    <a:lnTo>
                      <a:pt x="680" y="729"/>
                    </a:lnTo>
                    <a:lnTo>
                      <a:pt x="681" y="722"/>
                    </a:lnTo>
                    <a:lnTo>
                      <a:pt x="681" y="698"/>
                    </a:lnTo>
                    <a:lnTo>
                      <a:pt x="682" y="695"/>
                    </a:lnTo>
                    <a:lnTo>
                      <a:pt x="682" y="678"/>
                    </a:lnTo>
                    <a:lnTo>
                      <a:pt x="683" y="674"/>
                    </a:lnTo>
                    <a:lnTo>
                      <a:pt x="683" y="688"/>
                    </a:lnTo>
                    <a:lnTo>
                      <a:pt x="684" y="689"/>
                    </a:lnTo>
                    <a:lnTo>
                      <a:pt x="684" y="699"/>
                    </a:lnTo>
                    <a:lnTo>
                      <a:pt x="685" y="699"/>
                    </a:lnTo>
                    <a:lnTo>
                      <a:pt x="685" y="716"/>
                    </a:lnTo>
                    <a:lnTo>
                      <a:pt x="686" y="722"/>
                    </a:lnTo>
                    <a:lnTo>
                      <a:pt x="686" y="736"/>
                    </a:lnTo>
                    <a:lnTo>
                      <a:pt x="687" y="739"/>
                    </a:lnTo>
                    <a:lnTo>
                      <a:pt x="687" y="749"/>
                    </a:lnTo>
                    <a:lnTo>
                      <a:pt x="688" y="748"/>
                    </a:lnTo>
                    <a:lnTo>
                      <a:pt x="688" y="754"/>
                    </a:lnTo>
                    <a:lnTo>
                      <a:pt x="689" y="754"/>
                    </a:lnTo>
                    <a:lnTo>
                      <a:pt x="689" y="756"/>
                    </a:lnTo>
                    <a:lnTo>
                      <a:pt x="690" y="756"/>
                    </a:lnTo>
                    <a:lnTo>
                      <a:pt x="690" y="755"/>
                    </a:lnTo>
                    <a:lnTo>
                      <a:pt x="691" y="757"/>
                    </a:lnTo>
                    <a:lnTo>
                      <a:pt x="691" y="756"/>
                    </a:lnTo>
                    <a:lnTo>
                      <a:pt x="692" y="758"/>
                    </a:lnTo>
                    <a:lnTo>
                      <a:pt x="692" y="756"/>
                    </a:lnTo>
                    <a:lnTo>
                      <a:pt x="693" y="757"/>
                    </a:lnTo>
                    <a:lnTo>
                      <a:pt x="693" y="756"/>
                    </a:lnTo>
                    <a:lnTo>
                      <a:pt x="694" y="756"/>
                    </a:lnTo>
                    <a:lnTo>
                      <a:pt x="694" y="757"/>
                    </a:lnTo>
                    <a:lnTo>
                      <a:pt x="695" y="756"/>
                    </a:lnTo>
                    <a:lnTo>
                      <a:pt x="695" y="758"/>
                    </a:lnTo>
                    <a:lnTo>
                      <a:pt x="696" y="758"/>
                    </a:lnTo>
                    <a:lnTo>
                      <a:pt x="696" y="757"/>
                    </a:lnTo>
                    <a:lnTo>
                      <a:pt x="697" y="757"/>
                    </a:lnTo>
                    <a:lnTo>
                      <a:pt x="697" y="757"/>
                    </a:lnTo>
                    <a:lnTo>
                      <a:pt x="698" y="756"/>
                    </a:lnTo>
                    <a:lnTo>
                      <a:pt x="698" y="758"/>
                    </a:lnTo>
                    <a:lnTo>
                      <a:pt x="699" y="757"/>
                    </a:lnTo>
                    <a:lnTo>
                      <a:pt x="699" y="757"/>
                    </a:lnTo>
                    <a:lnTo>
                      <a:pt x="700" y="757"/>
                    </a:lnTo>
                    <a:lnTo>
                      <a:pt x="700" y="758"/>
                    </a:lnTo>
                    <a:lnTo>
                      <a:pt x="701" y="756"/>
                    </a:lnTo>
                    <a:lnTo>
                      <a:pt x="701" y="758"/>
                    </a:lnTo>
                    <a:lnTo>
                      <a:pt x="702" y="757"/>
                    </a:lnTo>
                    <a:lnTo>
                      <a:pt x="702" y="757"/>
                    </a:lnTo>
                    <a:lnTo>
                      <a:pt x="703" y="757"/>
                    </a:lnTo>
                    <a:lnTo>
                      <a:pt x="703" y="758"/>
                    </a:lnTo>
                    <a:lnTo>
                      <a:pt x="704" y="757"/>
                    </a:lnTo>
                    <a:lnTo>
                      <a:pt x="704" y="757"/>
                    </a:lnTo>
                    <a:lnTo>
                      <a:pt x="705" y="757"/>
                    </a:lnTo>
                    <a:lnTo>
                      <a:pt x="705" y="757"/>
                    </a:lnTo>
                    <a:lnTo>
                      <a:pt x="706" y="757"/>
                    </a:lnTo>
                    <a:lnTo>
                      <a:pt x="706" y="757"/>
                    </a:lnTo>
                    <a:lnTo>
                      <a:pt x="707" y="756"/>
                    </a:lnTo>
                    <a:lnTo>
                      <a:pt x="707" y="757"/>
                    </a:lnTo>
                    <a:lnTo>
                      <a:pt x="708" y="757"/>
                    </a:lnTo>
                    <a:lnTo>
                      <a:pt x="708" y="756"/>
                    </a:lnTo>
                    <a:lnTo>
                      <a:pt x="709" y="757"/>
                    </a:lnTo>
                    <a:lnTo>
                      <a:pt x="709" y="757"/>
                    </a:lnTo>
                    <a:lnTo>
                      <a:pt x="710" y="756"/>
                    </a:lnTo>
                    <a:lnTo>
                      <a:pt x="710" y="757"/>
                    </a:lnTo>
                    <a:lnTo>
                      <a:pt x="711" y="757"/>
                    </a:lnTo>
                    <a:lnTo>
                      <a:pt x="711" y="757"/>
                    </a:lnTo>
                    <a:lnTo>
                      <a:pt x="712" y="757"/>
                    </a:lnTo>
                    <a:lnTo>
                      <a:pt x="712" y="756"/>
                    </a:lnTo>
                    <a:lnTo>
                      <a:pt x="713" y="757"/>
                    </a:lnTo>
                    <a:lnTo>
                      <a:pt x="713" y="757"/>
                    </a:lnTo>
                    <a:lnTo>
                      <a:pt x="714" y="757"/>
                    </a:lnTo>
                    <a:lnTo>
                      <a:pt x="714" y="755"/>
                    </a:lnTo>
                    <a:lnTo>
                      <a:pt x="715" y="754"/>
                    </a:lnTo>
                    <a:lnTo>
                      <a:pt x="715" y="753"/>
                    </a:lnTo>
                    <a:lnTo>
                      <a:pt x="716" y="754"/>
                    </a:lnTo>
                    <a:lnTo>
                      <a:pt x="716" y="756"/>
                    </a:lnTo>
                    <a:lnTo>
                      <a:pt x="717" y="756"/>
                    </a:lnTo>
                    <a:lnTo>
                      <a:pt x="717" y="757"/>
                    </a:lnTo>
                    <a:lnTo>
                      <a:pt x="718" y="757"/>
                    </a:lnTo>
                    <a:lnTo>
                      <a:pt x="718" y="756"/>
                    </a:lnTo>
                    <a:lnTo>
                      <a:pt x="719" y="757"/>
                    </a:lnTo>
                    <a:lnTo>
                      <a:pt x="719" y="757"/>
                    </a:lnTo>
                    <a:lnTo>
                      <a:pt x="720" y="757"/>
                    </a:lnTo>
                    <a:lnTo>
                      <a:pt x="720" y="757"/>
                    </a:lnTo>
                    <a:lnTo>
                      <a:pt x="721" y="757"/>
                    </a:lnTo>
                    <a:lnTo>
                      <a:pt x="721" y="756"/>
                    </a:lnTo>
                    <a:lnTo>
                      <a:pt x="722" y="756"/>
                    </a:lnTo>
                    <a:lnTo>
                      <a:pt x="722" y="757"/>
                    </a:lnTo>
                    <a:lnTo>
                      <a:pt x="723" y="756"/>
                    </a:lnTo>
                    <a:lnTo>
                      <a:pt x="723" y="757"/>
                    </a:lnTo>
                    <a:lnTo>
                      <a:pt x="724" y="756"/>
                    </a:lnTo>
                    <a:lnTo>
                      <a:pt x="724" y="757"/>
                    </a:lnTo>
                    <a:lnTo>
                      <a:pt x="725" y="757"/>
                    </a:lnTo>
                    <a:lnTo>
                      <a:pt x="725" y="751"/>
                    </a:lnTo>
                    <a:lnTo>
                      <a:pt x="726" y="747"/>
                    </a:lnTo>
                    <a:lnTo>
                      <a:pt x="726" y="735"/>
                    </a:lnTo>
                    <a:lnTo>
                      <a:pt x="727" y="728"/>
                    </a:lnTo>
                    <a:lnTo>
                      <a:pt x="727" y="714"/>
                    </a:lnTo>
                    <a:lnTo>
                      <a:pt x="728" y="708"/>
                    </a:lnTo>
                    <a:lnTo>
                      <a:pt x="728" y="697"/>
                    </a:lnTo>
                    <a:lnTo>
                      <a:pt x="729" y="702"/>
                    </a:lnTo>
                    <a:lnTo>
                      <a:pt x="729" y="695"/>
                    </a:lnTo>
                    <a:lnTo>
                      <a:pt x="730" y="695"/>
                    </a:lnTo>
                    <a:lnTo>
                      <a:pt x="730" y="706"/>
                    </a:lnTo>
                    <a:lnTo>
                      <a:pt x="731" y="712"/>
                    </a:lnTo>
                    <a:lnTo>
                      <a:pt x="731" y="721"/>
                    </a:lnTo>
                    <a:lnTo>
                      <a:pt x="732" y="721"/>
                    </a:lnTo>
                    <a:lnTo>
                      <a:pt x="732" y="732"/>
                    </a:lnTo>
                    <a:lnTo>
                      <a:pt x="733" y="734"/>
                    </a:lnTo>
                    <a:lnTo>
                      <a:pt x="733" y="739"/>
                    </a:lnTo>
                    <a:lnTo>
                      <a:pt x="734" y="742"/>
                    </a:lnTo>
                    <a:lnTo>
                      <a:pt x="734" y="746"/>
                    </a:lnTo>
                    <a:lnTo>
                      <a:pt x="735" y="745"/>
                    </a:lnTo>
                    <a:lnTo>
                      <a:pt x="735" y="748"/>
                    </a:lnTo>
                    <a:lnTo>
                      <a:pt x="736" y="748"/>
                    </a:lnTo>
                    <a:lnTo>
                      <a:pt x="736" y="751"/>
                    </a:lnTo>
                    <a:lnTo>
                      <a:pt x="737" y="750"/>
                    </a:lnTo>
                    <a:lnTo>
                      <a:pt x="737" y="753"/>
                    </a:lnTo>
                    <a:lnTo>
                      <a:pt x="738" y="755"/>
                    </a:lnTo>
                    <a:lnTo>
                      <a:pt x="738" y="752"/>
                    </a:lnTo>
                    <a:lnTo>
                      <a:pt x="739" y="754"/>
                    </a:lnTo>
                    <a:lnTo>
                      <a:pt x="739" y="755"/>
                    </a:lnTo>
                    <a:lnTo>
                      <a:pt x="740" y="756"/>
                    </a:lnTo>
                    <a:lnTo>
                      <a:pt x="740" y="752"/>
                    </a:lnTo>
                    <a:lnTo>
                      <a:pt x="741" y="753"/>
                    </a:lnTo>
                    <a:lnTo>
                      <a:pt x="741" y="751"/>
                    </a:lnTo>
                    <a:lnTo>
                      <a:pt x="742" y="753"/>
                    </a:lnTo>
                    <a:lnTo>
                      <a:pt x="742" y="754"/>
                    </a:lnTo>
                    <a:lnTo>
                      <a:pt x="743" y="755"/>
                    </a:lnTo>
                    <a:lnTo>
                      <a:pt x="743" y="757"/>
                    </a:lnTo>
                    <a:lnTo>
                      <a:pt x="744" y="757"/>
                    </a:lnTo>
                    <a:lnTo>
                      <a:pt x="744" y="756"/>
                    </a:lnTo>
                    <a:lnTo>
                      <a:pt x="745" y="757"/>
                    </a:lnTo>
                    <a:lnTo>
                      <a:pt x="745" y="756"/>
                    </a:lnTo>
                    <a:lnTo>
                      <a:pt x="746" y="758"/>
                    </a:lnTo>
                    <a:lnTo>
                      <a:pt x="746" y="756"/>
                    </a:lnTo>
                    <a:lnTo>
                      <a:pt x="747" y="756"/>
                    </a:lnTo>
                    <a:lnTo>
                      <a:pt x="747" y="756"/>
                    </a:lnTo>
                    <a:lnTo>
                      <a:pt x="748" y="757"/>
                    </a:lnTo>
                    <a:lnTo>
                      <a:pt x="748" y="756"/>
                    </a:lnTo>
                    <a:lnTo>
                      <a:pt x="749" y="757"/>
                    </a:lnTo>
                    <a:lnTo>
                      <a:pt x="749" y="756"/>
                    </a:lnTo>
                    <a:lnTo>
                      <a:pt x="750" y="756"/>
                    </a:lnTo>
                    <a:lnTo>
                      <a:pt x="750" y="757"/>
                    </a:lnTo>
                    <a:lnTo>
                      <a:pt x="751" y="757"/>
                    </a:lnTo>
                    <a:lnTo>
                      <a:pt x="751" y="756"/>
                    </a:lnTo>
                    <a:lnTo>
                      <a:pt x="752" y="753"/>
                    </a:lnTo>
                    <a:lnTo>
                      <a:pt x="752" y="724"/>
                    </a:lnTo>
                    <a:lnTo>
                      <a:pt x="753" y="704"/>
                    </a:lnTo>
                    <a:lnTo>
                      <a:pt x="753" y="633"/>
                    </a:lnTo>
                    <a:lnTo>
                      <a:pt x="754" y="597"/>
                    </a:lnTo>
                    <a:lnTo>
                      <a:pt x="754" y="421"/>
                    </a:lnTo>
                    <a:lnTo>
                      <a:pt x="755" y="397"/>
                    </a:lnTo>
                    <a:lnTo>
                      <a:pt x="755" y="222"/>
                    </a:lnTo>
                    <a:lnTo>
                      <a:pt x="756" y="202"/>
                    </a:lnTo>
                    <a:lnTo>
                      <a:pt x="756" y="51"/>
                    </a:lnTo>
                    <a:lnTo>
                      <a:pt x="757" y="72"/>
                    </a:lnTo>
                    <a:lnTo>
                      <a:pt x="757" y="137"/>
                    </a:lnTo>
                    <a:lnTo>
                      <a:pt x="758" y="154"/>
                    </a:lnTo>
                    <a:lnTo>
                      <a:pt x="758" y="274"/>
                    </a:lnTo>
                    <a:lnTo>
                      <a:pt x="759" y="340"/>
                    </a:lnTo>
                    <a:lnTo>
                      <a:pt x="759" y="413"/>
                    </a:lnTo>
                    <a:lnTo>
                      <a:pt x="760" y="452"/>
                    </a:lnTo>
                    <a:lnTo>
                      <a:pt x="760" y="513"/>
                    </a:lnTo>
                    <a:lnTo>
                      <a:pt x="761" y="557"/>
                    </a:lnTo>
                    <a:lnTo>
                      <a:pt x="761" y="590"/>
                    </a:lnTo>
                    <a:lnTo>
                      <a:pt x="762" y="612"/>
                    </a:lnTo>
                    <a:lnTo>
                      <a:pt x="762" y="582"/>
                    </a:lnTo>
                    <a:lnTo>
                      <a:pt x="763" y="565"/>
                    </a:lnTo>
                    <a:lnTo>
                      <a:pt x="763" y="590"/>
                    </a:lnTo>
                    <a:lnTo>
                      <a:pt x="764" y="603"/>
                    </a:lnTo>
                    <a:lnTo>
                      <a:pt x="764" y="615"/>
                    </a:lnTo>
                    <a:lnTo>
                      <a:pt x="765" y="623"/>
                    </a:lnTo>
                    <a:lnTo>
                      <a:pt x="765" y="664"/>
                    </a:lnTo>
                    <a:lnTo>
                      <a:pt x="766" y="661"/>
                    </a:lnTo>
                    <a:lnTo>
                      <a:pt x="766" y="685"/>
                    </a:lnTo>
                    <a:lnTo>
                      <a:pt x="767" y="681"/>
                    </a:lnTo>
                    <a:lnTo>
                      <a:pt x="767" y="689"/>
                    </a:lnTo>
                    <a:lnTo>
                      <a:pt x="768" y="687"/>
                    </a:lnTo>
                    <a:lnTo>
                      <a:pt x="768" y="698"/>
                    </a:lnTo>
                    <a:lnTo>
                      <a:pt x="769" y="694"/>
                    </a:lnTo>
                    <a:lnTo>
                      <a:pt x="769" y="703"/>
                    </a:lnTo>
                    <a:lnTo>
                      <a:pt x="770" y="702"/>
                    </a:lnTo>
                    <a:lnTo>
                      <a:pt x="770" y="711"/>
                    </a:lnTo>
                    <a:lnTo>
                      <a:pt x="771" y="705"/>
                    </a:lnTo>
                    <a:lnTo>
                      <a:pt x="771" y="712"/>
                    </a:lnTo>
                    <a:lnTo>
                      <a:pt x="772" y="716"/>
                    </a:lnTo>
                    <a:lnTo>
                      <a:pt x="772" y="722"/>
                    </a:lnTo>
                    <a:lnTo>
                      <a:pt x="773" y="722"/>
                    </a:lnTo>
                    <a:lnTo>
                      <a:pt x="773" y="725"/>
                    </a:lnTo>
                    <a:lnTo>
                      <a:pt x="774" y="723"/>
                    </a:lnTo>
                    <a:lnTo>
                      <a:pt x="774" y="735"/>
                    </a:lnTo>
                    <a:lnTo>
                      <a:pt x="775" y="731"/>
                    </a:lnTo>
                    <a:lnTo>
                      <a:pt x="775" y="735"/>
                    </a:lnTo>
                    <a:lnTo>
                      <a:pt x="776" y="735"/>
                    </a:lnTo>
                    <a:lnTo>
                      <a:pt x="776" y="739"/>
                    </a:lnTo>
                    <a:lnTo>
                      <a:pt x="777" y="734"/>
                    </a:lnTo>
                    <a:lnTo>
                      <a:pt x="777" y="739"/>
                    </a:lnTo>
                    <a:lnTo>
                      <a:pt x="778" y="740"/>
                    </a:lnTo>
                    <a:lnTo>
                      <a:pt x="778" y="741"/>
                    </a:lnTo>
                    <a:lnTo>
                      <a:pt x="779" y="740"/>
                    </a:lnTo>
                    <a:lnTo>
                      <a:pt x="779" y="745"/>
                    </a:lnTo>
                    <a:lnTo>
                      <a:pt x="780" y="742"/>
                    </a:lnTo>
                    <a:lnTo>
                      <a:pt x="780" y="745"/>
                    </a:lnTo>
                    <a:lnTo>
                      <a:pt x="781" y="743"/>
                    </a:lnTo>
                    <a:lnTo>
                      <a:pt x="781" y="745"/>
                    </a:lnTo>
                    <a:lnTo>
                      <a:pt x="782" y="743"/>
                    </a:lnTo>
                    <a:lnTo>
                      <a:pt x="782" y="747"/>
                    </a:lnTo>
                    <a:lnTo>
                      <a:pt x="783" y="746"/>
                    </a:lnTo>
                    <a:lnTo>
                      <a:pt x="783" y="749"/>
                    </a:lnTo>
                    <a:lnTo>
                      <a:pt x="784" y="746"/>
                    </a:lnTo>
                    <a:lnTo>
                      <a:pt x="784" y="751"/>
                    </a:lnTo>
                    <a:lnTo>
                      <a:pt x="785" y="749"/>
                    </a:lnTo>
                    <a:lnTo>
                      <a:pt x="785" y="751"/>
                    </a:lnTo>
                    <a:lnTo>
                      <a:pt x="786" y="751"/>
                    </a:lnTo>
                    <a:lnTo>
                      <a:pt x="786" y="752"/>
                    </a:lnTo>
                    <a:lnTo>
                      <a:pt x="787" y="752"/>
                    </a:lnTo>
                    <a:lnTo>
                      <a:pt x="787" y="754"/>
                    </a:lnTo>
                    <a:lnTo>
                      <a:pt x="788" y="755"/>
                    </a:lnTo>
                    <a:lnTo>
                      <a:pt x="788" y="753"/>
                    </a:lnTo>
                    <a:lnTo>
                      <a:pt x="789" y="754"/>
                    </a:lnTo>
                    <a:lnTo>
                      <a:pt x="789" y="756"/>
                    </a:lnTo>
                    <a:lnTo>
                      <a:pt x="790" y="755"/>
                    </a:lnTo>
                    <a:lnTo>
                      <a:pt x="790" y="756"/>
                    </a:lnTo>
                    <a:lnTo>
                      <a:pt x="791" y="755"/>
                    </a:lnTo>
                    <a:lnTo>
                      <a:pt x="791" y="757"/>
                    </a:lnTo>
                    <a:lnTo>
                      <a:pt x="792" y="755"/>
                    </a:lnTo>
                    <a:lnTo>
                      <a:pt x="792" y="757"/>
                    </a:lnTo>
                    <a:lnTo>
                      <a:pt x="793" y="756"/>
                    </a:lnTo>
                    <a:lnTo>
                      <a:pt x="793" y="755"/>
                    </a:lnTo>
                    <a:lnTo>
                      <a:pt x="794" y="756"/>
                    </a:lnTo>
                    <a:lnTo>
                      <a:pt x="794" y="757"/>
                    </a:lnTo>
                    <a:lnTo>
                      <a:pt x="795" y="756"/>
                    </a:lnTo>
                    <a:lnTo>
                      <a:pt x="795" y="756"/>
                    </a:lnTo>
                    <a:lnTo>
                      <a:pt x="796" y="757"/>
                    </a:lnTo>
                    <a:lnTo>
                      <a:pt x="796" y="756"/>
                    </a:lnTo>
                    <a:lnTo>
                      <a:pt x="797" y="756"/>
                    </a:lnTo>
                    <a:lnTo>
                      <a:pt x="797" y="756"/>
                    </a:lnTo>
                    <a:lnTo>
                      <a:pt x="798" y="755"/>
                    </a:lnTo>
                    <a:lnTo>
                      <a:pt x="798" y="757"/>
                    </a:lnTo>
                    <a:lnTo>
                      <a:pt x="799" y="756"/>
                    </a:lnTo>
                    <a:lnTo>
                      <a:pt x="799" y="757"/>
                    </a:lnTo>
                    <a:lnTo>
                      <a:pt x="800" y="757"/>
                    </a:lnTo>
                    <a:lnTo>
                      <a:pt x="800" y="756"/>
                    </a:lnTo>
                    <a:lnTo>
                      <a:pt x="801" y="757"/>
                    </a:lnTo>
                    <a:lnTo>
                      <a:pt x="801" y="756"/>
                    </a:lnTo>
                    <a:lnTo>
                      <a:pt x="802" y="757"/>
                    </a:lnTo>
                    <a:lnTo>
                      <a:pt x="802" y="756"/>
                    </a:lnTo>
                    <a:lnTo>
                      <a:pt x="803" y="756"/>
                    </a:lnTo>
                    <a:lnTo>
                      <a:pt x="803" y="757"/>
                    </a:lnTo>
                    <a:lnTo>
                      <a:pt x="804" y="757"/>
                    </a:lnTo>
                    <a:lnTo>
                      <a:pt x="804" y="756"/>
                    </a:lnTo>
                    <a:lnTo>
                      <a:pt x="805" y="757"/>
                    </a:lnTo>
                    <a:lnTo>
                      <a:pt x="805" y="756"/>
                    </a:lnTo>
                    <a:lnTo>
                      <a:pt x="806" y="756"/>
                    </a:lnTo>
                    <a:lnTo>
                      <a:pt x="806" y="756"/>
                    </a:lnTo>
                    <a:lnTo>
                      <a:pt x="807" y="757"/>
                    </a:lnTo>
                    <a:lnTo>
                      <a:pt x="807" y="756"/>
                    </a:lnTo>
                    <a:lnTo>
                      <a:pt x="808" y="756"/>
                    </a:lnTo>
                    <a:lnTo>
                      <a:pt x="808" y="757"/>
                    </a:lnTo>
                    <a:lnTo>
                      <a:pt x="809" y="757"/>
                    </a:lnTo>
                    <a:lnTo>
                      <a:pt x="809" y="756"/>
                    </a:lnTo>
                    <a:lnTo>
                      <a:pt x="810" y="756"/>
                    </a:lnTo>
                    <a:lnTo>
                      <a:pt x="810" y="757"/>
                    </a:lnTo>
                    <a:lnTo>
                      <a:pt x="811" y="756"/>
                    </a:lnTo>
                    <a:lnTo>
                      <a:pt x="811" y="756"/>
                    </a:lnTo>
                    <a:lnTo>
                      <a:pt x="812" y="756"/>
                    </a:lnTo>
                    <a:lnTo>
                      <a:pt x="812" y="756"/>
                    </a:lnTo>
                    <a:lnTo>
                      <a:pt x="813" y="757"/>
                    </a:lnTo>
                    <a:lnTo>
                      <a:pt x="813" y="755"/>
                    </a:lnTo>
                    <a:lnTo>
                      <a:pt x="814" y="756"/>
                    </a:lnTo>
                    <a:lnTo>
                      <a:pt x="814" y="756"/>
                    </a:lnTo>
                    <a:lnTo>
                      <a:pt x="815" y="755"/>
                    </a:lnTo>
                    <a:lnTo>
                      <a:pt x="815" y="757"/>
                    </a:lnTo>
                    <a:lnTo>
                      <a:pt x="816" y="756"/>
                    </a:lnTo>
                    <a:lnTo>
                      <a:pt x="816" y="756"/>
                    </a:lnTo>
                    <a:lnTo>
                      <a:pt x="817" y="754"/>
                    </a:lnTo>
                    <a:lnTo>
                      <a:pt x="817" y="756"/>
                    </a:lnTo>
                    <a:lnTo>
                      <a:pt x="818" y="755"/>
                    </a:lnTo>
                    <a:lnTo>
                      <a:pt x="818" y="756"/>
                    </a:lnTo>
                    <a:lnTo>
                      <a:pt x="819" y="756"/>
                    </a:lnTo>
                    <a:lnTo>
                      <a:pt x="819" y="755"/>
                    </a:lnTo>
                    <a:lnTo>
                      <a:pt x="820" y="756"/>
                    </a:lnTo>
                    <a:lnTo>
                      <a:pt x="820" y="757"/>
                    </a:lnTo>
                    <a:lnTo>
                      <a:pt x="821" y="756"/>
                    </a:lnTo>
                    <a:lnTo>
                      <a:pt x="821" y="757"/>
                    </a:lnTo>
                    <a:lnTo>
                      <a:pt x="822" y="757"/>
                    </a:lnTo>
                    <a:lnTo>
                      <a:pt x="822" y="755"/>
                    </a:lnTo>
                    <a:lnTo>
                      <a:pt x="823" y="757"/>
                    </a:lnTo>
                    <a:lnTo>
                      <a:pt x="823" y="756"/>
                    </a:lnTo>
                    <a:lnTo>
                      <a:pt x="824" y="755"/>
                    </a:lnTo>
                    <a:lnTo>
                      <a:pt x="824" y="756"/>
                    </a:lnTo>
                    <a:lnTo>
                      <a:pt x="825" y="755"/>
                    </a:lnTo>
                    <a:lnTo>
                      <a:pt x="825" y="756"/>
                    </a:lnTo>
                    <a:lnTo>
                      <a:pt x="826" y="756"/>
                    </a:lnTo>
                    <a:lnTo>
                      <a:pt x="826" y="756"/>
                    </a:lnTo>
                    <a:lnTo>
                      <a:pt x="827" y="756"/>
                    </a:lnTo>
                    <a:lnTo>
                      <a:pt x="827" y="756"/>
                    </a:lnTo>
                    <a:lnTo>
                      <a:pt x="828" y="756"/>
                    </a:lnTo>
                    <a:lnTo>
                      <a:pt x="828" y="756"/>
                    </a:lnTo>
                    <a:lnTo>
                      <a:pt x="829" y="755"/>
                    </a:lnTo>
                    <a:lnTo>
                      <a:pt x="829" y="756"/>
                    </a:lnTo>
                    <a:lnTo>
                      <a:pt x="830" y="756"/>
                    </a:lnTo>
                    <a:lnTo>
                      <a:pt x="830" y="756"/>
                    </a:lnTo>
                    <a:lnTo>
                      <a:pt x="831" y="757"/>
                    </a:lnTo>
                    <a:lnTo>
                      <a:pt x="831" y="756"/>
                    </a:lnTo>
                    <a:lnTo>
                      <a:pt x="832" y="756"/>
                    </a:lnTo>
                    <a:lnTo>
                      <a:pt x="832" y="757"/>
                    </a:lnTo>
                    <a:lnTo>
                      <a:pt x="833" y="757"/>
                    </a:lnTo>
                    <a:lnTo>
                      <a:pt x="833" y="756"/>
                    </a:lnTo>
                    <a:lnTo>
                      <a:pt x="834" y="757"/>
                    </a:lnTo>
                    <a:lnTo>
                      <a:pt x="834" y="756"/>
                    </a:lnTo>
                    <a:lnTo>
                      <a:pt x="835" y="756"/>
                    </a:lnTo>
                    <a:lnTo>
                      <a:pt x="835" y="756"/>
                    </a:lnTo>
                    <a:lnTo>
                      <a:pt x="836" y="757"/>
                    </a:lnTo>
                    <a:lnTo>
                      <a:pt x="836" y="756"/>
                    </a:lnTo>
                    <a:lnTo>
                      <a:pt x="837" y="756"/>
                    </a:lnTo>
                    <a:lnTo>
                      <a:pt x="837" y="756"/>
                    </a:lnTo>
                    <a:lnTo>
                      <a:pt x="838" y="756"/>
                    </a:lnTo>
                    <a:lnTo>
                      <a:pt x="838" y="755"/>
                    </a:lnTo>
                    <a:lnTo>
                      <a:pt x="839" y="757"/>
                    </a:lnTo>
                    <a:lnTo>
                      <a:pt x="839" y="756"/>
                    </a:lnTo>
                    <a:lnTo>
                      <a:pt x="840" y="756"/>
                    </a:lnTo>
                    <a:lnTo>
                      <a:pt x="840" y="756"/>
                    </a:lnTo>
                    <a:lnTo>
                      <a:pt x="841" y="757"/>
                    </a:lnTo>
                    <a:lnTo>
                      <a:pt x="841" y="756"/>
                    </a:lnTo>
                    <a:lnTo>
                      <a:pt x="842" y="756"/>
                    </a:lnTo>
                    <a:lnTo>
                      <a:pt x="842" y="757"/>
                    </a:lnTo>
                    <a:lnTo>
                      <a:pt x="843" y="756"/>
                    </a:lnTo>
                    <a:lnTo>
                      <a:pt x="843" y="757"/>
                    </a:lnTo>
                    <a:lnTo>
                      <a:pt x="844" y="756"/>
                    </a:lnTo>
                    <a:lnTo>
                      <a:pt x="844" y="756"/>
                    </a:lnTo>
                    <a:lnTo>
                      <a:pt x="845" y="756"/>
                    </a:lnTo>
                    <a:lnTo>
                      <a:pt x="845" y="757"/>
                    </a:lnTo>
                    <a:lnTo>
                      <a:pt x="846" y="755"/>
                    </a:lnTo>
                    <a:lnTo>
                      <a:pt x="846" y="756"/>
                    </a:lnTo>
                    <a:lnTo>
                      <a:pt x="847" y="757"/>
                    </a:lnTo>
                    <a:lnTo>
                      <a:pt x="847" y="756"/>
                    </a:lnTo>
                    <a:lnTo>
                      <a:pt x="848" y="755"/>
                    </a:lnTo>
                    <a:lnTo>
                      <a:pt x="848" y="757"/>
                    </a:lnTo>
                    <a:lnTo>
                      <a:pt x="849" y="756"/>
                    </a:lnTo>
                    <a:lnTo>
                      <a:pt x="849" y="757"/>
                    </a:lnTo>
                    <a:lnTo>
                      <a:pt x="850" y="757"/>
                    </a:lnTo>
                    <a:lnTo>
                      <a:pt x="850" y="756"/>
                    </a:lnTo>
                    <a:lnTo>
                      <a:pt x="851" y="756"/>
                    </a:lnTo>
                    <a:lnTo>
                      <a:pt x="851" y="757"/>
                    </a:lnTo>
                    <a:lnTo>
                      <a:pt x="852" y="755"/>
                    </a:lnTo>
                    <a:lnTo>
                      <a:pt x="852" y="757"/>
                    </a:lnTo>
                    <a:lnTo>
                      <a:pt x="853" y="757"/>
                    </a:lnTo>
                    <a:lnTo>
                      <a:pt x="853" y="756"/>
                    </a:lnTo>
                    <a:lnTo>
                      <a:pt x="854" y="756"/>
                    </a:lnTo>
                    <a:lnTo>
                      <a:pt x="854" y="756"/>
                    </a:lnTo>
                    <a:lnTo>
                      <a:pt x="855" y="757"/>
                    </a:lnTo>
                    <a:lnTo>
                      <a:pt x="855" y="756"/>
                    </a:lnTo>
                    <a:lnTo>
                      <a:pt x="856" y="755"/>
                    </a:lnTo>
                    <a:lnTo>
                      <a:pt x="856" y="757"/>
                    </a:lnTo>
                    <a:lnTo>
                      <a:pt x="857" y="755"/>
                    </a:lnTo>
                    <a:lnTo>
                      <a:pt x="857" y="757"/>
                    </a:lnTo>
                    <a:lnTo>
                      <a:pt x="858" y="755"/>
                    </a:lnTo>
                    <a:lnTo>
                      <a:pt x="858" y="756"/>
                    </a:lnTo>
                    <a:lnTo>
                      <a:pt x="859" y="756"/>
                    </a:lnTo>
                    <a:lnTo>
                      <a:pt x="859" y="755"/>
                    </a:lnTo>
                    <a:lnTo>
                      <a:pt x="860" y="757"/>
                    </a:lnTo>
                    <a:lnTo>
                      <a:pt x="860" y="755"/>
                    </a:lnTo>
                    <a:lnTo>
                      <a:pt x="861" y="756"/>
                    </a:lnTo>
                    <a:lnTo>
                      <a:pt x="861" y="757"/>
                    </a:lnTo>
                    <a:lnTo>
                      <a:pt x="862" y="755"/>
                    </a:lnTo>
                    <a:lnTo>
                      <a:pt x="862" y="756"/>
                    </a:lnTo>
                    <a:lnTo>
                      <a:pt x="863" y="756"/>
                    </a:lnTo>
                    <a:lnTo>
                      <a:pt x="863" y="757"/>
                    </a:lnTo>
                    <a:lnTo>
                      <a:pt x="864" y="755"/>
                    </a:lnTo>
                    <a:lnTo>
                      <a:pt x="864" y="757"/>
                    </a:lnTo>
                    <a:lnTo>
                      <a:pt x="865" y="756"/>
                    </a:lnTo>
                    <a:lnTo>
                      <a:pt x="865" y="756"/>
                    </a:lnTo>
                    <a:lnTo>
                      <a:pt x="866" y="756"/>
                    </a:lnTo>
                    <a:lnTo>
                      <a:pt x="866" y="755"/>
                    </a:lnTo>
                    <a:lnTo>
                      <a:pt x="867" y="756"/>
                    </a:lnTo>
                    <a:lnTo>
                      <a:pt x="867" y="755"/>
                    </a:lnTo>
                    <a:lnTo>
                      <a:pt x="868" y="756"/>
                    </a:lnTo>
                    <a:lnTo>
                      <a:pt x="868" y="756"/>
                    </a:lnTo>
                    <a:lnTo>
                      <a:pt x="869" y="756"/>
                    </a:lnTo>
                    <a:lnTo>
                      <a:pt x="869" y="756"/>
                    </a:lnTo>
                    <a:lnTo>
                      <a:pt x="870" y="756"/>
                    </a:lnTo>
                    <a:lnTo>
                      <a:pt x="870" y="755"/>
                    </a:lnTo>
                    <a:lnTo>
                      <a:pt x="871" y="755"/>
                    </a:lnTo>
                    <a:lnTo>
                      <a:pt x="871" y="756"/>
                    </a:lnTo>
                    <a:lnTo>
                      <a:pt x="872" y="756"/>
                    </a:lnTo>
                    <a:lnTo>
                      <a:pt x="872" y="756"/>
                    </a:lnTo>
                    <a:lnTo>
                      <a:pt x="873" y="757"/>
                    </a:lnTo>
                    <a:lnTo>
                      <a:pt x="873" y="755"/>
                    </a:lnTo>
                    <a:lnTo>
                      <a:pt x="874" y="755"/>
                    </a:lnTo>
                    <a:lnTo>
                      <a:pt x="874" y="756"/>
                    </a:lnTo>
                    <a:lnTo>
                      <a:pt x="875" y="755"/>
                    </a:lnTo>
                    <a:lnTo>
                      <a:pt x="875" y="756"/>
                    </a:lnTo>
                    <a:lnTo>
                      <a:pt x="876" y="756"/>
                    </a:lnTo>
                    <a:lnTo>
                      <a:pt x="876" y="755"/>
                    </a:lnTo>
                    <a:lnTo>
                      <a:pt x="877" y="756"/>
                    </a:lnTo>
                    <a:lnTo>
                      <a:pt x="877" y="757"/>
                    </a:lnTo>
                    <a:lnTo>
                      <a:pt x="878" y="756"/>
                    </a:lnTo>
                    <a:lnTo>
                      <a:pt x="878" y="756"/>
                    </a:lnTo>
                    <a:lnTo>
                      <a:pt x="879" y="756"/>
                    </a:lnTo>
                    <a:lnTo>
                      <a:pt x="879" y="757"/>
                    </a:lnTo>
                    <a:lnTo>
                      <a:pt x="880" y="757"/>
                    </a:lnTo>
                    <a:lnTo>
                      <a:pt x="880" y="756"/>
                    </a:lnTo>
                    <a:lnTo>
                      <a:pt x="881" y="756"/>
                    </a:lnTo>
                    <a:lnTo>
                      <a:pt x="881" y="757"/>
                    </a:lnTo>
                    <a:lnTo>
                      <a:pt x="882" y="757"/>
                    </a:lnTo>
                    <a:lnTo>
                      <a:pt x="882" y="756"/>
                    </a:lnTo>
                    <a:lnTo>
                      <a:pt x="883" y="756"/>
                    </a:lnTo>
                    <a:lnTo>
                      <a:pt x="883" y="756"/>
                    </a:lnTo>
                    <a:lnTo>
                      <a:pt x="884" y="755"/>
                    </a:lnTo>
                    <a:lnTo>
                      <a:pt x="884" y="756"/>
                    </a:lnTo>
                    <a:lnTo>
                      <a:pt x="885" y="755"/>
                    </a:lnTo>
                    <a:lnTo>
                      <a:pt x="885" y="756"/>
                    </a:lnTo>
                    <a:lnTo>
                      <a:pt x="886" y="756"/>
                    </a:lnTo>
                    <a:lnTo>
                      <a:pt x="886" y="756"/>
                    </a:lnTo>
                    <a:lnTo>
                      <a:pt x="887" y="756"/>
                    </a:lnTo>
                    <a:lnTo>
                      <a:pt x="887" y="756"/>
                    </a:lnTo>
                    <a:lnTo>
                      <a:pt x="888" y="756"/>
                    </a:lnTo>
                    <a:lnTo>
                      <a:pt x="888" y="756"/>
                    </a:lnTo>
                    <a:lnTo>
                      <a:pt x="889" y="756"/>
                    </a:lnTo>
                    <a:lnTo>
                      <a:pt x="889" y="756"/>
                    </a:lnTo>
                    <a:lnTo>
                      <a:pt x="890" y="757"/>
                    </a:lnTo>
                    <a:lnTo>
                      <a:pt x="890" y="756"/>
                    </a:lnTo>
                    <a:lnTo>
                      <a:pt x="891" y="755"/>
                    </a:lnTo>
                    <a:lnTo>
                      <a:pt x="891" y="756"/>
                    </a:lnTo>
                    <a:lnTo>
                      <a:pt x="892" y="755"/>
                    </a:lnTo>
                    <a:lnTo>
                      <a:pt x="892" y="756"/>
                    </a:lnTo>
                    <a:lnTo>
                      <a:pt x="893" y="755"/>
                    </a:lnTo>
                    <a:lnTo>
                      <a:pt x="893" y="756"/>
                    </a:lnTo>
                    <a:lnTo>
                      <a:pt x="894" y="756"/>
                    </a:lnTo>
                    <a:lnTo>
                      <a:pt x="894" y="755"/>
                    </a:lnTo>
                    <a:lnTo>
                      <a:pt x="895" y="755"/>
                    </a:lnTo>
                    <a:lnTo>
                      <a:pt x="895" y="756"/>
                    </a:lnTo>
                    <a:lnTo>
                      <a:pt x="896" y="756"/>
                    </a:lnTo>
                    <a:lnTo>
                      <a:pt x="896" y="754"/>
                    </a:lnTo>
                    <a:lnTo>
                      <a:pt x="897" y="756"/>
                    </a:lnTo>
                    <a:lnTo>
                      <a:pt x="897" y="757"/>
                    </a:lnTo>
                    <a:lnTo>
                      <a:pt x="898" y="755"/>
                    </a:lnTo>
                    <a:lnTo>
                      <a:pt x="898" y="756"/>
                    </a:lnTo>
                    <a:lnTo>
                      <a:pt x="899" y="756"/>
                    </a:lnTo>
                    <a:lnTo>
                      <a:pt x="899" y="755"/>
                    </a:lnTo>
                    <a:lnTo>
                      <a:pt x="900" y="755"/>
                    </a:lnTo>
                    <a:lnTo>
                      <a:pt x="900" y="756"/>
                    </a:lnTo>
                    <a:lnTo>
                      <a:pt x="901" y="756"/>
                    </a:lnTo>
                    <a:lnTo>
                      <a:pt x="901" y="756"/>
                    </a:lnTo>
                    <a:lnTo>
                      <a:pt x="902" y="755"/>
                    </a:lnTo>
                    <a:lnTo>
                      <a:pt x="902" y="757"/>
                    </a:lnTo>
                    <a:lnTo>
                      <a:pt x="903" y="756"/>
                    </a:lnTo>
                    <a:lnTo>
                      <a:pt x="903" y="755"/>
                    </a:lnTo>
                    <a:lnTo>
                      <a:pt x="904" y="755"/>
                    </a:lnTo>
                    <a:lnTo>
                      <a:pt x="904" y="756"/>
                    </a:lnTo>
                    <a:lnTo>
                      <a:pt x="905" y="756"/>
                    </a:lnTo>
                    <a:lnTo>
                      <a:pt x="905" y="755"/>
                    </a:lnTo>
                    <a:lnTo>
                      <a:pt x="906" y="757"/>
                    </a:lnTo>
                    <a:lnTo>
                      <a:pt x="906" y="756"/>
                    </a:lnTo>
                    <a:lnTo>
                      <a:pt x="907" y="757"/>
                    </a:lnTo>
                    <a:lnTo>
                      <a:pt x="907" y="755"/>
                    </a:lnTo>
                    <a:lnTo>
                      <a:pt x="908" y="756"/>
                    </a:lnTo>
                    <a:lnTo>
                      <a:pt x="908" y="755"/>
                    </a:lnTo>
                    <a:lnTo>
                      <a:pt x="909" y="755"/>
                    </a:lnTo>
                    <a:lnTo>
                      <a:pt x="909" y="756"/>
                    </a:lnTo>
                    <a:lnTo>
                      <a:pt x="910" y="756"/>
                    </a:lnTo>
                    <a:lnTo>
                      <a:pt x="910" y="755"/>
                    </a:lnTo>
                    <a:lnTo>
                      <a:pt x="911" y="755"/>
                    </a:lnTo>
                    <a:lnTo>
                      <a:pt x="911" y="756"/>
                    </a:lnTo>
                    <a:lnTo>
                      <a:pt x="912" y="755"/>
                    </a:lnTo>
                    <a:lnTo>
                      <a:pt x="912" y="756"/>
                    </a:lnTo>
                    <a:lnTo>
                      <a:pt x="913" y="755"/>
                    </a:lnTo>
                    <a:lnTo>
                      <a:pt x="913" y="756"/>
                    </a:lnTo>
                    <a:lnTo>
                      <a:pt x="914" y="756"/>
                    </a:lnTo>
                    <a:lnTo>
                      <a:pt x="914" y="755"/>
                    </a:lnTo>
                    <a:lnTo>
                      <a:pt x="915" y="755"/>
                    </a:lnTo>
                    <a:lnTo>
                      <a:pt x="915" y="756"/>
                    </a:lnTo>
                    <a:lnTo>
                      <a:pt x="916" y="755"/>
                    </a:lnTo>
                    <a:lnTo>
                      <a:pt x="916" y="756"/>
                    </a:lnTo>
                    <a:lnTo>
                      <a:pt x="917" y="756"/>
                    </a:lnTo>
                    <a:lnTo>
                      <a:pt x="917" y="755"/>
                    </a:lnTo>
                    <a:lnTo>
                      <a:pt x="918" y="756"/>
                    </a:lnTo>
                    <a:lnTo>
                      <a:pt x="918" y="755"/>
                    </a:lnTo>
                    <a:lnTo>
                      <a:pt x="919" y="756"/>
                    </a:lnTo>
                    <a:lnTo>
                      <a:pt x="919" y="755"/>
                    </a:lnTo>
                    <a:lnTo>
                      <a:pt x="920" y="755"/>
                    </a:lnTo>
                    <a:lnTo>
                      <a:pt x="920" y="756"/>
                    </a:lnTo>
                    <a:lnTo>
                      <a:pt x="921" y="755"/>
                    </a:lnTo>
                    <a:lnTo>
                      <a:pt x="921" y="756"/>
                    </a:lnTo>
                    <a:lnTo>
                      <a:pt x="922" y="756"/>
                    </a:lnTo>
                    <a:lnTo>
                      <a:pt x="922" y="755"/>
                    </a:lnTo>
                    <a:lnTo>
                      <a:pt x="923" y="755"/>
                    </a:lnTo>
                    <a:lnTo>
                      <a:pt x="923" y="756"/>
                    </a:lnTo>
                    <a:lnTo>
                      <a:pt x="924" y="756"/>
                    </a:lnTo>
                    <a:lnTo>
                      <a:pt x="924" y="756"/>
                    </a:lnTo>
                    <a:lnTo>
                      <a:pt x="925" y="755"/>
                    </a:lnTo>
                    <a:lnTo>
                      <a:pt x="925" y="756"/>
                    </a:lnTo>
                    <a:lnTo>
                      <a:pt x="926" y="756"/>
                    </a:lnTo>
                    <a:lnTo>
                      <a:pt x="926" y="755"/>
                    </a:lnTo>
                    <a:lnTo>
                      <a:pt x="927" y="755"/>
                    </a:lnTo>
                    <a:lnTo>
                      <a:pt x="927" y="756"/>
                    </a:lnTo>
                    <a:lnTo>
                      <a:pt x="928" y="756"/>
                    </a:lnTo>
                    <a:lnTo>
                      <a:pt x="928" y="754"/>
                    </a:lnTo>
                    <a:lnTo>
                      <a:pt x="929" y="756"/>
                    </a:lnTo>
                    <a:lnTo>
                      <a:pt x="929" y="755"/>
                    </a:lnTo>
                    <a:lnTo>
                      <a:pt x="930" y="756"/>
                    </a:lnTo>
                    <a:lnTo>
                      <a:pt x="930" y="756"/>
                    </a:lnTo>
                    <a:lnTo>
                      <a:pt x="931" y="755"/>
                    </a:lnTo>
                    <a:lnTo>
                      <a:pt x="931" y="756"/>
                    </a:lnTo>
                    <a:lnTo>
                      <a:pt x="932" y="755"/>
                    </a:lnTo>
                    <a:lnTo>
                      <a:pt x="932" y="756"/>
                    </a:lnTo>
                    <a:lnTo>
                      <a:pt x="933" y="756"/>
                    </a:lnTo>
                    <a:lnTo>
                      <a:pt x="933" y="756"/>
                    </a:lnTo>
                    <a:lnTo>
                      <a:pt x="934" y="755"/>
                    </a:lnTo>
                    <a:lnTo>
                      <a:pt x="934" y="755"/>
                    </a:lnTo>
                    <a:lnTo>
                      <a:pt x="935" y="755"/>
                    </a:lnTo>
                    <a:lnTo>
                      <a:pt x="935" y="745"/>
                    </a:lnTo>
                    <a:lnTo>
                      <a:pt x="936" y="745"/>
                    </a:lnTo>
                    <a:lnTo>
                      <a:pt x="936" y="738"/>
                    </a:lnTo>
                    <a:lnTo>
                      <a:pt x="937" y="737"/>
                    </a:lnTo>
                    <a:lnTo>
                      <a:pt x="937" y="734"/>
                    </a:lnTo>
                    <a:lnTo>
                      <a:pt x="938" y="733"/>
                    </a:lnTo>
                    <a:lnTo>
                      <a:pt x="938" y="736"/>
                    </a:lnTo>
                    <a:lnTo>
                      <a:pt x="939" y="736"/>
                    </a:lnTo>
                    <a:lnTo>
                      <a:pt x="939" y="734"/>
                    </a:lnTo>
                    <a:lnTo>
                      <a:pt x="940" y="737"/>
                    </a:lnTo>
                    <a:lnTo>
                      <a:pt x="940" y="732"/>
                    </a:lnTo>
                    <a:lnTo>
                      <a:pt x="941" y="728"/>
                    </a:lnTo>
                    <a:lnTo>
                      <a:pt x="941" y="735"/>
                    </a:lnTo>
                    <a:lnTo>
                      <a:pt x="942" y="737"/>
                    </a:lnTo>
                    <a:lnTo>
                      <a:pt x="942" y="735"/>
                    </a:lnTo>
                    <a:lnTo>
                      <a:pt x="943" y="734"/>
                    </a:lnTo>
                    <a:lnTo>
                      <a:pt x="943" y="733"/>
                    </a:lnTo>
                    <a:lnTo>
                      <a:pt x="944" y="736"/>
                    </a:lnTo>
                    <a:lnTo>
                      <a:pt x="944" y="731"/>
                    </a:lnTo>
                    <a:lnTo>
                      <a:pt x="945" y="733"/>
                    </a:lnTo>
                    <a:lnTo>
                      <a:pt x="945" y="735"/>
                    </a:lnTo>
                    <a:lnTo>
                      <a:pt x="946" y="733"/>
                    </a:lnTo>
                    <a:lnTo>
                      <a:pt x="946" y="737"/>
                    </a:lnTo>
                    <a:lnTo>
                      <a:pt x="947" y="733"/>
                    </a:lnTo>
                    <a:lnTo>
                      <a:pt x="947" y="741"/>
                    </a:lnTo>
                    <a:lnTo>
                      <a:pt x="948" y="737"/>
                    </a:lnTo>
                    <a:lnTo>
                      <a:pt x="948" y="734"/>
                    </a:lnTo>
                    <a:lnTo>
                      <a:pt x="949" y="733"/>
                    </a:lnTo>
                    <a:lnTo>
                      <a:pt x="949" y="738"/>
                    </a:lnTo>
                    <a:lnTo>
                      <a:pt x="950" y="740"/>
                    </a:lnTo>
                    <a:lnTo>
                      <a:pt x="950" y="738"/>
                    </a:lnTo>
                    <a:lnTo>
                      <a:pt x="951" y="735"/>
                    </a:lnTo>
                    <a:lnTo>
                      <a:pt x="951" y="740"/>
                    </a:lnTo>
                    <a:lnTo>
                      <a:pt x="952" y="742"/>
                    </a:lnTo>
                    <a:lnTo>
                      <a:pt x="952" y="736"/>
                    </a:lnTo>
                    <a:lnTo>
                      <a:pt x="953" y="739"/>
                    </a:lnTo>
                    <a:lnTo>
                      <a:pt x="953" y="735"/>
                    </a:lnTo>
                    <a:lnTo>
                      <a:pt x="954" y="736"/>
                    </a:lnTo>
                    <a:lnTo>
                      <a:pt x="954" y="742"/>
                    </a:lnTo>
                    <a:lnTo>
                      <a:pt x="955" y="742"/>
                    </a:lnTo>
                    <a:lnTo>
                      <a:pt x="955" y="739"/>
                    </a:lnTo>
                    <a:lnTo>
                      <a:pt x="956" y="743"/>
                    </a:lnTo>
                    <a:lnTo>
                      <a:pt x="956" y="739"/>
                    </a:lnTo>
                    <a:lnTo>
                      <a:pt x="957" y="739"/>
                    </a:lnTo>
                    <a:lnTo>
                      <a:pt x="957" y="742"/>
                    </a:lnTo>
                    <a:lnTo>
                      <a:pt x="958" y="741"/>
                    </a:lnTo>
                    <a:lnTo>
                      <a:pt x="958" y="739"/>
                    </a:lnTo>
                    <a:lnTo>
                      <a:pt x="959" y="738"/>
                    </a:lnTo>
                    <a:lnTo>
                      <a:pt x="959" y="744"/>
                    </a:lnTo>
                    <a:lnTo>
                      <a:pt x="960" y="744"/>
                    </a:lnTo>
                    <a:lnTo>
                      <a:pt x="960" y="738"/>
                    </a:lnTo>
                    <a:lnTo>
                      <a:pt x="961" y="744"/>
                    </a:lnTo>
                    <a:lnTo>
                      <a:pt x="961" y="737"/>
                    </a:lnTo>
                    <a:lnTo>
                      <a:pt x="962" y="746"/>
                    </a:lnTo>
                    <a:lnTo>
                      <a:pt x="962" y="744"/>
                    </a:lnTo>
                    <a:lnTo>
                      <a:pt x="963" y="740"/>
                    </a:lnTo>
                    <a:lnTo>
                      <a:pt x="963" y="745"/>
                    </a:lnTo>
                    <a:lnTo>
                      <a:pt x="964" y="745"/>
                    </a:lnTo>
                    <a:lnTo>
                      <a:pt x="964" y="742"/>
                    </a:lnTo>
                    <a:lnTo>
                      <a:pt x="965" y="742"/>
                    </a:lnTo>
                    <a:lnTo>
                      <a:pt x="965" y="743"/>
                    </a:lnTo>
                    <a:lnTo>
                      <a:pt x="966" y="743"/>
                    </a:lnTo>
                    <a:lnTo>
                      <a:pt x="966" y="745"/>
                    </a:lnTo>
                    <a:lnTo>
                      <a:pt x="967" y="745"/>
                    </a:lnTo>
                    <a:lnTo>
                      <a:pt x="967" y="743"/>
                    </a:lnTo>
                    <a:lnTo>
                      <a:pt x="968" y="747"/>
                    </a:lnTo>
                    <a:lnTo>
                      <a:pt x="968" y="742"/>
                    </a:lnTo>
                    <a:lnTo>
                      <a:pt x="969" y="743"/>
                    </a:lnTo>
                    <a:lnTo>
                      <a:pt x="969" y="745"/>
                    </a:lnTo>
                    <a:lnTo>
                      <a:pt x="970" y="746"/>
                    </a:lnTo>
                    <a:lnTo>
                      <a:pt x="970" y="743"/>
                    </a:lnTo>
                    <a:lnTo>
                      <a:pt x="971" y="743"/>
                    </a:lnTo>
                    <a:lnTo>
                      <a:pt x="971" y="746"/>
                    </a:lnTo>
                    <a:lnTo>
                      <a:pt x="972" y="744"/>
                    </a:lnTo>
                    <a:lnTo>
                      <a:pt x="972" y="746"/>
                    </a:lnTo>
                    <a:lnTo>
                      <a:pt x="973" y="747"/>
                    </a:lnTo>
                    <a:lnTo>
                      <a:pt x="973" y="743"/>
                    </a:lnTo>
                    <a:lnTo>
                      <a:pt x="974" y="744"/>
                    </a:lnTo>
                    <a:lnTo>
                      <a:pt x="974" y="747"/>
                    </a:lnTo>
                    <a:lnTo>
                      <a:pt x="975" y="747"/>
                    </a:lnTo>
                    <a:lnTo>
                      <a:pt x="975" y="744"/>
                    </a:lnTo>
                    <a:lnTo>
                      <a:pt x="976" y="744"/>
                    </a:lnTo>
                    <a:lnTo>
                      <a:pt x="976" y="748"/>
                    </a:lnTo>
                    <a:lnTo>
                      <a:pt x="977" y="747"/>
                    </a:lnTo>
                    <a:lnTo>
                      <a:pt x="977" y="744"/>
                    </a:lnTo>
                    <a:lnTo>
                      <a:pt x="978" y="750"/>
                    </a:lnTo>
                    <a:lnTo>
                      <a:pt x="978" y="743"/>
                    </a:lnTo>
                    <a:lnTo>
                      <a:pt x="979" y="747"/>
                    </a:lnTo>
                    <a:lnTo>
                      <a:pt x="979" y="745"/>
                    </a:lnTo>
                    <a:lnTo>
                      <a:pt x="980" y="746"/>
                    </a:lnTo>
                    <a:lnTo>
                      <a:pt x="980" y="749"/>
                    </a:lnTo>
                    <a:lnTo>
                      <a:pt x="981" y="748"/>
                    </a:lnTo>
                    <a:lnTo>
                      <a:pt x="981" y="746"/>
                    </a:lnTo>
                    <a:lnTo>
                      <a:pt x="982" y="748"/>
                    </a:lnTo>
                    <a:lnTo>
                      <a:pt x="982" y="747"/>
                    </a:lnTo>
                    <a:lnTo>
                      <a:pt x="983" y="747"/>
                    </a:lnTo>
                    <a:lnTo>
                      <a:pt x="983" y="749"/>
                    </a:lnTo>
                    <a:lnTo>
                      <a:pt x="984" y="749"/>
                    </a:lnTo>
                    <a:lnTo>
                      <a:pt x="984" y="747"/>
                    </a:lnTo>
                    <a:lnTo>
                      <a:pt x="985" y="746"/>
                    </a:lnTo>
                    <a:lnTo>
                      <a:pt x="985" y="749"/>
                    </a:lnTo>
                    <a:lnTo>
                      <a:pt x="986" y="750"/>
                    </a:lnTo>
                    <a:lnTo>
                      <a:pt x="986" y="747"/>
                    </a:lnTo>
                    <a:lnTo>
                      <a:pt x="987" y="747"/>
                    </a:lnTo>
                    <a:lnTo>
                      <a:pt x="987" y="751"/>
                    </a:lnTo>
                    <a:lnTo>
                      <a:pt x="988" y="747"/>
                    </a:lnTo>
                    <a:lnTo>
                      <a:pt x="988" y="751"/>
                    </a:lnTo>
                    <a:lnTo>
                      <a:pt x="989" y="748"/>
                    </a:lnTo>
                    <a:lnTo>
                      <a:pt x="989" y="749"/>
                    </a:lnTo>
                    <a:lnTo>
                      <a:pt x="990" y="749"/>
                    </a:lnTo>
                    <a:lnTo>
                      <a:pt x="990" y="748"/>
                    </a:lnTo>
                    <a:lnTo>
                      <a:pt x="991" y="749"/>
                    </a:lnTo>
                    <a:lnTo>
                      <a:pt x="991" y="751"/>
                    </a:lnTo>
                    <a:lnTo>
                      <a:pt x="992" y="751"/>
                    </a:lnTo>
                    <a:lnTo>
                      <a:pt x="992" y="748"/>
                    </a:lnTo>
                    <a:lnTo>
                      <a:pt x="993" y="749"/>
                    </a:lnTo>
                    <a:lnTo>
                      <a:pt x="993" y="751"/>
                    </a:lnTo>
                    <a:lnTo>
                      <a:pt x="994" y="749"/>
                    </a:lnTo>
                    <a:lnTo>
                      <a:pt x="994" y="751"/>
                    </a:lnTo>
                    <a:lnTo>
                      <a:pt x="995" y="750"/>
                    </a:lnTo>
                    <a:lnTo>
                      <a:pt x="995" y="749"/>
                    </a:lnTo>
                    <a:lnTo>
                      <a:pt x="996" y="751"/>
                    </a:lnTo>
                    <a:lnTo>
                      <a:pt x="996" y="749"/>
                    </a:lnTo>
                    <a:lnTo>
                      <a:pt x="997" y="751"/>
                    </a:lnTo>
                    <a:lnTo>
                      <a:pt x="997" y="749"/>
                    </a:lnTo>
                    <a:lnTo>
                      <a:pt x="998" y="753"/>
                    </a:lnTo>
                    <a:lnTo>
                      <a:pt x="998" y="749"/>
                    </a:lnTo>
                    <a:lnTo>
                      <a:pt x="999" y="750"/>
                    </a:lnTo>
                    <a:lnTo>
                      <a:pt x="999" y="751"/>
                    </a:lnTo>
                    <a:lnTo>
                      <a:pt x="1000" y="750"/>
                    </a:lnTo>
                    <a:lnTo>
                      <a:pt x="1000" y="752"/>
                    </a:lnTo>
                    <a:lnTo>
                      <a:pt x="1001" y="750"/>
                    </a:lnTo>
                    <a:lnTo>
                      <a:pt x="1001" y="751"/>
                    </a:lnTo>
                    <a:lnTo>
                      <a:pt x="1002" y="750"/>
                    </a:lnTo>
                    <a:lnTo>
                      <a:pt x="1002" y="752"/>
                    </a:lnTo>
                    <a:lnTo>
                      <a:pt x="1003" y="751"/>
                    </a:lnTo>
                    <a:lnTo>
                      <a:pt x="1003" y="750"/>
                    </a:lnTo>
                    <a:lnTo>
                      <a:pt x="1004" y="749"/>
                    </a:lnTo>
                    <a:lnTo>
                      <a:pt x="1004" y="752"/>
                    </a:lnTo>
                    <a:lnTo>
                      <a:pt x="1005" y="750"/>
                    </a:lnTo>
                    <a:lnTo>
                      <a:pt x="1005" y="753"/>
                    </a:lnTo>
                    <a:lnTo>
                      <a:pt x="1006" y="749"/>
                    </a:lnTo>
                    <a:lnTo>
                      <a:pt x="1006" y="752"/>
                    </a:lnTo>
                    <a:lnTo>
                      <a:pt x="1007" y="751"/>
                    </a:lnTo>
                    <a:lnTo>
                      <a:pt x="1007" y="753"/>
                    </a:lnTo>
                    <a:lnTo>
                      <a:pt x="1008" y="752"/>
                    </a:lnTo>
                    <a:lnTo>
                      <a:pt x="1008" y="751"/>
                    </a:lnTo>
                    <a:lnTo>
                      <a:pt x="1009" y="751"/>
                    </a:lnTo>
                    <a:lnTo>
                      <a:pt x="1009" y="752"/>
                    </a:lnTo>
                    <a:lnTo>
                      <a:pt x="1010" y="752"/>
                    </a:lnTo>
                    <a:lnTo>
                      <a:pt x="1010" y="753"/>
                    </a:lnTo>
                    <a:lnTo>
                      <a:pt x="1011" y="751"/>
                    </a:lnTo>
                    <a:lnTo>
                      <a:pt x="1011" y="753"/>
                    </a:lnTo>
                    <a:lnTo>
                      <a:pt x="1012" y="754"/>
                    </a:lnTo>
                    <a:lnTo>
                      <a:pt x="1012" y="752"/>
                    </a:lnTo>
                    <a:lnTo>
                      <a:pt x="1013" y="753"/>
                    </a:lnTo>
                    <a:lnTo>
                      <a:pt x="1013" y="751"/>
                    </a:lnTo>
                    <a:lnTo>
                      <a:pt x="1014" y="751"/>
                    </a:lnTo>
                    <a:lnTo>
                      <a:pt x="1014" y="754"/>
                    </a:lnTo>
                    <a:lnTo>
                      <a:pt x="1015" y="751"/>
                    </a:lnTo>
                    <a:lnTo>
                      <a:pt x="1015" y="754"/>
                    </a:lnTo>
                    <a:lnTo>
                      <a:pt x="1016" y="754"/>
                    </a:lnTo>
                    <a:lnTo>
                      <a:pt x="1016" y="752"/>
                    </a:lnTo>
                    <a:lnTo>
                      <a:pt x="1017" y="753"/>
                    </a:lnTo>
                    <a:lnTo>
                      <a:pt x="1017" y="753"/>
                    </a:lnTo>
                    <a:lnTo>
                      <a:pt x="1018" y="752"/>
                    </a:lnTo>
                    <a:lnTo>
                      <a:pt x="1018" y="753"/>
                    </a:lnTo>
                    <a:lnTo>
                      <a:pt x="1019" y="754"/>
                    </a:lnTo>
                    <a:lnTo>
                      <a:pt x="1019" y="753"/>
                    </a:lnTo>
                    <a:lnTo>
                      <a:pt x="1020" y="754"/>
                    </a:lnTo>
                    <a:lnTo>
                      <a:pt x="1020" y="753"/>
                    </a:lnTo>
                    <a:lnTo>
                      <a:pt x="1021" y="753"/>
                    </a:lnTo>
                    <a:lnTo>
                      <a:pt x="1021" y="754"/>
                    </a:lnTo>
                    <a:lnTo>
                      <a:pt x="1022" y="754"/>
                    </a:lnTo>
                    <a:lnTo>
                      <a:pt x="1022" y="752"/>
                    </a:lnTo>
                    <a:lnTo>
                      <a:pt x="1023" y="754"/>
                    </a:lnTo>
                    <a:lnTo>
                      <a:pt x="1023" y="753"/>
                    </a:lnTo>
                    <a:lnTo>
                      <a:pt x="1024" y="755"/>
                    </a:lnTo>
                    <a:lnTo>
                      <a:pt x="1024" y="753"/>
                    </a:lnTo>
                    <a:lnTo>
                      <a:pt x="1025" y="754"/>
                    </a:lnTo>
                    <a:lnTo>
                      <a:pt x="1025" y="753"/>
                    </a:lnTo>
                    <a:lnTo>
                      <a:pt x="1026" y="753"/>
                    </a:lnTo>
                    <a:lnTo>
                      <a:pt x="1026" y="755"/>
                    </a:lnTo>
                    <a:lnTo>
                      <a:pt x="1027" y="754"/>
                    </a:lnTo>
                    <a:lnTo>
                      <a:pt x="1027" y="755"/>
                    </a:lnTo>
                    <a:lnTo>
                      <a:pt x="1028" y="754"/>
                    </a:lnTo>
                    <a:lnTo>
                      <a:pt x="1028" y="755"/>
                    </a:lnTo>
                    <a:lnTo>
                      <a:pt x="1029" y="754"/>
                    </a:lnTo>
                    <a:lnTo>
                      <a:pt x="1029" y="754"/>
                    </a:lnTo>
                    <a:lnTo>
                      <a:pt x="1030" y="755"/>
                    </a:lnTo>
                    <a:lnTo>
                      <a:pt x="1030" y="753"/>
                    </a:lnTo>
                    <a:lnTo>
                      <a:pt x="1031" y="754"/>
                    </a:lnTo>
                    <a:lnTo>
                      <a:pt x="1031" y="755"/>
                    </a:lnTo>
                    <a:lnTo>
                      <a:pt x="1032" y="755"/>
                    </a:lnTo>
                    <a:lnTo>
                      <a:pt x="1032" y="754"/>
                    </a:lnTo>
                    <a:lnTo>
                      <a:pt x="1033" y="754"/>
                    </a:lnTo>
                    <a:lnTo>
                      <a:pt x="1033" y="755"/>
                    </a:lnTo>
                    <a:lnTo>
                      <a:pt x="1034" y="754"/>
                    </a:lnTo>
                    <a:lnTo>
                      <a:pt x="1034" y="755"/>
                    </a:lnTo>
                    <a:lnTo>
                      <a:pt x="1035" y="755"/>
                    </a:lnTo>
                    <a:lnTo>
                      <a:pt x="1035" y="754"/>
                    </a:lnTo>
                    <a:lnTo>
                      <a:pt x="1036" y="754"/>
                    </a:lnTo>
                    <a:lnTo>
                      <a:pt x="1036" y="755"/>
                    </a:lnTo>
                    <a:lnTo>
                      <a:pt x="1037" y="755"/>
                    </a:lnTo>
                    <a:lnTo>
                      <a:pt x="1037" y="754"/>
                    </a:lnTo>
                    <a:lnTo>
                      <a:pt x="1038" y="756"/>
                    </a:lnTo>
                    <a:lnTo>
                      <a:pt x="1038" y="755"/>
                    </a:lnTo>
                    <a:lnTo>
                      <a:pt x="1039" y="755"/>
                    </a:lnTo>
                    <a:lnTo>
                      <a:pt x="1039" y="755"/>
                    </a:lnTo>
                    <a:lnTo>
                      <a:pt x="1040" y="755"/>
                    </a:lnTo>
                    <a:lnTo>
                      <a:pt x="1040" y="755"/>
                    </a:lnTo>
                    <a:lnTo>
                      <a:pt x="1041" y="755"/>
                    </a:lnTo>
                    <a:lnTo>
                      <a:pt x="1041" y="755"/>
                    </a:lnTo>
                    <a:lnTo>
                      <a:pt x="1042" y="755"/>
                    </a:lnTo>
                    <a:lnTo>
                      <a:pt x="1042" y="755"/>
                    </a:lnTo>
                    <a:lnTo>
                      <a:pt x="1043" y="755"/>
                    </a:lnTo>
                    <a:lnTo>
                      <a:pt x="1043" y="755"/>
                    </a:lnTo>
                    <a:lnTo>
                      <a:pt x="1044" y="755"/>
                    </a:lnTo>
                    <a:lnTo>
                      <a:pt x="1044" y="755"/>
                    </a:lnTo>
                    <a:lnTo>
                      <a:pt x="1045" y="755"/>
                    </a:lnTo>
                    <a:lnTo>
                      <a:pt x="1045" y="755"/>
                    </a:lnTo>
                    <a:lnTo>
                      <a:pt x="1046" y="755"/>
                    </a:lnTo>
                    <a:lnTo>
                      <a:pt x="1046" y="754"/>
                    </a:lnTo>
                    <a:lnTo>
                      <a:pt x="1047" y="755"/>
                    </a:lnTo>
                    <a:lnTo>
                      <a:pt x="1047" y="755"/>
                    </a:lnTo>
                    <a:lnTo>
                      <a:pt x="1048" y="756"/>
                    </a:lnTo>
                    <a:lnTo>
                      <a:pt x="1048" y="755"/>
                    </a:lnTo>
                    <a:lnTo>
                      <a:pt x="1049" y="755"/>
                    </a:lnTo>
                    <a:lnTo>
                      <a:pt x="1049" y="754"/>
                    </a:lnTo>
                    <a:lnTo>
                      <a:pt x="1050" y="756"/>
                    </a:lnTo>
                    <a:lnTo>
                      <a:pt x="1050" y="755"/>
                    </a:lnTo>
                    <a:lnTo>
                      <a:pt x="1051" y="755"/>
                    </a:lnTo>
                    <a:lnTo>
                      <a:pt x="1051" y="754"/>
                    </a:lnTo>
                    <a:lnTo>
                      <a:pt x="1052" y="754"/>
                    </a:lnTo>
                    <a:lnTo>
                      <a:pt x="1052" y="755"/>
                    </a:lnTo>
                    <a:lnTo>
                      <a:pt x="1053" y="756"/>
                    </a:lnTo>
                    <a:lnTo>
                      <a:pt x="1053" y="754"/>
                    </a:lnTo>
                    <a:lnTo>
                      <a:pt x="1054" y="754"/>
                    </a:lnTo>
                    <a:lnTo>
                      <a:pt x="1054" y="756"/>
                    </a:lnTo>
                    <a:lnTo>
                      <a:pt x="1055" y="755"/>
                    </a:lnTo>
                    <a:lnTo>
                      <a:pt x="1055" y="754"/>
                    </a:lnTo>
                    <a:lnTo>
                      <a:pt x="1056" y="754"/>
                    </a:lnTo>
                    <a:lnTo>
                      <a:pt x="1056" y="756"/>
                    </a:lnTo>
                    <a:lnTo>
                      <a:pt x="1057" y="755"/>
                    </a:lnTo>
                    <a:lnTo>
                      <a:pt x="1057" y="755"/>
                    </a:lnTo>
                    <a:lnTo>
                      <a:pt x="1058" y="754"/>
                    </a:lnTo>
                    <a:lnTo>
                      <a:pt x="1058" y="755"/>
                    </a:lnTo>
                    <a:lnTo>
                      <a:pt x="1059" y="756"/>
                    </a:lnTo>
                    <a:lnTo>
                      <a:pt x="1059" y="755"/>
                    </a:lnTo>
                    <a:lnTo>
                      <a:pt x="1060" y="754"/>
                    </a:lnTo>
                    <a:lnTo>
                      <a:pt x="1060" y="755"/>
                    </a:lnTo>
                    <a:lnTo>
                      <a:pt x="1061" y="755"/>
                    </a:lnTo>
                    <a:lnTo>
                      <a:pt x="1061" y="755"/>
                    </a:lnTo>
                    <a:lnTo>
                      <a:pt x="1062" y="754"/>
                    </a:lnTo>
                    <a:lnTo>
                      <a:pt x="1062" y="755"/>
                    </a:lnTo>
                    <a:lnTo>
                      <a:pt x="1063" y="754"/>
                    </a:lnTo>
                    <a:lnTo>
                      <a:pt x="1063" y="756"/>
                    </a:lnTo>
                    <a:lnTo>
                      <a:pt x="1064" y="755"/>
                    </a:lnTo>
                    <a:lnTo>
                      <a:pt x="1064" y="756"/>
                    </a:lnTo>
                    <a:lnTo>
                      <a:pt x="1065" y="754"/>
                    </a:lnTo>
                    <a:lnTo>
                      <a:pt x="1065" y="755"/>
                    </a:lnTo>
                    <a:lnTo>
                      <a:pt x="1066" y="754"/>
                    </a:lnTo>
                    <a:lnTo>
                      <a:pt x="1066" y="756"/>
                    </a:lnTo>
                    <a:lnTo>
                      <a:pt x="1067" y="754"/>
                    </a:lnTo>
                    <a:lnTo>
                      <a:pt x="1067" y="756"/>
                    </a:lnTo>
                    <a:lnTo>
                      <a:pt x="1068" y="755"/>
                    </a:lnTo>
                    <a:lnTo>
                      <a:pt x="1068" y="756"/>
                    </a:lnTo>
                    <a:lnTo>
                      <a:pt x="1069" y="755"/>
                    </a:lnTo>
                    <a:lnTo>
                      <a:pt x="1069" y="755"/>
                    </a:lnTo>
                    <a:lnTo>
                      <a:pt x="1070" y="754"/>
                    </a:lnTo>
                    <a:lnTo>
                      <a:pt x="1070" y="755"/>
                    </a:lnTo>
                    <a:lnTo>
                      <a:pt x="1071" y="755"/>
                    </a:lnTo>
                    <a:lnTo>
                      <a:pt x="1071" y="755"/>
                    </a:lnTo>
                    <a:lnTo>
                      <a:pt x="1072" y="756"/>
                    </a:lnTo>
                    <a:lnTo>
                      <a:pt x="1072" y="754"/>
                    </a:lnTo>
                    <a:lnTo>
                      <a:pt x="1073" y="754"/>
                    </a:lnTo>
                    <a:lnTo>
                      <a:pt x="1073" y="755"/>
                    </a:lnTo>
                    <a:lnTo>
                      <a:pt x="1074" y="756"/>
                    </a:lnTo>
                    <a:lnTo>
                      <a:pt x="1074" y="755"/>
                    </a:lnTo>
                    <a:lnTo>
                      <a:pt x="1075" y="755"/>
                    </a:lnTo>
                    <a:lnTo>
                      <a:pt x="1075" y="755"/>
                    </a:lnTo>
                    <a:lnTo>
                      <a:pt x="1076" y="754"/>
                    </a:lnTo>
                    <a:lnTo>
                      <a:pt x="1076" y="756"/>
                    </a:lnTo>
                    <a:lnTo>
                      <a:pt x="1077" y="754"/>
                    </a:lnTo>
                    <a:lnTo>
                      <a:pt x="1077" y="755"/>
                    </a:lnTo>
                    <a:lnTo>
                      <a:pt x="1078" y="755"/>
                    </a:lnTo>
                    <a:lnTo>
                      <a:pt x="1078" y="754"/>
                    </a:lnTo>
                    <a:lnTo>
                      <a:pt x="1079" y="755"/>
                    </a:lnTo>
                    <a:lnTo>
                      <a:pt x="1079" y="755"/>
                    </a:lnTo>
                    <a:lnTo>
                      <a:pt x="1080" y="755"/>
                    </a:lnTo>
                    <a:lnTo>
                      <a:pt x="1080" y="755"/>
                    </a:lnTo>
                    <a:lnTo>
                      <a:pt x="1081" y="756"/>
                    </a:lnTo>
                    <a:lnTo>
                      <a:pt x="1081" y="754"/>
                    </a:lnTo>
                    <a:lnTo>
                      <a:pt x="1082" y="754"/>
                    </a:lnTo>
                    <a:lnTo>
                      <a:pt x="1082" y="756"/>
                    </a:lnTo>
                    <a:lnTo>
                      <a:pt x="1083" y="755"/>
                    </a:lnTo>
                    <a:lnTo>
                      <a:pt x="1083" y="755"/>
                    </a:lnTo>
                    <a:lnTo>
                      <a:pt x="1084" y="754"/>
                    </a:lnTo>
                    <a:lnTo>
                      <a:pt x="1084" y="755"/>
                    </a:lnTo>
                    <a:lnTo>
                      <a:pt x="1085" y="755"/>
                    </a:lnTo>
                    <a:lnTo>
                      <a:pt x="1085" y="755"/>
                    </a:lnTo>
                    <a:lnTo>
                      <a:pt x="1086" y="755"/>
                    </a:lnTo>
                    <a:lnTo>
                      <a:pt x="1086" y="755"/>
                    </a:lnTo>
                    <a:lnTo>
                      <a:pt x="1087" y="756"/>
                    </a:lnTo>
                    <a:lnTo>
                      <a:pt x="1087" y="755"/>
                    </a:lnTo>
                    <a:lnTo>
                      <a:pt x="1088" y="755"/>
                    </a:lnTo>
                    <a:lnTo>
                      <a:pt x="1088" y="755"/>
                    </a:lnTo>
                    <a:lnTo>
                      <a:pt x="1089" y="754"/>
                    </a:lnTo>
                    <a:lnTo>
                      <a:pt x="1089" y="755"/>
                    </a:lnTo>
                    <a:lnTo>
                      <a:pt x="1090" y="755"/>
                    </a:lnTo>
                    <a:lnTo>
                      <a:pt x="1090" y="754"/>
                    </a:lnTo>
                    <a:lnTo>
                      <a:pt x="1091" y="756"/>
                    </a:lnTo>
                    <a:lnTo>
                      <a:pt x="1091" y="753"/>
                    </a:lnTo>
                    <a:lnTo>
                      <a:pt x="1092" y="755"/>
                    </a:lnTo>
                    <a:lnTo>
                      <a:pt x="1092" y="754"/>
                    </a:lnTo>
                    <a:lnTo>
                      <a:pt x="1093" y="754"/>
                    </a:lnTo>
                    <a:lnTo>
                      <a:pt x="1093" y="755"/>
                    </a:lnTo>
                    <a:lnTo>
                      <a:pt x="1094" y="755"/>
                    </a:lnTo>
                    <a:lnTo>
                      <a:pt x="1094" y="754"/>
                    </a:lnTo>
                    <a:lnTo>
                      <a:pt x="1095" y="755"/>
                    </a:lnTo>
                    <a:lnTo>
                      <a:pt x="1095" y="754"/>
                    </a:lnTo>
                    <a:lnTo>
                      <a:pt x="1096" y="755"/>
                    </a:lnTo>
                    <a:lnTo>
                      <a:pt x="1096" y="754"/>
                    </a:lnTo>
                    <a:lnTo>
                      <a:pt x="1097" y="755"/>
                    </a:lnTo>
                    <a:lnTo>
                      <a:pt x="1097" y="755"/>
                    </a:lnTo>
                    <a:lnTo>
                      <a:pt x="1098" y="754"/>
                    </a:lnTo>
                    <a:lnTo>
                      <a:pt x="1098" y="755"/>
                    </a:lnTo>
                    <a:lnTo>
                      <a:pt x="1099" y="754"/>
                    </a:lnTo>
                    <a:lnTo>
                      <a:pt x="1099" y="755"/>
                    </a:lnTo>
                    <a:lnTo>
                      <a:pt x="1100" y="754"/>
                    </a:lnTo>
                    <a:lnTo>
                      <a:pt x="1100" y="756"/>
                    </a:lnTo>
                    <a:lnTo>
                      <a:pt x="1101" y="755"/>
                    </a:lnTo>
                    <a:lnTo>
                      <a:pt x="1101" y="754"/>
                    </a:lnTo>
                    <a:lnTo>
                      <a:pt x="1102" y="754"/>
                    </a:lnTo>
                    <a:lnTo>
                      <a:pt x="1102" y="755"/>
                    </a:lnTo>
                    <a:lnTo>
                      <a:pt x="1103" y="754"/>
                    </a:lnTo>
                    <a:lnTo>
                      <a:pt x="1103" y="755"/>
                    </a:lnTo>
                    <a:lnTo>
                      <a:pt x="1104" y="754"/>
                    </a:lnTo>
                    <a:lnTo>
                      <a:pt x="1104" y="755"/>
                    </a:lnTo>
                    <a:lnTo>
                      <a:pt x="1105" y="754"/>
                    </a:lnTo>
                    <a:lnTo>
                      <a:pt x="1105" y="755"/>
                    </a:lnTo>
                    <a:lnTo>
                      <a:pt x="1106" y="754"/>
                    </a:lnTo>
                    <a:lnTo>
                      <a:pt x="1106" y="755"/>
                    </a:lnTo>
                    <a:lnTo>
                      <a:pt x="1107" y="755"/>
                    </a:lnTo>
                    <a:lnTo>
                      <a:pt x="1107" y="754"/>
                    </a:lnTo>
                    <a:lnTo>
                      <a:pt x="1108" y="756"/>
                    </a:lnTo>
                    <a:lnTo>
                      <a:pt x="1108" y="755"/>
                    </a:lnTo>
                    <a:lnTo>
                      <a:pt x="1109" y="755"/>
                    </a:lnTo>
                    <a:lnTo>
                      <a:pt x="1109" y="754"/>
                    </a:lnTo>
                    <a:lnTo>
                      <a:pt x="1110" y="755"/>
                    </a:lnTo>
                    <a:lnTo>
                      <a:pt x="1110" y="754"/>
                    </a:lnTo>
                    <a:lnTo>
                      <a:pt x="1111" y="755"/>
                    </a:lnTo>
                    <a:lnTo>
                      <a:pt x="1111" y="754"/>
                    </a:lnTo>
                    <a:lnTo>
                      <a:pt x="1112" y="755"/>
                    </a:lnTo>
                    <a:lnTo>
                      <a:pt x="1112" y="755"/>
                    </a:lnTo>
                    <a:lnTo>
                      <a:pt x="1113" y="754"/>
                    </a:lnTo>
                    <a:lnTo>
                      <a:pt x="1113" y="755"/>
                    </a:lnTo>
                    <a:lnTo>
                      <a:pt x="1114" y="755"/>
                    </a:lnTo>
                    <a:lnTo>
                      <a:pt x="1114" y="755"/>
                    </a:lnTo>
                    <a:lnTo>
                      <a:pt x="1115" y="753"/>
                    </a:lnTo>
                    <a:lnTo>
                      <a:pt x="1115" y="755"/>
                    </a:lnTo>
                    <a:lnTo>
                      <a:pt x="1116" y="755"/>
                    </a:lnTo>
                    <a:lnTo>
                      <a:pt x="1116" y="754"/>
                    </a:lnTo>
                    <a:lnTo>
                      <a:pt x="1117" y="754"/>
                    </a:lnTo>
                    <a:lnTo>
                      <a:pt x="1117" y="755"/>
                    </a:lnTo>
                    <a:lnTo>
                      <a:pt x="1118" y="754"/>
                    </a:lnTo>
                    <a:lnTo>
                      <a:pt x="1118" y="755"/>
                    </a:lnTo>
                    <a:lnTo>
                      <a:pt x="1119" y="755"/>
                    </a:lnTo>
                    <a:lnTo>
                      <a:pt x="1119" y="754"/>
                    </a:lnTo>
                    <a:lnTo>
                      <a:pt x="1120" y="754"/>
                    </a:lnTo>
                    <a:lnTo>
                      <a:pt x="1120" y="755"/>
                    </a:lnTo>
                    <a:lnTo>
                      <a:pt x="1121" y="753"/>
                    </a:lnTo>
                    <a:lnTo>
                      <a:pt x="1121" y="755"/>
                    </a:lnTo>
                    <a:lnTo>
                      <a:pt x="1122" y="754"/>
                    </a:lnTo>
                    <a:lnTo>
                      <a:pt x="1122" y="755"/>
                    </a:lnTo>
                    <a:lnTo>
                      <a:pt x="1123" y="755"/>
                    </a:lnTo>
                    <a:lnTo>
                      <a:pt x="1123" y="754"/>
                    </a:lnTo>
                    <a:lnTo>
                      <a:pt x="1124" y="755"/>
                    </a:lnTo>
                    <a:lnTo>
                      <a:pt x="1124" y="754"/>
                    </a:lnTo>
                    <a:lnTo>
                      <a:pt x="1125" y="754"/>
                    </a:lnTo>
                    <a:lnTo>
                      <a:pt x="1125" y="755"/>
                    </a:lnTo>
                    <a:lnTo>
                      <a:pt x="1126" y="754"/>
                    </a:lnTo>
                    <a:lnTo>
                      <a:pt x="1126" y="755"/>
                    </a:lnTo>
                    <a:lnTo>
                      <a:pt x="1127" y="755"/>
                    </a:lnTo>
                    <a:lnTo>
                      <a:pt x="1127" y="754"/>
                    </a:lnTo>
                    <a:lnTo>
                      <a:pt x="1128" y="755"/>
                    </a:lnTo>
                    <a:lnTo>
                      <a:pt x="1128" y="754"/>
                    </a:lnTo>
                    <a:lnTo>
                      <a:pt x="1129" y="755"/>
                    </a:lnTo>
                    <a:lnTo>
                      <a:pt x="1129" y="754"/>
                    </a:lnTo>
                    <a:lnTo>
                      <a:pt x="1130" y="754"/>
                    </a:lnTo>
                    <a:lnTo>
                      <a:pt x="1130" y="755"/>
                    </a:lnTo>
                    <a:lnTo>
                      <a:pt x="1131" y="755"/>
                    </a:lnTo>
                    <a:lnTo>
                      <a:pt x="1131" y="754"/>
                    </a:lnTo>
                    <a:lnTo>
                      <a:pt x="1132" y="755"/>
                    </a:lnTo>
                    <a:lnTo>
                      <a:pt x="1132" y="753"/>
                    </a:lnTo>
                    <a:lnTo>
                      <a:pt x="1133" y="755"/>
                    </a:lnTo>
                    <a:lnTo>
                      <a:pt x="1133" y="754"/>
                    </a:lnTo>
                    <a:lnTo>
                      <a:pt x="1134" y="755"/>
                    </a:lnTo>
                    <a:lnTo>
                      <a:pt x="1134" y="754"/>
                    </a:lnTo>
                    <a:lnTo>
                      <a:pt x="1135" y="753"/>
                    </a:lnTo>
                    <a:lnTo>
                      <a:pt x="1135" y="754"/>
                    </a:lnTo>
                    <a:lnTo>
                      <a:pt x="1136" y="753"/>
                    </a:lnTo>
                    <a:lnTo>
                      <a:pt x="1136" y="754"/>
                    </a:lnTo>
                    <a:lnTo>
                      <a:pt x="1137" y="755"/>
                    </a:lnTo>
                    <a:lnTo>
                      <a:pt x="1137" y="754"/>
                    </a:lnTo>
                    <a:lnTo>
                      <a:pt x="1138" y="754"/>
                    </a:lnTo>
                    <a:lnTo>
                      <a:pt x="1138" y="755"/>
                    </a:lnTo>
                    <a:lnTo>
                      <a:pt x="1139" y="755"/>
                    </a:lnTo>
                    <a:lnTo>
                      <a:pt x="1139" y="754"/>
                    </a:lnTo>
                    <a:lnTo>
                      <a:pt x="1140" y="754"/>
                    </a:lnTo>
                    <a:lnTo>
                      <a:pt x="1140" y="754"/>
                    </a:lnTo>
                    <a:lnTo>
                      <a:pt x="1141" y="755"/>
                    </a:lnTo>
                    <a:lnTo>
                      <a:pt x="1141" y="753"/>
                    </a:lnTo>
                    <a:lnTo>
                      <a:pt x="1142" y="754"/>
                    </a:lnTo>
                    <a:lnTo>
                      <a:pt x="1142" y="755"/>
                    </a:lnTo>
                    <a:lnTo>
                      <a:pt x="1143" y="754"/>
                    </a:lnTo>
                    <a:lnTo>
                      <a:pt x="1143" y="755"/>
                    </a:lnTo>
                    <a:lnTo>
                      <a:pt x="1144" y="755"/>
                    </a:lnTo>
                    <a:lnTo>
                      <a:pt x="1144" y="754"/>
                    </a:lnTo>
                    <a:lnTo>
                      <a:pt x="1145" y="753"/>
                    </a:lnTo>
                    <a:lnTo>
                      <a:pt x="1145" y="755"/>
                    </a:lnTo>
                    <a:lnTo>
                      <a:pt x="1146" y="754"/>
                    </a:lnTo>
                    <a:lnTo>
                      <a:pt x="1146" y="755"/>
                    </a:lnTo>
                    <a:lnTo>
                      <a:pt x="1147" y="754"/>
                    </a:lnTo>
                    <a:lnTo>
                      <a:pt x="1147" y="754"/>
                    </a:lnTo>
                    <a:lnTo>
                      <a:pt x="1148" y="754"/>
                    </a:lnTo>
                    <a:lnTo>
                      <a:pt x="1148" y="755"/>
                    </a:lnTo>
                    <a:lnTo>
                      <a:pt x="1149" y="754"/>
                    </a:lnTo>
                    <a:lnTo>
                      <a:pt x="1149" y="755"/>
                    </a:lnTo>
                    <a:lnTo>
                      <a:pt x="1150" y="754"/>
                    </a:lnTo>
                    <a:lnTo>
                      <a:pt x="1150" y="754"/>
                    </a:lnTo>
                    <a:lnTo>
                      <a:pt x="1151" y="755"/>
                    </a:lnTo>
                    <a:lnTo>
                      <a:pt x="1151" y="754"/>
                    </a:lnTo>
                    <a:lnTo>
                      <a:pt x="1152" y="754"/>
                    </a:lnTo>
                    <a:lnTo>
                      <a:pt x="1152" y="755"/>
                    </a:lnTo>
                    <a:lnTo>
                      <a:pt x="1153" y="755"/>
                    </a:lnTo>
                    <a:lnTo>
                      <a:pt x="1153" y="754"/>
                    </a:lnTo>
                    <a:lnTo>
                      <a:pt x="1154" y="754"/>
                    </a:lnTo>
                    <a:lnTo>
                      <a:pt x="1154" y="753"/>
                    </a:lnTo>
                    <a:lnTo>
                      <a:pt x="1155" y="754"/>
                    </a:lnTo>
                    <a:lnTo>
                      <a:pt x="1155" y="754"/>
                    </a:lnTo>
                    <a:lnTo>
                      <a:pt x="1156" y="753"/>
                    </a:lnTo>
                    <a:lnTo>
                      <a:pt x="1156" y="754"/>
                    </a:lnTo>
                    <a:lnTo>
                      <a:pt x="1157" y="754"/>
                    </a:lnTo>
                    <a:lnTo>
                      <a:pt x="1157" y="753"/>
                    </a:lnTo>
                    <a:lnTo>
                      <a:pt x="1158" y="753"/>
                    </a:lnTo>
                    <a:lnTo>
                      <a:pt x="1158" y="754"/>
                    </a:lnTo>
                    <a:lnTo>
                      <a:pt x="1159" y="754"/>
                    </a:lnTo>
                    <a:lnTo>
                      <a:pt x="1159" y="754"/>
                    </a:lnTo>
                    <a:lnTo>
                      <a:pt x="1160" y="754"/>
                    </a:lnTo>
                    <a:lnTo>
                      <a:pt x="1160" y="754"/>
                    </a:lnTo>
                    <a:lnTo>
                      <a:pt x="1161" y="754"/>
                    </a:lnTo>
                    <a:lnTo>
                      <a:pt x="1161" y="754"/>
                    </a:lnTo>
                    <a:lnTo>
                      <a:pt x="1162" y="753"/>
                    </a:lnTo>
                    <a:lnTo>
                      <a:pt x="1162" y="754"/>
                    </a:lnTo>
                    <a:lnTo>
                      <a:pt x="1163" y="755"/>
                    </a:lnTo>
                    <a:lnTo>
                      <a:pt x="1163" y="754"/>
                    </a:lnTo>
                    <a:lnTo>
                      <a:pt x="1164" y="754"/>
                    </a:lnTo>
                    <a:lnTo>
                      <a:pt x="1164" y="754"/>
                    </a:lnTo>
                    <a:lnTo>
                      <a:pt x="1165" y="754"/>
                    </a:lnTo>
                    <a:lnTo>
                      <a:pt x="1165" y="755"/>
                    </a:lnTo>
                    <a:lnTo>
                      <a:pt x="1166" y="753"/>
                    </a:lnTo>
                    <a:lnTo>
                      <a:pt x="1166" y="755"/>
                    </a:lnTo>
                    <a:lnTo>
                      <a:pt x="1167" y="753"/>
                    </a:lnTo>
                    <a:lnTo>
                      <a:pt x="1167" y="755"/>
                    </a:lnTo>
                    <a:lnTo>
                      <a:pt x="1168" y="755"/>
                    </a:lnTo>
                    <a:lnTo>
                      <a:pt x="1168" y="753"/>
                    </a:lnTo>
                    <a:lnTo>
                      <a:pt x="1169" y="755"/>
                    </a:lnTo>
                    <a:lnTo>
                      <a:pt x="1169" y="753"/>
                    </a:lnTo>
                    <a:lnTo>
                      <a:pt x="1170" y="754"/>
                    </a:lnTo>
                    <a:lnTo>
                      <a:pt x="1170" y="755"/>
                    </a:lnTo>
                    <a:lnTo>
                      <a:pt x="1171" y="755"/>
                    </a:lnTo>
                    <a:lnTo>
                      <a:pt x="1171" y="754"/>
                    </a:lnTo>
                    <a:lnTo>
                      <a:pt x="1172" y="755"/>
                    </a:lnTo>
                    <a:lnTo>
                      <a:pt x="1172" y="754"/>
                    </a:lnTo>
                    <a:lnTo>
                      <a:pt x="1173" y="754"/>
                    </a:lnTo>
                    <a:lnTo>
                      <a:pt x="1173" y="753"/>
                    </a:lnTo>
                    <a:lnTo>
                      <a:pt x="1174" y="753"/>
                    </a:lnTo>
                    <a:lnTo>
                      <a:pt x="1174" y="754"/>
                    </a:lnTo>
                    <a:lnTo>
                      <a:pt x="1175" y="754"/>
                    </a:lnTo>
                    <a:lnTo>
                      <a:pt x="1175" y="754"/>
                    </a:lnTo>
                    <a:lnTo>
                      <a:pt x="1176" y="755"/>
                    </a:lnTo>
                    <a:lnTo>
                      <a:pt x="1176" y="753"/>
                    </a:lnTo>
                    <a:lnTo>
                      <a:pt x="1177" y="755"/>
                    </a:lnTo>
                    <a:lnTo>
                      <a:pt x="1177" y="754"/>
                    </a:lnTo>
                    <a:lnTo>
                      <a:pt x="1178" y="754"/>
                    </a:lnTo>
                    <a:lnTo>
                      <a:pt x="1178" y="755"/>
                    </a:lnTo>
                    <a:lnTo>
                      <a:pt x="1179" y="754"/>
                    </a:lnTo>
                    <a:lnTo>
                      <a:pt x="1179" y="755"/>
                    </a:lnTo>
                    <a:lnTo>
                      <a:pt x="1180" y="753"/>
                    </a:lnTo>
                    <a:lnTo>
                      <a:pt x="1180" y="754"/>
                    </a:lnTo>
                    <a:lnTo>
                      <a:pt x="1181" y="754"/>
                    </a:lnTo>
                    <a:lnTo>
                      <a:pt x="1181" y="754"/>
                    </a:lnTo>
                    <a:lnTo>
                      <a:pt x="1182" y="755"/>
                    </a:lnTo>
                    <a:lnTo>
                      <a:pt x="1182" y="753"/>
                    </a:lnTo>
                    <a:lnTo>
                      <a:pt x="1183" y="754"/>
                    </a:lnTo>
                    <a:lnTo>
                      <a:pt x="1183" y="755"/>
                    </a:lnTo>
                    <a:lnTo>
                      <a:pt x="1184" y="753"/>
                    </a:lnTo>
                    <a:lnTo>
                      <a:pt x="1184" y="755"/>
                    </a:lnTo>
                    <a:lnTo>
                      <a:pt x="1185" y="754"/>
                    </a:lnTo>
                    <a:lnTo>
                      <a:pt x="1185" y="753"/>
                    </a:lnTo>
                    <a:lnTo>
                      <a:pt x="1186" y="755"/>
                    </a:lnTo>
                    <a:lnTo>
                      <a:pt x="1186" y="753"/>
                    </a:lnTo>
                    <a:lnTo>
                      <a:pt x="1187" y="754"/>
                    </a:lnTo>
                    <a:lnTo>
                      <a:pt x="1187" y="754"/>
                    </a:lnTo>
                    <a:lnTo>
                      <a:pt x="1188" y="754"/>
                    </a:lnTo>
                    <a:lnTo>
                      <a:pt x="1188" y="755"/>
                    </a:lnTo>
                    <a:lnTo>
                      <a:pt x="1189" y="755"/>
                    </a:lnTo>
                    <a:lnTo>
                      <a:pt x="1189" y="754"/>
                    </a:lnTo>
                    <a:lnTo>
                      <a:pt x="1190" y="754"/>
                    </a:lnTo>
                    <a:lnTo>
                      <a:pt x="1190" y="754"/>
                    </a:lnTo>
                    <a:lnTo>
                      <a:pt x="1191" y="753"/>
                    </a:lnTo>
                    <a:lnTo>
                      <a:pt x="1191" y="754"/>
                    </a:lnTo>
                    <a:lnTo>
                      <a:pt x="1192" y="753"/>
                    </a:lnTo>
                    <a:lnTo>
                      <a:pt x="1192" y="755"/>
                    </a:lnTo>
                    <a:lnTo>
                      <a:pt x="1193" y="753"/>
                    </a:lnTo>
                    <a:lnTo>
                      <a:pt x="1193" y="754"/>
                    </a:lnTo>
                    <a:lnTo>
                      <a:pt x="1194" y="754"/>
                    </a:lnTo>
                    <a:lnTo>
                      <a:pt x="1194" y="753"/>
                    </a:lnTo>
                    <a:lnTo>
                      <a:pt x="1195" y="755"/>
                    </a:lnTo>
                    <a:lnTo>
                      <a:pt x="1195" y="753"/>
                    </a:lnTo>
                    <a:lnTo>
                      <a:pt x="1196" y="753"/>
                    </a:lnTo>
                    <a:lnTo>
                      <a:pt x="1196" y="755"/>
                    </a:lnTo>
                    <a:lnTo>
                      <a:pt x="1197" y="753"/>
                    </a:lnTo>
                    <a:lnTo>
                      <a:pt x="1197" y="755"/>
                    </a:lnTo>
                    <a:lnTo>
                      <a:pt x="1198" y="754"/>
                    </a:lnTo>
                    <a:lnTo>
                      <a:pt x="1198" y="754"/>
                    </a:lnTo>
                    <a:lnTo>
                      <a:pt x="1199" y="754"/>
                    </a:lnTo>
                    <a:lnTo>
                      <a:pt x="1199" y="755"/>
                    </a:lnTo>
                    <a:lnTo>
                      <a:pt x="1200" y="754"/>
                    </a:lnTo>
                    <a:lnTo>
                      <a:pt x="1200" y="753"/>
                    </a:lnTo>
                    <a:lnTo>
                      <a:pt x="1201" y="754"/>
                    </a:lnTo>
                    <a:lnTo>
                      <a:pt x="1201" y="753"/>
                    </a:lnTo>
                    <a:lnTo>
                      <a:pt x="1202" y="753"/>
                    </a:lnTo>
                    <a:lnTo>
                      <a:pt x="1202" y="755"/>
                    </a:lnTo>
                    <a:lnTo>
                      <a:pt x="1203" y="754"/>
                    </a:lnTo>
                    <a:lnTo>
                      <a:pt x="1203" y="753"/>
                    </a:lnTo>
                    <a:lnTo>
                      <a:pt x="1204" y="754"/>
                    </a:lnTo>
                    <a:lnTo>
                      <a:pt x="1204" y="753"/>
                    </a:lnTo>
                    <a:lnTo>
                      <a:pt x="1205" y="754"/>
                    </a:lnTo>
                    <a:lnTo>
                      <a:pt x="1205" y="753"/>
                    </a:lnTo>
                    <a:lnTo>
                      <a:pt x="1206" y="754"/>
                    </a:lnTo>
                    <a:lnTo>
                      <a:pt x="1206" y="754"/>
                    </a:lnTo>
                    <a:lnTo>
                      <a:pt x="1207" y="753"/>
                    </a:lnTo>
                    <a:lnTo>
                      <a:pt x="1207" y="755"/>
                    </a:lnTo>
                    <a:lnTo>
                      <a:pt x="1208" y="753"/>
                    </a:lnTo>
                    <a:lnTo>
                      <a:pt x="1208" y="755"/>
                    </a:lnTo>
                    <a:lnTo>
                      <a:pt x="1209" y="755"/>
                    </a:lnTo>
                    <a:lnTo>
                      <a:pt x="1209" y="753"/>
                    </a:lnTo>
                    <a:lnTo>
                      <a:pt x="1210" y="753"/>
                    </a:lnTo>
                    <a:lnTo>
                      <a:pt x="1210" y="754"/>
                    </a:lnTo>
                    <a:lnTo>
                      <a:pt x="1211" y="754"/>
                    </a:lnTo>
                    <a:lnTo>
                      <a:pt x="1211" y="753"/>
                    </a:lnTo>
                    <a:lnTo>
                      <a:pt x="1212" y="753"/>
                    </a:lnTo>
                    <a:lnTo>
                      <a:pt x="1212" y="754"/>
                    </a:lnTo>
                    <a:lnTo>
                      <a:pt x="1213" y="754"/>
                    </a:lnTo>
                    <a:lnTo>
                      <a:pt x="1213" y="753"/>
                    </a:lnTo>
                    <a:lnTo>
                      <a:pt x="1214" y="753"/>
                    </a:lnTo>
                    <a:lnTo>
                      <a:pt x="1214" y="754"/>
                    </a:lnTo>
                    <a:lnTo>
                      <a:pt x="1215" y="754"/>
                    </a:lnTo>
                    <a:lnTo>
                      <a:pt x="1215" y="753"/>
                    </a:lnTo>
                    <a:lnTo>
                      <a:pt x="1216" y="754"/>
                    </a:lnTo>
                    <a:lnTo>
                      <a:pt x="1216" y="753"/>
                    </a:lnTo>
                    <a:lnTo>
                      <a:pt x="1217" y="753"/>
                    </a:lnTo>
                    <a:lnTo>
                      <a:pt x="1217" y="754"/>
                    </a:lnTo>
                    <a:lnTo>
                      <a:pt x="1218" y="755"/>
                    </a:lnTo>
                    <a:lnTo>
                      <a:pt x="1218" y="753"/>
                    </a:lnTo>
                    <a:lnTo>
                      <a:pt x="1219" y="753"/>
                    </a:lnTo>
                    <a:lnTo>
                      <a:pt x="1219" y="754"/>
                    </a:lnTo>
                    <a:lnTo>
                      <a:pt x="1220" y="753"/>
                    </a:lnTo>
                    <a:lnTo>
                      <a:pt x="1220" y="754"/>
                    </a:lnTo>
                    <a:lnTo>
                      <a:pt x="1221" y="754"/>
                    </a:lnTo>
                    <a:lnTo>
                      <a:pt x="1221" y="754"/>
                    </a:lnTo>
                    <a:lnTo>
                      <a:pt x="1222" y="753"/>
                    </a:lnTo>
                    <a:lnTo>
                      <a:pt x="1222" y="754"/>
                    </a:lnTo>
                    <a:lnTo>
                      <a:pt x="1223" y="754"/>
                    </a:lnTo>
                    <a:lnTo>
                      <a:pt x="1223" y="753"/>
                    </a:lnTo>
                    <a:lnTo>
                      <a:pt x="1224" y="753"/>
                    </a:lnTo>
                    <a:lnTo>
                      <a:pt x="1224" y="754"/>
                    </a:lnTo>
                    <a:lnTo>
                      <a:pt x="1225" y="754"/>
                    </a:lnTo>
                    <a:lnTo>
                      <a:pt x="1225" y="753"/>
                    </a:lnTo>
                    <a:lnTo>
                      <a:pt x="1226" y="754"/>
                    </a:lnTo>
                    <a:lnTo>
                      <a:pt x="1226" y="753"/>
                    </a:lnTo>
                    <a:lnTo>
                      <a:pt x="1227" y="754"/>
                    </a:lnTo>
                    <a:lnTo>
                      <a:pt x="1227" y="753"/>
                    </a:lnTo>
                    <a:lnTo>
                      <a:pt x="1228" y="753"/>
                    </a:lnTo>
                    <a:lnTo>
                      <a:pt x="1228" y="754"/>
                    </a:lnTo>
                    <a:lnTo>
                      <a:pt x="1229" y="754"/>
                    </a:lnTo>
                    <a:lnTo>
                      <a:pt x="1229" y="753"/>
                    </a:lnTo>
                    <a:lnTo>
                      <a:pt x="1230" y="755"/>
                    </a:lnTo>
                    <a:lnTo>
                      <a:pt x="1230" y="753"/>
                    </a:lnTo>
                    <a:lnTo>
                      <a:pt x="1231" y="753"/>
                    </a:lnTo>
                    <a:lnTo>
                      <a:pt x="1231" y="754"/>
                    </a:lnTo>
                    <a:lnTo>
                      <a:pt x="1232" y="754"/>
                    </a:lnTo>
                    <a:lnTo>
                      <a:pt x="1232" y="753"/>
                    </a:lnTo>
                    <a:lnTo>
                      <a:pt x="1233" y="753"/>
                    </a:lnTo>
                    <a:lnTo>
                      <a:pt x="1233" y="754"/>
                    </a:lnTo>
                    <a:lnTo>
                      <a:pt x="1234" y="754"/>
                    </a:lnTo>
                    <a:lnTo>
                      <a:pt x="1234" y="754"/>
                    </a:lnTo>
                    <a:lnTo>
                      <a:pt x="1235" y="753"/>
                    </a:lnTo>
                    <a:lnTo>
                      <a:pt x="1235" y="754"/>
                    </a:lnTo>
                    <a:lnTo>
                      <a:pt x="1236" y="754"/>
                    </a:lnTo>
                    <a:lnTo>
                      <a:pt x="1236" y="753"/>
                    </a:lnTo>
                    <a:lnTo>
                      <a:pt x="1237" y="753"/>
                    </a:lnTo>
                    <a:lnTo>
                      <a:pt x="1237" y="754"/>
                    </a:lnTo>
                    <a:lnTo>
                      <a:pt x="1238" y="753"/>
                    </a:lnTo>
                    <a:lnTo>
                      <a:pt x="1238" y="754"/>
                    </a:lnTo>
                    <a:lnTo>
                      <a:pt x="1239" y="755"/>
                    </a:lnTo>
                    <a:lnTo>
                      <a:pt x="1239" y="753"/>
                    </a:lnTo>
                    <a:lnTo>
                      <a:pt x="1240" y="753"/>
                    </a:lnTo>
                    <a:lnTo>
                      <a:pt x="1240" y="755"/>
                    </a:lnTo>
                    <a:lnTo>
                      <a:pt x="1241" y="754"/>
                    </a:lnTo>
                    <a:lnTo>
                      <a:pt x="1241" y="754"/>
                    </a:lnTo>
                    <a:lnTo>
                      <a:pt x="1242" y="755"/>
                    </a:lnTo>
                    <a:lnTo>
                      <a:pt x="1242" y="753"/>
                    </a:lnTo>
                    <a:lnTo>
                      <a:pt x="1243" y="755"/>
                    </a:lnTo>
                    <a:lnTo>
                      <a:pt x="1243" y="753"/>
                    </a:lnTo>
                    <a:lnTo>
                      <a:pt x="1244" y="754"/>
                    </a:lnTo>
                    <a:lnTo>
                      <a:pt x="1244" y="753"/>
                    </a:lnTo>
                    <a:lnTo>
                      <a:pt x="1245" y="754"/>
                    </a:lnTo>
                    <a:lnTo>
                      <a:pt x="1245" y="753"/>
                    </a:lnTo>
                    <a:lnTo>
                      <a:pt x="1246" y="754"/>
                    </a:lnTo>
                    <a:lnTo>
                      <a:pt x="1246" y="753"/>
                    </a:lnTo>
                    <a:lnTo>
                      <a:pt x="1247" y="753"/>
                    </a:lnTo>
                    <a:lnTo>
                      <a:pt x="1247" y="754"/>
                    </a:lnTo>
                    <a:lnTo>
                      <a:pt x="1248" y="753"/>
                    </a:lnTo>
                    <a:lnTo>
                      <a:pt x="1248" y="754"/>
                    </a:lnTo>
                    <a:lnTo>
                      <a:pt x="1249" y="754"/>
                    </a:lnTo>
                    <a:lnTo>
                      <a:pt x="1249" y="754"/>
                    </a:lnTo>
                    <a:lnTo>
                      <a:pt x="1250" y="754"/>
                    </a:lnTo>
                    <a:lnTo>
                      <a:pt x="1250" y="754"/>
                    </a:lnTo>
                    <a:lnTo>
                      <a:pt x="1251" y="753"/>
                    </a:lnTo>
                    <a:lnTo>
                      <a:pt x="1251" y="754"/>
                    </a:lnTo>
                    <a:lnTo>
                      <a:pt x="1252" y="753"/>
                    </a:lnTo>
                    <a:lnTo>
                      <a:pt x="1252" y="754"/>
                    </a:lnTo>
                    <a:lnTo>
                      <a:pt x="1253" y="754"/>
                    </a:lnTo>
                    <a:lnTo>
                      <a:pt x="1253" y="753"/>
                    </a:lnTo>
                    <a:lnTo>
                      <a:pt x="1254" y="755"/>
                    </a:lnTo>
                    <a:lnTo>
                      <a:pt x="1254" y="753"/>
                    </a:lnTo>
                    <a:lnTo>
                      <a:pt x="1255" y="753"/>
                    </a:lnTo>
                    <a:lnTo>
                      <a:pt x="1255" y="754"/>
                    </a:lnTo>
                    <a:lnTo>
                      <a:pt x="1256" y="754"/>
                    </a:lnTo>
                    <a:lnTo>
                      <a:pt x="1256" y="753"/>
                    </a:lnTo>
                    <a:lnTo>
                      <a:pt x="1257" y="753"/>
                    </a:lnTo>
                    <a:lnTo>
                      <a:pt x="1257" y="754"/>
                    </a:lnTo>
                    <a:lnTo>
                      <a:pt x="1258" y="754"/>
                    </a:lnTo>
                    <a:lnTo>
                      <a:pt x="1258" y="753"/>
                    </a:lnTo>
                    <a:lnTo>
                      <a:pt x="1259" y="754"/>
                    </a:lnTo>
                    <a:lnTo>
                      <a:pt x="1259" y="753"/>
                    </a:lnTo>
                    <a:lnTo>
                      <a:pt x="1260" y="753"/>
                    </a:lnTo>
                    <a:lnTo>
                      <a:pt x="1260" y="754"/>
                    </a:lnTo>
                    <a:lnTo>
                      <a:pt x="1261" y="753"/>
                    </a:lnTo>
                    <a:lnTo>
                      <a:pt x="1261" y="754"/>
                    </a:lnTo>
                    <a:lnTo>
                      <a:pt x="1262" y="753"/>
                    </a:lnTo>
                    <a:lnTo>
                      <a:pt x="1262" y="755"/>
                    </a:lnTo>
                    <a:lnTo>
                      <a:pt x="1263" y="754"/>
                    </a:lnTo>
                    <a:lnTo>
                      <a:pt x="1263" y="753"/>
                    </a:lnTo>
                    <a:lnTo>
                      <a:pt x="1264" y="753"/>
                    </a:lnTo>
                    <a:lnTo>
                      <a:pt x="1264" y="754"/>
                    </a:lnTo>
                    <a:lnTo>
                      <a:pt x="1265" y="753"/>
                    </a:lnTo>
                    <a:lnTo>
                      <a:pt x="1265" y="754"/>
                    </a:lnTo>
                    <a:lnTo>
                      <a:pt x="1266" y="754"/>
                    </a:lnTo>
                    <a:lnTo>
                      <a:pt x="1266" y="753"/>
                    </a:lnTo>
                    <a:lnTo>
                      <a:pt x="1267" y="754"/>
                    </a:lnTo>
                    <a:lnTo>
                      <a:pt x="1267" y="752"/>
                    </a:lnTo>
                    <a:lnTo>
                      <a:pt x="1268" y="753"/>
                    </a:lnTo>
                    <a:lnTo>
                      <a:pt x="1268" y="754"/>
                    </a:lnTo>
                    <a:lnTo>
                      <a:pt x="1269" y="753"/>
                    </a:lnTo>
                    <a:lnTo>
                      <a:pt x="1269" y="755"/>
                    </a:lnTo>
                    <a:lnTo>
                      <a:pt x="1270" y="754"/>
                    </a:lnTo>
                    <a:lnTo>
                      <a:pt x="1270" y="754"/>
                    </a:lnTo>
                    <a:lnTo>
                      <a:pt x="1271" y="753"/>
                    </a:lnTo>
                    <a:lnTo>
                      <a:pt x="1271" y="754"/>
                    </a:lnTo>
                    <a:lnTo>
                      <a:pt x="1272" y="754"/>
                    </a:lnTo>
                    <a:lnTo>
                      <a:pt x="1272" y="753"/>
                    </a:lnTo>
                    <a:lnTo>
                      <a:pt x="1273" y="754"/>
                    </a:lnTo>
                    <a:lnTo>
                      <a:pt x="1273" y="753"/>
                    </a:lnTo>
                    <a:lnTo>
                      <a:pt x="1274" y="754"/>
                    </a:lnTo>
                    <a:lnTo>
                      <a:pt x="1274" y="753"/>
                    </a:lnTo>
                    <a:lnTo>
                      <a:pt x="1275" y="754"/>
                    </a:lnTo>
                    <a:lnTo>
                      <a:pt x="1275" y="753"/>
                    </a:lnTo>
                    <a:lnTo>
                      <a:pt x="1276" y="754"/>
                    </a:lnTo>
                    <a:lnTo>
                      <a:pt x="1276" y="753"/>
                    </a:lnTo>
                    <a:lnTo>
                      <a:pt x="1277" y="755"/>
                    </a:lnTo>
                    <a:lnTo>
                      <a:pt x="1277" y="753"/>
                    </a:lnTo>
                    <a:lnTo>
                      <a:pt x="1278" y="754"/>
                    </a:lnTo>
                    <a:lnTo>
                      <a:pt x="1278" y="753"/>
                    </a:lnTo>
                    <a:lnTo>
                      <a:pt x="1279" y="755"/>
                    </a:lnTo>
                    <a:lnTo>
                      <a:pt x="1279" y="753"/>
                    </a:lnTo>
                    <a:lnTo>
                      <a:pt x="1280" y="753"/>
                    </a:lnTo>
                    <a:lnTo>
                      <a:pt x="1280" y="754"/>
                    </a:lnTo>
                    <a:lnTo>
                      <a:pt x="1281" y="754"/>
                    </a:lnTo>
                    <a:lnTo>
                      <a:pt x="1281" y="753"/>
                    </a:lnTo>
                    <a:lnTo>
                      <a:pt x="1282" y="753"/>
                    </a:lnTo>
                    <a:lnTo>
                      <a:pt x="1282" y="754"/>
                    </a:lnTo>
                    <a:lnTo>
                      <a:pt x="1283" y="753"/>
                    </a:lnTo>
                    <a:lnTo>
                      <a:pt x="1283" y="754"/>
                    </a:lnTo>
                    <a:lnTo>
                      <a:pt x="1284" y="754"/>
                    </a:lnTo>
                    <a:lnTo>
                      <a:pt x="1284" y="752"/>
                    </a:lnTo>
                    <a:lnTo>
                      <a:pt x="1285" y="753"/>
                    </a:lnTo>
                    <a:lnTo>
                      <a:pt x="1285" y="754"/>
                    </a:lnTo>
                    <a:lnTo>
                      <a:pt x="1286" y="755"/>
                    </a:lnTo>
                    <a:lnTo>
                      <a:pt x="1286" y="754"/>
                    </a:lnTo>
                    <a:lnTo>
                      <a:pt x="1287" y="753"/>
                    </a:lnTo>
                    <a:lnTo>
                      <a:pt x="1287" y="754"/>
                    </a:lnTo>
                    <a:lnTo>
                      <a:pt x="1288" y="754"/>
                    </a:lnTo>
                    <a:lnTo>
                      <a:pt x="1288" y="754"/>
                    </a:lnTo>
                    <a:lnTo>
                      <a:pt x="1289" y="753"/>
                    </a:lnTo>
                    <a:lnTo>
                      <a:pt x="1289" y="754"/>
                    </a:lnTo>
                    <a:lnTo>
                      <a:pt x="1290" y="755"/>
                    </a:lnTo>
                    <a:lnTo>
                      <a:pt x="1290" y="753"/>
                    </a:lnTo>
                    <a:lnTo>
                      <a:pt x="1291" y="753"/>
                    </a:lnTo>
                    <a:lnTo>
                      <a:pt x="1291" y="754"/>
                    </a:lnTo>
                    <a:lnTo>
                      <a:pt x="1292" y="753"/>
                    </a:lnTo>
                    <a:lnTo>
                      <a:pt x="1292" y="754"/>
                    </a:lnTo>
                    <a:lnTo>
                      <a:pt x="1293" y="753"/>
                    </a:lnTo>
                    <a:lnTo>
                      <a:pt x="1293" y="754"/>
                    </a:lnTo>
                    <a:lnTo>
                      <a:pt x="1294" y="753"/>
                    </a:lnTo>
                    <a:lnTo>
                      <a:pt x="1294" y="754"/>
                    </a:lnTo>
                    <a:lnTo>
                      <a:pt x="1295" y="753"/>
                    </a:lnTo>
                    <a:lnTo>
                      <a:pt x="1295" y="754"/>
                    </a:lnTo>
                    <a:lnTo>
                      <a:pt x="1296" y="754"/>
                    </a:lnTo>
                    <a:lnTo>
                      <a:pt x="1296" y="753"/>
                    </a:lnTo>
                    <a:lnTo>
                      <a:pt x="1297" y="754"/>
                    </a:lnTo>
                    <a:lnTo>
                      <a:pt x="1297" y="753"/>
                    </a:lnTo>
                    <a:lnTo>
                      <a:pt x="1298" y="753"/>
                    </a:lnTo>
                    <a:lnTo>
                      <a:pt x="1298" y="754"/>
                    </a:lnTo>
                    <a:lnTo>
                      <a:pt x="1299" y="753"/>
                    </a:lnTo>
                    <a:lnTo>
                      <a:pt x="1299" y="754"/>
                    </a:lnTo>
                    <a:lnTo>
                      <a:pt x="1300" y="753"/>
                    </a:lnTo>
                    <a:lnTo>
                      <a:pt x="1300" y="754"/>
                    </a:lnTo>
                    <a:lnTo>
                      <a:pt x="1301" y="754"/>
                    </a:lnTo>
                    <a:lnTo>
                      <a:pt x="1301" y="753"/>
                    </a:lnTo>
                    <a:lnTo>
                      <a:pt x="1302" y="754"/>
                    </a:lnTo>
                    <a:lnTo>
                      <a:pt x="1302" y="753"/>
                    </a:lnTo>
                    <a:lnTo>
                      <a:pt x="1303" y="754"/>
                    </a:lnTo>
                    <a:lnTo>
                      <a:pt x="1303" y="753"/>
                    </a:lnTo>
                    <a:lnTo>
                      <a:pt x="1304" y="754"/>
                    </a:lnTo>
                    <a:lnTo>
                      <a:pt x="1304" y="753"/>
                    </a:lnTo>
                    <a:lnTo>
                      <a:pt x="1305" y="752"/>
                    </a:lnTo>
                    <a:lnTo>
                      <a:pt x="1305" y="753"/>
                    </a:lnTo>
                    <a:lnTo>
                      <a:pt x="1306" y="754"/>
                    </a:lnTo>
                    <a:lnTo>
                      <a:pt x="1306" y="753"/>
                    </a:lnTo>
                    <a:lnTo>
                      <a:pt x="1307" y="754"/>
                    </a:lnTo>
                    <a:lnTo>
                      <a:pt x="1307" y="753"/>
                    </a:lnTo>
                    <a:lnTo>
                      <a:pt x="1308" y="754"/>
                    </a:lnTo>
                    <a:lnTo>
                      <a:pt x="1308" y="753"/>
                    </a:lnTo>
                    <a:lnTo>
                      <a:pt x="1309" y="754"/>
                    </a:lnTo>
                    <a:lnTo>
                      <a:pt x="1309" y="753"/>
                    </a:lnTo>
                    <a:lnTo>
                      <a:pt x="1310" y="754"/>
                    </a:lnTo>
                    <a:lnTo>
                      <a:pt x="1310" y="753"/>
                    </a:lnTo>
                    <a:lnTo>
                      <a:pt x="1311" y="754"/>
                    </a:lnTo>
                    <a:lnTo>
                      <a:pt x="1311" y="753"/>
                    </a:lnTo>
                    <a:lnTo>
                      <a:pt x="1312" y="753"/>
                    </a:lnTo>
                    <a:lnTo>
                      <a:pt x="1312" y="754"/>
                    </a:lnTo>
                    <a:lnTo>
                      <a:pt x="1313" y="755"/>
                    </a:lnTo>
                    <a:lnTo>
                      <a:pt x="1313" y="753"/>
                    </a:lnTo>
                    <a:lnTo>
                      <a:pt x="1314" y="753"/>
                    </a:lnTo>
                    <a:lnTo>
                      <a:pt x="1314" y="754"/>
                    </a:lnTo>
                    <a:lnTo>
                      <a:pt x="1315" y="754"/>
                    </a:lnTo>
                    <a:lnTo>
                      <a:pt x="1315" y="753"/>
                    </a:lnTo>
                    <a:lnTo>
                      <a:pt x="1316" y="752"/>
                    </a:lnTo>
                    <a:lnTo>
                      <a:pt x="1316" y="754"/>
                    </a:lnTo>
                    <a:lnTo>
                      <a:pt x="1317" y="753"/>
                    </a:lnTo>
                    <a:lnTo>
                      <a:pt x="1317" y="754"/>
                    </a:lnTo>
                    <a:lnTo>
                      <a:pt x="1318" y="753"/>
                    </a:lnTo>
                    <a:lnTo>
                      <a:pt x="1318" y="754"/>
                    </a:lnTo>
                    <a:lnTo>
                      <a:pt x="1319" y="753"/>
                    </a:lnTo>
                    <a:lnTo>
                      <a:pt x="1319" y="753"/>
                    </a:lnTo>
                    <a:lnTo>
                      <a:pt x="1320" y="753"/>
                    </a:lnTo>
                    <a:lnTo>
                      <a:pt x="1320" y="754"/>
                    </a:lnTo>
                    <a:lnTo>
                      <a:pt x="1321" y="753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28" name="Rectangle 227">
                <a:extLst>
                  <a:ext uri="{FF2B5EF4-FFF2-40B4-BE49-F238E27FC236}">
                    <a16:creationId xmlns:a16="http://schemas.microsoft.com/office/drawing/2014/main" xmlns="" id="{E7CAEEDB-E875-466E-B54D-0BE67FFBCF8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10" y="178"/>
                <a:ext cx="78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.04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" name="Rectangle 228">
                <a:extLst>
                  <a:ext uri="{FF2B5EF4-FFF2-40B4-BE49-F238E27FC236}">
                    <a16:creationId xmlns:a16="http://schemas.microsoft.com/office/drawing/2014/main" xmlns="" id="{70851283-5233-46A7-BAFB-2A5F1CE0A14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98" y="281"/>
                <a:ext cx="78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.60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" name="Rectangle 229">
                <a:extLst>
                  <a:ext uri="{FF2B5EF4-FFF2-40B4-BE49-F238E27FC236}">
                    <a16:creationId xmlns:a16="http://schemas.microsoft.com/office/drawing/2014/main" xmlns="" id="{06BBF429-E5C7-4A9C-B73E-36BB25549B2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66" y="362"/>
                <a:ext cx="78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.08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" name="Line 230">
                <a:extLst>
                  <a:ext uri="{FF2B5EF4-FFF2-40B4-BE49-F238E27FC236}">
                    <a16:creationId xmlns:a16="http://schemas.microsoft.com/office/drawing/2014/main" xmlns="" id="{8D73EEF4-F3EF-4B67-A177-9897E8EECA3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263" y="400"/>
                <a:ext cx="50" cy="6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32" name="Rectangle 231">
                <a:extLst>
                  <a:ext uri="{FF2B5EF4-FFF2-40B4-BE49-F238E27FC236}">
                    <a16:creationId xmlns:a16="http://schemas.microsoft.com/office/drawing/2014/main" xmlns="" id="{FD7AD8C0-6B65-42B2-8575-495DC37DB6B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71" y="445"/>
                <a:ext cx="78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.10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3" name="Line 232">
                <a:extLst>
                  <a:ext uri="{FF2B5EF4-FFF2-40B4-BE49-F238E27FC236}">
                    <a16:creationId xmlns:a16="http://schemas.microsoft.com/office/drawing/2014/main" xmlns="" id="{7A459B74-1EF1-4CCE-808B-C4F582E6FDF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267" y="483"/>
                <a:ext cx="51" cy="6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34" name="Rectangle 233">
                <a:extLst>
                  <a:ext uri="{FF2B5EF4-FFF2-40B4-BE49-F238E27FC236}">
                    <a16:creationId xmlns:a16="http://schemas.microsoft.com/office/drawing/2014/main" xmlns="" id="{00CC389A-34B8-4420-9FF6-A839DB90407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24" y="489"/>
                <a:ext cx="78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.37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5" name="Rectangle 234">
                <a:extLst>
                  <a:ext uri="{FF2B5EF4-FFF2-40B4-BE49-F238E27FC236}">
                    <a16:creationId xmlns:a16="http://schemas.microsoft.com/office/drawing/2014/main" xmlns="" id="{58939632-A2D3-4A41-92A7-0DE50EB2A6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41" y="572"/>
                <a:ext cx="78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.00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6" name="Line 235">
                <a:extLst>
                  <a:ext uri="{FF2B5EF4-FFF2-40B4-BE49-F238E27FC236}">
                    <a16:creationId xmlns:a16="http://schemas.microsoft.com/office/drawing/2014/main" xmlns="" id="{07A2EA35-3D5D-452F-826C-ED20F0685AA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2188" y="610"/>
                <a:ext cx="61" cy="6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37" name="Rectangle 236">
                <a:extLst>
                  <a:ext uri="{FF2B5EF4-FFF2-40B4-BE49-F238E27FC236}">
                    <a16:creationId xmlns:a16="http://schemas.microsoft.com/office/drawing/2014/main" xmlns="" id="{F9FC7C21-D32F-48B6-84D0-732FD64CA7B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57" y="589"/>
                <a:ext cx="78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.33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8" name="Line 237">
                <a:extLst>
                  <a:ext uri="{FF2B5EF4-FFF2-40B4-BE49-F238E27FC236}">
                    <a16:creationId xmlns:a16="http://schemas.microsoft.com/office/drawing/2014/main" xmlns="" id="{AF7F2545-F2C0-4E61-ABB5-0059BF21352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2604" y="627"/>
                <a:ext cx="61" cy="6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39" name="Rectangle 238">
                <a:extLst>
                  <a:ext uri="{FF2B5EF4-FFF2-40B4-BE49-F238E27FC236}">
                    <a16:creationId xmlns:a16="http://schemas.microsoft.com/office/drawing/2014/main" xmlns="" id="{5435A734-522A-4CB9-93C0-E2D12877C9B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75" y="637"/>
                <a:ext cx="78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7.34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0" name="Rectangle 239">
                <a:extLst>
                  <a:ext uri="{FF2B5EF4-FFF2-40B4-BE49-F238E27FC236}">
                    <a16:creationId xmlns:a16="http://schemas.microsoft.com/office/drawing/2014/main" xmlns="" id="{B38C5CCD-AE71-47F1-A3D2-AD89D9D8C0A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49" y="702"/>
                <a:ext cx="78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.23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1" name="Line 240">
                <a:extLst>
                  <a:ext uri="{FF2B5EF4-FFF2-40B4-BE49-F238E27FC236}">
                    <a16:creationId xmlns:a16="http://schemas.microsoft.com/office/drawing/2014/main" xmlns="" id="{53C2D25A-4A33-4B23-BA0B-F78D607D964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2596" y="740"/>
                <a:ext cx="51" cy="6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42" name="Rectangle 241">
                <a:extLst>
                  <a:ext uri="{FF2B5EF4-FFF2-40B4-BE49-F238E27FC236}">
                    <a16:creationId xmlns:a16="http://schemas.microsoft.com/office/drawing/2014/main" xmlns="" id="{E47C8504-2417-4F72-BD41-8B95F833E89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77" y="714"/>
                <a:ext cx="78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.14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3" name="Line 242">
                <a:extLst>
                  <a:ext uri="{FF2B5EF4-FFF2-40B4-BE49-F238E27FC236}">
                    <a16:creationId xmlns:a16="http://schemas.microsoft.com/office/drawing/2014/main" xmlns="" id="{CEC59554-9B97-4C5F-8658-00296928965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273" y="752"/>
                <a:ext cx="51" cy="6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44" name="Rectangle 243">
                <a:extLst>
                  <a:ext uri="{FF2B5EF4-FFF2-40B4-BE49-F238E27FC236}">
                    <a16:creationId xmlns:a16="http://schemas.microsoft.com/office/drawing/2014/main" xmlns="" id="{79A721C2-D0C9-43F0-8726-972264B98C0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34" y="817"/>
                <a:ext cx="78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7.51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5" name="Line 244">
                <a:extLst>
                  <a:ext uri="{FF2B5EF4-FFF2-40B4-BE49-F238E27FC236}">
                    <a16:creationId xmlns:a16="http://schemas.microsoft.com/office/drawing/2014/main" xmlns="" id="{BF4602D0-8A06-4E3E-A7A8-37F252F6852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51" y="855"/>
                <a:ext cx="30" cy="6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46" name="Rectangle 245">
                <a:extLst>
                  <a:ext uri="{FF2B5EF4-FFF2-40B4-BE49-F238E27FC236}">
                    <a16:creationId xmlns:a16="http://schemas.microsoft.com/office/drawing/2014/main" xmlns="" id="{0B86CA54-1ADD-46E3-9A3B-1925E53C47A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31" y="854"/>
                <a:ext cx="78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.96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7" name="Line 246">
                <a:extLst>
                  <a:ext uri="{FF2B5EF4-FFF2-40B4-BE49-F238E27FC236}">
                    <a16:creationId xmlns:a16="http://schemas.microsoft.com/office/drawing/2014/main" xmlns="" id="{725397E3-0B90-4D7D-948C-5C983F52704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2578" y="892"/>
                <a:ext cx="20" cy="6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48" name="Rectangle 247">
                <a:extLst>
                  <a:ext uri="{FF2B5EF4-FFF2-40B4-BE49-F238E27FC236}">
                    <a16:creationId xmlns:a16="http://schemas.microsoft.com/office/drawing/2014/main" xmlns="" id="{1AE82184-C35C-41AE-B153-F41BB5B4DC9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48" y="945"/>
                <a:ext cx="78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.13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9" name="Rectangle 248">
                <a:extLst>
                  <a:ext uri="{FF2B5EF4-FFF2-40B4-BE49-F238E27FC236}">
                    <a16:creationId xmlns:a16="http://schemas.microsoft.com/office/drawing/2014/main" xmlns="" id="{3D1311C3-E8E2-4046-AF46-0A580831D0A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91" y="949"/>
                <a:ext cx="78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.87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0" name="Rectangle 249">
                <a:extLst>
                  <a:ext uri="{FF2B5EF4-FFF2-40B4-BE49-F238E27FC236}">
                    <a16:creationId xmlns:a16="http://schemas.microsoft.com/office/drawing/2014/main" xmlns="" id="{20F915F5-DFA9-42DE-880C-12181907B42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07" y="997"/>
                <a:ext cx="78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.18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1" name="Line 250">
                <a:extLst>
                  <a:ext uri="{FF2B5EF4-FFF2-40B4-BE49-F238E27FC236}">
                    <a16:creationId xmlns:a16="http://schemas.microsoft.com/office/drawing/2014/main" xmlns="" id="{4E8C6A77-CAA6-4FE0-819D-4322E23F2BA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103" y="1035"/>
                <a:ext cx="51" cy="6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52" name="Rectangle 251">
                <a:extLst>
                  <a:ext uri="{FF2B5EF4-FFF2-40B4-BE49-F238E27FC236}">
                    <a16:creationId xmlns:a16="http://schemas.microsoft.com/office/drawing/2014/main" xmlns="" id="{90D293D6-6F30-4CBA-8E8F-DD40D72E6DD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24" y="1011"/>
                <a:ext cx="78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.83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3" name="Line 252">
                <a:extLst>
                  <a:ext uri="{FF2B5EF4-FFF2-40B4-BE49-F238E27FC236}">
                    <a16:creationId xmlns:a16="http://schemas.microsoft.com/office/drawing/2014/main" xmlns="" id="{0EA04948-171F-431F-8011-3DC3FD772C0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2871" y="1049"/>
                <a:ext cx="61" cy="6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54" name="Rectangle 253">
                <a:extLst>
                  <a:ext uri="{FF2B5EF4-FFF2-40B4-BE49-F238E27FC236}">
                    <a16:creationId xmlns:a16="http://schemas.microsoft.com/office/drawing/2014/main" xmlns="" id="{F17CD4E1-034C-43B3-8DFD-A67D3A457D3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13" y="1046"/>
                <a:ext cx="78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.21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5" name="Line 254">
                <a:extLst>
                  <a:ext uri="{FF2B5EF4-FFF2-40B4-BE49-F238E27FC236}">
                    <a16:creationId xmlns:a16="http://schemas.microsoft.com/office/drawing/2014/main" xmlns="" id="{F88128FA-96FC-42F7-A916-00A7EE1F64B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109" y="1084"/>
                <a:ext cx="51" cy="6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56" name="Rectangle 255">
                <a:extLst>
                  <a:ext uri="{FF2B5EF4-FFF2-40B4-BE49-F238E27FC236}">
                    <a16:creationId xmlns:a16="http://schemas.microsoft.com/office/drawing/2014/main" xmlns="" id="{2BA7C30F-8E22-4DA2-98E3-7584E064AB1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78" y="1149"/>
                <a:ext cx="78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.73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7" name="Rectangle 256">
                <a:extLst>
                  <a:ext uri="{FF2B5EF4-FFF2-40B4-BE49-F238E27FC236}">
                    <a16:creationId xmlns:a16="http://schemas.microsoft.com/office/drawing/2014/main" xmlns="" id="{42DF24AE-3FBC-4078-8F45-1F3EC4FC481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79" y="1161"/>
                <a:ext cx="78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.83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8" name="Line 257">
                <a:extLst>
                  <a:ext uri="{FF2B5EF4-FFF2-40B4-BE49-F238E27FC236}">
                    <a16:creationId xmlns:a16="http://schemas.microsoft.com/office/drawing/2014/main" xmlns="" id="{8AAC10D9-0AB9-485E-BDF1-13D498A5D24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2526" y="1199"/>
                <a:ext cx="50" cy="6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59" name="Rectangle 258">
                <a:extLst>
                  <a:ext uri="{FF2B5EF4-FFF2-40B4-BE49-F238E27FC236}">
                    <a16:creationId xmlns:a16="http://schemas.microsoft.com/office/drawing/2014/main" xmlns="" id="{4483F2C6-4839-41E0-8EAC-FF235D968C2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49" y="1191"/>
                <a:ext cx="78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.08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0" name="Rectangle 259">
                <a:extLst>
                  <a:ext uri="{FF2B5EF4-FFF2-40B4-BE49-F238E27FC236}">
                    <a16:creationId xmlns:a16="http://schemas.microsoft.com/office/drawing/2014/main" xmlns="" id="{01FDCD65-EB8A-4E92-900C-489B15522A8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12" y="1248"/>
                <a:ext cx="78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.14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1" name="Line 260">
                <a:extLst>
                  <a:ext uri="{FF2B5EF4-FFF2-40B4-BE49-F238E27FC236}">
                    <a16:creationId xmlns:a16="http://schemas.microsoft.com/office/drawing/2014/main" xmlns="" id="{3939A230-208A-414C-BD77-382D3E9FC7C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808" y="1286"/>
                <a:ext cx="51" cy="6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2" name="Rectangle 261">
                <a:extLst>
                  <a:ext uri="{FF2B5EF4-FFF2-40B4-BE49-F238E27FC236}">
                    <a16:creationId xmlns:a16="http://schemas.microsoft.com/office/drawing/2014/main" xmlns="" id="{427F9116-9F0C-459B-AC30-3D0399F507D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60" y="1252"/>
                <a:ext cx="78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.79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3" name="Line 262">
                <a:extLst>
                  <a:ext uri="{FF2B5EF4-FFF2-40B4-BE49-F238E27FC236}">
                    <a16:creationId xmlns:a16="http://schemas.microsoft.com/office/drawing/2014/main" xmlns="" id="{80590883-1C49-4309-9E04-3509B6954BD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2507" y="1290"/>
                <a:ext cx="61" cy="6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4" name="Rectangle 263">
                <a:extLst>
                  <a:ext uri="{FF2B5EF4-FFF2-40B4-BE49-F238E27FC236}">
                    <a16:creationId xmlns:a16="http://schemas.microsoft.com/office/drawing/2014/main" xmlns="" id="{D2D5BCFF-37CA-4EEF-8A41-66ABBB6321B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58" y="1317"/>
                <a:ext cx="78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.55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5" name="Line 264">
                <a:extLst>
                  <a:ext uri="{FF2B5EF4-FFF2-40B4-BE49-F238E27FC236}">
                    <a16:creationId xmlns:a16="http://schemas.microsoft.com/office/drawing/2014/main" xmlns="" id="{7F6829B1-CA05-4004-A5BE-DBB2CD0CF82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2505" y="1355"/>
                <a:ext cx="21" cy="6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6" name="Rectangle 265">
                <a:extLst>
                  <a:ext uri="{FF2B5EF4-FFF2-40B4-BE49-F238E27FC236}">
                    <a16:creationId xmlns:a16="http://schemas.microsoft.com/office/drawing/2014/main" xmlns="" id="{69A81342-1363-45BC-8882-5E9EB2C93BA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62" y="1321"/>
                <a:ext cx="78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.67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7" name="Line 266">
                <a:extLst>
                  <a:ext uri="{FF2B5EF4-FFF2-40B4-BE49-F238E27FC236}">
                    <a16:creationId xmlns:a16="http://schemas.microsoft.com/office/drawing/2014/main" xmlns="" id="{80298FD2-281A-4B38-979F-E76D9AB6BEE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59" y="1359"/>
                <a:ext cx="50" cy="6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8" name="Rectangle 267">
                <a:extLst>
                  <a:ext uri="{FF2B5EF4-FFF2-40B4-BE49-F238E27FC236}">
                    <a16:creationId xmlns:a16="http://schemas.microsoft.com/office/drawing/2014/main" xmlns="" id="{711A0378-6E4D-4817-A57B-1D21433235B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18" y="1325"/>
                <a:ext cx="78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.24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9" name="Line 268">
                <a:extLst>
                  <a:ext uri="{FF2B5EF4-FFF2-40B4-BE49-F238E27FC236}">
                    <a16:creationId xmlns:a16="http://schemas.microsoft.com/office/drawing/2014/main" xmlns="" id="{B85382D8-907F-42EE-AEEA-BF101B7B632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824" y="1363"/>
                <a:ext cx="41" cy="6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0" name="Rectangle 269">
                <a:extLst>
                  <a:ext uri="{FF2B5EF4-FFF2-40B4-BE49-F238E27FC236}">
                    <a16:creationId xmlns:a16="http://schemas.microsoft.com/office/drawing/2014/main" xmlns="" id="{894F05C1-4E14-46D0-940D-18D8449CDED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49" y="1343"/>
                <a:ext cx="78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.51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1" name="Line 270">
                <a:extLst>
                  <a:ext uri="{FF2B5EF4-FFF2-40B4-BE49-F238E27FC236}">
                    <a16:creationId xmlns:a16="http://schemas.microsoft.com/office/drawing/2014/main" xmlns="" id="{0D803675-BA50-472B-89C6-C6C3CB75DD9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2396" y="1381"/>
                <a:ext cx="121" cy="6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2" name="Rectangle 271">
                <a:extLst>
                  <a:ext uri="{FF2B5EF4-FFF2-40B4-BE49-F238E27FC236}">
                    <a16:creationId xmlns:a16="http://schemas.microsoft.com/office/drawing/2014/main" xmlns="" id="{41681416-2FF4-40B3-8CA1-0E4BA59A9E1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06" y="1394"/>
                <a:ext cx="78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.48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3" name="Line 272">
                <a:extLst>
                  <a:ext uri="{FF2B5EF4-FFF2-40B4-BE49-F238E27FC236}">
                    <a16:creationId xmlns:a16="http://schemas.microsoft.com/office/drawing/2014/main" xmlns="" id="{22EA174E-6621-4A4D-B962-99BF57EF4D8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2453" y="1432"/>
                <a:ext cx="60" cy="6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4" name="Rectangle 273">
                <a:extLst>
                  <a:ext uri="{FF2B5EF4-FFF2-40B4-BE49-F238E27FC236}">
                    <a16:creationId xmlns:a16="http://schemas.microsoft.com/office/drawing/2014/main" xmlns="" id="{ABEC23A3-4749-44E9-815A-0B3C2A23964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76" y="1468"/>
                <a:ext cx="78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.26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5" name="Line 274">
                <a:extLst>
                  <a:ext uri="{FF2B5EF4-FFF2-40B4-BE49-F238E27FC236}">
                    <a16:creationId xmlns:a16="http://schemas.microsoft.com/office/drawing/2014/main" xmlns="" id="{7A4BFBCD-B2B5-40B0-9E75-4835CF46EB9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2423" y="1506"/>
                <a:ext cx="50" cy="6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6" name="Rectangle 275">
                <a:extLst>
                  <a:ext uri="{FF2B5EF4-FFF2-40B4-BE49-F238E27FC236}">
                    <a16:creationId xmlns:a16="http://schemas.microsoft.com/office/drawing/2014/main" xmlns="" id="{708A05D2-2BC2-4561-90DF-6C714DF0F17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85" y="1479"/>
                <a:ext cx="78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.21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7" name="Rectangle 276">
                <a:extLst>
                  <a:ext uri="{FF2B5EF4-FFF2-40B4-BE49-F238E27FC236}">
                    <a16:creationId xmlns:a16="http://schemas.microsoft.com/office/drawing/2014/main" xmlns="" id="{F71597EC-8517-4161-8A49-FFA628EAB29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53" y="1519"/>
                <a:ext cx="78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.19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8" name="Line 277">
                <a:extLst>
                  <a:ext uri="{FF2B5EF4-FFF2-40B4-BE49-F238E27FC236}">
                    <a16:creationId xmlns:a16="http://schemas.microsoft.com/office/drawing/2014/main" xmlns="" id="{C1BD1B0C-8768-4C02-B282-7FC6FBF8479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2400" y="1557"/>
                <a:ext cx="61" cy="6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9" name="Rectangle 278">
                <a:extLst>
                  <a:ext uri="{FF2B5EF4-FFF2-40B4-BE49-F238E27FC236}">
                    <a16:creationId xmlns:a16="http://schemas.microsoft.com/office/drawing/2014/main" xmlns="" id="{AC932F44-E1AC-433B-8A90-3E2E37156D6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70" y="1541"/>
                <a:ext cx="78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7.77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0" name="Line 279">
                <a:extLst>
                  <a:ext uri="{FF2B5EF4-FFF2-40B4-BE49-F238E27FC236}">
                    <a16:creationId xmlns:a16="http://schemas.microsoft.com/office/drawing/2014/main" xmlns="" id="{2C5BCA80-C402-4948-AA42-A903A1BC6B8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7" y="1579"/>
                <a:ext cx="20" cy="6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81" name="Rectangle 280">
                <a:extLst>
                  <a:ext uri="{FF2B5EF4-FFF2-40B4-BE49-F238E27FC236}">
                    <a16:creationId xmlns:a16="http://schemas.microsoft.com/office/drawing/2014/main" xmlns="" id="{93DB362E-AFBD-4241-984B-A3028D2DC1A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14" y="1588"/>
                <a:ext cx="78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.16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2" name="Line 281">
                <a:extLst>
                  <a:ext uri="{FF2B5EF4-FFF2-40B4-BE49-F238E27FC236}">
                    <a16:creationId xmlns:a16="http://schemas.microsoft.com/office/drawing/2014/main" xmlns="" id="{08F1C7A7-EDDC-490B-8AAE-7982DFC433C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1861" y="1626"/>
                <a:ext cx="61" cy="6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83" name="Rectangle 282">
                <a:extLst>
                  <a:ext uri="{FF2B5EF4-FFF2-40B4-BE49-F238E27FC236}">
                    <a16:creationId xmlns:a16="http://schemas.microsoft.com/office/drawing/2014/main" xmlns="" id="{530F9A2D-F905-409D-9F4E-D16F7161F56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17" y="1620"/>
                <a:ext cx="78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.36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4" name="Line 283">
                <a:extLst>
                  <a:ext uri="{FF2B5EF4-FFF2-40B4-BE49-F238E27FC236}">
                    <a16:creationId xmlns:a16="http://schemas.microsoft.com/office/drawing/2014/main" xmlns="" id="{6CD7A7B2-EB3E-459C-8ACC-9FBBD7853AD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313" y="1658"/>
                <a:ext cx="51" cy="6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85" name="Rectangle 284">
                <a:extLst>
                  <a:ext uri="{FF2B5EF4-FFF2-40B4-BE49-F238E27FC236}">
                    <a16:creationId xmlns:a16="http://schemas.microsoft.com/office/drawing/2014/main" xmlns="" id="{B3B003FC-F0C6-495C-9691-9BA80780005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60" y="1650"/>
                <a:ext cx="100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.70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6" name="Rectangle 285">
                <a:extLst>
                  <a:ext uri="{FF2B5EF4-FFF2-40B4-BE49-F238E27FC236}">
                    <a16:creationId xmlns:a16="http://schemas.microsoft.com/office/drawing/2014/main" xmlns="" id="{D599B8C1-E8FF-4BB8-AEBC-820C9BD1AB6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14" y="1652"/>
                <a:ext cx="78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98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7" name="Line 286">
                <a:extLst>
                  <a:ext uri="{FF2B5EF4-FFF2-40B4-BE49-F238E27FC236}">
                    <a16:creationId xmlns:a16="http://schemas.microsoft.com/office/drawing/2014/main" xmlns="" id="{3206C186-F382-4EAB-A3EE-ACBF0698464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1861" y="1690"/>
                <a:ext cx="30" cy="7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88" name="Rectangle 287">
                <a:extLst>
                  <a:ext uri="{FF2B5EF4-FFF2-40B4-BE49-F238E27FC236}">
                    <a16:creationId xmlns:a16="http://schemas.microsoft.com/office/drawing/2014/main" xmlns="" id="{3077ED39-4EE5-4BCB-80C2-B67F7A76EA6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87" y="1656"/>
                <a:ext cx="100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.73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9" name="Line 288">
                <a:extLst>
                  <a:ext uri="{FF2B5EF4-FFF2-40B4-BE49-F238E27FC236}">
                    <a16:creationId xmlns:a16="http://schemas.microsoft.com/office/drawing/2014/main" xmlns="" id="{A6746B2D-C9C9-455E-AB0F-032A3DEBEFD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24" y="1695"/>
                <a:ext cx="121" cy="6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0" name="Rectangle 289">
                <a:extLst>
                  <a:ext uri="{FF2B5EF4-FFF2-40B4-BE49-F238E27FC236}">
                    <a16:creationId xmlns:a16="http://schemas.microsoft.com/office/drawing/2014/main" xmlns="" id="{74A37326-EF02-461A-803A-F2465EF9167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33" y="1661"/>
                <a:ext cx="100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.66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1" name="Line 290">
                <a:extLst>
                  <a:ext uri="{FF2B5EF4-FFF2-40B4-BE49-F238E27FC236}">
                    <a16:creationId xmlns:a16="http://schemas.microsoft.com/office/drawing/2014/main" xmlns="" id="{ECFF805D-89A9-49F1-8DDA-7675B51FBF6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3491" y="1699"/>
                <a:ext cx="121" cy="6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2" name="Rectangle 291">
                <a:extLst>
                  <a:ext uri="{FF2B5EF4-FFF2-40B4-BE49-F238E27FC236}">
                    <a16:creationId xmlns:a16="http://schemas.microsoft.com/office/drawing/2014/main" xmlns="" id="{51410D3B-FDEE-4EF9-8726-A1217996DA1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91" y="1663"/>
                <a:ext cx="78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.83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3" name="Line 292">
                <a:extLst>
                  <a:ext uri="{FF2B5EF4-FFF2-40B4-BE49-F238E27FC236}">
                    <a16:creationId xmlns:a16="http://schemas.microsoft.com/office/drawing/2014/main" xmlns="" id="{EB25FC89-2556-4DF1-B137-2D8949209DA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87" y="1701"/>
                <a:ext cx="51" cy="6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4" name="Rectangle 293">
                <a:extLst>
                  <a:ext uri="{FF2B5EF4-FFF2-40B4-BE49-F238E27FC236}">
                    <a16:creationId xmlns:a16="http://schemas.microsoft.com/office/drawing/2014/main" xmlns="" id="{4A48D161-81EC-4258-973A-159EEA929EB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13" y="1693"/>
                <a:ext cx="100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1.43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5" name="Line 294">
                <a:extLst>
                  <a:ext uri="{FF2B5EF4-FFF2-40B4-BE49-F238E27FC236}">
                    <a16:creationId xmlns:a16="http://schemas.microsoft.com/office/drawing/2014/main" xmlns="" id="{EFA63A77-70A2-452B-A893-7DD52C80D05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50" y="1731"/>
                <a:ext cx="121" cy="6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6" name="Rectangle 295">
                <a:extLst>
                  <a:ext uri="{FF2B5EF4-FFF2-40B4-BE49-F238E27FC236}">
                    <a16:creationId xmlns:a16="http://schemas.microsoft.com/office/drawing/2014/main" xmlns="" id="{5151A6AD-41F1-4F0E-9D27-31BB23DA08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67" y="1699"/>
                <a:ext cx="100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4.96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7" name="Line 296">
                <a:extLst>
                  <a:ext uri="{FF2B5EF4-FFF2-40B4-BE49-F238E27FC236}">
                    <a16:creationId xmlns:a16="http://schemas.microsoft.com/office/drawing/2014/main" xmlns="" id="{BF36CB3E-8ADB-407A-9240-4151558942D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4325" y="1737"/>
                <a:ext cx="51" cy="6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8" name="Rectangle 297">
                <a:extLst>
                  <a:ext uri="{FF2B5EF4-FFF2-40B4-BE49-F238E27FC236}">
                    <a16:creationId xmlns:a16="http://schemas.microsoft.com/office/drawing/2014/main" xmlns="" id="{AA24AE15-3B30-4265-9C90-9041A2BA7A8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08" y="1701"/>
                <a:ext cx="100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3.78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9" name="Rectangle 298">
                <a:extLst>
                  <a:ext uri="{FF2B5EF4-FFF2-40B4-BE49-F238E27FC236}">
                    <a16:creationId xmlns:a16="http://schemas.microsoft.com/office/drawing/2014/main" xmlns="" id="{FC2E5FC9-226C-44C2-9FF9-DB065A7BD3E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82" y="1701"/>
                <a:ext cx="100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3.42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0" name="Line 299">
                <a:extLst>
                  <a:ext uri="{FF2B5EF4-FFF2-40B4-BE49-F238E27FC236}">
                    <a16:creationId xmlns:a16="http://schemas.microsoft.com/office/drawing/2014/main" xmlns="" id="{834FC068-5709-439A-B8E0-8B84308B871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4040" y="1739"/>
                <a:ext cx="61" cy="6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101" name="Rectangle 300">
                <a:extLst>
                  <a:ext uri="{FF2B5EF4-FFF2-40B4-BE49-F238E27FC236}">
                    <a16:creationId xmlns:a16="http://schemas.microsoft.com/office/drawing/2014/main" xmlns="" id="{CE626D9F-DD08-45DA-A033-8F2C784592C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29" y="1709"/>
                <a:ext cx="78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8</a:t>
                </a:r>
                <a:endParaRPr kumimoji="0" lang="en-US" altLang="en-US" sz="5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2" name="Line 301">
                <a:extLst>
                  <a:ext uri="{FF2B5EF4-FFF2-40B4-BE49-F238E27FC236}">
                    <a16:creationId xmlns:a16="http://schemas.microsoft.com/office/drawing/2014/main" xmlns="" id="{0C4F35E0-18B6-4189-A65D-37D9DC8FECA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766" y="1747"/>
                <a:ext cx="10" cy="6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103" name="Rectangle 302">
                <a:extLst>
                  <a:ext uri="{FF2B5EF4-FFF2-40B4-BE49-F238E27FC236}">
                    <a16:creationId xmlns:a16="http://schemas.microsoft.com/office/drawing/2014/main" xmlns="" id="{EB0CA559-643A-443E-A0A9-EAD395986AC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86" y="174"/>
                <a:ext cx="0" cy="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grpSp>
          <p:nvGrpSpPr>
            <p:cNvPr id="304" name="Group 308">
              <a:extLst>
                <a:ext uri="{FF2B5EF4-FFF2-40B4-BE49-F238E27FC236}">
                  <a16:creationId xmlns:a16="http://schemas.microsoft.com/office/drawing/2014/main" xmlns="" id="{0F66C2D2-0DCA-49F5-97B8-9593339DDAC3}"/>
                </a:ext>
              </a:extLst>
            </p:cNvPr>
            <p:cNvGrpSpPr>
              <a:grpSpLocks noChangeAspect="1"/>
            </p:cNvGrpSpPr>
            <p:nvPr/>
          </p:nvGrpSpPr>
          <p:grpSpPr bwMode="auto">
            <a:xfrm>
              <a:off x="3661543" y="1862442"/>
              <a:ext cx="6339016" cy="3896899"/>
              <a:chOff x="1125" y="808"/>
              <a:chExt cx="3242" cy="2368"/>
            </a:xfrm>
          </p:grpSpPr>
          <p:sp>
            <p:nvSpPr>
              <p:cNvPr id="305" name="AutoShape 307">
                <a:extLst>
                  <a:ext uri="{FF2B5EF4-FFF2-40B4-BE49-F238E27FC236}">
                    <a16:creationId xmlns:a16="http://schemas.microsoft.com/office/drawing/2014/main" xmlns="" id="{568D796C-C79E-4F55-8CFC-7846372A626F}"/>
                  </a:ext>
                </a:extLst>
              </p:cNvPr>
              <p:cNvSpPr>
                <a:spLocks noChangeAspect="1" noChangeArrowheads="1" noTextEdit="1"/>
              </p:cNvSpPr>
              <p:nvPr/>
            </p:nvSpPr>
            <p:spPr bwMode="auto">
              <a:xfrm>
                <a:off x="1125" y="1914"/>
                <a:ext cx="3242" cy="126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grpSp>
            <p:nvGrpSpPr>
              <p:cNvPr id="306" name="Group 509">
                <a:extLst>
                  <a:ext uri="{FF2B5EF4-FFF2-40B4-BE49-F238E27FC236}">
                    <a16:creationId xmlns:a16="http://schemas.microsoft.com/office/drawing/2014/main" xmlns="" id="{80450307-1E84-4DD8-ABFA-FDB1212A755D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198" y="1917"/>
                <a:ext cx="3114" cy="1259"/>
                <a:chOff x="1198" y="1917"/>
                <a:chExt cx="3114" cy="1259"/>
              </a:xfrm>
            </p:grpSpPr>
            <p:sp>
              <p:nvSpPr>
                <p:cNvPr id="368" name="Rectangle 310">
                  <a:extLst>
                    <a:ext uri="{FF2B5EF4-FFF2-40B4-BE49-F238E27FC236}">
                      <a16:creationId xmlns:a16="http://schemas.microsoft.com/office/drawing/2014/main" xmlns="" id="{B33BA0CC-D408-4FA1-8127-C2AED8B11D0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228" y="1917"/>
                  <a:ext cx="36" cy="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 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69" name="Line 321">
                  <a:extLst>
                    <a:ext uri="{FF2B5EF4-FFF2-40B4-BE49-F238E27FC236}">
                      <a16:creationId xmlns:a16="http://schemas.microsoft.com/office/drawing/2014/main" xmlns="" id="{6E4AE567-691E-41E2-BC9E-92CF220E1BB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302" y="3074"/>
                  <a:ext cx="2992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70" name="Line 322">
                  <a:extLst>
                    <a:ext uri="{FF2B5EF4-FFF2-40B4-BE49-F238E27FC236}">
                      <a16:creationId xmlns:a16="http://schemas.microsoft.com/office/drawing/2014/main" xmlns="" id="{B5831C3B-E37E-47EB-A598-9F58277277C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345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71" name="Line 323">
                  <a:extLst>
                    <a:ext uri="{FF2B5EF4-FFF2-40B4-BE49-F238E27FC236}">
                      <a16:creationId xmlns:a16="http://schemas.microsoft.com/office/drawing/2014/main" xmlns="" id="{9AC97DC0-4A7F-4806-B0B6-D816E6BFB73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388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72" name="Line 324">
                  <a:extLst>
                    <a:ext uri="{FF2B5EF4-FFF2-40B4-BE49-F238E27FC236}">
                      <a16:creationId xmlns:a16="http://schemas.microsoft.com/office/drawing/2014/main" xmlns="" id="{05E62587-13B8-4B3E-9255-DE9C31EC766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430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73" name="Line 325">
                  <a:extLst>
                    <a:ext uri="{FF2B5EF4-FFF2-40B4-BE49-F238E27FC236}">
                      <a16:creationId xmlns:a16="http://schemas.microsoft.com/office/drawing/2014/main" xmlns="" id="{912B90A9-F3B7-49FF-9896-D004AD5784F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473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74" name="Line 326">
                  <a:extLst>
                    <a:ext uri="{FF2B5EF4-FFF2-40B4-BE49-F238E27FC236}">
                      <a16:creationId xmlns:a16="http://schemas.microsoft.com/office/drawing/2014/main" xmlns="" id="{1573B011-3B29-4818-9EC9-F63CCACB670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556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75" name="Line 327">
                  <a:extLst>
                    <a:ext uri="{FF2B5EF4-FFF2-40B4-BE49-F238E27FC236}">
                      <a16:creationId xmlns:a16="http://schemas.microsoft.com/office/drawing/2014/main" xmlns="" id="{E0AFDDCF-EE1F-4025-A025-E192826081C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599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76" name="Line 328">
                  <a:extLst>
                    <a:ext uri="{FF2B5EF4-FFF2-40B4-BE49-F238E27FC236}">
                      <a16:creationId xmlns:a16="http://schemas.microsoft.com/office/drawing/2014/main" xmlns="" id="{1E2101D4-400B-44E0-A521-2265C42432E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642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77" name="Line 329">
                  <a:extLst>
                    <a:ext uri="{FF2B5EF4-FFF2-40B4-BE49-F238E27FC236}">
                      <a16:creationId xmlns:a16="http://schemas.microsoft.com/office/drawing/2014/main" xmlns="" id="{D200E443-0832-4D04-B7A5-7C73CC801A2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685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78" name="Line 330">
                  <a:extLst>
                    <a:ext uri="{FF2B5EF4-FFF2-40B4-BE49-F238E27FC236}">
                      <a16:creationId xmlns:a16="http://schemas.microsoft.com/office/drawing/2014/main" xmlns="" id="{09A120AF-D748-46CA-8B70-7E3E4F0A463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768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79" name="Line 331">
                  <a:extLst>
                    <a:ext uri="{FF2B5EF4-FFF2-40B4-BE49-F238E27FC236}">
                      <a16:creationId xmlns:a16="http://schemas.microsoft.com/office/drawing/2014/main" xmlns="" id="{54DCE54F-C8BD-455D-8046-F9CFFB7B3FD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811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80" name="Line 332">
                  <a:extLst>
                    <a:ext uri="{FF2B5EF4-FFF2-40B4-BE49-F238E27FC236}">
                      <a16:creationId xmlns:a16="http://schemas.microsoft.com/office/drawing/2014/main" xmlns="" id="{D2B319C2-AAA2-49F5-8B3A-B6449C2CB70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853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81" name="Line 333">
                  <a:extLst>
                    <a:ext uri="{FF2B5EF4-FFF2-40B4-BE49-F238E27FC236}">
                      <a16:creationId xmlns:a16="http://schemas.microsoft.com/office/drawing/2014/main" xmlns="" id="{EC5B0B54-D8D7-4CE6-A62D-4A2F3BCD7D8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894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82" name="Line 334">
                  <a:extLst>
                    <a:ext uri="{FF2B5EF4-FFF2-40B4-BE49-F238E27FC236}">
                      <a16:creationId xmlns:a16="http://schemas.microsoft.com/office/drawing/2014/main" xmlns="" id="{15954858-E3C1-479D-9399-EB25A88A0E7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979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83" name="Line 335">
                  <a:extLst>
                    <a:ext uri="{FF2B5EF4-FFF2-40B4-BE49-F238E27FC236}">
                      <a16:creationId xmlns:a16="http://schemas.microsoft.com/office/drawing/2014/main" xmlns="" id="{6236C519-64A0-4229-BF89-87EC5546E31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022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84" name="Line 336">
                  <a:extLst>
                    <a:ext uri="{FF2B5EF4-FFF2-40B4-BE49-F238E27FC236}">
                      <a16:creationId xmlns:a16="http://schemas.microsoft.com/office/drawing/2014/main" xmlns="" id="{5CA8FD0C-01F2-4BBC-B9AB-198DB07DF1A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065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85" name="Line 337">
                  <a:extLst>
                    <a:ext uri="{FF2B5EF4-FFF2-40B4-BE49-F238E27FC236}">
                      <a16:creationId xmlns:a16="http://schemas.microsoft.com/office/drawing/2014/main" xmlns="" id="{AD884714-0098-4DC2-8910-30233BF607D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105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86" name="Line 338">
                  <a:extLst>
                    <a:ext uri="{FF2B5EF4-FFF2-40B4-BE49-F238E27FC236}">
                      <a16:creationId xmlns:a16="http://schemas.microsoft.com/office/drawing/2014/main" xmlns="" id="{A9C6961D-D25A-4D42-9A61-3CCA84428BA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191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87" name="Line 339">
                  <a:extLst>
                    <a:ext uri="{FF2B5EF4-FFF2-40B4-BE49-F238E27FC236}">
                      <a16:creationId xmlns:a16="http://schemas.microsoft.com/office/drawing/2014/main" xmlns="" id="{6F84DB47-9BA8-4D13-BFB6-A8C604E09BB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233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88" name="Line 340">
                  <a:extLst>
                    <a:ext uri="{FF2B5EF4-FFF2-40B4-BE49-F238E27FC236}">
                      <a16:creationId xmlns:a16="http://schemas.microsoft.com/office/drawing/2014/main" xmlns="" id="{3F733824-C72B-4461-8970-9BE42B20123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276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89" name="Line 341">
                  <a:extLst>
                    <a:ext uri="{FF2B5EF4-FFF2-40B4-BE49-F238E27FC236}">
                      <a16:creationId xmlns:a16="http://schemas.microsoft.com/office/drawing/2014/main" xmlns="" id="{3C9E0E3A-B125-46A2-ADD8-32BC058DA9A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317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90" name="Line 342">
                  <a:extLst>
                    <a:ext uri="{FF2B5EF4-FFF2-40B4-BE49-F238E27FC236}">
                      <a16:creationId xmlns:a16="http://schemas.microsoft.com/office/drawing/2014/main" xmlns="" id="{40642E06-2F3A-4AF7-AF15-524F6B3E6DA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402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91" name="Line 343">
                  <a:extLst>
                    <a:ext uri="{FF2B5EF4-FFF2-40B4-BE49-F238E27FC236}">
                      <a16:creationId xmlns:a16="http://schemas.microsoft.com/office/drawing/2014/main" xmlns="" id="{0F53E3D6-27E3-4A90-BE98-EF3C468C502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445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92" name="Line 344">
                  <a:extLst>
                    <a:ext uri="{FF2B5EF4-FFF2-40B4-BE49-F238E27FC236}">
                      <a16:creationId xmlns:a16="http://schemas.microsoft.com/office/drawing/2014/main" xmlns="" id="{ECE0D356-B7CC-4A55-9F38-E00899B31E8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485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93" name="Line 345">
                  <a:extLst>
                    <a:ext uri="{FF2B5EF4-FFF2-40B4-BE49-F238E27FC236}">
                      <a16:creationId xmlns:a16="http://schemas.microsoft.com/office/drawing/2014/main" xmlns="" id="{8BAC03F9-6EF5-47F3-83CE-2353A0CE527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528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94" name="Line 346">
                  <a:extLst>
                    <a:ext uri="{FF2B5EF4-FFF2-40B4-BE49-F238E27FC236}">
                      <a16:creationId xmlns:a16="http://schemas.microsoft.com/office/drawing/2014/main" xmlns="" id="{E64E3C55-9032-4F6E-87C4-1A400A279BD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614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95" name="Line 347">
                  <a:extLst>
                    <a:ext uri="{FF2B5EF4-FFF2-40B4-BE49-F238E27FC236}">
                      <a16:creationId xmlns:a16="http://schemas.microsoft.com/office/drawing/2014/main" xmlns="" id="{DC8B4C79-5223-4E36-AE71-F61475FB639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656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96" name="Line 348">
                  <a:extLst>
                    <a:ext uri="{FF2B5EF4-FFF2-40B4-BE49-F238E27FC236}">
                      <a16:creationId xmlns:a16="http://schemas.microsoft.com/office/drawing/2014/main" xmlns="" id="{9EE97539-9A4A-4792-A62F-6015E8ACCD5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697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97" name="Line 349">
                  <a:extLst>
                    <a:ext uri="{FF2B5EF4-FFF2-40B4-BE49-F238E27FC236}">
                      <a16:creationId xmlns:a16="http://schemas.microsoft.com/office/drawing/2014/main" xmlns="" id="{8B2E51EC-4FC9-453C-9873-BBDEA807D93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740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98" name="Line 350">
                  <a:extLst>
                    <a:ext uri="{FF2B5EF4-FFF2-40B4-BE49-F238E27FC236}">
                      <a16:creationId xmlns:a16="http://schemas.microsoft.com/office/drawing/2014/main" xmlns="" id="{D4FCF9F4-3B00-4184-94A7-075525DEBD2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825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99" name="Line 351">
                  <a:extLst>
                    <a:ext uri="{FF2B5EF4-FFF2-40B4-BE49-F238E27FC236}">
                      <a16:creationId xmlns:a16="http://schemas.microsoft.com/office/drawing/2014/main" xmlns="" id="{FBDA15F9-C3C4-46E1-B5A8-DA15519CDCD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868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00" name="Line 352">
                  <a:extLst>
                    <a:ext uri="{FF2B5EF4-FFF2-40B4-BE49-F238E27FC236}">
                      <a16:creationId xmlns:a16="http://schemas.microsoft.com/office/drawing/2014/main" xmlns="" id="{5FCC9E16-0C88-47B1-A7A4-69521FD483E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908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01" name="Line 353">
                  <a:extLst>
                    <a:ext uri="{FF2B5EF4-FFF2-40B4-BE49-F238E27FC236}">
                      <a16:creationId xmlns:a16="http://schemas.microsoft.com/office/drawing/2014/main" xmlns="" id="{E3A06F5D-9868-4A16-A9FA-AA296DCEC13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951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02" name="Line 354">
                  <a:extLst>
                    <a:ext uri="{FF2B5EF4-FFF2-40B4-BE49-F238E27FC236}">
                      <a16:creationId xmlns:a16="http://schemas.microsoft.com/office/drawing/2014/main" xmlns="" id="{EF5B8FEE-B055-44DE-9D6A-098DC8E9C60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036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03" name="Line 355">
                  <a:extLst>
                    <a:ext uri="{FF2B5EF4-FFF2-40B4-BE49-F238E27FC236}">
                      <a16:creationId xmlns:a16="http://schemas.microsoft.com/office/drawing/2014/main" xmlns="" id="{0E8849F5-58F1-4E2F-9D97-61267B1AA73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077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04" name="Line 356">
                  <a:extLst>
                    <a:ext uri="{FF2B5EF4-FFF2-40B4-BE49-F238E27FC236}">
                      <a16:creationId xmlns:a16="http://schemas.microsoft.com/office/drawing/2014/main" xmlns="" id="{867914CF-436B-4706-9A65-6DCB2879AA0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20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05" name="Line 357">
                  <a:extLst>
                    <a:ext uri="{FF2B5EF4-FFF2-40B4-BE49-F238E27FC236}">
                      <a16:creationId xmlns:a16="http://schemas.microsoft.com/office/drawing/2014/main" xmlns="" id="{3DE02B5D-E01F-4C19-9468-39A3C2286FC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62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06" name="Line 358">
                  <a:extLst>
                    <a:ext uri="{FF2B5EF4-FFF2-40B4-BE49-F238E27FC236}">
                      <a16:creationId xmlns:a16="http://schemas.microsoft.com/office/drawing/2014/main" xmlns="" id="{6853E3B3-BC6D-4834-9961-BEF164DC5D5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248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07" name="Line 359">
                  <a:extLst>
                    <a:ext uri="{FF2B5EF4-FFF2-40B4-BE49-F238E27FC236}">
                      <a16:creationId xmlns:a16="http://schemas.microsoft.com/office/drawing/2014/main" xmlns="" id="{B694D6A4-220E-413D-ADA9-D9454B323DE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288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08" name="Line 360">
                  <a:extLst>
                    <a:ext uri="{FF2B5EF4-FFF2-40B4-BE49-F238E27FC236}">
                      <a16:creationId xmlns:a16="http://schemas.microsoft.com/office/drawing/2014/main" xmlns="" id="{603423F6-7D60-4F4C-A631-DDC9466D4A9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331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09" name="Line 361">
                  <a:extLst>
                    <a:ext uri="{FF2B5EF4-FFF2-40B4-BE49-F238E27FC236}">
                      <a16:creationId xmlns:a16="http://schemas.microsoft.com/office/drawing/2014/main" xmlns="" id="{05A2D17E-BC41-4876-80E9-F30C61AE6DA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374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10" name="Line 362">
                  <a:extLst>
                    <a:ext uri="{FF2B5EF4-FFF2-40B4-BE49-F238E27FC236}">
                      <a16:creationId xmlns:a16="http://schemas.microsoft.com/office/drawing/2014/main" xmlns="" id="{6E62FA64-CCA1-4ED0-9151-953FD845FED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459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11" name="Line 363">
                  <a:extLst>
                    <a:ext uri="{FF2B5EF4-FFF2-40B4-BE49-F238E27FC236}">
                      <a16:creationId xmlns:a16="http://schemas.microsoft.com/office/drawing/2014/main" xmlns="" id="{76A81F64-8CF0-4BA2-9383-CF58A156753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500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12" name="Line 364">
                  <a:extLst>
                    <a:ext uri="{FF2B5EF4-FFF2-40B4-BE49-F238E27FC236}">
                      <a16:creationId xmlns:a16="http://schemas.microsoft.com/office/drawing/2014/main" xmlns="" id="{18425A22-9C91-45DD-A6C8-02440B6EDD6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543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13" name="Line 365">
                  <a:extLst>
                    <a:ext uri="{FF2B5EF4-FFF2-40B4-BE49-F238E27FC236}">
                      <a16:creationId xmlns:a16="http://schemas.microsoft.com/office/drawing/2014/main" xmlns="" id="{6E8A2FDE-4245-42D0-9E66-D4439F2378D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585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14" name="Line 366">
                  <a:extLst>
                    <a:ext uri="{FF2B5EF4-FFF2-40B4-BE49-F238E27FC236}">
                      <a16:creationId xmlns:a16="http://schemas.microsoft.com/office/drawing/2014/main" xmlns="" id="{DF552734-1D01-43A2-9213-F4838906235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669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15" name="Line 367">
                  <a:extLst>
                    <a:ext uri="{FF2B5EF4-FFF2-40B4-BE49-F238E27FC236}">
                      <a16:creationId xmlns:a16="http://schemas.microsoft.com/office/drawing/2014/main" xmlns="" id="{D7C5B133-AA57-470C-9470-13CE6886532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711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16" name="Line 368">
                  <a:extLst>
                    <a:ext uri="{FF2B5EF4-FFF2-40B4-BE49-F238E27FC236}">
                      <a16:creationId xmlns:a16="http://schemas.microsoft.com/office/drawing/2014/main" xmlns="" id="{15B2969B-A119-4F9E-BFAA-F47C004FCBC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754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17" name="Line 369">
                  <a:extLst>
                    <a:ext uri="{FF2B5EF4-FFF2-40B4-BE49-F238E27FC236}">
                      <a16:creationId xmlns:a16="http://schemas.microsoft.com/office/drawing/2014/main" xmlns="" id="{3BFB40EE-556E-46D6-A943-C94AD0A3CC7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797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18" name="Line 370">
                  <a:extLst>
                    <a:ext uri="{FF2B5EF4-FFF2-40B4-BE49-F238E27FC236}">
                      <a16:creationId xmlns:a16="http://schemas.microsoft.com/office/drawing/2014/main" xmlns="" id="{4EDD9EB3-7DB2-450C-88F3-D02E3D2A9A0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880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19" name="Line 371">
                  <a:extLst>
                    <a:ext uri="{FF2B5EF4-FFF2-40B4-BE49-F238E27FC236}">
                      <a16:creationId xmlns:a16="http://schemas.microsoft.com/office/drawing/2014/main" xmlns="" id="{B7BF8F80-C46F-493A-92AE-5D6918A8B7E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923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20" name="Line 372">
                  <a:extLst>
                    <a:ext uri="{FF2B5EF4-FFF2-40B4-BE49-F238E27FC236}">
                      <a16:creationId xmlns:a16="http://schemas.microsoft.com/office/drawing/2014/main" xmlns="" id="{2ED72D2D-4937-4F40-87CA-195342F07FA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966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21" name="Line 373">
                  <a:extLst>
                    <a:ext uri="{FF2B5EF4-FFF2-40B4-BE49-F238E27FC236}">
                      <a16:creationId xmlns:a16="http://schemas.microsoft.com/office/drawing/2014/main" xmlns="" id="{640936AF-4FEA-419A-97A5-CECE2CF38CF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008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22" name="Line 374">
                  <a:extLst>
                    <a:ext uri="{FF2B5EF4-FFF2-40B4-BE49-F238E27FC236}">
                      <a16:creationId xmlns:a16="http://schemas.microsoft.com/office/drawing/2014/main" xmlns="" id="{DBD303EB-AFF1-421C-A1D3-2B211065FA7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092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23" name="Line 375">
                  <a:extLst>
                    <a:ext uri="{FF2B5EF4-FFF2-40B4-BE49-F238E27FC236}">
                      <a16:creationId xmlns:a16="http://schemas.microsoft.com/office/drawing/2014/main" xmlns="" id="{034EC32A-0F4F-476B-B154-841B47A92BD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134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24" name="Line 376">
                  <a:extLst>
                    <a:ext uri="{FF2B5EF4-FFF2-40B4-BE49-F238E27FC236}">
                      <a16:creationId xmlns:a16="http://schemas.microsoft.com/office/drawing/2014/main" xmlns="" id="{60002D17-63CD-423B-B9EF-3968AD618D5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177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25" name="Line 377">
                  <a:extLst>
                    <a:ext uri="{FF2B5EF4-FFF2-40B4-BE49-F238E27FC236}">
                      <a16:creationId xmlns:a16="http://schemas.microsoft.com/office/drawing/2014/main" xmlns="" id="{D74E9D05-7354-4ABE-9779-4F1065EE7B0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220" y="3074"/>
                  <a:ext cx="0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26" name="Line 378">
                  <a:extLst>
                    <a:ext uri="{FF2B5EF4-FFF2-40B4-BE49-F238E27FC236}">
                      <a16:creationId xmlns:a16="http://schemas.microsoft.com/office/drawing/2014/main" xmlns="" id="{F04901C2-E825-4A97-9E49-B5731FF344A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302" y="3074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27" name="Rectangle 379">
                  <a:extLst>
                    <a:ext uri="{FF2B5EF4-FFF2-40B4-BE49-F238E27FC236}">
                      <a16:creationId xmlns:a16="http://schemas.microsoft.com/office/drawing/2014/main" xmlns="" id="{BDD57D37-BACB-4821-93BF-ED41225FD4A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264" y="3093"/>
                  <a:ext cx="76" cy="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50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28" name="Line 380">
                  <a:extLst>
                    <a:ext uri="{FF2B5EF4-FFF2-40B4-BE49-F238E27FC236}">
                      <a16:creationId xmlns:a16="http://schemas.microsoft.com/office/drawing/2014/main" xmlns="" id="{94CC1FA8-92D3-423B-8BB5-1A58CCECD87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514" y="3074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29" name="Rectangle 381">
                  <a:extLst>
                    <a:ext uri="{FF2B5EF4-FFF2-40B4-BE49-F238E27FC236}">
                      <a16:creationId xmlns:a16="http://schemas.microsoft.com/office/drawing/2014/main" xmlns="" id="{A49776DC-EE2C-424C-AB25-067717C4BDD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462" y="3093"/>
                  <a:ext cx="104" cy="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00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30" name="Line 382">
                  <a:extLst>
                    <a:ext uri="{FF2B5EF4-FFF2-40B4-BE49-F238E27FC236}">
                      <a16:creationId xmlns:a16="http://schemas.microsoft.com/office/drawing/2014/main" xmlns="" id="{7AE11840-B707-4E60-850D-DE6FA085156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725" y="3074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31" name="Rectangle 383">
                  <a:extLst>
                    <a:ext uri="{FF2B5EF4-FFF2-40B4-BE49-F238E27FC236}">
                      <a16:creationId xmlns:a16="http://schemas.microsoft.com/office/drawing/2014/main" xmlns="" id="{0790FA7F-FD98-4C3B-BEE7-57BE11C7B64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673" y="3093"/>
                  <a:ext cx="104" cy="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50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32" name="Line 384">
                  <a:extLst>
                    <a:ext uri="{FF2B5EF4-FFF2-40B4-BE49-F238E27FC236}">
                      <a16:creationId xmlns:a16="http://schemas.microsoft.com/office/drawing/2014/main" xmlns="" id="{C89D4C51-26C5-46BF-BD1E-E524F82C20C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937" y="3074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33" name="Rectangle 385">
                  <a:extLst>
                    <a:ext uri="{FF2B5EF4-FFF2-40B4-BE49-F238E27FC236}">
                      <a16:creationId xmlns:a16="http://schemas.microsoft.com/office/drawing/2014/main" xmlns="" id="{D4CA2CE3-37D7-41AC-9C50-9EEB47A3CFC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885" y="3093"/>
                  <a:ext cx="104" cy="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200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34" name="Line 386">
                  <a:extLst>
                    <a:ext uri="{FF2B5EF4-FFF2-40B4-BE49-F238E27FC236}">
                      <a16:creationId xmlns:a16="http://schemas.microsoft.com/office/drawing/2014/main" xmlns="" id="{B259C3B9-D941-4966-A394-085B3E0C1CE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148" y="3074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35" name="Rectangle 387">
                  <a:extLst>
                    <a:ext uri="{FF2B5EF4-FFF2-40B4-BE49-F238E27FC236}">
                      <a16:creationId xmlns:a16="http://schemas.microsoft.com/office/drawing/2014/main" xmlns="" id="{C6962B8C-C57D-47D3-A39F-1EF7C9F8F4A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096" y="3093"/>
                  <a:ext cx="104" cy="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250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36" name="Line 388">
                  <a:extLst>
                    <a:ext uri="{FF2B5EF4-FFF2-40B4-BE49-F238E27FC236}">
                      <a16:creationId xmlns:a16="http://schemas.microsoft.com/office/drawing/2014/main" xmlns="" id="{579A5C5E-6156-4BC3-ABFA-C1ADE2F644B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359" y="3074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37" name="Rectangle 389">
                  <a:extLst>
                    <a:ext uri="{FF2B5EF4-FFF2-40B4-BE49-F238E27FC236}">
                      <a16:creationId xmlns:a16="http://schemas.microsoft.com/office/drawing/2014/main" xmlns="" id="{2482FABE-98FA-4E0D-AE8F-6FE1BC0D949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307" y="3093"/>
                  <a:ext cx="104" cy="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300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38" name="Line 390">
                  <a:extLst>
                    <a:ext uri="{FF2B5EF4-FFF2-40B4-BE49-F238E27FC236}">
                      <a16:creationId xmlns:a16="http://schemas.microsoft.com/office/drawing/2014/main" xmlns="" id="{2465F9AF-3930-4714-AD24-5A0B3DC18AB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571" y="3074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39" name="Rectangle 391">
                  <a:extLst>
                    <a:ext uri="{FF2B5EF4-FFF2-40B4-BE49-F238E27FC236}">
                      <a16:creationId xmlns:a16="http://schemas.microsoft.com/office/drawing/2014/main" xmlns="" id="{A673DC1E-5742-4120-AA45-32FA06BB094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19" y="3093"/>
                  <a:ext cx="104" cy="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350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40" name="Line 392">
                  <a:extLst>
                    <a:ext uri="{FF2B5EF4-FFF2-40B4-BE49-F238E27FC236}">
                      <a16:creationId xmlns:a16="http://schemas.microsoft.com/office/drawing/2014/main" xmlns="" id="{DB1C7F62-022A-4C99-8831-23579D6DA3D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782" y="3074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41" name="Rectangle 393">
                  <a:extLst>
                    <a:ext uri="{FF2B5EF4-FFF2-40B4-BE49-F238E27FC236}">
                      <a16:creationId xmlns:a16="http://schemas.microsoft.com/office/drawing/2014/main" xmlns="" id="{FC828B86-8A33-4FCE-82DD-47A630492F8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30" y="3093"/>
                  <a:ext cx="104" cy="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400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42" name="Line 394">
                  <a:extLst>
                    <a:ext uri="{FF2B5EF4-FFF2-40B4-BE49-F238E27FC236}">
                      <a16:creationId xmlns:a16="http://schemas.microsoft.com/office/drawing/2014/main" xmlns="" id="{58E6B141-DE84-40D0-926E-CA8ED1AEDF2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994" y="3074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43" name="Rectangle 395">
                  <a:extLst>
                    <a:ext uri="{FF2B5EF4-FFF2-40B4-BE49-F238E27FC236}">
                      <a16:creationId xmlns:a16="http://schemas.microsoft.com/office/drawing/2014/main" xmlns="" id="{A706DA1B-CFDF-42BD-88DA-03C00104587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942" y="3093"/>
                  <a:ext cx="104" cy="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450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44" name="Line 396">
                  <a:extLst>
                    <a:ext uri="{FF2B5EF4-FFF2-40B4-BE49-F238E27FC236}">
                      <a16:creationId xmlns:a16="http://schemas.microsoft.com/office/drawing/2014/main" xmlns="" id="{E0BC3996-9B9D-41A5-A6AD-F08AC55EB35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205" y="3074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45" name="Rectangle 397">
                  <a:extLst>
                    <a:ext uri="{FF2B5EF4-FFF2-40B4-BE49-F238E27FC236}">
                      <a16:creationId xmlns:a16="http://schemas.microsoft.com/office/drawing/2014/main" xmlns="" id="{FF58D550-D8E5-4563-89C3-A6561C26700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53" y="3093"/>
                  <a:ext cx="104" cy="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500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46" name="Line 398">
                  <a:extLst>
                    <a:ext uri="{FF2B5EF4-FFF2-40B4-BE49-F238E27FC236}">
                      <a16:creationId xmlns:a16="http://schemas.microsoft.com/office/drawing/2014/main" xmlns="" id="{EA786523-2C36-4049-A8A1-5F3C38822BB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417" y="3074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47" name="Rectangle 399">
                  <a:extLst>
                    <a:ext uri="{FF2B5EF4-FFF2-40B4-BE49-F238E27FC236}">
                      <a16:creationId xmlns:a16="http://schemas.microsoft.com/office/drawing/2014/main" xmlns="" id="{D1B139AB-C7E9-406A-835F-079B3D78F0B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65" y="3093"/>
                  <a:ext cx="104" cy="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550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48" name="Line 400">
                  <a:extLst>
                    <a:ext uri="{FF2B5EF4-FFF2-40B4-BE49-F238E27FC236}">
                      <a16:creationId xmlns:a16="http://schemas.microsoft.com/office/drawing/2014/main" xmlns="" id="{23EE6946-D61F-42B6-A4FD-5C556F2E9BF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628" y="3074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49" name="Rectangle 401">
                  <a:extLst>
                    <a:ext uri="{FF2B5EF4-FFF2-40B4-BE49-F238E27FC236}">
                      <a16:creationId xmlns:a16="http://schemas.microsoft.com/office/drawing/2014/main" xmlns="" id="{A9C066AF-71F9-47DC-99E9-28EABC35667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76" y="3093"/>
                  <a:ext cx="104" cy="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600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50" name="Line 402">
                  <a:extLst>
                    <a:ext uri="{FF2B5EF4-FFF2-40B4-BE49-F238E27FC236}">
                      <a16:creationId xmlns:a16="http://schemas.microsoft.com/office/drawing/2014/main" xmlns="" id="{4483946B-E578-4C04-BD20-EBDD441D9ED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839" y="3074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51" name="Rectangle 403">
                  <a:extLst>
                    <a:ext uri="{FF2B5EF4-FFF2-40B4-BE49-F238E27FC236}">
                      <a16:creationId xmlns:a16="http://schemas.microsoft.com/office/drawing/2014/main" xmlns="" id="{6FFCA1FB-6337-4E17-B3F1-F2083A19104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787" y="3093"/>
                  <a:ext cx="104" cy="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650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52" name="Line 404">
                  <a:extLst>
                    <a:ext uri="{FF2B5EF4-FFF2-40B4-BE49-F238E27FC236}">
                      <a16:creationId xmlns:a16="http://schemas.microsoft.com/office/drawing/2014/main" xmlns="" id="{6A89A6D3-6B47-4107-ABC7-3A460B4C7D8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051" y="3074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53" name="Rectangle 405">
                  <a:extLst>
                    <a:ext uri="{FF2B5EF4-FFF2-40B4-BE49-F238E27FC236}">
                      <a16:creationId xmlns:a16="http://schemas.microsoft.com/office/drawing/2014/main" xmlns="" id="{CDCAC39D-B77F-4C92-B5A4-245955207CC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999" y="3093"/>
                  <a:ext cx="104" cy="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700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54" name="Line 406">
                  <a:extLst>
                    <a:ext uri="{FF2B5EF4-FFF2-40B4-BE49-F238E27FC236}">
                      <a16:creationId xmlns:a16="http://schemas.microsoft.com/office/drawing/2014/main" xmlns="" id="{25DCD202-78F8-46C6-AAFE-1A3DE0925CA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260" y="3074"/>
                  <a:ext cx="0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55" name="Rectangle 407">
                  <a:extLst>
                    <a:ext uri="{FF2B5EF4-FFF2-40B4-BE49-F238E27FC236}">
                      <a16:creationId xmlns:a16="http://schemas.microsoft.com/office/drawing/2014/main" xmlns="" id="{4F5BE39E-36B0-4369-BF5F-7FC027EA892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208" y="3093"/>
                  <a:ext cx="104" cy="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750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56" name="Rectangle 408">
                  <a:extLst>
                    <a:ext uri="{FF2B5EF4-FFF2-40B4-BE49-F238E27FC236}">
                      <a16:creationId xmlns:a16="http://schemas.microsoft.com/office/drawing/2014/main" xmlns="" id="{6460E16D-37DC-428A-96D4-98100E308C7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47" y="3131"/>
                  <a:ext cx="100" cy="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m/z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57" name="Line 409">
                  <a:extLst>
                    <a:ext uri="{FF2B5EF4-FFF2-40B4-BE49-F238E27FC236}">
                      <a16:creationId xmlns:a16="http://schemas.microsoft.com/office/drawing/2014/main" xmlns="" id="{4D02DA10-AC13-4440-BCCA-6B09FEFB1A8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1302" y="2018"/>
                  <a:ext cx="0" cy="105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58" name="Line 410">
                  <a:extLst>
                    <a:ext uri="{FF2B5EF4-FFF2-40B4-BE49-F238E27FC236}">
                      <a16:creationId xmlns:a16="http://schemas.microsoft.com/office/drawing/2014/main" xmlns="" id="{794D878E-146E-440B-B220-920B32D72B1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3063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59" name="Line 411">
                  <a:extLst>
                    <a:ext uri="{FF2B5EF4-FFF2-40B4-BE49-F238E27FC236}">
                      <a16:creationId xmlns:a16="http://schemas.microsoft.com/office/drawing/2014/main" xmlns="" id="{1F7376E0-F225-4C21-BC06-EB6B60370CE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3053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60" name="Line 412">
                  <a:extLst>
                    <a:ext uri="{FF2B5EF4-FFF2-40B4-BE49-F238E27FC236}">
                      <a16:creationId xmlns:a16="http://schemas.microsoft.com/office/drawing/2014/main" xmlns="" id="{1D484774-CDEA-4728-B03A-2FC35E0C9CC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3042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61" name="Line 413">
                  <a:extLst>
                    <a:ext uri="{FF2B5EF4-FFF2-40B4-BE49-F238E27FC236}">
                      <a16:creationId xmlns:a16="http://schemas.microsoft.com/office/drawing/2014/main" xmlns="" id="{A8C1A8C5-BE4C-4A25-95EF-C2BF275398B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3032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62" name="Line 414">
                  <a:extLst>
                    <a:ext uri="{FF2B5EF4-FFF2-40B4-BE49-F238E27FC236}">
                      <a16:creationId xmlns:a16="http://schemas.microsoft.com/office/drawing/2014/main" xmlns="" id="{A7EFFE00-AA84-4351-A86D-1B31FBA5732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3010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63" name="Line 415">
                  <a:extLst>
                    <a:ext uri="{FF2B5EF4-FFF2-40B4-BE49-F238E27FC236}">
                      <a16:creationId xmlns:a16="http://schemas.microsoft.com/office/drawing/2014/main" xmlns="" id="{684F504B-9154-4CAC-82A1-D3B2AB9DBED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999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64" name="Line 416">
                  <a:extLst>
                    <a:ext uri="{FF2B5EF4-FFF2-40B4-BE49-F238E27FC236}">
                      <a16:creationId xmlns:a16="http://schemas.microsoft.com/office/drawing/2014/main" xmlns="" id="{A698DB29-1E06-4CE3-B839-CD5079E67DD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989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65" name="Line 417">
                  <a:extLst>
                    <a:ext uri="{FF2B5EF4-FFF2-40B4-BE49-F238E27FC236}">
                      <a16:creationId xmlns:a16="http://schemas.microsoft.com/office/drawing/2014/main" xmlns="" id="{5CAAB4F0-F903-4CCC-AEA1-542E722D79B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979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66" name="Line 418">
                  <a:extLst>
                    <a:ext uri="{FF2B5EF4-FFF2-40B4-BE49-F238E27FC236}">
                      <a16:creationId xmlns:a16="http://schemas.microsoft.com/office/drawing/2014/main" xmlns="" id="{C4389B80-1EAD-43D1-9887-B8168E62B99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958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67" name="Line 419">
                  <a:extLst>
                    <a:ext uri="{FF2B5EF4-FFF2-40B4-BE49-F238E27FC236}">
                      <a16:creationId xmlns:a16="http://schemas.microsoft.com/office/drawing/2014/main" xmlns="" id="{DD8F215F-9AE3-4C11-8EB0-9ED652F7CCB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946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68" name="Line 420">
                  <a:extLst>
                    <a:ext uri="{FF2B5EF4-FFF2-40B4-BE49-F238E27FC236}">
                      <a16:creationId xmlns:a16="http://schemas.microsoft.com/office/drawing/2014/main" xmlns="" id="{FF7F67C5-A911-422B-89C4-4CE0203C2F3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936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69" name="Line 421">
                  <a:extLst>
                    <a:ext uri="{FF2B5EF4-FFF2-40B4-BE49-F238E27FC236}">
                      <a16:creationId xmlns:a16="http://schemas.microsoft.com/office/drawing/2014/main" xmlns="" id="{F4491D74-06DF-4B8E-9D50-56F91CBE2B4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925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70" name="Line 422">
                  <a:extLst>
                    <a:ext uri="{FF2B5EF4-FFF2-40B4-BE49-F238E27FC236}">
                      <a16:creationId xmlns:a16="http://schemas.microsoft.com/office/drawing/2014/main" xmlns="" id="{9A87F57D-2AE9-42B5-A9AA-BF08E9E99B1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905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71" name="Line 423">
                  <a:extLst>
                    <a:ext uri="{FF2B5EF4-FFF2-40B4-BE49-F238E27FC236}">
                      <a16:creationId xmlns:a16="http://schemas.microsoft.com/office/drawing/2014/main" xmlns="" id="{AA0B0B36-A134-49AB-A972-6D3307EABB1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894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72" name="Line 424">
                  <a:extLst>
                    <a:ext uri="{FF2B5EF4-FFF2-40B4-BE49-F238E27FC236}">
                      <a16:creationId xmlns:a16="http://schemas.microsoft.com/office/drawing/2014/main" xmlns="" id="{A5A1F096-6F83-47F2-B8BC-41C9B6378AE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884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73" name="Line 425">
                  <a:extLst>
                    <a:ext uri="{FF2B5EF4-FFF2-40B4-BE49-F238E27FC236}">
                      <a16:creationId xmlns:a16="http://schemas.microsoft.com/office/drawing/2014/main" xmlns="" id="{2765851C-9A14-4CE3-8285-D02D94FFD50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873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74" name="Line 426">
                  <a:extLst>
                    <a:ext uri="{FF2B5EF4-FFF2-40B4-BE49-F238E27FC236}">
                      <a16:creationId xmlns:a16="http://schemas.microsoft.com/office/drawing/2014/main" xmlns="" id="{382E3907-2211-4EE5-9B87-612BA92A183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851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75" name="Line 427">
                  <a:extLst>
                    <a:ext uri="{FF2B5EF4-FFF2-40B4-BE49-F238E27FC236}">
                      <a16:creationId xmlns:a16="http://schemas.microsoft.com/office/drawing/2014/main" xmlns="" id="{A033FF92-3F4E-42D4-8207-C7FFA910EA1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841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76" name="Line 428">
                  <a:extLst>
                    <a:ext uri="{FF2B5EF4-FFF2-40B4-BE49-F238E27FC236}">
                      <a16:creationId xmlns:a16="http://schemas.microsoft.com/office/drawing/2014/main" xmlns="" id="{7F1D8EFB-BCA7-48D8-8E86-919C51661C4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831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77" name="Line 429">
                  <a:extLst>
                    <a:ext uri="{FF2B5EF4-FFF2-40B4-BE49-F238E27FC236}">
                      <a16:creationId xmlns:a16="http://schemas.microsoft.com/office/drawing/2014/main" xmlns="" id="{A2704E4E-2B5C-4D77-B878-D5A9C46B197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820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78" name="Line 430">
                  <a:extLst>
                    <a:ext uri="{FF2B5EF4-FFF2-40B4-BE49-F238E27FC236}">
                      <a16:creationId xmlns:a16="http://schemas.microsoft.com/office/drawing/2014/main" xmlns="" id="{43D1A48C-9082-4F3A-855E-DA0660AC853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799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79" name="Line 431">
                  <a:extLst>
                    <a:ext uri="{FF2B5EF4-FFF2-40B4-BE49-F238E27FC236}">
                      <a16:creationId xmlns:a16="http://schemas.microsoft.com/office/drawing/2014/main" xmlns="" id="{10F50204-9DE2-4769-AC45-84A3340AEF9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789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80" name="Line 432">
                  <a:extLst>
                    <a:ext uri="{FF2B5EF4-FFF2-40B4-BE49-F238E27FC236}">
                      <a16:creationId xmlns:a16="http://schemas.microsoft.com/office/drawing/2014/main" xmlns="" id="{5CF7A02C-DEA0-4210-88F8-9B906D0FB8C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777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81" name="Line 433">
                  <a:extLst>
                    <a:ext uri="{FF2B5EF4-FFF2-40B4-BE49-F238E27FC236}">
                      <a16:creationId xmlns:a16="http://schemas.microsoft.com/office/drawing/2014/main" xmlns="" id="{12B4E9FE-1E4E-4539-B3C5-B652AE6300D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767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82" name="Line 434">
                  <a:extLst>
                    <a:ext uri="{FF2B5EF4-FFF2-40B4-BE49-F238E27FC236}">
                      <a16:creationId xmlns:a16="http://schemas.microsoft.com/office/drawing/2014/main" xmlns="" id="{FE539395-C1FB-4008-B982-B06F86ADB7B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746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83" name="Line 435">
                  <a:extLst>
                    <a:ext uri="{FF2B5EF4-FFF2-40B4-BE49-F238E27FC236}">
                      <a16:creationId xmlns:a16="http://schemas.microsoft.com/office/drawing/2014/main" xmlns="" id="{5D166AF0-EB5C-4AF0-9257-CA7C1A5E65C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736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84" name="Line 436">
                  <a:extLst>
                    <a:ext uri="{FF2B5EF4-FFF2-40B4-BE49-F238E27FC236}">
                      <a16:creationId xmlns:a16="http://schemas.microsoft.com/office/drawing/2014/main" xmlns="" id="{0F7487E0-6275-4099-89FD-B6DB77C8709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725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85" name="Line 437">
                  <a:extLst>
                    <a:ext uri="{FF2B5EF4-FFF2-40B4-BE49-F238E27FC236}">
                      <a16:creationId xmlns:a16="http://schemas.microsoft.com/office/drawing/2014/main" xmlns="" id="{1936DF02-9DA9-4E98-96D5-7BB4CF8993C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715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86" name="Line 438">
                  <a:extLst>
                    <a:ext uri="{FF2B5EF4-FFF2-40B4-BE49-F238E27FC236}">
                      <a16:creationId xmlns:a16="http://schemas.microsoft.com/office/drawing/2014/main" xmlns="" id="{36C6FDC4-472D-416D-BB5E-F94B461DB5A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694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87" name="Line 439">
                  <a:extLst>
                    <a:ext uri="{FF2B5EF4-FFF2-40B4-BE49-F238E27FC236}">
                      <a16:creationId xmlns:a16="http://schemas.microsoft.com/office/drawing/2014/main" xmlns="" id="{2D70ED95-682E-4D33-9855-BC4D7B7ABD5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684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88" name="Line 440">
                  <a:extLst>
                    <a:ext uri="{FF2B5EF4-FFF2-40B4-BE49-F238E27FC236}">
                      <a16:creationId xmlns:a16="http://schemas.microsoft.com/office/drawing/2014/main" xmlns="" id="{30059A21-2600-491B-8FB0-8DA3EDB94B6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672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89" name="Line 441">
                  <a:extLst>
                    <a:ext uri="{FF2B5EF4-FFF2-40B4-BE49-F238E27FC236}">
                      <a16:creationId xmlns:a16="http://schemas.microsoft.com/office/drawing/2014/main" xmlns="" id="{1EA3C9E1-E553-41AA-97FA-A128952D601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662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90" name="Line 442">
                  <a:extLst>
                    <a:ext uri="{FF2B5EF4-FFF2-40B4-BE49-F238E27FC236}">
                      <a16:creationId xmlns:a16="http://schemas.microsoft.com/office/drawing/2014/main" xmlns="" id="{BE3C8F25-7701-4D50-B905-D5B4B19FF58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641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91" name="Line 443">
                  <a:extLst>
                    <a:ext uri="{FF2B5EF4-FFF2-40B4-BE49-F238E27FC236}">
                      <a16:creationId xmlns:a16="http://schemas.microsoft.com/office/drawing/2014/main" xmlns="" id="{A2D9E673-B77D-4B7B-A55F-BE560A3A10F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630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92" name="Line 444">
                  <a:extLst>
                    <a:ext uri="{FF2B5EF4-FFF2-40B4-BE49-F238E27FC236}">
                      <a16:creationId xmlns:a16="http://schemas.microsoft.com/office/drawing/2014/main" xmlns="" id="{7FF68286-D14E-45D1-A02B-677172EA460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620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93" name="Line 445">
                  <a:extLst>
                    <a:ext uri="{FF2B5EF4-FFF2-40B4-BE49-F238E27FC236}">
                      <a16:creationId xmlns:a16="http://schemas.microsoft.com/office/drawing/2014/main" xmlns="" id="{ED8F80BA-62AB-471A-B406-2A039C940F1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610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94" name="Line 446">
                  <a:extLst>
                    <a:ext uri="{FF2B5EF4-FFF2-40B4-BE49-F238E27FC236}">
                      <a16:creationId xmlns:a16="http://schemas.microsoft.com/office/drawing/2014/main" xmlns="" id="{2DFD56FA-5696-4026-AA31-AF4360385BC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589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95" name="Line 447">
                  <a:extLst>
                    <a:ext uri="{FF2B5EF4-FFF2-40B4-BE49-F238E27FC236}">
                      <a16:creationId xmlns:a16="http://schemas.microsoft.com/office/drawing/2014/main" xmlns="" id="{71571199-47E5-4AD0-9F78-FEC66DF88F0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577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96" name="Line 448">
                  <a:extLst>
                    <a:ext uri="{FF2B5EF4-FFF2-40B4-BE49-F238E27FC236}">
                      <a16:creationId xmlns:a16="http://schemas.microsoft.com/office/drawing/2014/main" xmlns="" id="{E6B87DA8-156A-4AF9-B97D-5229AC91913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567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97" name="Line 449">
                  <a:extLst>
                    <a:ext uri="{FF2B5EF4-FFF2-40B4-BE49-F238E27FC236}">
                      <a16:creationId xmlns:a16="http://schemas.microsoft.com/office/drawing/2014/main" xmlns="" id="{A4F72A86-0280-48D2-BF9B-87B11E453FA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556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98" name="Line 450">
                  <a:extLst>
                    <a:ext uri="{FF2B5EF4-FFF2-40B4-BE49-F238E27FC236}">
                      <a16:creationId xmlns:a16="http://schemas.microsoft.com/office/drawing/2014/main" xmlns="" id="{29CD4C3A-525B-4E83-BF56-A56FD0C9CAB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536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99" name="Line 451">
                  <a:extLst>
                    <a:ext uri="{FF2B5EF4-FFF2-40B4-BE49-F238E27FC236}">
                      <a16:creationId xmlns:a16="http://schemas.microsoft.com/office/drawing/2014/main" xmlns="" id="{A2939E5D-B60C-41DD-B456-FC59BDCEFBE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525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00" name="Line 452">
                  <a:extLst>
                    <a:ext uri="{FF2B5EF4-FFF2-40B4-BE49-F238E27FC236}">
                      <a16:creationId xmlns:a16="http://schemas.microsoft.com/office/drawing/2014/main" xmlns="" id="{03CCD7A4-5933-45EA-A08E-236319F952A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515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01" name="Line 453">
                  <a:extLst>
                    <a:ext uri="{FF2B5EF4-FFF2-40B4-BE49-F238E27FC236}">
                      <a16:creationId xmlns:a16="http://schemas.microsoft.com/office/drawing/2014/main" xmlns="" id="{1F965029-FBB4-4962-A7A6-66DCE91C915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503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02" name="Line 454">
                  <a:extLst>
                    <a:ext uri="{FF2B5EF4-FFF2-40B4-BE49-F238E27FC236}">
                      <a16:creationId xmlns:a16="http://schemas.microsoft.com/office/drawing/2014/main" xmlns="" id="{1CCAF485-777E-4954-8E83-EE4C222E3FF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482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03" name="Line 455">
                  <a:extLst>
                    <a:ext uri="{FF2B5EF4-FFF2-40B4-BE49-F238E27FC236}">
                      <a16:creationId xmlns:a16="http://schemas.microsoft.com/office/drawing/2014/main" xmlns="" id="{56F68B98-BE9B-4CC5-8C11-E382CBC24CE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472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04" name="Line 456">
                  <a:extLst>
                    <a:ext uri="{FF2B5EF4-FFF2-40B4-BE49-F238E27FC236}">
                      <a16:creationId xmlns:a16="http://schemas.microsoft.com/office/drawing/2014/main" xmlns="" id="{65DB4703-450C-4554-908E-38252DE2B89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462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05" name="Line 457">
                  <a:extLst>
                    <a:ext uri="{FF2B5EF4-FFF2-40B4-BE49-F238E27FC236}">
                      <a16:creationId xmlns:a16="http://schemas.microsoft.com/office/drawing/2014/main" xmlns="" id="{BE470D4D-3C8E-4F5F-91AA-1D61BF84E22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451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06" name="Line 458">
                  <a:extLst>
                    <a:ext uri="{FF2B5EF4-FFF2-40B4-BE49-F238E27FC236}">
                      <a16:creationId xmlns:a16="http://schemas.microsoft.com/office/drawing/2014/main" xmlns="" id="{90E3A982-41AE-49DA-B22A-13ED193E537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429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07" name="Line 459">
                  <a:extLst>
                    <a:ext uri="{FF2B5EF4-FFF2-40B4-BE49-F238E27FC236}">
                      <a16:creationId xmlns:a16="http://schemas.microsoft.com/office/drawing/2014/main" xmlns="" id="{58E5BB82-987B-4CE8-BD09-D194B9F29D6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420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08" name="Line 460">
                  <a:extLst>
                    <a:ext uri="{FF2B5EF4-FFF2-40B4-BE49-F238E27FC236}">
                      <a16:creationId xmlns:a16="http://schemas.microsoft.com/office/drawing/2014/main" xmlns="" id="{9922EB03-B4B9-4CAB-A768-9269D7C96F5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408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09" name="Line 461">
                  <a:extLst>
                    <a:ext uri="{FF2B5EF4-FFF2-40B4-BE49-F238E27FC236}">
                      <a16:creationId xmlns:a16="http://schemas.microsoft.com/office/drawing/2014/main" xmlns="" id="{9C0801EC-101B-4334-8645-847280EB443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398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10" name="Line 462">
                  <a:extLst>
                    <a:ext uri="{FF2B5EF4-FFF2-40B4-BE49-F238E27FC236}">
                      <a16:creationId xmlns:a16="http://schemas.microsoft.com/office/drawing/2014/main" xmlns="" id="{B2149093-1307-4974-9525-91F7AC99476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377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11" name="Line 463">
                  <a:extLst>
                    <a:ext uri="{FF2B5EF4-FFF2-40B4-BE49-F238E27FC236}">
                      <a16:creationId xmlns:a16="http://schemas.microsoft.com/office/drawing/2014/main" xmlns="" id="{5B4C2025-E891-4794-9547-E2AFD80A45A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367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12" name="Line 464">
                  <a:extLst>
                    <a:ext uri="{FF2B5EF4-FFF2-40B4-BE49-F238E27FC236}">
                      <a16:creationId xmlns:a16="http://schemas.microsoft.com/office/drawing/2014/main" xmlns="" id="{A5594BE1-6C7B-444D-ADE3-0976A1F7551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356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13" name="Line 465">
                  <a:extLst>
                    <a:ext uri="{FF2B5EF4-FFF2-40B4-BE49-F238E27FC236}">
                      <a16:creationId xmlns:a16="http://schemas.microsoft.com/office/drawing/2014/main" xmlns="" id="{9AE054CD-95B8-4128-9EC0-35F6E93544D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346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14" name="Line 466">
                  <a:extLst>
                    <a:ext uri="{FF2B5EF4-FFF2-40B4-BE49-F238E27FC236}">
                      <a16:creationId xmlns:a16="http://schemas.microsoft.com/office/drawing/2014/main" xmlns="" id="{2652BB02-57F9-48B6-9B6E-DEB65921CCD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324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15" name="Line 467">
                  <a:extLst>
                    <a:ext uri="{FF2B5EF4-FFF2-40B4-BE49-F238E27FC236}">
                      <a16:creationId xmlns:a16="http://schemas.microsoft.com/office/drawing/2014/main" xmlns="" id="{8D223853-2E27-439D-BA34-97559745AF3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314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16" name="Line 468">
                  <a:extLst>
                    <a:ext uri="{FF2B5EF4-FFF2-40B4-BE49-F238E27FC236}">
                      <a16:creationId xmlns:a16="http://schemas.microsoft.com/office/drawing/2014/main" xmlns="" id="{243E4DC9-5047-4A32-9BA4-299444F3ED0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303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17" name="Line 469">
                  <a:extLst>
                    <a:ext uri="{FF2B5EF4-FFF2-40B4-BE49-F238E27FC236}">
                      <a16:creationId xmlns:a16="http://schemas.microsoft.com/office/drawing/2014/main" xmlns="" id="{327B3166-478A-4033-954F-BED2B81EBD0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293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18" name="Line 470">
                  <a:extLst>
                    <a:ext uri="{FF2B5EF4-FFF2-40B4-BE49-F238E27FC236}">
                      <a16:creationId xmlns:a16="http://schemas.microsoft.com/office/drawing/2014/main" xmlns="" id="{DCE249F6-E979-4CCC-B7E2-23F780A54DD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272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19" name="Line 471">
                  <a:extLst>
                    <a:ext uri="{FF2B5EF4-FFF2-40B4-BE49-F238E27FC236}">
                      <a16:creationId xmlns:a16="http://schemas.microsoft.com/office/drawing/2014/main" xmlns="" id="{265345B1-F491-40A1-AEA8-86F0565F41B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260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20" name="Line 472">
                  <a:extLst>
                    <a:ext uri="{FF2B5EF4-FFF2-40B4-BE49-F238E27FC236}">
                      <a16:creationId xmlns:a16="http://schemas.microsoft.com/office/drawing/2014/main" xmlns="" id="{E9AFEF21-E138-4339-A075-A8851BE49F6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251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21" name="Line 473">
                  <a:extLst>
                    <a:ext uri="{FF2B5EF4-FFF2-40B4-BE49-F238E27FC236}">
                      <a16:creationId xmlns:a16="http://schemas.microsoft.com/office/drawing/2014/main" xmlns="" id="{AC0B1047-E24C-440F-A3DE-75CB743D29B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241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22" name="Line 474">
                  <a:extLst>
                    <a:ext uri="{FF2B5EF4-FFF2-40B4-BE49-F238E27FC236}">
                      <a16:creationId xmlns:a16="http://schemas.microsoft.com/office/drawing/2014/main" xmlns="" id="{AEA816D2-23C1-41B5-ACB6-D8C37A5A111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219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23" name="Line 475">
                  <a:extLst>
                    <a:ext uri="{FF2B5EF4-FFF2-40B4-BE49-F238E27FC236}">
                      <a16:creationId xmlns:a16="http://schemas.microsoft.com/office/drawing/2014/main" xmlns="" id="{4BCB2B33-49F9-416C-92FA-60339754550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208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24" name="Line 476">
                  <a:extLst>
                    <a:ext uri="{FF2B5EF4-FFF2-40B4-BE49-F238E27FC236}">
                      <a16:creationId xmlns:a16="http://schemas.microsoft.com/office/drawing/2014/main" xmlns="" id="{718C3D04-17B8-4258-8579-581CA0F314B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198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25" name="Line 477">
                  <a:extLst>
                    <a:ext uri="{FF2B5EF4-FFF2-40B4-BE49-F238E27FC236}">
                      <a16:creationId xmlns:a16="http://schemas.microsoft.com/office/drawing/2014/main" xmlns="" id="{06E8A653-7C6A-4078-900F-56321842049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187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26" name="Line 478">
                  <a:extLst>
                    <a:ext uri="{FF2B5EF4-FFF2-40B4-BE49-F238E27FC236}">
                      <a16:creationId xmlns:a16="http://schemas.microsoft.com/office/drawing/2014/main" xmlns="" id="{1FA1ABC8-2D46-4392-8B55-C02DCCAC840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167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27" name="Line 479">
                  <a:extLst>
                    <a:ext uri="{FF2B5EF4-FFF2-40B4-BE49-F238E27FC236}">
                      <a16:creationId xmlns:a16="http://schemas.microsoft.com/office/drawing/2014/main" xmlns="" id="{9F79B8FD-2049-4D4F-AE98-67E9D54D511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155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28" name="Line 480">
                  <a:extLst>
                    <a:ext uri="{FF2B5EF4-FFF2-40B4-BE49-F238E27FC236}">
                      <a16:creationId xmlns:a16="http://schemas.microsoft.com/office/drawing/2014/main" xmlns="" id="{8289E013-9C28-4E2C-9287-831D9F8E106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145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29" name="Line 481">
                  <a:extLst>
                    <a:ext uri="{FF2B5EF4-FFF2-40B4-BE49-F238E27FC236}">
                      <a16:creationId xmlns:a16="http://schemas.microsoft.com/office/drawing/2014/main" xmlns="" id="{06754A83-5EFE-40BC-9C77-D5AE64AB5D0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134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30" name="Line 482">
                  <a:extLst>
                    <a:ext uri="{FF2B5EF4-FFF2-40B4-BE49-F238E27FC236}">
                      <a16:creationId xmlns:a16="http://schemas.microsoft.com/office/drawing/2014/main" xmlns="" id="{CD937D87-18C7-4CC9-8A1A-C2DD6546AB0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113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31" name="Line 483">
                  <a:extLst>
                    <a:ext uri="{FF2B5EF4-FFF2-40B4-BE49-F238E27FC236}">
                      <a16:creationId xmlns:a16="http://schemas.microsoft.com/office/drawing/2014/main" xmlns="" id="{723C6943-0DFC-4A4A-8117-F80517FE944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103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32" name="Line 484">
                  <a:extLst>
                    <a:ext uri="{FF2B5EF4-FFF2-40B4-BE49-F238E27FC236}">
                      <a16:creationId xmlns:a16="http://schemas.microsoft.com/office/drawing/2014/main" xmlns="" id="{351106F6-49D5-4094-B114-5E9D3A0D9AC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093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33" name="Line 485">
                  <a:extLst>
                    <a:ext uri="{FF2B5EF4-FFF2-40B4-BE49-F238E27FC236}">
                      <a16:creationId xmlns:a16="http://schemas.microsoft.com/office/drawing/2014/main" xmlns="" id="{549E89AE-3106-4CE8-B361-BDA85CA1EAE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082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34" name="Line 486">
                  <a:extLst>
                    <a:ext uri="{FF2B5EF4-FFF2-40B4-BE49-F238E27FC236}">
                      <a16:creationId xmlns:a16="http://schemas.microsoft.com/office/drawing/2014/main" xmlns="" id="{938F1524-46B2-4920-844D-B7AB595EAD8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060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35" name="Line 487">
                  <a:extLst>
                    <a:ext uri="{FF2B5EF4-FFF2-40B4-BE49-F238E27FC236}">
                      <a16:creationId xmlns:a16="http://schemas.microsoft.com/office/drawing/2014/main" xmlns="" id="{CC975601-8940-4D9B-BCC6-33C487C0B40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050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36" name="Line 488">
                  <a:extLst>
                    <a:ext uri="{FF2B5EF4-FFF2-40B4-BE49-F238E27FC236}">
                      <a16:creationId xmlns:a16="http://schemas.microsoft.com/office/drawing/2014/main" xmlns="" id="{7CC8E4CA-6BD9-45D9-A305-5F99ABD2E75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039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37" name="Line 489">
                  <a:extLst>
                    <a:ext uri="{FF2B5EF4-FFF2-40B4-BE49-F238E27FC236}">
                      <a16:creationId xmlns:a16="http://schemas.microsoft.com/office/drawing/2014/main" xmlns="" id="{6DF067D1-AA8C-4F7D-A186-C3A9267DD9D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3" y="2029"/>
                  <a:ext cx="1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38" name="Line 490">
                  <a:extLst>
                    <a:ext uri="{FF2B5EF4-FFF2-40B4-BE49-F238E27FC236}">
                      <a16:creationId xmlns:a16="http://schemas.microsoft.com/office/drawing/2014/main" xmlns="" id="{142013A6-A978-4717-8CFA-A4656DDA023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75" y="3073"/>
                  <a:ext cx="27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39" name="Rectangle 491">
                  <a:extLst>
                    <a:ext uri="{FF2B5EF4-FFF2-40B4-BE49-F238E27FC236}">
                      <a16:creationId xmlns:a16="http://schemas.microsoft.com/office/drawing/2014/main" xmlns="" id="{7589377F-5E96-4044-82B2-868C396D4EF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226" y="3057"/>
                  <a:ext cx="49" cy="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540" name="Line 492">
                  <a:extLst>
                    <a:ext uri="{FF2B5EF4-FFF2-40B4-BE49-F238E27FC236}">
                      <a16:creationId xmlns:a16="http://schemas.microsoft.com/office/drawing/2014/main" xmlns="" id="{FDB59E3F-7084-479A-8B62-02A16B44481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75" y="3020"/>
                  <a:ext cx="27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41" name="Rectangle 493">
                  <a:extLst>
                    <a:ext uri="{FF2B5EF4-FFF2-40B4-BE49-F238E27FC236}">
                      <a16:creationId xmlns:a16="http://schemas.microsoft.com/office/drawing/2014/main" xmlns="" id="{98E6D611-CBF4-4E2D-AB12-54C460D5132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226" y="3004"/>
                  <a:ext cx="49" cy="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5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542" name="Line 494">
                  <a:extLst>
                    <a:ext uri="{FF2B5EF4-FFF2-40B4-BE49-F238E27FC236}">
                      <a16:creationId xmlns:a16="http://schemas.microsoft.com/office/drawing/2014/main" xmlns="" id="{C43AA966-0071-4C77-A25D-55A51AD441E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75" y="2968"/>
                  <a:ext cx="27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43" name="Rectangle 495">
                  <a:extLst>
                    <a:ext uri="{FF2B5EF4-FFF2-40B4-BE49-F238E27FC236}">
                      <a16:creationId xmlns:a16="http://schemas.microsoft.com/office/drawing/2014/main" xmlns="" id="{A0A45701-21F5-4588-9D03-C8AFC9ED5C5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198" y="2952"/>
                  <a:ext cx="77" cy="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0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544" name="Line 496">
                  <a:extLst>
                    <a:ext uri="{FF2B5EF4-FFF2-40B4-BE49-F238E27FC236}">
                      <a16:creationId xmlns:a16="http://schemas.microsoft.com/office/drawing/2014/main" xmlns="" id="{54B1B32D-1154-4479-93E8-DB63FD85264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75" y="2915"/>
                  <a:ext cx="27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45" name="Rectangle 497">
                  <a:extLst>
                    <a:ext uri="{FF2B5EF4-FFF2-40B4-BE49-F238E27FC236}">
                      <a16:creationId xmlns:a16="http://schemas.microsoft.com/office/drawing/2014/main" xmlns="" id="{35722C17-CB90-4D93-8809-E54942FCDDD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198" y="2899"/>
                  <a:ext cx="77" cy="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5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546" name="Line 498">
                  <a:extLst>
                    <a:ext uri="{FF2B5EF4-FFF2-40B4-BE49-F238E27FC236}">
                      <a16:creationId xmlns:a16="http://schemas.microsoft.com/office/drawing/2014/main" xmlns="" id="{FCEA688B-2C9D-4DB7-BFDA-9C93156D692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75" y="2863"/>
                  <a:ext cx="27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47" name="Rectangle 499">
                  <a:extLst>
                    <a:ext uri="{FF2B5EF4-FFF2-40B4-BE49-F238E27FC236}">
                      <a16:creationId xmlns:a16="http://schemas.microsoft.com/office/drawing/2014/main" xmlns="" id="{8FC7C30B-D7B0-47F0-BE67-FF4A3FF229A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198" y="2847"/>
                  <a:ext cx="77" cy="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20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548" name="Line 500">
                  <a:extLst>
                    <a:ext uri="{FF2B5EF4-FFF2-40B4-BE49-F238E27FC236}">
                      <a16:creationId xmlns:a16="http://schemas.microsoft.com/office/drawing/2014/main" xmlns="" id="{7681E453-C154-426C-B913-DFA40A6FA88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75" y="2810"/>
                  <a:ext cx="27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49" name="Rectangle 501">
                  <a:extLst>
                    <a:ext uri="{FF2B5EF4-FFF2-40B4-BE49-F238E27FC236}">
                      <a16:creationId xmlns:a16="http://schemas.microsoft.com/office/drawing/2014/main" xmlns="" id="{8D7DC956-DD34-4702-B9A4-37804D7E8DA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198" y="2794"/>
                  <a:ext cx="77" cy="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25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550" name="Line 502">
                  <a:extLst>
                    <a:ext uri="{FF2B5EF4-FFF2-40B4-BE49-F238E27FC236}">
                      <a16:creationId xmlns:a16="http://schemas.microsoft.com/office/drawing/2014/main" xmlns="" id="{3314A7A3-5F1A-424D-82CD-4C20CE73041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75" y="2758"/>
                  <a:ext cx="27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51" name="Rectangle 503">
                  <a:extLst>
                    <a:ext uri="{FF2B5EF4-FFF2-40B4-BE49-F238E27FC236}">
                      <a16:creationId xmlns:a16="http://schemas.microsoft.com/office/drawing/2014/main" xmlns="" id="{D66F9D6A-311D-4C1F-A9C2-FBC8B5AE70C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198" y="2741"/>
                  <a:ext cx="77" cy="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30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552" name="Line 504">
                  <a:extLst>
                    <a:ext uri="{FF2B5EF4-FFF2-40B4-BE49-F238E27FC236}">
                      <a16:creationId xmlns:a16="http://schemas.microsoft.com/office/drawing/2014/main" xmlns="" id="{B36AFF5C-0E94-40C1-9881-CB80947BB62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75" y="2704"/>
                  <a:ext cx="27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53" name="Rectangle 505">
                  <a:extLst>
                    <a:ext uri="{FF2B5EF4-FFF2-40B4-BE49-F238E27FC236}">
                      <a16:creationId xmlns:a16="http://schemas.microsoft.com/office/drawing/2014/main" xmlns="" id="{DD6D7C05-652F-43D6-9366-325658B90E8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198" y="2688"/>
                  <a:ext cx="77" cy="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35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554" name="Line 506">
                  <a:extLst>
                    <a:ext uri="{FF2B5EF4-FFF2-40B4-BE49-F238E27FC236}">
                      <a16:creationId xmlns:a16="http://schemas.microsoft.com/office/drawing/2014/main" xmlns="" id="{A44EC2DB-4C91-44F9-B32D-584D69671FD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75" y="2651"/>
                  <a:ext cx="27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55" name="Rectangle 507">
                  <a:extLst>
                    <a:ext uri="{FF2B5EF4-FFF2-40B4-BE49-F238E27FC236}">
                      <a16:creationId xmlns:a16="http://schemas.microsoft.com/office/drawing/2014/main" xmlns="" id="{6AADC329-4F88-4A02-ADCE-C0479FC607B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198" y="2635"/>
                  <a:ext cx="77" cy="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40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556" name="Line 508">
                  <a:extLst>
                    <a:ext uri="{FF2B5EF4-FFF2-40B4-BE49-F238E27FC236}">
                      <a16:creationId xmlns:a16="http://schemas.microsoft.com/office/drawing/2014/main" xmlns="" id="{ADD6E1EA-6157-4EF6-8F68-C36C91D35AC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75" y="2598"/>
                  <a:ext cx="27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  <p:sp>
            <p:nvSpPr>
              <p:cNvPr id="307" name="Rectangle 510">
                <a:extLst>
                  <a:ext uri="{FF2B5EF4-FFF2-40B4-BE49-F238E27FC236}">
                    <a16:creationId xmlns:a16="http://schemas.microsoft.com/office/drawing/2014/main" xmlns="" id="{6184FA7A-8263-41DA-8549-FBFB564AD0E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98" y="2582"/>
                <a:ext cx="77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8" name="Line 511">
                <a:extLst>
                  <a:ext uri="{FF2B5EF4-FFF2-40B4-BE49-F238E27FC236}">
                    <a16:creationId xmlns:a16="http://schemas.microsoft.com/office/drawing/2014/main" xmlns="" id="{722507D9-C904-4A9D-AB17-7382DFB00D9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275" y="2546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09" name="Rectangle 512">
                <a:extLst>
                  <a:ext uri="{FF2B5EF4-FFF2-40B4-BE49-F238E27FC236}">
                    <a16:creationId xmlns:a16="http://schemas.microsoft.com/office/drawing/2014/main" xmlns="" id="{7F85D60B-E0F8-4100-A0DC-12FF4648C91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98" y="2530"/>
                <a:ext cx="77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0" name="Line 513">
                <a:extLst>
                  <a:ext uri="{FF2B5EF4-FFF2-40B4-BE49-F238E27FC236}">
                    <a16:creationId xmlns:a16="http://schemas.microsoft.com/office/drawing/2014/main" xmlns="" id="{CEFEF0EC-3FA3-4B9F-90F2-5EDF6B47EB2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275" y="2493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11" name="Rectangle 514">
                <a:extLst>
                  <a:ext uri="{FF2B5EF4-FFF2-40B4-BE49-F238E27FC236}">
                    <a16:creationId xmlns:a16="http://schemas.microsoft.com/office/drawing/2014/main" xmlns="" id="{E60EB1E4-91B7-4551-9EDB-75A3A04482F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98" y="2477"/>
                <a:ext cx="77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2" name="Line 515">
                <a:extLst>
                  <a:ext uri="{FF2B5EF4-FFF2-40B4-BE49-F238E27FC236}">
                    <a16:creationId xmlns:a16="http://schemas.microsoft.com/office/drawing/2014/main" xmlns="" id="{9FF43A91-36FA-423A-A43C-369ED94CBDB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275" y="2441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13" name="Rectangle 516">
                <a:extLst>
                  <a:ext uri="{FF2B5EF4-FFF2-40B4-BE49-F238E27FC236}">
                    <a16:creationId xmlns:a16="http://schemas.microsoft.com/office/drawing/2014/main" xmlns="" id="{6FFFC9BF-900C-4CDC-BA0E-B75A160E12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98" y="2425"/>
                <a:ext cx="77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4" name="Line 517">
                <a:extLst>
                  <a:ext uri="{FF2B5EF4-FFF2-40B4-BE49-F238E27FC236}">
                    <a16:creationId xmlns:a16="http://schemas.microsoft.com/office/drawing/2014/main" xmlns="" id="{802768FD-7CF5-4330-8EED-0010DC3C0F9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275" y="2388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15" name="Rectangle 518">
                <a:extLst>
                  <a:ext uri="{FF2B5EF4-FFF2-40B4-BE49-F238E27FC236}">
                    <a16:creationId xmlns:a16="http://schemas.microsoft.com/office/drawing/2014/main" xmlns="" id="{8F2E53C1-2A38-447E-AF0F-A69676F2CBF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98" y="2372"/>
                <a:ext cx="77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6" name="Line 519">
                <a:extLst>
                  <a:ext uri="{FF2B5EF4-FFF2-40B4-BE49-F238E27FC236}">
                    <a16:creationId xmlns:a16="http://schemas.microsoft.com/office/drawing/2014/main" xmlns="" id="{93EEDE7F-7D21-442B-AC9D-24C030C4773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275" y="2334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17" name="Rectangle 520">
                <a:extLst>
                  <a:ext uri="{FF2B5EF4-FFF2-40B4-BE49-F238E27FC236}">
                    <a16:creationId xmlns:a16="http://schemas.microsoft.com/office/drawing/2014/main" xmlns="" id="{9C8B5F3E-9FBE-45AE-8428-C514CCB60D0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98" y="2318"/>
                <a:ext cx="77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7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8" name="Line 521">
                <a:extLst>
                  <a:ext uri="{FF2B5EF4-FFF2-40B4-BE49-F238E27FC236}">
                    <a16:creationId xmlns:a16="http://schemas.microsoft.com/office/drawing/2014/main" xmlns="" id="{F1136E8A-8027-4C82-A1DF-5DE2B5CC89C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275" y="2282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19" name="Rectangle 522">
                <a:extLst>
                  <a:ext uri="{FF2B5EF4-FFF2-40B4-BE49-F238E27FC236}">
                    <a16:creationId xmlns:a16="http://schemas.microsoft.com/office/drawing/2014/main" xmlns="" id="{9A5FB5F9-ADAF-4DB2-BD63-584AC38DBC5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98" y="2266"/>
                <a:ext cx="77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7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0" name="Line 523">
                <a:extLst>
                  <a:ext uri="{FF2B5EF4-FFF2-40B4-BE49-F238E27FC236}">
                    <a16:creationId xmlns:a16="http://schemas.microsoft.com/office/drawing/2014/main" xmlns="" id="{A78FF1A1-0DC7-450E-9BCC-CCC2A6385F9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275" y="2229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21" name="Rectangle 524">
                <a:extLst>
                  <a:ext uri="{FF2B5EF4-FFF2-40B4-BE49-F238E27FC236}">
                    <a16:creationId xmlns:a16="http://schemas.microsoft.com/office/drawing/2014/main" xmlns="" id="{2031F55E-30D6-4EDC-81CB-75AF036808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98" y="2213"/>
                <a:ext cx="77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2" name="Line 525">
                <a:extLst>
                  <a:ext uri="{FF2B5EF4-FFF2-40B4-BE49-F238E27FC236}">
                    <a16:creationId xmlns:a16="http://schemas.microsoft.com/office/drawing/2014/main" xmlns="" id="{E2D5BB7D-1E07-4471-9304-CEAC0E61343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275" y="2177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23" name="Rectangle 526">
                <a:extLst>
                  <a:ext uri="{FF2B5EF4-FFF2-40B4-BE49-F238E27FC236}">
                    <a16:creationId xmlns:a16="http://schemas.microsoft.com/office/drawing/2014/main" xmlns="" id="{047B67A8-9063-4567-AF8E-C5BCB3AF075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98" y="2161"/>
                <a:ext cx="77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4" name="Line 527">
                <a:extLst>
                  <a:ext uri="{FF2B5EF4-FFF2-40B4-BE49-F238E27FC236}">
                    <a16:creationId xmlns:a16="http://schemas.microsoft.com/office/drawing/2014/main" xmlns="" id="{A35B4C05-15CD-4EEB-8747-9A5660FD6A1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275" y="2124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25" name="Rectangle 528">
                <a:extLst>
                  <a:ext uri="{FF2B5EF4-FFF2-40B4-BE49-F238E27FC236}">
                    <a16:creationId xmlns:a16="http://schemas.microsoft.com/office/drawing/2014/main" xmlns="" id="{E73F78B6-66FC-4251-B0E7-AD96A31E31A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98" y="2108"/>
                <a:ext cx="77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9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6" name="Line 529">
                <a:extLst>
                  <a:ext uri="{FF2B5EF4-FFF2-40B4-BE49-F238E27FC236}">
                    <a16:creationId xmlns:a16="http://schemas.microsoft.com/office/drawing/2014/main" xmlns="" id="{C8F040CF-0513-4E91-AEF1-5BB05E65530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275" y="2072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27" name="Rectangle 530">
                <a:extLst>
                  <a:ext uri="{FF2B5EF4-FFF2-40B4-BE49-F238E27FC236}">
                    <a16:creationId xmlns:a16="http://schemas.microsoft.com/office/drawing/2014/main" xmlns="" id="{85357BAF-193A-4488-8B68-E13BA1120C1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98" y="2056"/>
                <a:ext cx="77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9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8" name="Line 531">
                <a:extLst>
                  <a:ext uri="{FF2B5EF4-FFF2-40B4-BE49-F238E27FC236}">
                    <a16:creationId xmlns:a16="http://schemas.microsoft.com/office/drawing/2014/main" xmlns="" id="{7677E966-159F-4650-B558-BEA9EDC2191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275" y="2018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29" name="Rectangle 532">
                <a:extLst>
                  <a:ext uri="{FF2B5EF4-FFF2-40B4-BE49-F238E27FC236}">
                    <a16:creationId xmlns:a16="http://schemas.microsoft.com/office/drawing/2014/main" xmlns="" id="{E4CC6D3A-E72F-4CE4-AC4A-BA1E3776E58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70" y="2002"/>
                <a:ext cx="105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30" name="Rectangle 533">
                <a:extLst>
                  <a:ext uri="{FF2B5EF4-FFF2-40B4-BE49-F238E27FC236}">
                    <a16:creationId xmlns:a16="http://schemas.microsoft.com/office/drawing/2014/main" xmlns="" id="{4C92FD9A-82B5-497D-A459-F561AC4B8C7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955" y="2522"/>
                <a:ext cx="470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Relative Abundance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31" name="Freeform 534">
                <a:extLst>
                  <a:ext uri="{FF2B5EF4-FFF2-40B4-BE49-F238E27FC236}">
                    <a16:creationId xmlns:a16="http://schemas.microsoft.com/office/drawing/2014/main" xmlns="" id="{82670FAB-A535-48E4-B2F5-2F19B249A27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02" y="2018"/>
                <a:ext cx="2992" cy="1055"/>
              </a:xfrm>
              <a:custGeom>
                <a:avLst/>
                <a:gdLst>
                  <a:gd name="T0" fmla="*/ 21 w 1401"/>
                  <a:gd name="T1" fmla="*/ 743 h 743"/>
                  <a:gd name="T2" fmla="*/ 43 w 1401"/>
                  <a:gd name="T3" fmla="*/ 743 h 743"/>
                  <a:gd name="T4" fmla="*/ 65 w 1401"/>
                  <a:gd name="T5" fmla="*/ 743 h 743"/>
                  <a:gd name="T6" fmla="*/ 87 w 1401"/>
                  <a:gd name="T7" fmla="*/ 743 h 743"/>
                  <a:gd name="T8" fmla="*/ 109 w 1401"/>
                  <a:gd name="T9" fmla="*/ 695 h 743"/>
                  <a:gd name="T10" fmla="*/ 131 w 1401"/>
                  <a:gd name="T11" fmla="*/ 743 h 743"/>
                  <a:gd name="T12" fmla="*/ 153 w 1401"/>
                  <a:gd name="T13" fmla="*/ 739 h 743"/>
                  <a:gd name="T14" fmla="*/ 175 w 1401"/>
                  <a:gd name="T15" fmla="*/ 742 h 743"/>
                  <a:gd name="T16" fmla="*/ 197 w 1401"/>
                  <a:gd name="T17" fmla="*/ 743 h 743"/>
                  <a:gd name="T18" fmla="*/ 219 w 1401"/>
                  <a:gd name="T19" fmla="*/ 743 h 743"/>
                  <a:gd name="T20" fmla="*/ 241 w 1401"/>
                  <a:gd name="T21" fmla="*/ 743 h 743"/>
                  <a:gd name="T22" fmla="*/ 263 w 1401"/>
                  <a:gd name="T23" fmla="*/ 743 h 743"/>
                  <a:gd name="T24" fmla="*/ 285 w 1401"/>
                  <a:gd name="T25" fmla="*/ 741 h 743"/>
                  <a:gd name="T26" fmla="*/ 307 w 1401"/>
                  <a:gd name="T27" fmla="*/ 707 h 743"/>
                  <a:gd name="T28" fmla="*/ 329 w 1401"/>
                  <a:gd name="T29" fmla="*/ 743 h 743"/>
                  <a:gd name="T30" fmla="*/ 351 w 1401"/>
                  <a:gd name="T31" fmla="*/ 743 h 743"/>
                  <a:gd name="T32" fmla="*/ 373 w 1401"/>
                  <a:gd name="T33" fmla="*/ 743 h 743"/>
                  <a:gd name="T34" fmla="*/ 395 w 1401"/>
                  <a:gd name="T35" fmla="*/ 743 h 743"/>
                  <a:gd name="T36" fmla="*/ 417 w 1401"/>
                  <a:gd name="T37" fmla="*/ 743 h 743"/>
                  <a:gd name="T38" fmla="*/ 439 w 1401"/>
                  <a:gd name="T39" fmla="*/ 743 h 743"/>
                  <a:gd name="T40" fmla="*/ 461 w 1401"/>
                  <a:gd name="T41" fmla="*/ 743 h 743"/>
                  <a:gd name="T42" fmla="*/ 483 w 1401"/>
                  <a:gd name="T43" fmla="*/ 742 h 743"/>
                  <a:gd name="T44" fmla="*/ 505 w 1401"/>
                  <a:gd name="T45" fmla="*/ 742 h 743"/>
                  <a:gd name="T46" fmla="*/ 527 w 1401"/>
                  <a:gd name="T47" fmla="*/ 743 h 743"/>
                  <a:gd name="T48" fmla="*/ 549 w 1401"/>
                  <a:gd name="T49" fmla="*/ 743 h 743"/>
                  <a:gd name="T50" fmla="*/ 571 w 1401"/>
                  <a:gd name="T51" fmla="*/ 743 h 743"/>
                  <a:gd name="T52" fmla="*/ 593 w 1401"/>
                  <a:gd name="T53" fmla="*/ 743 h 743"/>
                  <a:gd name="T54" fmla="*/ 615 w 1401"/>
                  <a:gd name="T55" fmla="*/ 743 h 743"/>
                  <a:gd name="T56" fmla="*/ 637 w 1401"/>
                  <a:gd name="T57" fmla="*/ 743 h 743"/>
                  <a:gd name="T58" fmla="*/ 659 w 1401"/>
                  <a:gd name="T59" fmla="*/ 743 h 743"/>
                  <a:gd name="T60" fmla="*/ 681 w 1401"/>
                  <a:gd name="T61" fmla="*/ 743 h 743"/>
                  <a:gd name="T62" fmla="*/ 703 w 1401"/>
                  <a:gd name="T63" fmla="*/ 743 h 743"/>
                  <a:gd name="T64" fmla="*/ 725 w 1401"/>
                  <a:gd name="T65" fmla="*/ 743 h 743"/>
                  <a:gd name="T66" fmla="*/ 747 w 1401"/>
                  <a:gd name="T67" fmla="*/ 743 h 743"/>
                  <a:gd name="T68" fmla="*/ 769 w 1401"/>
                  <a:gd name="T69" fmla="*/ 743 h 743"/>
                  <a:gd name="T70" fmla="*/ 791 w 1401"/>
                  <a:gd name="T71" fmla="*/ 743 h 743"/>
                  <a:gd name="T72" fmla="*/ 813 w 1401"/>
                  <a:gd name="T73" fmla="*/ 742 h 743"/>
                  <a:gd name="T74" fmla="*/ 835 w 1401"/>
                  <a:gd name="T75" fmla="*/ 743 h 743"/>
                  <a:gd name="T76" fmla="*/ 857 w 1401"/>
                  <a:gd name="T77" fmla="*/ 743 h 743"/>
                  <a:gd name="T78" fmla="*/ 879 w 1401"/>
                  <a:gd name="T79" fmla="*/ 743 h 743"/>
                  <a:gd name="T80" fmla="*/ 901 w 1401"/>
                  <a:gd name="T81" fmla="*/ 743 h 743"/>
                  <a:gd name="T82" fmla="*/ 923 w 1401"/>
                  <a:gd name="T83" fmla="*/ 743 h 743"/>
                  <a:gd name="T84" fmla="*/ 945 w 1401"/>
                  <a:gd name="T85" fmla="*/ 743 h 743"/>
                  <a:gd name="T86" fmla="*/ 967 w 1401"/>
                  <a:gd name="T87" fmla="*/ 743 h 743"/>
                  <a:gd name="T88" fmla="*/ 989 w 1401"/>
                  <a:gd name="T89" fmla="*/ 743 h 743"/>
                  <a:gd name="T90" fmla="*/ 1011 w 1401"/>
                  <a:gd name="T91" fmla="*/ 743 h 743"/>
                  <a:gd name="T92" fmla="*/ 1033 w 1401"/>
                  <a:gd name="T93" fmla="*/ 743 h 743"/>
                  <a:gd name="T94" fmla="*/ 1055 w 1401"/>
                  <a:gd name="T95" fmla="*/ 743 h 743"/>
                  <a:gd name="T96" fmla="*/ 1077 w 1401"/>
                  <a:gd name="T97" fmla="*/ 743 h 743"/>
                  <a:gd name="T98" fmla="*/ 1099 w 1401"/>
                  <a:gd name="T99" fmla="*/ 742 h 743"/>
                  <a:gd name="T100" fmla="*/ 1121 w 1401"/>
                  <a:gd name="T101" fmla="*/ 743 h 743"/>
                  <a:gd name="T102" fmla="*/ 1144 w 1401"/>
                  <a:gd name="T103" fmla="*/ 743 h 743"/>
                  <a:gd name="T104" fmla="*/ 1166 w 1401"/>
                  <a:gd name="T105" fmla="*/ 743 h 743"/>
                  <a:gd name="T106" fmla="*/ 1188 w 1401"/>
                  <a:gd name="T107" fmla="*/ 743 h 743"/>
                  <a:gd name="T108" fmla="*/ 1210 w 1401"/>
                  <a:gd name="T109" fmla="*/ 743 h 743"/>
                  <a:gd name="T110" fmla="*/ 1232 w 1401"/>
                  <a:gd name="T111" fmla="*/ 737 h 743"/>
                  <a:gd name="T112" fmla="*/ 1254 w 1401"/>
                  <a:gd name="T113" fmla="*/ 743 h 743"/>
                  <a:gd name="T114" fmla="*/ 1276 w 1401"/>
                  <a:gd name="T115" fmla="*/ 743 h 743"/>
                  <a:gd name="T116" fmla="*/ 1298 w 1401"/>
                  <a:gd name="T117" fmla="*/ 742 h 743"/>
                  <a:gd name="T118" fmla="*/ 1320 w 1401"/>
                  <a:gd name="T119" fmla="*/ 743 h 743"/>
                  <a:gd name="T120" fmla="*/ 1342 w 1401"/>
                  <a:gd name="T121" fmla="*/ 743 h 743"/>
                  <a:gd name="T122" fmla="*/ 1364 w 1401"/>
                  <a:gd name="T123" fmla="*/ 743 h 743"/>
                  <a:gd name="T124" fmla="*/ 1386 w 1401"/>
                  <a:gd name="T125" fmla="*/ 743 h 74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  <a:cxn ang="0">
                    <a:pos x="T118" y="T119"/>
                  </a:cxn>
                  <a:cxn ang="0">
                    <a:pos x="T120" y="T121"/>
                  </a:cxn>
                  <a:cxn ang="0">
                    <a:pos x="T122" y="T123"/>
                  </a:cxn>
                  <a:cxn ang="0">
                    <a:pos x="T124" y="T125"/>
                  </a:cxn>
                </a:cxnLst>
                <a:rect l="0" t="0" r="r" b="b"/>
                <a:pathLst>
                  <a:path w="1401" h="743">
                    <a:moveTo>
                      <a:pt x="0" y="743"/>
                    </a:moveTo>
                    <a:lnTo>
                      <a:pt x="0" y="743"/>
                    </a:lnTo>
                    <a:lnTo>
                      <a:pt x="1" y="743"/>
                    </a:lnTo>
                    <a:lnTo>
                      <a:pt x="1" y="743"/>
                    </a:lnTo>
                    <a:lnTo>
                      <a:pt x="2" y="743"/>
                    </a:lnTo>
                    <a:lnTo>
                      <a:pt x="2" y="743"/>
                    </a:lnTo>
                    <a:lnTo>
                      <a:pt x="3" y="743"/>
                    </a:lnTo>
                    <a:lnTo>
                      <a:pt x="3" y="743"/>
                    </a:lnTo>
                    <a:lnTo>
                      <a:pt x="4" y="743"/>
                    </a:lnTo>
                    <a:lnTo>
                      <a:pt x="4" y="743"/>
                    </a:lnTo>
                    <a:lnTo>
                      <a:pt x="5" y="743"/>
                    </a:lnTo>
                    <a:lnTo>
                      <a:pt x="5" y="743"/>
                    </a:lnTo>
                    <a:lnTo>
                      <a:pt x="6" y="743"/>
                    </a:lnTo>
                    <a:lnTo>
                      <a:pt x="6" y="743"/>
                    </a:lnTo>
                    <a:lnTo>
                      <a:pt x="7" y="743"/>
                    </a:lnTo>
                    <a:lnTo>
                      <a:pt x="7" y="743"/>
                    </a:lnTo>
                    <a:lnTo>
                      <a:pt x="8" y="740"/>
                    </a:lnTo>
                    <a:lnTo>
                      <a:pt x="8" y="743"/>
                    </a:lnTo>
                    <a:lnTo>
                      <a:pt x="9" y="743"/>
                    </a:lnTo>
                    <a:lnTo>
                      <a:pt x="9" y="743"/>
                    </a:lnTo>
                    <a:lnTo>
                      <a:pt x="10" y="743"/>
                    </a:lnTo>
                    <a:lnTo>
                      <a:pt x="10" y="743"/>
                    </a:lnTo>
                    <a:lnTo>
                      <a:pt x="11" y="743"/>
                    </a:lnTo>
                    <a:lnTo>
                      <a:pt x="11" y="743"/>
                    </a:lnTo>
                    <a:lnTo>
                      <a:pt x="12" y="743"/>
                    </a:lnTo>
                    <a:lnTo>
                      <a:pt x="12" y="743"/>
                    </a:lnTo>
                    <a:lnTo>
                      <a:pt x="13" y="743"/>
                    </a:lnTo>
                    <a:lnTo>
                      <a:pt x="13" y="743"/>
                    </a:lnTo>
                    <a:lnTo>
                      <a:pt x="14" y="743"/>
                    </a:lnTo>
                    <a:lnTo>
                      <a:pt x="14" y="743"/>
                    </a:lnTo>
                    <a:lnTo>
                      <a:pt x="15" y="743"/>
                    </a:lnTo>
                    <a:lnTo>
                      <a:pt x="15" y="743"/>
                    </a:lnTo>
                    <a:lnTo>
                      <a:pt x="16" y="743"/>
                    </a:lnTo>
                    <a:lnTo>
                      <a:pt x="16" y="737"/>
                    </a:lnTo>
                    <a:lnTo>
                      <a:pt x="17" y="743"/>
                    </a:lnTo>
                    <a:lnTo>
                      <a:pt x="17" y="743"/>
                    </a:lnTo>
                    <a:lnTo>
                      <a:pt x="18" y="733"/>
                    </a:lnTo>
                    <a:lnTo>
                      <a:pt x="18" y="743"/>
                    </a:lnTo>
                    <a:lnTo>
                      <a:pt x="19" y="743"/>
                    </a:lnTo>
                    <a:lnTo>
                      <a:pt x="19" y="743"/>
                    </a:lnTo>
                    <a:lnTo>
                      <a:pt x="20" y="728"/>
                    </a:lnTo>
                    <a:lnTo>
                      <a:pt x="20" y="743"/>
                    </a:lnTo>
                    <a:lnTo>
                      <a:pt x="21" y="743"/>
                    </a:lnTo>
                    <a:lnTo>
                      <a:pt x="21" y="743"/>
                    </a:lnTo>
                    <a:lnTo>
                      <a:pt x="22" y="591"/>
                    </a:lnTo>
                    <a:lnTo>
                      <a:pt x="22" y="743"/>
                    </a:lnTo>
                    <a:lnTo>
                      <a:pt x="23" y="743"/>
                    </a:lnTo>
                    <a:lnTo>
                      <a:pt x="23" y="743"/>
                    </a:lnTo>
                    <a:lnTo>
                      <a:pt x="24" y="738"/>
                    </a:lnTo>
                    <a:lnTo>
                      <a:pt x="24" y="743"/>
                    </a:lnTo>
                    <a:lnTo>
                      <a:pt x="25" y="743"/>
                    </a:lnTo>
                    <a:lnTo>
                      <a:pt x="25" y="743"/>
                    </a:lnTo>
                    <a:lnTo>
                      <a:pt x="26" y="743"/>
                    </a:lnTo>
                    <a:lnTo>
                      <a:pt x="26" y="743"/>
                    </a:lnTo>
                    <a:lnTo>
                      <a:pt x="27" y="743"/>
                    </a:lnTo>
                    <a:lnTo>
                      <a:pt x="27" y="743"/>
                    </a:lnTo>
                    <a:lnTo>
                      <a:pt x="28" y="402"/>
                    </a:lnTo>
                    <a:lnTo>
                      <a:pt x="28" y="743"/>
                    </a:lnTo>
                    <a:lnTo>
                      <a:pt x="29" y="743"/>
                    </a:lnTo>
                    <a:lnTo>
                      <a:pt x="29" y="743"/>
                    </a:lnTo>
                    <a:lnTo>
                      <a:pt x="30" y="736"/>
                    </a:lnTo>
                    <a:lnTo>
                      <a:pt x="30" y="743"/>
                    </a:lnTo>
                    <a:lnTo>
                      <a:pt x="31" y="743"/>
                    </a:lnTo>
                    <a:lnTo>
                      <a:pt x="31" y="743"/>
                    </a:lnTo>
                    <a:lnTo>
                      <a:pt x="32" y="743"/>
                    </a:lnTo>
                    <a:lnTo>
                      <a:pt x="32" y="743"/>
                    </a:lnTo>
                    <a:lnTo>
                      <a:pt x="33" y="743"/>
                    </a:lnTo>
                    <a:lnTo>
                      <a:pt x="33" y="743"/>
                    </a:lnTo>
                    <a:lnTo>
                      <a:pt x="34" y="743"/>
                    </a:lnTo>
                    <a:lnTo>
                      <a:pt x="34" y="743"/>
                    </a:lnTo>
                    <a:lnTo>
                      <a:pt x="35" y="743"/>
                    </a:lnTo>
                    <a:lnTo>
                      <a:pt x="35" y="743"/>
                    </a:lnTo>
                    <a:lnTo>
                      <a:pt x="36" y="743"/>
                    </a:lnTo>
                    <a:lnTo>
                      <a:pt x="36" y="743"/>
                    </a:lnTo>
                    <a:lnTo>
                      <a:pt x="37" y="743"/>
                    </a:lnTo>
                    <a:lnTo>
                      <a:pt x="37" y="743"/>
                    </a:lnTo>
                    <a:lnTo>
                      <a:pt x="38" y="743"/>
                    </a:lnTo>
                    <a:lnTo>
                      <a:pt x="38" y="743"/>
                    </a:lnTo>
                    <a:lnTo>
                      <a:pt x="39" y="743"/>
                    </a:lnTo>
                    <a:lnTo>
                      <a:pt x="39" y="743"/>
                    </a:lnTo>
                    <a:lnTo>
                      <a:pt x="40" y="739"/>
                    </a:lnTo>
                    <a:lnTo>
                      <a:pt x="40" y="743"/>
                    </a:lnTo>
                    <a:lnTo>
                      <a:pt x="41" y="743"/>
                    </a:lnTo>
                    <a:lnTo>
                      <a:pt x="41" y="743"/>
                    </a:lnTo>
                    <a:lnTo>
                      <a:pt x="42" y="743"/>
                    </a:lnTo>
                    <a:lnTo>
                      <a:pt x="42" y="743"/>
                    </a:lnTo>
                    <a:lnTo>
                      <a:pt x="43" y="743"/>
                    </a:lnTo>
                    <a:lnTo>
                      <a:pt x="43" y="743"/>
                    </a:lnTo>
                    <a:lnTo>
                      <a:pt x="44" y="737"/>
                    </a:lnTo>
                    <a:lnTo>
                      <a:pt x="44" y="743"/>
                    </a:lnTo>
                    <a:lnTo>
                      <a:pt x="45" y="743"/>
                    </a:lnTo>
                    <a:lnTo>
                      <a:pt x="45" y="743"/>
                    </a:lnTo>
                    <a:lnTo>
                      <a:pt x="46" y="743"/>
                    </a:lnTo>
                    <a:lnTo>
                      <a:pt x="46" y="743"/>
                    </a:lnTo>
                    <a:lnTo>
                      <a:pt x="47" y="743"/>
                    </a:lnTo>
                    <a:lnTo>
                      <a:pt x="47" y="743"/>
                    </a:lnTo>
                    <a:lnTo>
                      <a:pt x="48" y="743"/>
                    </a:lnTo>
                    <a:lnTo>
                      <a:pt x="48" y="733"/>
                    </a:lnTo>
                    <a:lnTo>
                      <a:pt x="49" y="743"/>
                    </a:lnTo>
                    <a:lnTo>
                      <a:pt x="49" y="743"/>
                    </a:lnTo>
                    <a:lnTo>
                      <a:pt x="50" y="743"/>
                    </a:lnTo>
                    <a:lnTo>
                      <a:pt x="50" y="743"/>
                    </a:lnTo>
                    <a:lnTo>
                      <a:pt x="51" y="743"/>
                    </a:lnTo>
                    <a:lnTo>
                      <a:pt x="51" y="743"/>
                    </a:lnTo>
                    <a:lnTo>
                      <a:pt x="52" y="736"/>
                    </a:lnTo>
                    <a:lnTo>
                      <a:pt x="52" y="743"/>
                    </a:lnTo>
                    <a:lnTo>
                      <a:pt x="53" y="743"/>
                    </a:lnTo>
                    <a:lnTo>
                      <a:pt x="53" y="743"/>
                    </a:lnTo>
                    <a:lnTo>
                      <a:pt x="54" y="743"/>
                    </a:lnTo>
                    <a:lnTo>
                      <a:pt x="54" y="743"/>
                    </a:lnTo>
                    <a:lnTo>
                      <a:pt x="55" y="743"/>
                    </a:lnTo>
                    <a:lnTo>
                      <a:pt x="55" y="743"/>
                    </a:lnTo>
                    <a:lnTo>
                      <a:pt x="56" y="743"/>
                    </a:lnTo>
                    <a:lnTo>
                      <a:pt x="56" y="743"/>
                    </a:lnTo>
                    <a:lnTo>
                      <a:pt x="57" y="743"/>
                    </a:lnTo>
                    <a:lnTo>
                      <a:pt x="57" y="743"/>
                    </a:lnTo>
                    <a:lnTo>
                      <a:pt x="58" y="743"/>
                    </a:lnTo>
                    <a:lnTo>
                      <a:pt x="58" y="743"/>
                    </a:lnTo>
                    <a:lnTo>
                      <a:pt x="59" y="743"/>
                    </a:lnTo>
                    <a:lnTo>
                      <a:pt x="59" y="743"/>
                    </a:lnTo>
                    <a:lnTo>
                      <a:pt x="60" y="743"/>
                    </a:lnTo>
                    <a:lnTo>
                      <a:pt x="60" y="715"/>
                    </a:lnTo>
                    <a:lnTo>
                      <a:pt x="61" y="743"/>
                    </a:lnTo>
                    <a:lnTo>
                      <a:pt x="61" y="743"/>
                    </a:lnTo>
                    <a:lnTo>
                      <a:pt x="62" y="743"/>
                    </a:lnTo>
                    <a:lnTo>
                      <a:pt x="62" y="739"/>
                    </a:lnTo>
                    <a:lnTo>
                      <a:pt x="63" y="743"/>
                    </a:lnTo>
                    <a:lnTo>
                      <a:pt x="63" y="743"/>
                    </a:lnTo>
                    <a:lnTo>
                      <a:pt x="64" y="741"/>
                    </a:lnTo>
                    <a:lnTo>
                      <a:pt x="64" y="743"/>
                    </a:lnTo>
                    <a:lnTo>
                      <a:pt x="65" y="743"/>
                    </a:lnTo>
                    <a:lnTo>
                      <a:pt x="65" y="743"/>
                    </a:lnTo>
                    <a:lnTo>
                      <a:pt x="66" y="743"/>
                    </a:lnTo>
                    <a:lnTo>
                      <a:pt x="66" y="727"/>
                    </a:lnTo>
                    <a:lnTo>
                      <a:pt x="67" y="743"/>
                    </a:lnTo>
                    <a:lnTo>
                      <a:pt x="67" y="743"/>
                    </a:lnTo>
                    <a:lnTo>
                      <a:pt x="68" y="742"/>
                    </a:lnTo>
                    <a:lnTo>
                      <a:pt x="68" y="743"/>
                    </a:lnTo>
                    <a:lnTo>
                      <a:pt x="69" y="743"/>
                    </a:lnTo>
                    <a:lnTo>
                      <a:pt x="69" y="743"/>
                    </a:lnTo>
                    <a:lnTo>
                      <a:pt x="70" y="743"/>
                    </a:lnTo>
                    <a:lnTo>
                      <a:pt x="70" y="743"/>
                    </a:lnTo>
                    <a:lnTo>
                      <a:pt x="71" y="743"/>
                    </a:lnTo>
                    <a:lnTo>
                      <a:pt x="71" y="743"/>
                    </a:lnTo>
                    <a:lnTo>
                      <a:pt x="72" y="743"/>
                    </a:lnTo>
                    <a:lnTo>
                      <a:pt x="72" y="734"/>
                    </a:lnTo>
                    <a:lnTo>
                      <a:pt x="73" y="743"/>
                    </a:lnTo>
                    <a:lnTo>
                      <a:pt x="73" y="743"/>
                    </a:lnTo>
                    <a:lnTo>
                      <a:pt x="74" y="742"/>
                    </a:lnTo>
                    <a:lnTo>
                      <a:pt x="74" y="743"/>
                    </a:lnTo>
                    <a:lnTo>
                      <a:pt x="75" y="743"/>
                    </a:lnTo>
                    <a:lnTo>
                      <a:pt x="75" y="743"/>
                    </a:lnTo>
                    <a:lnTo>
                      <a:pt x="76" y="743"/>
                    </a:lnTo>
                    <a:lnTo>
                      <a:pt x="76" y="736"/>
                    </a:lnTo>
                    <a:lnTo>
                      <a:pt x="77" y="743"/>
                    </a:lnTo>
                    <a:lnTo>
                      <a:pt x="77" y="743"/>
                    </a:lnTo>
                    <a:lnTo>
                      <a:pt x="78" y="743"/>
                    </a:lnTo>
                    <a:lnTo>
                      <a:pt x="78" y="743"/>
                    </a:lnTo>
                    <a:lnTo>
                      <a:pt x="79" y="743"/>
                    </a:lnTo>
                    <a:lnTo>
                      <a:pt x="79" y="743"/>
                    </a:lnTo>
                    <a:lnTo>
                      <a:pt x="80" y="699"/>
                    </a:lnTo>
                    <a:lnTo>
                      <a:pt x="80" y="743"/>
                    </a:lnTo>
                    <a:lnTo>
                      <a:pt x="81" y="743"/>
                    </a:lnTo>
                    <a:lnTo>
                      <a:pt x="81" y="743"/>
                    </a:lnTo>
                    <a:lnTo>
                      <a:pt x="82" y="556"/>
                    </a:lnTo>
                    <a:lnTo>
                      <a:pt x="82" y="743"/>
                    </a:lnTo>
                    <a:lnTo>
                      <a:pt x="83" y="743"/>
                    </a:lnTo>
                    <a:lnTo>
                      <a:pt x="83" y="743"/>
                    </a:lnTo>
                    <a:lnTo>
                      <a:pt x="84" y="743"/>
                    </a:lnTo>
                    <a:lnTo>
                      <a:pt x="84" y="742"/>
                    </a:lnTo>
                    <a:lnTo>
                      <a:pt x="85" y="743"/>
                    </a:lnTo>
                    <a:lnTo>
                      <a:pt x="85" y="743"/>
                    </a:lnTo>
                    <a:lnTo>
                      <a:pt x="86" y="741"/>
                    </a:lnTo>
                    <a:lnTo>
                      <a:pt x="86" y="743"/>
                    </a:lnTo>
                    <a:lnTo>
                      <a:pt x="87" y="743"/>
                    </a:lnTo>
                    <a:lnTo>
                      <a:pt x="87" y="743"/>
                    </a:lnTo>
                    <a:lnTo>
                      <a:pt x="88" y="711"/>
                    </a:lnTo>
                    <a:lnTo>
                      <a:pt x="88" y="743"/>
                    </a:lnTo>
                    <a:lnTo>
                      <a:pt x="89" y="743"/>
                    </a:lnTo>
                    <a:lnTo>
                      <a:pt x="89" y="743"/>
                    </a:lnTo>
                    <a:lnTo>
                      <a:pt x="90" y="743"/>
                    </a:lnTo>
                    <a:lnTo>
                      <a:pt x="90" y="743"/>
                    </a:lnTo>
                    <a:lnTo>
                      <a:pt x="91" y="743"/>
                    </a:lnTo>
                    <a:lnTo>
                      <a:pt x="91" y="743"/>
                    </a:lnTo>
                    <a:lnTo>
                      <a:pt x="92" y="743"/>
                    </a:lnTo>
                    <a:lnTo>
                      <a:pt x="92" y="743"/>
                    </a:lnTo>
                    <a:lnTo>
                      <a:pt x="93" y="743"/>
                    </a:lnTo>
                    <a:lnTo>
                      <a:pt x="93" y="743"/>
                    </a:lnTo>
                    <a:lnTo>
                      <a:pt x="94" y="743"/>
                    </a:lnTo>
                    <a:lnTo>
                      <a:pt x="94" y="743"/>
                    </a:lnTo>
                    <a:lnTo>
                      <a:pt x="95" y="743"/>
                    </a:lnTo>
                    <a:lnTo>
                      <a:pt x="95" y="743"/>
                    </a:lnTo>
                    <a:lnTo>
                      <a:pt x="96" y="743"/>
                    </a:lnTo>
                    <a:lnTo>
                      <a:pt x="96" y="743"/>
                    </a:lnTo>
                    <a:lnTo>
                      <a:pt x="97" y="743"/>
                    </a:lnTo>
                    <a:lnTo>
                      <a:pt x="97" y="743"/>
                    </a:lnTo>
                    <a:lnTo>
                      <a:pt x="98" y="743"/>
                    </a:lnTo>
                    <a:lnTo>
                      <a:pt x="98" y="743"/>
                    </a:lnTo>
                    <a:lnTo>
                      <a:pt x="99" y="743"/>
                    </a:lnTo>
                    <a:lnTo>
                      <a:pt x="99" y="743"/>
                    </a:lnTo>
                    <a:lnTo>
                      <a:pt x="100" y="742"/>
                    </a:lnTo>
                    <a:lnTo>
                      <a:pt x="100" y="743"/>
                    </a:lnTo>
                    <a:lnTo>
                      <a:pt x="101" y="743"/>
                    </a:lnTo>
                    <a:lnTo>
                      <a:pt x="101" y="743"/>
                    </a:lnTo>
                    <a:lnTo>
                      <a:pt x="102" y="738"/>
                    </a:lnTo>
                    <a:lnTo>
                      <a:pt x="102" y="743"/>
                    </a:lnTo>
                    <a:lnTo>
                      <a:pt x="103" y="743"/>
                    </a:lnTo>
                    <a:lnTo>
                      <a:pt x="103" y="741"/>
                    </a:lnTo>
                    <a:lnTo>
                      <a:pt x="104" y="738"/>
                    </a:lnTo>
                    <a:lnTo>
                      <a:pt x="104" y="743"/>
                    </a:lnTo>
                    <a:lnTo>
                      <a:pt x="105" y="743"/>
                    </a:lnTo>
                    <a:lnTo>
                      <a:pt x="105" y="743"/>
                    </a:lnTo>
                    <a:lnTo>
                      <a:pt x="106" y="743"/>
                    </a:lnTo>
                    <a:lnTo>
                      <a:pt x="106" y="743"/>
                    </a:lnTo>
                    <a:lnTo>
                      <a:pt x="107" y="742"/>
                    </a:lnTo>
                    <a:lnTo>
                      <a:pt x="107" y="743"/>
                    </a:lnTo>
                    <a:lnTo>
                      <a:pt x="108" y="742"/>
                    </a:lnTo>
                    <a:lnTo>
                      <a:pt x="108" y="743"/>
                    </a:lnTo>
                    <a:lnTo>
                      <a:pt x="109" y="743"/>
                    </a:lnTo>
                    <a:lnTo>
                      <a:pt x="109" y="695"/>
                    </a:lnTo>
                    <a:lnTo>
                      <a:pt x="110" y="743"/>
                    </a:lnTo>
                    <a:lnTo>
                      <a:pt x="110" y="743"/>
                    </a:lnTo>
                    <a:lnTo>
                      <a:pt x="111" y="743"/>
                    </a:lnTo>
                    <a:lnTo>
                      <a:pt x="111" y="727"/>
                    </a:lnTo>
                    <a:lnTo>
                      <a:pt x="112" y="743"/>
                    </a:lnTo>
                    <a:lnTo>
                      <a:pt x="112" y="743"/>
                    </a:lnTo>
                    <a:lnTo>
                      <a:pt x="113" y="742"/>
                    </a:lnTo>
                    <a:lnTo>
                      <a:pt x="113" y="743"/>
                    </a:lnTo>
                    <a:lnTo>
                      <a:pt x="114" y="743"/>
                    </a:lnTo>
                    <a:lnTo>
                      <a:pt x="114" y="743"/>
                    </a:lnTo>
                    <a:lnTo>
                      <a:pt x="115" y="743"/>
                    </a:lnTo>
                    <a:lnTo>
                      <a:pt x="115" y="743"/>
                    </a:lnTo>
                    <a:lnTo>
                      <a:pt x="116" y="743"/>
                    </a:lnTo>
                    <a:lnTo>
                      <a:pt x="116" y="743"/>
                    </a:lnTo>
                    <a:lnTo>
                      <a:pt x="117" y="743"/>
                    </a:lnTo>
                    <a:lnTo>
                      <a:pt x="117" y="743"/>
                    </a:lnTo>
                    <a:lnTo>
                      <a:pt x="118" y="743"/>
                    </a:lnTo>
                    <a:lnTo>
                      <a:pt x="118" y="743"/>
                    </a:lnTo>
                    <a:lnTo>
                      <a:pt x="119" y="742"/>
                    </a:lnTo>
                    <a:lnTo>
                      <a:pt x="119" y="743"/>
                    </a:lnTo>
                    <a:lnTo>
                      <a:pt x="120" y="743"/>
                    </a:lnTo>
                    <a:lnTo>
                      <a:pt x="120" y="743"/>
                    </a:lnTo>
                    <a:lnTo>
                      <a:pt x="121" y="743"/>
                    </a:lnTo>
                    <a:lnTo>
                      <a:pt x="121" y="743"/>
                    </a:lnTo>
                    <a:lnTo>
                      <a:pt x="122" y="743"/>
                    </a:lnTo>
                    <a:lnTo>
                      <a:pt x="122" y="743"/>
                    </a:lnTo>
                    <a:lnTo>
                      <a:pt x="123" y="685"/>
                    </a:lnTo>
                    <a:lnTo>
                      <a:pt x="123" y="743"/>
                    </a:lnTo>
                    <a:lnTo>
                      <a:pt x="124" y="743"/>
                    </a:lnTo>
                    <a:lnTo>
                      <a:pt x="124" y="743"/>
                    </a:lnTo>
                    <a:lnTo>
                      <a:pt x="125" y="741"/>
                    </a:lnTo>
                    <a:lnTo>
                      <a:pt x="125" y="743"/>
                    </a:lnTo>
                    <a:lnTo>
                      <a:pt x="126" y="743"/>
                    </a:lnTo>
                    <a:lnTo>
                      <a:pt x="126" y="743"/>
                    </a:lnTo>
                    <a:lnTo>
                      <a:pt x="127" y="735"/>
                    </a:lnTo>
                    <a:lnTo>
                      <a:pt x="127" y="743"/>
                    </a:lnTo>
                    <a:lnTo>
                      <a:pt x="128" y="743"/>
                    </a:lnTo>
                    <a:lnTo>
                      <a:pt x="128" y="743"/>
                    </a:lnTo>
                    <a:lnTo>
                      <a:pt x="129" y="741"/>
                    </a:lnTo>
                    <a:lnTo>
                      <a:pt x="129" y="743"/>
                    </a:lnTo>
                    <a:lnTo>
                      <a:pt x="130" y="743"/>
                    </a:lnTo>
                    <a:lnTo>
                      <a:pt x="130" y="743"/>
                    </a:lnTo>
                    <a:lnTo>
                      <a:pt x="131" y="635"/>
                    </a:lnTo>
                    <a:lnTo>
                      <a:pt x="131" y="743"/>
                    </a:lnTo>
                    <a:lnTo>
                      <a:pt x="132" y="743"/>
                    </a:lnTo>
                    <a:lnTo>
                      <a:pt x="132" y="743"/>
                    </a:lnTo>
                    <a:lnTo>
                      <a:pt x="133" y="738"/>
                    </a:lnTo>
                    <a:lnTo>
                      <a:pt x="133" y="743"/>
                    </a:lnTo>
                    <a:lnTo>
                      <a:pt x="134" y="743"/>
                    </a:lnTo>
                    <a:lnTo>
                      <a:pt x="134" y="743"/>
                    </a:lnTo>
                    <a:lnTo>
                      <a:pt x="135" y="743"/>
                    </a:lnTo>
                    <a:lnTo>
                      <a:pt x="135" y="0"/>
                    </a:lnTo>
                    <a:lnTo>
                      <a:pt x="136" y="743"/>
                    </a:lnTo>
                    <a:lnTo>
                      <a:pt x="136" y="743"/>
                    </a:lnTo>
                    <a:lnTo>
                      <a:pt x="137" y="704"/>
                    </a:lnTo>
                    <a:lnTo>
                      <a:pt x="137" y="743"/>
                    </a:lnTo>
                    <a:lnTo>
                      <a:pt x="138" y="743"/>
                    </a:lnTo>
                    <a:lnTo>
                      <a:pt x="138" y="743"/>
                    </a:lnTo>
                    <a:lnTo>
                      <a:pt x="139" y="743"/>
                    </a:lnTo>
                    <a:lnTo>
                      <a:pt x="139" y="680"/>
                    </a:lnTo>
                    <a:lnTo>
                      <a:pt x="140" y="743"/>
                    </a:lnTo>
                    <a:lnTo>
                      <a:pt x="140" y="743"/>
                    </a:lnTo>
                    <a:lnTo>
                      <a:pt x="141" y="743"/>
                    </a:lnTo>
                    <a:lnTo>
                      <a:pt x="141" y="741"/>
                    </a:lnTo>
                    <a:lnTo>
                      <a:pt x="142" y="743"/>
                    </a:lnTo>
                    <a:lnTo>
                      <a:pt x="142" y="743"/>
                    </a:lnTo>
                    <a:lnTo>
                      <a:pt x="143" y="743"/>
                    </a:lnTo>
                    <a:lnTo>
                      <a:pt x="143" y="741"/>
                    </a:lnTo>
                    <a:lnTo>
                      <a:pt x="144" y="743"/>
                    </a:lnTo>
                    <a:lnTo>
                      <a:pt x="144" y="743"/>
                    </a:lnTo>
                    <a:lnTo>
                      <a:pt x="145" y="705"/>
                    </a:lnTo>
                    <a:lnTo>
                      <a:pt x="145" y="743"/>
                    </a:lnTo>
                    <a:lnTo>
                      <a:pt x="146" y="743"/>
                    </a:lnTo>
                    <a:lnTo>
                      <a:pt x="146" y="743"/>
                    </a:lnTo>
                    <a:lnTo>
                      <a:pt x="147" y="741"/>
                    </a:lnTo>
                    <a:lnTo>
                      <a:pt x="147" y="743"/>
                    </a:lnTo>
                    <a:lnTo>
                      <a:pt x="148" y="743"/>
                    </a:lnTo>
                    <a:lnTo>
                      <a:pt x="148" y="743"/>
                    </a:lnTo>
                    <a:lnTo>
                      <a:pt x="149" y="743"/>
                    </a:lnTo>
                    <a:lnTo>
                      <a:pt x="149" y="738"/>
                    </a:lnTo>
                    <a:lnTo>
                      <a:pt x="150" y="743"/>
                    </a:lnTo>
                    <a:lnTo>
                      <a:pt x="150" y="743"/>
                    </a:lnTo>
                    <a:lnTo>
                      <a:pt x="151" y="743"/>
                    </a:lnTo>
                    <a:lnTo>
                      <a:pt x="151" y="532"/>
                    </a:lnTo>
                    <a:lnTo>
                      <a:pt x="152" y="743"/>
                    </a:lnTo>
                    <a:lnTo>
                      <a:pt x="152" y="743"/>
                    </a:lnTo>
                    <a:lnTo>
                      <a:pt x="153" y="743"/>
                    </a:lnTo>
                    <a:lnTo>
                      <a:pt x="153" y="739"/>
                    </a:lnTo>
                    <a:lnTo>
                      <a:pt x="154" y="743"/>
                    </a:lnTo>
                    <a:lnTo>
                      <a:pt x="154" y="743"/>
                    </a:lnTo>
                    <a:lnTo>
                      <a:pt x="155" y="734"/>
                    </a:lnTo>
                    <a:lnTo>
                      <a:pt x="155" y="743"/>
                    </a:lnTo>
                    <a:lnTo>
                      <a:pt x="156" y="743"/>
                    </a:lnTo>
                    <a:lnTo>
                      <a:pt x="156" y="743"/>
                    </a:lnTo>
                    <a:lnTo>
                      <a:pt x="157" y="743"/>
                    </a:lnTo>
                    <a:lnTo>
                      <a:pt x="157" y="735"/>
                    </a:lnTo>
                    <a:lnTo>
                      <a:pt x="158" y="743"/>
                    </a:lnTo>
                    <a:lnTo>
                      <a:pt x="158" y="743"/>
                    </a:lnTo>
                    <a:lnTo>
                      <a:pt x="159" y="711"/>
                    </a:lnTo>
                    <a:lnTo>
                      <a:pt x="159" y="743"/>
                    </a:lnTo>
                    <a:lnTo>
                      <a:pt x="160" y="743"/>
                    </a:lnTo>
                    <a:lnTo>
                      <a:pt x="160" y="743"/>
                    </a:lnTo>
                    <a:lnTo>
                      <a:pt x="161" y="743"/>
                    </a:lnTo>
                    <a:lnTo>
                      <a:pt x="161" y="742"/>
                    </a:lnTo>
                    <a:lnTo>
                      <a:pt x="162" y="743"/>
                    </a:lnTo>
                    <a:lnTo>
                      <a:pt x="162" y="743"/>
                    </a:lnTo>
                    <a:lnTo>
                      <a:pt x="163" y="556"/>
                    </a:lnTo>
                    <a:lnTo>
                      <a:pt x="163" y="743"/>
                    </a:lnTo>
                    <a:lnTo>
                      <a:pt x="164" y="743"/>
                    </a:lnTo>
                    <a:lnTo>
                      <a:pt x="164" y="743"/>
                    </a:lnTo>
                    <a:lnTo>
                      <a:pt x="165" y="732"/>
                    </a:lnTo>
                    <a:lnTo>
                      <a:pt x="165" y="743"/>
                    </a:lnTo>
                    <a:lnTo>
                      <a:pt x="166" y="743"/>
                    </a:lnTo>
                    <a:lnTo>
                      <a:pt x="166" y="743"/>
                    </a:lnTo>
                    <a:lnTo>
                      <a:pt x="167" y="738"/>
                    </a:lnTo>
                    <a:lnTo>
                      <a:pt x="167" y="743"/>
                    </a:lnTo>
                    <a:lnTo>
                      <a:pt x="168" y="743"/>
                    </a:lnTo>
                    <a:lnTo>
                      <a:pt x="168" y="743"/>
                    </a:lnTo>
                    <a:lnTo>
                      <a:pt x="169" y="743"/>
                    </a:lnTo>
                    <a:lnTo>
                      <a:pt x="169" y="743"/>
                    </a:lnTo>
                    <a:lnTo>
                      <a:pt x="170" y="743"/>
                    </a:lnTo>
                    <a:lnTo>
                      <a:pt x="170" y="743"/>
                    </a:lnTo>
                    <a:lnTo>
                      <a:pt x="171" y="739"/>
                    </a:lnTo>
                    <a:lnTo>
                      <a:pt x="171" y="743"/>
                    </a:lnTo>
                    <a:lnTo>
                      <a:pt x="172" y="743"/>
                    </a:lnTo>
                    <a:lnTo>
                      <a:pt x="172" y="743"/>
                    </a:lnTo>
                    <a:lnTo>
                      <a:pt x="173" y="743"/>
                    </a:lnTo>
                    <a:lnTo>
                      <a:pt x="173" y="743"/>
                    </a:lnTo>
                    <a:lnTo>
                      <a:pt x="174" y="743"/>
                    </a:lnTo>
                    <a:lnTo>
                      <a:pt x="174" y="743"/>
                    </a:lnTo>
                    <a:lnTo>
                      <a:pt x="175" y="743"/>
                    </a:lnTo>
                    <a:lnTo>
                      <a:pt x="175" y="742"/>
                    </a:lnTo>
                    <a:lnTo>
                      <a:pt x="176" y="743"/>
                    </a:lnTo>
                    <a:lnTo>
                      <a:pt x="176" y="743"/>
                    </a:lnTo>
                    <a:lnTo>
                      <a:pt x="177" y="743"/>
                    </a:lnTo>
                    <a:lnTo>
                      <a:pt x="177" y="743"/>
                    </a:lnTo>
                    <a:lnTo>
                      <a:pt x="178" y="743"/>
                    </a:lnTo>
                    <a:lnTo>
                      <a:pt x="178" y="743"/>
                    </a:lnTo>
                    <a:lnTo>
                      <a:pt x="179" y="743"/>
                    </a:lnTo>
                    <a:lnTo>
                      <a:pt x="179" y="734"/>
                    </a:lnTo>
                    <a:lnTo>
                      <a:pt x="180" y="743"/>
                    </a:lnTo>
                    <a:lnTo>
                      <a:pt x="180" y="743"/>
                    </a:lnTo>
                    <a:lnTo>
                      <a:pt x="181" y="741"/>
                    </a:lnTo>
                    <a:lnTo>
                      <a:pt x="181" y="743"/>
                    </a:lnTo>
                    <a:lnTo>
                      <a:pt x="182" y="736"/>
                    </a:lnTo>
                    <a:lnTo>
                      <a:pt x="182" y="743"/>
                    </a:lnTo>
                    <a:lnTo>
                      <a:pt x="183" y="743"/>
                    </a:lnTo>
                    <a:lnTo>
                      <a:pt x="183" y="743"/>
                    </a:lnTo>
                    <a:lnTo>
                      <a:pt x="184" y="743"/>
                    </a:lnTo>
                    <a:lnTo>
                      <a:pt x="184" y="743"/>
                    </a:lnTo>
                    <a:lnTo>
                      <a:pt x="185" y="739"/>
                    </a:lnTo>
                    <a:lnTo>
                      <a:pt x="185" y="743"/>
                    </a:lnTo>
                    <a:lnTo>
                      <a:pt x="186" y="743"/>
                    </a:lnTo>
                    <a:lnTo>
                      <a:pt x="186" y="743"/>
                    </a:lnTo>
                    <a:lnTo>
                      <a:pt x="187" y="743"/>
                    </a:lnTo>
                    <a:lnTo>
                      <a:pt x="187" y="743"/>
                    </a:lnTo>
                    <a:lnTo>
                      <a:pt x="188" y="738"/>
                    </a:lnTo>
                    <a:lnTo>
                      <a:pt x="188" y="743"/>
                    </a:lnTo>
                    <a:lnTo>
                      <a:pt x="189" y="743"/>
                    </a:lnTo>
                    <a:lnTo>
                      <a:pt x="189" y="743"/>
                    </a:lnTo>
                    <a:lnTo>
                      <a:pt x="190" y="743"/>
                    </a:lnTo>
                    <a:lnTo>
                      <a:pt x="190" y="743"/>
                    </a:lnTo>
                    <a:lnTo>
                      <a:pt x="191" y="743"/>
                    </a:lnTo>
                    <a:lnTo>
                      <a:pt x="191" y="740"/>
                    </a:lnTo>
                    <a:lnTo>
                      <a:pt x="192" y="743"/>
                    </a:lnTo>
                    <a:lnTo>
                      <a:pt x="192" y="741"/>
                    </a:lnTo>
                    <a:lnTo>
                      <a:pt x="193" y="571"/>
                    </a:lnTo>
                    <a:lnTo>
                      <a:pt x="193" y="743"/>
                    </a:lnTo>
                    <a:lnTo>
                      <a:pt x="194" y="743"/>
                    </a:lnTo>
                    <a:lnTo>
                      <a:pt x="194" y="733"/>
                    </a:lnTo>
                    <a:lnTo>
                      <a:pt x="195" y="687"/>
                    </a:lnTo>
                    <a:lnTo>
                      <a:pt x="195" y="743"/>
                    </a:lnTo>
                    <a:lnTo>
                      <a:pt x="196" y="743"/>
                    </a:lnTo>
                    <a:lnTo>
                      <a:pt x="196" y="741"/>
                    </a:lnTo>
                    <a:lnTo>
                      <a:pt x="197" y="737"/>
                    </a:lnTo>
                    <a:lnTo>
                      <a:pt x="197" y="743"/>
                    </a:lnTo>
                    <a:lnTo>
                      <a:pt x="198" y="743"/>
                    </a:lnTo>
                    <a:lnTo>
                      <a:pt x="198" y="706"/>
                    </a:lnTo>
                    <a:lnTo>
                      <a:pt x="199" y="743"/>
                    </a:lnTo>
                    <a:lnTo>
                      <a:pt x="199" y="743"/>
                    </a:lnTo>
                    <a:lnTo>
                      <a:pt x="200" y="742"/>
                    </a:lnTo>
                    <a:lnTo>
                      <a:pt x="200" y="743"/>
                    </a:lnTo>
                    <a:lnTo>
                      <a:pt x="201" y="741"/>
                    </a:lnTo>
                    <a:lnTo>
                      <a:pt x="201" y="743"/>
                    </a:lnTo>
                    <a:lnTo>
                      <a:pt x="202" y="743"/>
                    </a:lnTo>
                    <a:lnTo>
                      <a:pt x="202" y="742"/>
                    </a:lnTo>
                    <a:lnTo>
                      <a:pt x="203" y="743"/>
                    </a:lnTo>
                    <a:lnTo>
                      <a:pt x="203" y="743"/>
                    </a:lnTo>
                    <a:lnTo>
                      <a:pt x="204" y="743"/>
                    </a:lnTo>
                    <a:lnTo>
                      <a:pt x="204" y="743"/>
                    </a:lnTo>
                    <a:lnTo>
                      <a:pt x="205" y="743"/>
                    </a:lnTo>
                    <a:lnTo>
                      <a:pt x="205" y="743"/>
                    </a:lnTo>
                    <a:lnTo>
                      <a:pt x="206" y="743"/>
                    </a:lnTo>
                    <a:lnTo>
                      <a:pt x="206" y="719"/>
                    </a:lnTo>
                    <a:lnTo>
                      <a:pt x="207" y="743"/>
                    </a:lnTo>
                    <a:lnTo>
                      <a:pt x="207" y="743"/>
                    </a:lnTo>
                    <a:lnTo>
                      <a:pt x="208" y="742"/>
                    </a:lnTo>
                    <a:lnTo>
                      <a:pt x="208" y="743"/>
                    </a:lnTo>
                    <a:lnTo>
                      <a:pt x="209" y="743"/>
                    </a:lnTo>
                    <a:lnTo>
                      <a:pt x="209" y="743"/>
                    </a:lnTo>
                    <a:lnTo>
                      <a:pt x="210" y="699"/>
                    </a:lnTo>
                    <a:lnTo>
                      <a:pt x="210" y="743"/>
                    </a:lnTo>
                    <a:lnTo>
                      <a:pt x="211" y="743"/>
                    </a:lnTo>
                    <a:lnTo>
                      <a:pt x="211" y="743"/>
                    </a:lnTo>
                    <a:lnTo>
                      <a:pt x="212" y="741"/>
                    </a:lnTo>
                    <a:lnTo>
                      <a:pt x="212" y="743"/>
                    </a:lnTo>
                    <a:lnTo>
                      <a:pt x="213" y="743"/>
                    </a:lnTo>
                    <a:lnTo>
                      <a:pt x="213" y="743"/>
                    </a:lnTo>
                    <a:lnTo>
                      <a:pt x="214" y="743"/>
                    </a:lnTo>
                    <a:lnTo>
                      <a:pt x="214" y="740"/>
                    </a:lnTo>
                    <a:lnTo>
                      <a:pt x="215" y="742"/>
                    </a:lnTo>
                    <a:lnTo>
                      <a:pt x="215" y="743"/>
                    </a:lnTo>
                    <a:lnTo>
                      <a:pt x="216" y="639"/>
                    </a:lnTo>
                    <a:lnTo>
                      <a:pt x="216" y="743"/>
                    </a:lnTo>
                    <a:lnTo>
                      <a:pt x="217" y="743"/>
                    </a:lnTo>
                    <a:lnTo>
                      <a:pt x="217" y="743"/>
                    </a:lnTo>
                    <a:lnTo>
                      <a:pt x="218" y="721"/>
                    </a:lnTo>
                    <a:lnTo>
                      <a:pt x="218" y="743"/>
                    </a:lnTo>
                    <a:lnTo>
                      <a:pt x="219" y="743"/>
                    </a:lnTo>
                    <a:lnTo>
                      <a:pt x="219" y="743"/>
                    </a:lnTo>
                    <a:lnTo>
                      <a:pt x="220" y="742"/>
                    </a:lnTo>
                    <a:lnTo>
                      <a:pt x="220" y="743"/>
                    </a:lnTo>
                    <a:lnTo>
                      <a:pt x="221" y="743"/>
                    </a:lnTo>
                    <a:lnTo>
                      <a:pt x="221" y="743"/>
                    </a:lnTo>
                    <a:lnTo>
                      <a:pt x="222" y="174"/>
                    </a:lnTo>
                    <a:lnTo>
                      <a:pt x="222" y="743"/>
                    </a:lnTo>
                    <a:lnTo>
                      <a:pt x="223" y="743"/>
                    </a:lnTo>
                    <a:lnTo>
                      <a:pt x="223" y="743"/>
                    </a:lnTo>
                    <a:lnTo>
                      <a:pt x="224" y="743"/>
                    </a:lnTo>
                    <a:lnTo>
                      <a:pt x="224" y="701"/>
                    </a:lnTo>
                    <a:lnTo>
                      <a:pt x="225" y="743"/>
                    </a:lnTo>
                    <a:lnTo>
                      <a:pt x="225" y="743"/>
                    </a:lnTo>
                    <a:lnTo>
                      <a:pt x="226" y="738"/>
                    </a:lnTo>
                    <a:lnTo>
                      <a:pt x="226" y="743"/>
                    </a:lnTo>
                    <a:lnTo>
                      <a:pt x="227" y="743"/>
                    </a:lnTo>
                    <a:lnTo>
                      <a:pt x="227" y="743"/>
                    </a:lnTo>
                    <a:lnTo>
                      <a:pt x="228" y="743"/>
                    </a:lnTo>
                    <a:lnTo>
                      <a:pt x="228" y="743"/>
                    </a:lnTo>
                    <a:lnTo>
                      <a:pt x="229" y="743"/>
                    </a:lnTo>
                    <a:lnTo>
                      <a:pt x="229" y="743"/>
                    </a:lnTo>
                    <a:lnTo>
                      <a:pt x="230" y="696"/>
                    </a:lnTo>
                    <a:lnTo>
                      <a:pt x="230" y="743"/>
                    </a:lnTo>
                    <a:lnTo>
                      <a:pt x="231" y="743"/>
                    </a:lnTo>
                    <a:lnTo>
                      <a:pt x="231" y="743"/>
                    </a:lnTo>
                    <a:lnTo>
                      <a:pt x="232" y="739"/>
                    </a:lnTo>
                    <a:lnTo>
                      <a:pt x="232" y="743"/>
                    </a:lnTo>
                    <a:lnTo>
                      <a:pt x="233" y="743"/>
                    </a:lnTo>
                    <a:lnTo>
                      <a:pt x="233" y="743"/>
                    </a:lnTo>
                    <a:lnTo>
                      <a:pt x="234" y="742"/>
                    </a:lnTo>
                    <a:lnTo>
                      <a:pt x="234" y="743"/>
                    </a:lnTo>
                    <a:lnTo>
                      <a:pt x="235" y="743"/>
                    </a:lnTo>
                    <a:lnTo>
                      <a:pt x="235" y="743"/>
                    </a:lnTo>
                    <a:lnTo>
                      <a:pt x="236" y="743"/>
                    </a:lnTo>
                    <a:lnTo>
                      <a:pt x="236" y="731"/>
                    </a:lnTo>
                    <a:lnTo>
                      <a:pt x="237" y="743"/>
                    </a:lnTo>
                    <a:lnTo>
                      <a:pt x="237" y="743"/>
                    </a:lnTo>
                    <a:lnTo>
                      <a:pt x="238" y="743"/>
                    </a:lnTo>
                    <a:lnTo>
                      <a:pt x="238" y="741"/>
                    </a:lnTo>
                    <a:lnTo>
                      <a:pt x="239" y="743"/>
                    </a:lnTo>
                    <a:lnTo>
                      <a:pt x="239" y="743"/>
                    </a:lnTo>
                    <a:lnTo>
                      <a:pt x="240" y="735"/>
                    </a:lnTo>
                    <a:lnTo>
                      <a:pt x="240" y="743"/>
                    </a:lnTo>
                    <a:lnTo>
                      <a:pt x="241" y="743"/>
                    </a:lnTo>
                    <a:lnTo>
                      <a:pt x="241" y="743"/>
                    </a:lnTo>
                    <a:lnTo>
                      <a:pt x="242" y="743"/>
                    </a:lnTo>
                    <a:lnTo>
                      <a:pt x="242" y="743"/>
                    </a:lnTo>
                    <a:lnTo>
                      <a:pt x="243" y="743"/>
                    </a:lnTo>
                    <a:lnTo>
                      <a:pt x="243" y="743"/>
                    </a:lnTo>
                    <a:lnTo>
                      <a:pt x="244" y="743"/>
                    </a:lnTo>
                    <a:lnTo>
                      <a:pt x="244" y="740"/>
                    </a:lnTo>
                    <a:lnTo>
                      <a:pt x="245" y="743"/>
                    </a:lnTo>
                    <a:lnTo>
                      <a:pt x="245" y="743"/>
                    </a:lnTo>
                    <a:lnTo>
                      <a:pt x="246" y="743"/>
                    </a:lnTo>
                    <a:lnTo>
                      <a:pt x="246" y="743"/>
                    </a:lnTo>
                    <a:lnTo>
                      <a:pt x="247" y="743"/>
                    </a:lnTo>
                    <a:lnTo>
                      <a:pt x="247" y="743"/>
                    </a:lnTo>
                    <a:lnTo>
                      <a:pt x="248" y="743"/>
                    </a:lnTo>
                    <a:lnTo>
                      <a:pt x="248" y="743"/>
                    </a:lnTo>
                    <a:lnTo>
                      <a:pt x="249" y="743"/>
                    </a:lnTo>
                    <a:lnTo>
                      <a:pt x="249" y="743"/>
                    </a:lnTo>
                    <a:lnTo>
                      <a:pt x="250" y="721"/>
                    </a:lnTo>
                    <a:lnTo>
                      <a:pt x="250" y="743"/>
                    </a:lnTo>
                    <a:lnTo>
                      <a:pt x="251" y="743"/>
                    </a:lnTo>
                    <a:lnTo>
                      <a:pt x="251" y="743"/>
                    </a:lnTo>
                    <a:lnTo>
                      <a:pt x="252" y="741"/>
                    </a:lnTo>
                    <a:lnTo>
                      <a:pt x="252" y="743"/>
                    </a:lnTo>
                    <a:lnTo>
                      <a:pt x="253" y="743"/>
                    </a:lnTo>
                    <a:lnTo>
                      <a:pt x="253" y="743"/>
                    </a:lnTo>
                    <a:lnTo>
                      <a:pt x="254" y="743"/>
                    </a:lnTo>
                    <a:lnTo>
                      <a:pt x="254" y="743"/>
                    </a:lnTo>
                    <a:lnTo>
                      <a:pt x="255" y="743"/>
                    </a:lnTo>
                    <a:lnTo>
                      <a:pt x="255" y="743"/>
                    </a:lnTo>
                    <a:lnTo>
                      <a:pt x="256" y="743"/>
                    </a:lnTo>
                    <a:lnTo>
                      <a:pt x="256" y="743"/>
                    </a:lnTo>
                    <a:lnTo>
                      <a:pt x="257" y="743"/>
                    </a:lnTo>
                    <a:lnTo>
                      <a:pt x="257" y="743"/>
                    </a:lnTo>
                    <a:lnTo>
                      <a:pt x="258" y="741"/>
                    </a:lnTo>
                    <a:lnTo>
                      <a:pt x="258" y="743"/>
                    </a:lnTo>
                    <a:lnTo>
                      <a:pt x="259" y="743"/>
                    </a:lnTo>
                    <a:lnTo>
                      <a:pt x="259" y="743"/>
                    </a:lnTo>
                    <a:lnTo>
                      <a:pt x="260" y="741"/>
                    </a:lnTo>
                    <a:lnTo>
                      <a:pt x="260" y="743"/>
                    </a:lnTo>
                    <a:lnTo>
                      <a:pt x="261" y="743"/>
                    </a:lnTo>
                    <a:lnTo>
                      <a:pt x="261" y="743"/>
                    </a:lnTo>
                    <a:lnTo>
                      <a:pt x="262" y="741"/>
                    </a:lnTo>
                    <a:lnTo>
                      <a:pt x="262" y="743"/>
                    </a:lnTo>
                    <a:lnTo>
                      <a:pt x="263" y="743"/>
                    </a:lnTo>
                    <a:lnTo>
                      <a:pt x="263" y="743"/>
                    </a:lnTo>
                    <a:lnTo>
                      <a:pt x="264" y="699"/>
                    </a:lnTo>
                    <a:lnTo>
                      <a:pt x="264" y="743"/>
                    </a:lnTo>
                    <a:lnTo>
                      <a:pt x="265" y="743"/>
                    </a:lnTo>
                    <a:lnTo>
                      <a:pt x="265" y="743"/>
                    </a:lnTo>
                    <a:lnTo>
                      <a:pt x="266" y="742"/>
                    </a:lnTo>
                    <a:lnTo>
                      <a:pt x="266" y="743"/>
                    </a:lnTo>
                    <a:lnTo>
                      <a:pt x="267" y="737"/>
                    </a:lnTo>
                    <a:lnTo>
                      <a:pt x="267" y="743"/>
                    </a:lnTo>
                    <a:lnTo>
                      <a:pt x="268" y="743"/>
                    </a:lnTo>
                    <a:lnTo>
                      <a:pt x="268" y="739"/>
                    </a:lnTo>
                    <a:lnTo>
                      <a:pt x="269" y="743"/>
                    </a:lnTo>
                    <a:lnTo>
                      <a:pt x="269" y="743"/>
                    </a:lnTo>
                    <a:lnTo>
                      <a:pt x="270" y="742"/>
                    </a:lnTo>
                    <a:lnTo>
                      <a:pt x="270" y="743"/>
                    </a:lnTo>
                    <a:lnTo>
                      <a:pt x="271" y="743"/>
                    </a:lnTo>
                    <a:lnTo>
                      <a:pt x="271" y="739"/>
                    </a:lnTo>
                    <a:lnTo>
                      <a:pt x="272" y="742"/>
                    </a:lnTo>
                    <a:lnTo>
                      <a:pt x="272" y="743"/>
                    </a:lnTo>
                    <a:lnTo>
                      <a:pt x="273" y="743"/>
                    </a:lnTo>
                    <a:lnTo>
                      <a:pt x="273" y="743"/>
                    </a:lnTo>
                    <a:lnTo>
                      <a:pt x="274" y="737"/>
                    </a:lnTo>
                    <a:lnTo>
                      <a:pt x="274" y="743"/>
                    </a:lnTo>
                    <a:lnTo>
                      <a:pt x="275" y="743"/>
                    </a:lnTo>
                    <a:lnTo>
                      <a:pt x="275" y="743"/>
                    </a:lnTo>
                    <a:lnTo>
                      <a:pt x="276" y="742"/>
                    </a:lnTo>
                    <a:lnTo>
                      <a:pt x="276" y="743"/>
                    </a:lnTo>
                    <a:lnTo>
                      <a:pt x="277" y="743"/>
                    </a:lnTo>
                    <a:lnTo>
                      <a:pt x="277" y="743"/>
                    </a:lnTo>
                    <a:lnTo>
                      <a:pt x="278" y="742"/>
                    </a:lnTo>
                    <a:lnTo>
                      <a:pt x="278" y="743"/>
                    </a:lnTo>
                    <a:lnTo>
                      <a:pt x="279" y="742"/>
                    </a:lnTo>
                    <a:lnTo>
                      <a:pt x="279" y="743"/>
                    </a:lnTo>
                    <a:lnTo>
                      <a:pt x="280" y="743"/>
                    </a:lnTo>
                    <a:lnTo>
                      <a:pt x="280" y="742"/>
                    </a:lnTo>
                    <a:lnTo>
                      <a:pt x="281" y="743"/>
                    </a:lnTo>
                    <a:lnTo>
                      <a:pt x="281" y="742"/>
                    </a:lnTo>
                    <a:lnTo>
                      <a:pt x="282" y="742"/>
                    </a:lnTo>
                    <a:lnTo>
                      <a:pt x="282" y="743"/>
                    </a:lnTo>
                    <a:lnTo>
                      <a:pt x="283" y="743"/>
                    </a:lnTo>
                    <a:lnTo>
                      <a:pt x="283" y="743"/>
                    </a:lnTo>
                    <a:lnTo>
                      <a:pt x="284" y="743"/>
                    </a:lnTo>
                    <a:lnTo>
                      <a:pt x="284" y="743"/>
                    </a:lnTo>
                    <a:lnTo>
                      <a:pt x="285" y="743"/>
                    </a:lnTo>
                    <a:lnTo>
                      <a:pt x="285" y="741"/>
                    </a:lnTo>
                    <a:lnTo>
                      <a:pt x="286" y="742"/>
                    </a:lnTo>
                    <a:lnTo>
                      <a:pt x="286" y="743"/>
                    </a:lnTo>
                    <a:lnTo>
                      <a:pt x="287" y="743"/>
                    </a:lnTo>
                    <a:lnTo>
                      <a:pt x="287" y="743"/>
                    </a:lnTo>
                    <a:lnTo>
                      <a:pt x="288" y="743"/>
                    </a:lnTo>
                    <a:lnTo>
                      <a:pt x="288" y="738"/>
                    </a:lnTo>
                    <a:lnTo>
                      <a:pt x="289" y="743"/>
                    </a:lnTo>
                    <a:lnTo>
                      <a:pt x="289" y="743"/>
                    </a:lnTo>
                    <a:lnTo>
                      <a:pt x="290" y="743"/>
                    </a:lnTo>
                    <a:lnTo>
                      <a:pt x="290" y="743"/>
                    </a:lnTo>
                    <a:lnTo>
                      <a:pt x="291" y="743"/>
                    </a:lnTo>
                    <a:lnTo>
                      <a:pt x="291" y="732"/>
                    </a:lnTo>
                    <a:lnTo>
                      <a:pt x="292" y="743"/>
                    </a:lnTo>
                    <a:lnTo>
                      <a:pt x="292" y="743"/>
                    </a:lnTo>
                    <a:lnTo>
                      <a:pt x="293" y="743"/>
                    </a:lnTo>
                    <a:lnTo>
                      <a:pt x="293" y="738"/>
                    </a:lnTo>
                    <a:lnTo>
                      <a:pt x="294" y="736"/>
                    </a:lnTo>
                    <a:lnTo>
                      <a:pt x="294" y="743"/>
                    </a:lnTo>
                    <a:lnTo>
                      <a:pt x="295" y="743"/>
                    </a:lnTo>
                    <a:lnTo>
                      <a:pt x="295" y="743"/>
                    </a:lnTo>
                    <a:lnTo>
                      <a:pt x="296" y="743"/>
                    </a:lnTo>
                    <a:lnTo>
                      <a:pt x="296" y="743"/>
                    </a:lnTo>
                    <a:lnTo>
                      <a:pt x="297" y="743"/>
                    </a:lnTo>
                    <a:lnTo>
                      <a:pt x="297" y="743"/>
                    </a:lnTo>
                    <a:lnTo>
                      <a:pt x="298" y="743"/>
                    </a:lnTo>
                    <a:lnTo>
                      <a:pt x="298" y="743"/>
                    </a:lnTo>
                    <a:lnTo>
                      <a:pt x="299" y="743"/>
                    </a:lnTo>
                    <a:lnTo>
                      <a:pt x="299" y="743"/>
                    </a:lnTo>
                    <a:lnTo>
                      <a:pt x="300" y="743"/>
                    </a:lnTo>
                    <a:lnTo>
                      <a:pt x="300" y="743"/>
                    </a:lnTo>
                    <a:lnTo>
                      <a:pt x="301" y="742"/>
                    </a:lnTo>
                    <a:lnTo>
                      <a:pt x="301" y="743"/>
                    </a:lnTo>
                    <a:lnTo>
                      <a:pt x="302" y="743"/>
                    </a:lnTo>
                    <a:lnTo>
                      <a:pt x="302" y="743"/>
                    </a:lnTo>
                    <a:lnTo>
                      <a:pt x="303" y="743"/>
                    </a:lnTo>
                    <a:lnTo>
                      <a:pt x="303" y="740"/>
                    </a:lnTo>
                    <a:lnTo>
                      <a:pt x="304" y="738"/>
                    </a:lnTo>
                    <a:lnTo>
                      <a:pt x="304" y="743"/>
                    </a:lnTo>
                    <a:lnTo>
                      <a:pt x="305" y="743"/>
                    </a:lnTo>
                    <a:lnTo>
                      <a:pt x="305" y="735"/>
                    </a:lnTo>
                    <a:lnTo>
                      <a:pt x="306" y="743"/>
                    </a:lnTo>
                    <a:lnTo>
                      <a:pt x="306" y="743"/>
                    </a:lnTo>
                    <a:lnTo>
                      <a:pt x="307" y="743"/>
                    </a:lnTo>
                    <a:lnTo>
                      <a:pt x="307" y="707"/>
                    </a:lnTo>
                    <a:lnTo>
                      <a:pt x="308" y="743"/>
                    </a:lnTo>
                    <a:lnTo>
                      <a:pt x="308" y="743"/>
                    </a:lnTo>
                    <a:lnTo>
                      <a:pt x="309" y="739"/>
                    </a:lnTo>
                    <a:lnTo>
                      <a:pt x="309" y="743"/>
                    </a:lnTo>
                    <a:lnTo>
                      <a:pt x="310" y="743"/>
                    </a:lnTo>
                    <a:lnTo>
                      <a:pt x="310" y="743"/>
                    </a:lnTo>
                    <a:lnTo>
                      <a:pt x="311" y="727"/>
                    </a:lnTo>
                    <a:lnTo>
                      <a:pt x="311" y="743"/>
                    </a:lnTo>
                    <a:lnTo>
                      <a:pt x="312" y="743"/>
                    </a:lnTo>
                    <a:lnTo>
                      <a:pt x="312" y="743"/>
                    </a:lnTo>
                    <a:lnTo>
                      <a:pt x="313" y="743"/>
                    </a:lnTo>
                    <a:lnTo>
                      <a:pt x="313" y="723"/>
                    </a:lnTo>
                    <a:lnTo>
                      <a:pt x="314" y="743"/>
                    </a:lnTo>
                    <a:lnTo>
                      <a:pt x="314" y="743"/>
                    </a:lnTo>
                    <a:lnTo>
                      <a:pt x="315" y="743"/>
                    </a:lnTo>
                    <a:lnTo>
                      <a:pt x="315" y="740"/>
                    </a:lnTo>
                    <a:lnTo>
                      <a:pt x="316" y="743"/>
                    </a:lnTo>
                    <a:lnTo>
                      <a:pt x="316" y="743"/>
                    </a:lnTo>
                    <a:lnTo>
                      <a:pt x="317" y="741"/>
                    </a:lnTo>
                    <a:lnTo>
                      <a:pt x="317" y="743"/>
                    </a:lnTo>
                    <a:lnTo>
                      <a:pt x="318" y="743"/>
                    </a:lnTo>
                    <a:lnTo>
                      <a:pt x="318" y="743"/>
                    </a:lnTo>
                    <a:lnTo>
                      <a:pt x="319" y="743"/>
                    </a:lnTo>
                    <a:lnTo>
                      <a:pt x="319" y="743"/>
                    </a:lnTo>
                    <a:lnTo>
                      <a:pt x="320" y="743"/>
                    </a:lnTo>
                    <a:lnTo>
                      <a:pt x="320" y="743"/>
                    </a:lnTo>
                    <a:lnTo>
                      <a:pt x="321" y="742"/>
                    </a:lnTo>
                    <a:lnTo>
                      <a:pt x="321" y="743"/>
                    </a:lnTo>
                    <a:lnTo>
                      <a:pt x="322" y="743"/>
                    </a:lnTo>
                    <a:lnTo>
                      <a:pt x="322" y="743"/>
                    </a:lnTo>
                    <a:lnTo>
                      <a:pt x="323" y="743"/>
                    </a:lnTo>
                    <a:lnTo>
                      <a:pt x="323" y="743"/>
                    </a:lnTo>
                    <a:lnTo>
                      <a:pt x="324" y="743"/>
                    </a:lnTo>
                    <a:lnTo>
                      <a:pt x="324" y="743"/>
                    </a:lnTo>
                    <a:lnTo>
                      <a:pt x="325" y="743"/>
                    </a:lnTo>
                    <a:lnTo>
                      <a:pt x="325" y="743"/>
                    </a:lnTo>
                    <a:lnTo>
                      <a:pt x="326" y="743"/>
                    </a:lnTo>
                    <a:lnTo>
                      <a:pt x="326" y="743"/>
                    </a:lnTo>
                    <a:lnTo>
                      <a:pt x="327" y="743"/>
                    </a:lnTo>
                    <a:lnTo>
                      <a:pt x="327" y="743"/>
                    </a:lnTo>
                    <a:lnTo>
                      <a:pt x="328" y="743"/>
                    </a:lnTo>
                    <a:lnTo>
                      <a:pt x="328" y="743"/>
                    </a:lnTo>
                    <a:lnTo>
                      <a:pt x="329" y="742"/>
                    </a:lnTo>
                    <a:lnTo>
                      <a:pt x="329" y="743"/>
                    </a:lnTo>
                    <a:lnTo>
                      <a:pt x="330" y="743"/>
                    </a:lnTo>
                    <a:lnTo>
                      <a:pt x="330" y="743"/>
                    </a:lnTo>
                    <a:lnTo>
                      <a:pt x="331" y="743"/>
                    </a:lnTo>
                    <a:lnTo>
                      <a:pt x="331" y="742"/>
                    </a:lnTo>
                    <a:lnTo>
                      <a:pt x="332" y="743"/>
                    </a:lnTo>
                    <a:lnTo>
                      <a:pt x="332" y="743"/>
                    </a:lnTo>
                    <a:lnTo>
                      <a:pt x="333" y="743"/>
                    </a:lnTo>
                    <a:lnTo>
                      <a:pt x="333" y="743"/>
                    </a:lnTo>
                    <a:lnTo>
                      <a:pt x="334" y="743"/>
                    </a:lnTo>
                    <a:lnTo>
                      <a:pt x="334" y="743"/>
                    </a:lnTo>
                    <a:lnTo>
                      <a:pt x="335" y="742"/>
                    </a:lnTo>
                    <a:lnTo>
                      <a:pt x="335" y="743"/>
                    </a:lnTo>
                    <a:lnTo>
                      <a:pt x="336" y="743"/>
                    </a:lnTo>
                    <a:lnTo>
                      <a:pt x="336" y="743"/>
                    </a:lnTo>
                    <a:lnTo>
                      <a:pt x="337" y="743"/>
                    </a:lnTo>
                    <a:lnTo>
                      <a:pt x="337" y="743"/>
                    </a:lnTo>
                    <a:lnTo>
                      <a:pt x="338" y="743"/>
                    </a:lnTo>
                    <a:lnTo>
                      <a:pt x="338" y="743"/>
                    </a:lnTo>
                    <a:lnTo>
                      <a:pt x="339" y="741"/>
                    </a:lnTo>
                    <a:lnTo>
                      <a:pt x="339" y="743"/>
                    </a:lnTo>
                    <a:lnTo>
                      <a:pt x="340" y="743"/>
                    </a:lnTo>
                    <a:lnTo>
                      <a:pt x="340" y="743"/>
                    </a:lnTo>
                    <a:lnTo>
                      <a:pt x="341" y="739"/>
                    </a:lnTo>
                    <a:lnTo>
                      <a:pt x="341" y="743"/>
                    </a:lnTo>
                    <a:lnTo>
                      <a:pt x="342" y="743"/>
                    </a:lnTo>
                    <a:lnTo>
                      <a:pt x="342" y="743"/>
                    </a:lnTo>
                    <a:lnTo>
                      <a:pt x="343" y="743"/>
                    </a:lnTo>
                    <a:lnTo>
                      <a:pt x="343" y="743"/>
                    </a:lnTo>
                    <a:lnTo>
                      <a:pt x="344" y="743"/>
                    </a:lnTo>
                    <a:lnTo>
                      <a:pt x="344" y="743"/>
                    </a:lnTo>
                    <a:lnTo>
                      <a:pt x="345" y="742"/>
                    </a:lnTo>
                    <a:lnTo>
                      <a:pt x="345" y="743"/>
                    </a:lnTo>
                    <a:lnTo>
                      <a:pt x="346" y="743"/>
                    </a:lnTo>
                    <a:lnTo>
                      <a:pt x="346" y="743"/>
                    </a:lnTo>
                    <a:lnTo>
                      <a:pt x="347" y="743"/>
                    </a:lnTo>
                    <a:lnTo>
                      <a:pt x="347" y="743"/>
                    </a:lnTo>
                    <a:lnTo>
                      <a:pt x="348" y="743"/>
                    </a:lnTo>
                    <a:lnTo>
                      <a:pt x="348" y="743"/>
                    </a:lnTo>
                    <a:lnTo>
                      <a:pt x="349" y="740"/>
                    </a:lnTo>
                    <a:lnTo>
                      <a:pt x="349" y="743"/>
                    </a:lnTo>
                    <a:lnTo>
                      <a:pt x="350" y="743"/>
                    </a:lnTo>
                    <a:lnTo>
                      <a:pt x="350" y="743"/>
                    </a:lnTo>
                    <a:lnTo>
                      <a:pt x="351" y="378"/>
                    </a:lnTo>
                    <a:lnTo>
                      <a:pt x="351" y="743"/>
                    </a:lnTo>
                    <a:lnTo>
                      <a:pt x="352" y="743"/>
                    </a:lnTo>
                    <a:lnTo>
                      <a:pt x="352" y="743"/>
                    </a:lnTo>
                    <a:lnTo>
                      <a:pt x="353" y="686"/>
                    </a:lnTo>
                    <a:lnTo>
                      <a:pt x="353" y="743"/>
                    </a:lnTo>
                    <a:lnTo>
                      <a:pt x="354" y="743"/>
                    </a:lnTo>
                    <a:lnTo>
                      <a:pt x="354" y="743"/>
                    </a:lnTo>
                    <a:lnTo>
                      <a:pt x="355" y="737"/>
                    </a:lnTo>
                    <a:lnTo>
                      <a:pt x="355" y="743"/>
                    </a:lnTo>
                    <a:lnTo>
                      <a:pt x="356" y="743"/>
                    </a:lnTo>
                    <a:lnTo>
                      <a:pt x="356" y="743"/>
                    </a:lnTo>
                    <a:lnTo>
                      <a:pt x="357" y="740"/>
                    </a:lnTo>
                    <a:lnTo>
                      <a:pt x="357" y="743"/>
                    </a:lnTo>
                    <a:lnTo>
                      <a:pt x="358" y="743"/>
                    </a:lnTo>
                    <a:lnTo>
                      <a:pt x="358" y="743"/>
                    </a:lnTo>
                    <a:lnTo>
                      <a:pt x="359" y="743"/>
                    </a:lnTo>
                    <a:lnTo>
                      <a:pt x="359" y="743"/>
                    </a:lnTo>
                    <a:lnTo>
                      <a:pt x="360" y="743"/>
                    </a:lnTo>
                    <a:lnTo>
                      <a:pt x="360" y="743"/>
                    </a:lnTo>
                    <a:lnTo>
                      <a:pt x="361" y="743"/>
                    </a:lnTo>
                    <a:lnTo>
                      <a:pt x="361" y="743"/>
                    </a:lnTo>
                    <a:lnTo>
                      <a:pt x="362" y="743"/>
                    </a:lnTo>
                    <a:lnTo>
                      <a:pt x="362" y="743"/>
                    </a:lnTo>
                    <a:lnTo>
                      <a:pt x="363" y="743"/>
                    </a:lnTo>
                    <a:lnTo>
                      <a:pt x="363" y="743"/>
                    </a:lnTo>
                    <a:lnTo>
                      <a:pt x="364" y="743"/>
                    </a:lnTo>
                    <a:lnTo>
                      <a:pt x="364" y="743"/>
                    </a:lnTo>
                    <a:lnTo>
                      <a:pt x="365" y="743"/>
                    </a:lnTo>
                    <a:lnTo>
                      <a:pt x="365" y="743"/>
                    </a:lnTo>
                    <a:lnTo>
                      <a:pt x="366" y="743"/>
                    </a:lnTo>
                    <a:lnTo>
                      <a:pt x="366" y="743"/>
                    </a:lnTo>
                    <a:lnTo>
                      <a:pt x="367" y="743"/>
                    </a:lnTo>
                    <a:lnTo>
                      <a:pt x="367" y="690"/>
                    </a:lnTo>
                    <a:lnTo>
                      <a:pt x="368" y="743"/>
                    </a:lnTo>
                    <a:lnTo>
                      <a:pt x="368" y="743"/>
                    </a:lnTo>
                    <a:lnTo>
                      <a:pt x="369" y="738"/>
                    </a:lnTo>
                    <a:lnTo>
                      <a:pt x="369" y="743"/>
                    </a:lnTo>
                    <a:lnTo>
                      <a:pt x="370" y="743"/>
                    </a:lnTo>
                    <a:lnTo>
                      <a:pt x="370" y="743"/>
                    </a:lnTo>
                    <a:lnTo>
                      <a:pt x="371" y="743"/>
                    </a:lnTo>
                    <a:lnTo>
                      <a:pt x="371" y="743"/>
                    </a:lnTo>
                    <a:lnTo>
                      <a:pt x="372" y="743"/>
                    </a:lnTo>
                    <a:lnTo>
                      <a:pt x="372" y="743"/>
                    </a:lnTo>
                    <a:lnTo>
                      <a:pt x="373" y="743"/>
                    </a:lnTo>
                    <a:lnTo>
                      <a:pt x="373" y="743"/>
                    </a:lnTo>
                    <a:lnTo>
                      <a:pt x="374" y="743"/>
                    </a:lnTo>
                    <a:lnTo>
                      <a:pt x="374" y="743"/>
                    </a:lnTo>
                    <a:lnTo>
                      <a:pt x="375" y="740"/>
                    </a:lnTo>
                    <a:lnTo>
                      <a:pt x="375" y="743"/>
                    </a:lnTo>
                    <a:lnTo>
                      <a:pt x="376" y="743"/>
                    </a:lnTo>
                    <a:lnTo>
                      <a:pt x="376" y="743"/>
                    </a:lnTo>
                    <a:lnTo>
                      <a:pt x="377" y="743"/>
                    </a:lnTo>
                    <a:lnTo>
                      <a:pt x="377" y="743"/>
                    </a:lnTo>
                    <a:lnTo>
                      <a:pt x="378" y="743"/>
                    </a:lnTo>
                    <a:lnTo>
                      <a:pt x="378" y="732"/>
                    </a:lnTo>
                    <a:lnTo>
                      <a:pt x="379" y="743"/>
                    </a:lnTo>
                    <a:lnTo>
                      <a:pt x="379" y="743"/>
                    </a:lnTo>
                    <a:lnTo>
                      <a:pt x="380" y="732"/>
                    </a:lnTo>
                    <a:lnTo>
                      <a:pt x="380" y="743"/>
                    </a:lnTo>
                    <a:lnTo>
                      <a:pt x="381" y="740"/>
                    </a:lnTo>
                    <a:lnTo>
                      <a:pt x="381" y="743"/>
                    </a:lnTo>
                    <a:lnTo>
                      <a:pt x="382" y="742"/>
                    </a:lnTo>
                    <a:lnTo>
                      <a:pt x="382" y="743"/>
                    </a:lnTo>
                    <a:lnTo>
                      <a:pt x="383" y="743"/>
                    </a:lnTo>
                    <a:lnTo>
                      <a:pt x="383" y="743"/>
                    </a:lnTo>
                    <a:lnTo>
                      <a:pt x="384" y="743"/>
                    </a:lnTo>
                    <a:lnTo>
                      <a:pt x="384" y="742"/>
                    </a:lnTo>
                    <a:lnTo>
                      <a:pt x="385" y="731"/>
                    </a:lnTo>
                    <a:lnTo>
                      <a:pt x="385" y="743"/>
                    </a:lnTo>
                    <a:lnTo>
                      <a:pt x="386" y="743"/>
                    </a:lnTo>
                    <a:lnTo>
                      <a:pt x="386" y="742"/>
                    </a:lnTo>
                    <a:lnTo>
                      <a:pt x="387" y="743"/>
                    </a:lnTo>
                    <a:lnTo>
                      <a:pt x="387" y="743"/>
                    </a:lnTo>
                    <a:lnTo>
                      <a:pt x="388" y="743"/>
                    </a:lnTo>
                    <a:lnTo>
                      <a:pt x="388" y="743"/>
                    </a:lnTo>
                    <a:lnTo>
                      <a:pt x="389" y="743"/>
                    </a:lnTo>
                    <a:lnTo>
                      <a:pt x="389" y="743"/>
                    </a:lnTo>
                    <a:lnTo>
                      <a:pt x="390" y="743"/>
                    </a:lnTo>
                    <a:lnTo>
                      <a:pt x="390" y="743"/>
                    </a:lnTo>
                    <a:lnTo>
                      <a:pt x="391" y="742"/>
                    </a:lnTo>
                    <a:lnTo>
                      <a:pt x="391" y="743"/>
                    </a:lnTo>
                    <a:lnTo>
                      <a:pt x="392" y="743"/>
                    </a:lnTo>
                    <a:lnTo>
                      <a:pt x="392" y="743"/>
                    </a:lnTo>
                    <a:lnTo>
                      <a:pt x="393" y="743"/>
                    </a:lnTo>
                    <a:lnTo>
                      <a:pt x="393" y="743"/>
                    </a:lnTo>
                    <a:lnTo>
                      <a:pt x="394" y="743"/>
                    </a:lnTo>
                    <a:lnTo>
                      <a:pt x="394" y="739"/>
                    </a:lnTo>
                    <a:lnTo>
                      <a:pt x="395" y="743"/>
                    </a:lnTo>
                    <a:lnTo>
                      <a:pt x="395" y="743"/>
                    </a:lnTo>
                    <a:lnTo>
                      <a:pt x="396" y="743"/>
                    </a:lnTo>
                    <a:lnTo>
                      <a:pt x="396" y="743"/>
                    </a:lnTo>
                    <a:lnTo>
                      <a:pt x="397" y="743"/>
                    </a:lnTo>
                    <a:lnTo>
                      <a:pt x="397" y="743"/>
                    </a:lnTo>
                    <a:lnTo>
                      <a:pt x="398" y="743"/>
                    </a:lnTo>
                    <a:lnTo>
                      <a:pt x="398" y="708"/>
                    </a:lnTo>
                    <a:lnTo>
                      <a:pt x="399" y="743"/>
                    </a:lnTo>
                    <a:lnTo>
                      <a:pt x="399" y="743"/>
                    </a:lnTo>
                    <a:lnTo>
                      <a:pt x="400" y="743"/>
                    </a:lnTo>
                    <a:lnTo>
                      <a:pt x="400" y="742"/>
                    </a:lnTo>
                    <a:lnTo>
                      <a:pt x="401" y="743"/>
                    </a:lnTo>
                    <a:lnTo>
                      <a:pt x="401" y="743"/>
                    </a:lnTo>
                    <a:lnTo>
                      <a:pt x="402" y="743"/>
                    </a:lnTo>
                    <a:lnTo>
                      <a:pt x="402" y="740"/>
                    </a:lnTo>
                    <a:lnTo>
                      <a:pt x="403" y="743"/>
                    </a:lnTo>
                    <a:lnTo>
                      <a:pt x="403" y="743"/>
                    </a:lnTo>
                    <a:lnTo>
                      <a:pt x="404" y="743"/>
                    </a:lnTo>
                    <a:lnTo>
                      <a:pt x="404" y="743"/>
                    </a:lnTo>
                    <a:lnTo>
                      <a:pt x="405" y="743"/>
                    </a:lnTo>
                    <a:lnTo>
                      <a:pt x="405" y="743"/>
                    </a:lnTo>
                    <a:lnTo>
                      <a:pt x="406" y="743"/>
                    </a:lnTo>
                    <a:lnTo>
                      <a:pt x="406" y="743"/>
                    </a:lnTo>
                    <a:lnTo>
                      <a:pt x="407" y="743"/>
                    </a:lnTo>
                    <a:lnTo>
                      <a:pt x="407" y="743"/>
                    </a:lnTo>
                    <a:lnTo>
                      <a:pt x="408" y="743"/>
                    </a:lnTo>
                    <a:lnTo>
                      <a:pt x="408" y="739"/>
                    </a:lnTo>
                    <a:lnTo>
                      <a:pt x="409" y="743"/>
                    </a:lnTo>
                    <a:lnTo>
                      <a:pt x="409" y="743"/>
                    </a:lnTo>
                    <a:lnTo>
                      <a:pt x="410" y="741"/>
                    </a:lnTo>
                    <a:lnTo>
                      <a:pt x="410" y="743"/>
                    </a:lnTo>
                    <a:lnTo>
                      <a:pt x="411" y="743"/>
                    </a:lnTo>
                    <a:lnTo>
                      <a:pt x="411" y="743"/>
                    </a:lnTo>
                    <a:lnTo>
                      <a:pt x="412" y="743"/>
                    </a:lnTo>
                    <a:lnTo>
                      <a:pt x="412" y="597"/>
                    </a:lnTo>
                    <a:lnTo>
                      <a:pt x="413" y="743"/>
                    </a:lnTo>
                    <a:lnTo>
                      <a:pt x="413" y="743"/>
                    </a:lnTo>
                    <a:lnTo>
                      <a:pt x="414" y="731"/>
                    </a:lnTo>
                    <a:lnTo>
                      <a:pt x="414" y="743"/>
                    </a:lnTo>
                    <a:lnTo>
                      <a:pt x="415" y="743"/>
                    </a:lnTo>
                    <a:lnTo>
                      <a:pt x="415" y="743"/>
                    </a:lnTo>
                    <a:lnTo>
                      <a:pt x="416" y="743"/>
                    </a:lnTo>
                    <a:lnTo>
                      <a:pt x="416" y="741"/>
                    </a:lnTo>
                    <a:lnTo>
                      <a:pt x="417" y="743"/>
                    </a:lnTo>
                    <a:lnTo>
                      <a:pt x="417" y="743"/>
                    </a:lnTo>
                    <a:lnTo>
                      <a:pt x="418" y="742"/>
                    </a:lnTo>
                    <a:lnTo>
                      <a:pt x="418" y="743"/>
                    </a:lnTo>
                    <a:lnTo>
                      <a:pt x="419" y="743"/>
                    </a:lnTo>
                    <a:lnTo>
                      <a:pt x="419" y="743"/>
                    </a:lnTo>
                    <a:lnTo>
                      <a:pt x="420" y="742"/>
                    </a:lnTo>
                    <a:lnTo>
                      <a:pt x="420" y="743"/>
                    </a:lnTo>
                    <a:lnTo>
                      <a:pt x="421" y="743"/>
                    </a:lnTo>
                    <a:lnTo>
                      <a:pt x="421" y="743"/>
                    </a:lnTo>
                    <a:lnTo>
                      <a:pt x="422" y="735"/>
                    </a:lnTo>
                    <a:lnTo>
                      <a:pt x="422" y="743"/>
                    </a:lnTo>
                    <a:lnTo>
                      <a:pt x="423" y="743"/>
                    </a:lnTo>
                    <a:lnTo>
                      <a:pt x="423" y="743"/>
                    </a:lnTo>
                    <a:lnTo>
                      <a:pt x="424" y="743"/>
                    </a:lnTo>
                    <a:lnTo>
                      <a:pt x="424" y="743"/>
                    </a:lnTo>
                    <a:lnTo>
                      <a:pt x="425" y="743"/>
                    </a:lnTo>
                    <a:lnTo>
                      <a:pt x="425" y="743"/>
                    </a:lnTo>
                    <a:lnTo>
                      <a:pt x="426" y="742"/>
                    </a:lnTo>
                    <a:lnTo>
                      <a:pt x="426" y="743"/>
                    </a:lnTo>
                    <a:lnTo>
                      <a:pt x="427" y="743"/>
                    </a:lnTo>
                    <a:lnTo>
                      <a:pt x="427" y="743"/>
                    </a:lnTo>
                    <a:lnTo>
                      <a:pt x="428" y="743"/>
                    </a:lnTo>
                    <a:lnTo>
                      <a:pt x="428" y="743"/>
                    </a:lnTo>
                    <a:lnTo>
                      <a:pt x="429" y="743"/>
                    </a:lnTo>
                    <a:lnTo>
                      <a:pt x="429" y="743"/>
                    </a:lnTo>
                    <a:lnTo>
                      <a:pt x="430" y="743"/>
                    </a:lnTo>
                    <a:lnTo>
                      <a:pt x="430" y="743"/>
                    </a:lnTo>
                    <a:lnTo>
                      <a:pt x="431" y="743"/>
                    </a:lnTo>
                    <a:lnTo>
                      <a:pt x="431" y="743"/>
                    </a:lnTo>
                    <a:lnTo>
                      <a:pt x="432" y="743"/>
                    </a:lnTo>
                    <a:lnTo>
                      <a:pt x="432" y="743"/>
                    </a:lnTo>
                    <a:lnTo>
                      <a:pt x="433" y="743"/>
                    </a:lnTo>
                    <a:lnTo>
                      <a:pt x="433" y="743"/>
                    </a:lnTo>
                    <a:lnTo>
                      <a:pt x="434" y="743"/>
                    </a:lnTo>
                    <a:lnTo>
                      <a:pt x="434" y="743"/>
                    </a:lnTo>
                    <a:lnTo>
                      <a:pt x="435" y="743"/>
                    </a:lnTo>
                    <a:lnTo>
                      <a:pt x="435" y="743"/>
                    </a:lnTo>
                    <a:lnTo>
                      <a:pt x="436" y="743"/>
                    </a:lnTo>
                    <a:lnTo>
                      <a:pt x="436" y="743"/>
                    </a:lnTo>
                    <a:lnTo>
                      <a:pt x="437" y="743"/>
                    </a:lnTo>
                    <a:lnTo>
                      <a:pt x="437" y="743"/>
                    </a:lnTo>
                    <a:lnTo>
                      <a:pt x="438" y="743"/>
                    </a:lnTo>
                    <a:lnTo>
                      <a:pt x="438" y="743"/>
                    </a:lnTo>
                    <a:lnTo>
                      <a:pt x="439" y="743"/>
                    </a:lnTo>
                    <a:lnTo>
                      <a:pt x="439" y="743"/>
                    </a:lnTo>
                    <a:lnTo>
                      <a:pt x="440" y="743"/>
                    </a:lnTo>
                    <a:lnTo>
                      <a:pt x="440" y="743"/>
                    </a:lnTo>
                    <a:lnTo>
                      <a:pt x="441" y="743"/>
                    </a:lnTo>
                    <a:lnTo>
                      <a:pt x="441" y="743"/>
                    </a:lnTo>
                    <a:lnTo>
                      <a:pt x="442" y="740"/>
                    </a:lnTo>
                    <a:lnTo>
                      <a:pt x="442" y="743"/>
                    </a:lnTo>
                    <a:lnTo>
                      <a:pt x="443" y="743"/>
                    </a:lnTo>
                    <a:lnTo>
                      <a:pt x="443" y="743"/>
                    </a:lnTo>
                    <a:lnTo>
                      <a:pt x="444" y="743"/>
                    </a:lnTo>
                    <a:lnTo>
                      <a:pt x="444" y="743"/>
                    </a:lnTo>
                    <a:lnTo>
                      <a:pt x="445" y="743"/>
                    </a:lnTo>
                    <a:lnTo>
                      <a:pt x="445" y="742"/>
                    </a:lnTo>
                    <a:lnTo>
                      <a:pt x="446" y="743"/>
                    </a:lnTo>
                    <a:lnTo>
                      <a:pt x="446" y="743"/>
                    </a:lnTo>
                    <a:lnTo>
                      <a:pt x="447" y="743"/>
                    </a:lnTo>
                    <a:lnTo>
                      <a:pt x="447" y="743"/>
                    </a:lnTo>
                    <a:lnTo>
                      <a:pt x="448" y="743"/>
                    </a:lnTo>
                    <a:lnTo>
                      <a:pt x="448" y="743"/>
                    </a:lnTo>
                    <a:lnTo>
                      <a:pt x="449" y="743"/>
                    </a:lnTo>
                    <a:lnTo>
                      <a:pt x="449" y="743"/>
                    </a:lnTo>
                    <a:lnTo>
                      <a:pt x="450" y="742"/>
                    </a:lnTo>
                    <a:lnTo>
                      <a:pt x="450" y="743"/>
                    </a:lnTo>
                    <a:lnTo>
                      <a:pt x="451" y="743"/>
                    </a:lnTo>
                    <a:lnTo>
                      <a:pt x="451" y="743"/>
                    </a:lnTo>
                    <a:lnTo>
                      <a:pt x="452" y="743"/>
                    </a:lnTo>
                    <a:lnTo>
                      <a:pt x="452" y="743"/>
                    </a:lnTo>
                    <a:lnTo>
                      <a:pt x="453" y="743"/>
                    </a:lnTo>
                    <a:lnTo>
                      <a:pt x="453" y="743"/>
                    </a:lnTo>
                    <a:lnTo>
                      <a:pt x="454" y="743"/>
                    </a:lnTo>
                    <a:lnTo>
                      <a:pt x="454" y="741"/>
                    </a:lnTo>
                    <a:lnTo>
                      <a:pt x="455" y="743"/>
                    </a:lnTo>
                    <a:lnTo>
                      <a:pt x="455" y="743"/>
                    </a:lnTo>
                    <a:lnTo>
                      <a:pt x="456" y="723"/>
                    </a:lnTo>
                    <a:lnTo>
                      <a:pt x="456" y="743"/>
                    </a:lnTo>
                    <a:lnTo>
                      <a:pt x="457" y="743"/>
                    </a:lnTo>
                    <a:lnTo>
                      <a:pt x="457" y="743"/>
                    </a:lnTo>
                    <a:lnTo>
                      <a:pt x="458" y="742"/>
                    </a:lnTo>
                    <a:lnTo>
                      <a:pt x="458" y="743"/>
                    </a:lnTo>
                    <a:lnTo>
                      <a:pt x="459" y="743"/>
                    </a:lnTo>
                    <a:lnTo>
                      <a:pt x="459" y="743"/>
                    </a:lnTo>
                    <a:lnTo>
                      <a:pt x="460" y="741"/>
                    </a:lnTo>
                    <a:lnTo>
                      <a:pt x="460" y="743"/>
                    </a:lnTo>
                    <a:lnTo>
                      <a:pt x="461" y="743"/>
                    </a:lnTo>
                    <a:lnTo>
                      <a:pt x="461" y="743"/>
                    </a:lnTo>
                    <a:lnTo>
                      <a:pt x="462" y="743"/>
                    </a:lnTo>
                    <a:lnTo>
                      <a:pt x="462" y="743"/>
                    </a:lnTo>
                    <a:lnTo>
                      <a:pt x="463" y="743"/>
                    </a:lnTo>
                    <a:lnTo>
                      <a:pt x="463" y="743"/>
                    </a:lnTo>
                    <a:lnTo>
                      <a:pt x="464" y="742"/>
                    </a:lnTo>
                    <a:lnTo>
                      <a:pt x="464" y="743"/>
                    </a:lnTo>
                    <a:lnTo>
                      <a:pt x="465" y="743"/>
                    </a:lnTo>
                    <a:lnTo>
                      <a:pt x="465" y="743"/>
                    </a:lnTo>
                    <a:lnTo>
                      <a:pt x="466" y="741"/>
                    </a:lnTo>
                    <a:lnTo>
                      <a:pt x="466" y="743"/>
                    </a:lnTo>
                    <a:lnTo>
                      <a:pt x="467" y="743"/>
                    </a:lnTo>
                    <a:lnTo>
                      <a:pt x="467" y="743"/>
                    </a:lnTo>
                    <a:lnTo>
                      <a:pt x="468" y="743"/>
                    </a:lnTo>
                    <a:lnTo>
                      <a:pt x="468" y="743"/>
                    </a:lnTo>
                    <a:lnTo>
                      <a:pt x="469" y="743"/>
                    </a:lnTo>
                    <a:lnTo>
                      <a:pt x="469" y="743"/>
                    </a:lnTo>
                    <a:lnTo>
                      <a:pt x="470" y="743"/>
                    </a:lnTo>
                    <a:lnTo>
                      <a:pt x="470" y="743"/>
                    </a:lnTo>
                    <a:lnTo>
                      <a:pt x="471" y="743"/>
                    </a:lnTo>
                    <a:lnTo>
                      <a:pt x="471" y="743"/>
                    </a:lnTo>
                    <a:lnTo>
                      <a:pt x="472" y="743"/>
                    </a:lnTo>
                    <a:lnTo>
                      <a:pt x="472" y="743"/>
                    </a:lnTo>
                    <a:lnTo>
                      <a:pt x="473" y="743"/>
                    </a:lnTo>
                    <a:lnTo>
                      <a:pt x="473" y="743"/>
                    </a:lnTo>
                    <a:lnTo>
                      <a:pt x="474" y="743"/>
                    </a:lnTo>
                    <a:lnTo>
                      <a:pt x="474" y="743"/>
                    </a:lnTo>
                    <a:lnTo>
                      <a:pt x="475" y="743"/>
                    </a:lnTo>
                    <a:lnTo>
                      <a:pt x="475" y="743"/>
                    </a:lnTo>
                    <a:lnTo>
                      <a:pt x="476" y="743"/>
                    </a:lnTo>
                    <a:lnTo>
                      <a:pt x="476" y="743"/>
                    </a:lnTo>
                    <a:lnTo>
                      <a:pt x="477" y="743"/>
                    </a:lnTo>
                    <a:lnTo>
                      <a:pt x="477" y="727"/>
                    </a:lnTo>
                    <a:lnTo>
                      <a:pt x="478" y="743"/>
                    </a:lnTo>
                    <a:lnTo>
                      <a:pt x="478" y="743"/>
                    </a:lnTo>
                    <a:lnTo>
                      <a:pt x="479" y="743"/>
                    </a:lnTo>
                    <a:lnTo>
                      <a:pt x="479" y="738"/>
                    </a:lnTo>
                    <a:lnTo>
                      <a:pt x="480" y="742"/>
                    </a:lnTo>
                    <a:lnTo>
                      <a:pt x="480" y="743"/>
                    </a:lnTo>
                    <a:lnTo>
                      <a:pt x="481" y="743"/>
                    </a:lnTo>
                    <a:lnTo>
                      <a:pt x="481" y="739"/>
                    </a:lnTo>
                    <a:lnTo>
                      <a:pt x="482" y="743"/>
                    </a:lnTo>
                    <a:lnTo>
                      <a:pt x="482" y="743"/>
                    </a:lnTo>
                    <a:lnTo>
                      <a:pt x="483" y="743"/>
                    </a:lnTo>
                    <a:lnTo>
                      <a:pt x="483" y="742"/>
                    </a:lnTo>
                    <a:lnTo>
                      <a:pt x="484" y="743"/>
                    </a:lnTo>
                    <a:lnTo>
                      <a:pt x="484" y="743"/>
                    </a:lnTo>
                    <a:lnTo>
                      <a:pt x="485" y="743"/>
                    </a:lnTo>
                    <a:lnTo>
                      <a:pt x="485" y="647"/>
                    </a:lnTo>
                    <a:lnTo>
                      <a:pt x="486" y="743"/>
                    </a:lnTo>
                    <a:lnTo>
                      <a:pt x="486" y="743"/>
                    </a:lnTo>
                    <a:lnTo>
                      <a:pt x="487" y="743"/>
                    </a:lnTo>
                    <a:lnTo>
                      <a:pt x="487" y="735"/>
                    </a:lnTo>
                    <a:lnTo>
                      <a:pt x="488" y="743"/>
                    </a:lnTo>
                    <a:lnTo>
                      <a:pt x="488" y="743"/>
                    </a:lnTo>
                    <a:lnTo>
                      <a:pt x="489" y="742"/>
                    </a:lnTo>
                    <a:lnTo>
                      <a:pt x="489" y="743"/>
                    </a:lnTo>
                    <a:lnTo>
                      <a:pt x="490" y="742"/>
                    </a:lnTo>
                    <a:lnTo>
                      <a:pt x="490" y="743"/>
                    </a:lnTo>
                    <a:lnTo>
                      <a:pt x="491" y="743"/>
                    </a:lnTo>
                    <a:lnTo>
                      <a:pt x="491" y="737"/>
                    </a:lnTo>
                    <a:lnTo>
                      <a:pt x="492" y="742"/>
                    </a:lnTo>
                    <a:lnTo>
                      <a:pt x="492" y="743"/>
                    </a:lnTo>
                    <a:lnTo>
                      <a:pt x="493" y="743"/>
                    </a:lnTo>
                    <a:lnTo>
                      <a:pt x="493" y="743"/>
                    </a:lnTo>
                    <a:lnTo>
                      <a:pt x="494" y="743"/>
                    </a:lnTo>
                    <a:lnTo>
                      <a:pt x="494" y="743"/>
                    </a:lnTo>
                    <a:lnTo>
                      <a:pt x="495" y="743"/>
                    </a:lnTo>
                    <a:lnTo>
                      <a:pt x="495" y="743"/>
                    </a:lnTo>
                    <a:lnTo>
                      <a:pt x="496" y="740"/>
                    </a:lnTo>
                    <a:lnTo>
                      <a:pt x="496" y="743"/>
                    </a:lnTo>
                    <a:lnTo>
                      <a:pt x="497" y="743"/>
                    </a:lnTo>
                    <a:lnTo>
                      <a:pt x="497" y="743"/>
                    </a:lnTo>
                    <a:lnTo>
                      <a:pt x="498" y="743"/>
                    </a:lnTo>
                    <a:lnTo>
                      <a:pt x="498" y="743"/>
                    </a:lnTo>
                    <a:lnTo>
                      <a:pt x="499" y="743"/>
                    </a:lnTo>
                    <a:lnTo>
                      <a:pt x="499" y="743"/>
                    </a:lnTo>
                    <a:lnTo>
                      <a:pt x="500" y="743"/>
                    </a:lnTo>
                    <a:lnTo>
                      <a:pt x="500" y="743"/>
                    </a:lnTo>
                    <a:lnTo>
                      <a:pt x="501" y="743"/>
                    </a:lnTo>
                    <a:lnTo>
                      <a:pt x="501" y="743"/>
                    </a:lnTo>
                    <a:lnTo>
                      <a:pt x="502" y="743"/>
                    </a:lnTo>
                    <a:lnTo>
                      <a:pt x="502" y="743"/>
                    </a:lnTo>
                    <a:lnTo>
                      <a:pt x="503" y="743"/>
                    </a:lnTo>
                    <a:lnTo>
                      <a:pt x="503" y="743"/>
                    </a:lnTo>
                    <a:lnTo>
                      <a:pt x="504" y="743"/>
                    </a:lnTo>
                    <a:lnTo>
                      <a:pt x="504" y="743"/>
                    </a:lnTo>
                    <a:lnTo>
                      <a:pt x="505" y="743"/>
                    </a:lnTo>
                    <a:lnTo>
                      <a:pt x="505" y="742"/>
                    </a:lnTo>
                    <a:lnTo>
                      <a:pt x="506" y="743"/>
                    </a:lnTo>
                    <a:lnTo>
                      <a:pt x="506" y="743"/>
                    </a:lnTo>
                    <a:lnTo>
                      <a:pt x="507" y="743"/>
                    </a:lnTo>
                    <a:lnTo>
                      <a:pt x="507" y="743"/>
                    </a:lnTo>
                    <a:lnTo>
                      <a:pt x="508" y="743"/>
                    </a:lnTo>
                    <a:lnTo>
                      <a:pt x="508" y="743"/>
                    </a:lnTo>
                    <a:lnTo>
                      <a:pt x="509" y="743"/>
                    </a:lnTo>
                    <a:lnTo>
                      <a:pt x="509" y="743"/>
                    </a:lnTo>
                    <a:lnTo>
                      <a:pt x="510" y="743"/>
                    </a:lnTo>
                    <a:lnTo>
                      <a:pt x="510" y="743"/>
                    </a:lnTo>
                    <a:lnTo>
                      <a:pt x="511" y="743"/>
                    </a:lnTo>
                    <a:lnTo>
                      <a:pt x="511" y="743"/>
                    </a:lnTo>
                    <a:lnTo>
                      <a:pt x="512" y="743"/>
                    </a:lnTo>
                    <a:lnTo>
                      <a:pt x="512" y="743"/>
                    </a:lnTo>
                    <a:lnTo>
                      <a:pt x="513" y="737"/>
                    </a:lnTo>
                    <a:lnTo>
                      <a:pt x="513" y="743"/>
                    </a:lnTo>
                    <a:lnTo>
                      <a:pt x="514" y="743"/>
                    </a:lnTo>
                    <a:lnTo>
                      <a:pt x="514" y="743"/>
                    </a:lnTo>
                    <a:lnTo>
                      <a:pt x="515" y="743"/>
                    </a:lnTo>
                    <a:lnTo>
                      <a:pt x="515" y="743"/>
                    </a:lnTo>
                    <a:lnTo>
                      <a:pt x="516" y="743"/>
                    </a:lnTo>
                    <a:lnTo>
                      <a:pt x="516" y="743"/>
                    </a:lnTo>
                    <a:lnTo>
                      <a:pt x="517" y="743"/>
                    </a:lnTo>
                    <a:lnTo>
                      <a:pt x="517" y="743"/>
                    </a:lnTo>
                    <a:lnTo>
                      <a:pt x="518" y="743"/>
                    </a:lnTo>
                    <a:lnTo>
                      <a:pt x="518" y="743"/>
                    </a:lnTo>
                    <a:lnTo>
                      <a:pt x="519" y="743"/>
                    </a:lnTo>
                    <a:lnTo>
                      <a:pt x="519" y="743"/>
                    </a:lnTo>
                    <a:lnTo>
                      <a:pt x="520" y="743"/>
                    </a:lnTo>
                    <a:lnTo>
                      <a:pt x="520" y="743"/>
                    </a:lnTo>
                    <a:lnTo>
                      <a:pt x="521" y="743"/>
                    </a:lnTo>
                    <a:lnTo>
                      <a:pt x="521" y="743"/>
                    </a:lnTo>
                    <a:lnTo>
                      <a:pt x="522" y="743"/>
                    </a:lnTo>
                    <a:lnTo>
                      <a:pt x="522" y="743"/>
                    </a:lnTo>
                    <a:lnTo>
                      <a:pt x="523" y="743"/>
                    </a:lnTo>
                    <a:lnTo>
                      <a:pt x="523" y="743"/>
                    </a:lnTo>
                    <a:lnTo>
                      <a:pt x="524" y="743"/>
                    </a:lnTo>
                    <a:lnTo>
                      <a:pt x="524" y="743"/>
                    </a:lnTo>
                    <a:lnTo>
                      <a:pt x="525" y="743"/>
                    </a:lnTo>
                    <a:lnTo>
                      <a:pt x="525" y="743"/>
                    </a:lnTo>
                    <a:lnTo>
                      <a:pt x="526" y="743"/>
                    </a:lnTo>
                    <a:lnTo>
                      <a:pt x="526" y="743"/>
                    </a:lnTo>
                    <a:lnTo>
                      <a:pt x="527" y="743"/>
                    </a:lnTo>
                    <a:lnTo>
                      <a:pt x="527" y="743"/>
                    </a:lnTo>
                    <a:lnTo>
                      <a:pt x="528" y="743"/>
                    </a:lnTo>
                    <a:lnTo>
                      <a:pt x="528" y="743"/>
                    </a:lnTo>
                    <a:lnTo>
                      <a:pt x="529" y="742"/>
                    </a:lnTo>
                    <a:lnTo>
                      <a:pt x="529" y="743"/>
                    </a:lnTo>
                    <a:lnTo>
                      <a:pt x="530" y="743"/>
                    </a:lnTo>
                    <a:lnTo>
                      <a:pt x="530" y="743"/>
                    </a:lnTo>
                    <a:lnTo>
                      <a:pt x="531" y="743"/>
                    </a:lnTo>
                    <a:lnTo>
                      <a:pt x="531" y="743"/>
                    </a:lnTo>
                    <a:lnTo>
                      <a:pt x="532" y="743"/>
                    </a:lnTo>
                    <a:lnTo>
                      <a:pt x="532" y="743"/>
                    </a:lnTo>
                    <a:lnTo>
                      <a:pt x="533" y="740"/>
                    </a:lnTo>
                    <a:lnTo>
                      <a:pt x="533" y="743"/>
                    </a:lnTo>
                    <a:lnTo>
                      <a:pt x="534" y="743"/>
                    </a:lnTo>
                    <a:lnTo>
                      <a:pt x="534" y="743"/>
                    </a:lnTo>
                    <a:lnTo>
                      <a:pt x="535" y="742"/>
                    </a:lnTo>
                    <a:lnTo>
                      <a:pt x="535" y="743"/>
                    </a:lnTo>
                    <a:lnTo>
                      <a:pt x="536" y="743"/>
                    </a:lnTo>
                    <a:lnTo>
                      <a:pt x="536" y="743"/>
                    </a:lnTo>
                    <a:lnTo>
                      <a:pt x="537" y="743"/>
                    </a:lnTo>
                    <a:lnTo>
                      <a:pt x="537" y="743"/>
                    </a:lnTo>
                    <a:lnTo>
                      <a:pt x="538" y="743"/>
                    </a:lnTo>
                    <a:lnTo>
                      <a:pt x="538" y="743"/>
                    </a:lnTo>
                    <a:lnTo>
                      <a:pt x="539" y="743"/>
                    </a:lnTo>
                    <a:lnTo>
                      <a:pt x="539" y="743"/>
                    </a:lnTo>
                    <a:lnTo>
                      <a:pt x="540" y="743"/>
                    </a:lnTo>
                    <a:lnTo>
                      <a:pt x="540" y="743"/>
                    </a:lnTo>
                    <a:lnTo>
                      <a:pt x="541" y="743"/>
                    </a:lnTo>
                    <a:lnTo>
                      <a:pt x="541" y="743"/>
                    </a:lnTo>
                    <a:lnTo>
                      <a:pt x="542" y="743"/>
                    </a:lnTo>
                    <a:lnTo>
                      <a:pt x="542" y="743"/>
                    </a:lnTo>
                    <a:lnTo>
                      <a:pt x="543" y="743"/>
                    </a:lnTo>
                    <a:lnTo>
                      <a:pt x="543" y="743"/>
                    </a:lnTo>
                    <a:lnTo>
                      <a:pt x="544" y="743"/>
                    </a:lnTo>
                    <a:lnTo>
                      <a:pt x="544" y="743"/>
                    </a:lnTo>
                    <a:lnTo>
                      <a:pt x="545" y="743"/>
                    </a:lnTo>
                    <a:lnTo>
                      <a:pt x="545" y="743"/>
                    </a:lnTo>
                    <a:lnTo>
                      <a:pt x="546" y="743"/>
                    </a:lnTo>
                    <a:lnTo>
                      <a:pt x="546" y="741"/>
                    </a:lnTo>
                    <a:lnTo>
                      <a:pt x="547" y="742"/>
                    </a:lnTo>
                    <a:lnTo>
                      <a:pt x="547" y="743"/>
                    </a:lnTo>
                    <a:lnTo>
                      <a:pt x="548" y="743"/>
                    </a:lnTo>
                    <a:lnTo>
                      <a:pt x="548" y="743"/>
                    </a:lnTo>
                    <a:lnTo>
                      <a:pt x="549" y="743"/>
                    </a:lnTo>
                    <a:lnTo>
                      <a:pt x="549" y="743"/>
                    </a:lnTo>
                    <a:lnTo>
                      <a:pt x="550" y="743"/>
                    </a:lnTo>
                    <a:lnTo>
                      <a:pt x="550" y="743"/>
                    </a:lnTo>
                    <a:lnTo>
                      <a:pt x="551" y="741"/>
                    </a:lnTo>
                    <a:lnTo>
                      <a:pt x="551" y="743"/>
                    </a:lnTo>
                    <a:lnTo>
                      <a:pt x="552" y="743"/>
                    </a:lnTo>
                    <a:lnTo>
                      <a:pt x="552" y="743"/>
                    </a:lnTo>
                    <a:lnTo>
                      <a:pt x="553" y="743"/>
                    </a:lnTo>
                    <a:lnTo>
                      <a:pt x="553" y="743"/>
                    </a:lnTo>
                    <a:lnTo>
                      <a:pt x="554" y="743"/>
                    </a:lnTo>
                    <a:lnTo>
                      <a:pt x="554" y="743"/>
                    </a:lnTo>
                    <a:lnTo>
                      <a:pt x="555" y="743"/>
                    </a:lnTo>
                    <a:lnTo>
                      <a:pt x="555" y="743"/>
                    </a:lnTo>
                    <a:lnTo>
                      <a:pt x="556" y="743"/>
                    </a:lnTo>
                    <a:lnTo>
                      <a:pt x="556" y="743"/>
                    </a:lnTo>
                    <a:lnTo>
                      <a:pt x="557" y="742"/>
                    </a:lnTo>
                    <a:lnTo>
                      <a:pt x="557" y="743"/>
                    </a:lnTo>
                    <a:lnTo>
                      <a:pt x="558" y="743"/>
                    </a:lnTo>
                    <a:lnTo>
                      <a:pt x="558" y="743"/>
                    </a:lnTo>
                    <a:lnTo>
                      <a:pt x="559" y="743"/>
                    </a:lnTo>
                    <a:lnTo>
                      <a:pt x="559" y="743"/>
                    </a:lnTo>
                    <a:lnTo>
                      <a:pt x="560" y="743"/>
                    </a:lnTo>
                    <a:lnTo>
                      <a:pt x="560" y="743"/>
                    </a:lnTo>
                    <a:lnTo>
                      <a:pt x="561" y="743"/>
                    </a:lnTo>
                    <a:lnTo>
                      <a:pt x="561" y="743"/>
                    </a:lnTo>
                    <a:lnTo>
                      <a:pt x="562" y="743"/>
                    </a:lnTo>
                    <a:lnTo>
                      <a:pt x="562" y="743"/>
                    </a:lnTo>
                    <a:lnTo>
                      <a:pt x="563" y="743"/>
                    </a:lnTo>
                    <a:lnTo>
                      <a:pt x="563" y="743"/>
                    </a:lnTo>
                    <a:lnTo>
                      <a:pt x="564" y="743"/>
                    </a:lnTo>
                    <a:lnTo>
                      <a:pt x="564" y="743"/>
                    </a:lnTo>
                    <a:lnTo>
                      <a:pt x="565" y="743"/>
                    </a:lnTo>
                    <a:lnTo>
                      <a:pt x="565" y="743"/>
                    </a:lnTo>
                    <a:lnTo>
                      <a:pt x="566" y="743"/>
                    </a:lnTo>
                    <a:lnTo>
                      <a:pt x="566" y="743"/>
                    </a:lnTo>
                    <a:lnTo>
                      <a:pt x="567" y="719"/>
                    </a:lnTo>
                    <a:lnTo>
                      <a:pt x="567" y="743"/>
                    </a:lnTo>
                    <a:lnTo>
                      <a:pt x="568" y="743"/>
                    </a:lnTo>
                    <a:lnTo>
                      <a:pt x="568" y="743"/>
                    </a:lnTo>
                    <a:lnTo>
                      <a:pt x="569" y="739"/>
                    </a:lnTo>
                    <a:lnTo>
                      <a:pt x="569" y="743"/>
                    </a:lnTo>
                    <a:lnTo>
                      <a:pt x="570" y="743"/>
                    </a:lnTo>
                    <a:lnTo>
                      <a:pt x="570" y="743"/>
                    </a:lnTo>
                    <a:lnTo>
                      <a:pt x="571" y="743"/>
                    </a:lnTo>
                    <a:lnTo>
                      <a:pt x="571" y="743"/>
                    </a:lnTo>
                    <a:lnTo>
                      <a:pt x="572" y="743"/>
                    </a:lnTo>
                    <a:lnTo>
                      <a:pt x="572" y="743"/>
                    </a:lnTo>
                    <a:lnTo>
                      <a:pt x="573" y="743"/>
                    </a:lnTo>
                    <a:lnTo>
                      <a:pt x="573" y="743"/>
                    </a:lnTo>
                    <a:lnTo>
                      <a:pt x="574" y="743"/>
                    </a:lnTo>
                    <a:lnTo>
                      <a:pt x="574" y="743"/>
                    </a:lnTo>
                    <a:lnTo>
                      <a:pt x="575" y="743"/>
                    </a:lnTo>
                    <a:lnTo>
                      <a:pt x="575" y="743"/>
                    </a:lnTo>
                    <a:lnTo>
                      <a:pt x="576" y="743"/>
                    </a:lnTo>
                    <a:lnTo>
                      <a:pt x="576" y="743"/>
                    </a:lnTo>
                    <a:lnTo>
                      <a:pt x="577" y="739"/>
                    </a:lnTo>
                    <a:lnTo>
                      <a:pt x="577" y="743"/>
                    </a:lnTo>
                    <a:lnTo>
                      <a:pt x="578" y="743"/>
                    </a:lnTo>
                    <a:lnTo>
                      <a:pt x="578" y="743"/>
                    </a:lnTo>
                    <a:lnTo>
                      <a:pt x="579" y="743"/>
                    </a:lnTo>
                    <a:lnTo>
                      <a:pt x="579" y="743"/>
                    </a:lnTo>
                    <a:lnTo>
                      <a:pt x="580" y="743"/>
                    </a:lnTo>
                    <a:lnTo>
                      <a:pt x="580" y="743"/>
                    </a:lnTo>
                    <a:lnTo>
                      <a:pt x="581" y="743"/>
                    </a:lnTo>
                    <a:lnTo>
                      <a:pt x="581" y="743"/>
                    </a:lnTo>
                    <a:lnTo>
                      <a:pt x="582" y="743"/>
                    </a:lnTo>
                    <a:lnTo>
                      <a:pt x="582" y="742"/>
                    </a:lnTo>
                    <a:lnTo>
                      <a:pt x="583" y="741"/>
                    </a:lnTo>
                    <a:lnTo>
                      <a:pt x="583" y="743"/>
                    </a:lnTo>
                    <a:lnTo>
                      <a:pt x="584" y="743"/>
                    </a:lnTo>
                    <a:lnTo>
                      <a:pt x="584" y="743"/>
                    </a:lnTo>
                    <a:lnTo>
                      <a:pt x="585" y="743"/>
                    </a:lnTo>
                    <a:lnTo>
                      <a:pt x="585" y="743"/>
                    </a:lnTo>
                    <a:lnTo>
                      <a:pt x="586" y="743"/>
                    </a:lnTo>
                    <a:lnTo>
                      <a:pt x="586" y="742"/>
                    </a:lnTo>
                    <a:lnTo>
                      <a:pt x="587" y="743"/>
                    </a:lnTo>
                    <a:lnTo>
                      <a:pt x="587" y="743"/>
                    </a:lnTo>
                    <a:lnTo>
                      <a:pt x="588" y="743"/>
                    </a:lnTo>
                    <a:lnTo>
                      <a:pt x="588" y="743"/>
                    </a:lnTo>
                    <a:lnTo>
                      <a:pt x="589" y="743"/>
                    </a:lnTo>
                    <a:lnTo>
                      <a:pt x="589" y="743"/>
                    </a:lnTo>
                    <a:lnTo>
                      <a:pt x="590" y="743"/>
                    </a:lnTo>
                    <a:lnTo>
                      <a:pt x="590" y="743"/>
                    </a:lnTo>
                    <a:lnTo>
                      <a:pt x="591" y="743"/>
                    </a:lnTo>
                    <a:lnTo>
                      <a:pt x="591" y="743"/>
                    </a:lnTo>
                    <a:lnTo>
                      <a:pt x="592" y="743"/>
                    </a:lnTo>
                    <a:lnTo>
                      <a:pt x="592" y="743"/>
                    </a:lnTo>
                    <a:lnTo>
                      <a:pt x="593" y="743"/>
                    </a:lnTo>
                    <a:lnTo>
                      <a:pt x="593" y="743"/>
                    </a:lnTo>
                    <a:lnTo>
                      <a:pt x="594" y="743"/>
                    </a:lnTo>
                    <a:lnTo>
                      <a:pt x="594" y="743"/>
                    </a:lnTo>
                    <a:lnTo>
                      <a:pt x="595" y="743"/>
                    </a:lnTo>
                    <a:lnTo>
                      <a:pt x="595" y="741"/>
                    </a:lnTo>
                    <a:lnTo>
                      <a:pt x="596" y="743"/>
                    </a:lnTo>
                    <a:lnTo>
                      <a:pt x="596" y="743"/>
                    </a:lnTo>
                    <a:lnTo>
                      <a:pt x="597" y="743"/>
                    </a:lnTo>
                    <a:lnTo>
                      <a:pt x="597" y="743"/>
                    </a:lnTo>
                    <a:lnTo>
                      <a:pt x="598" y="743"/>
                    </a:lnTo>
                    <a:lnTo>
                      <a:pt x="598" y="743"/>
                    </a:lnTo>
                    <a:lnTo>
                      <a:pt x="599" y="743"/>
                    </a:lnTo>
                    <a:lnTo>
                      <a:pt x="599" y="743"/>
                    </a:lnTo>
                    <a:lnTo>
                      <a:pt x="600" y="743"/>
                    </a:lnTo>
                    <a:lnTo>
                      <a:pt x="600" y="743"/>
                    </a:lnTo>
                    <a:lnTo>
                      <a:pt x="601" y="743"/>
                    </a:lnTo>
                    <a:lnTo>
                      <a:pt x="601" y="743"/>
                    </a:lnTo>
                    <a:lnTo>
                      <a:pt x="602" y="743"/>
                    </a:lnTo>
                    <a:lnTo>
                      <a:pt x="602" y="743"/>
                    </a:lnTo>
                    <a:lnTo>
                      <a:pt x="603" y="743"/>
                    </a:lnTo>
                    <a:lnTo>
                      <a:pt x="603" y="743"/>
                    </a:lnTo>
                    <a:lnTo>
                      <a:pt x="604" y="743"/>
                    </a:lnTo>
                    <a:lnTo>
                      <a:pt x="604" y="743"/>
                    </a:lnTo>
                    <a:lnTo>
                      <a:pt x="605" y="743"/>
                    </a:lnTo>
                    <a:lnTo>
                      <a:pt x="605" y="743"/>
                    </a:lnTo>
                    <a:lnTo>
                      <a:pt x="606" y="743"/>
                    </a:lnTo>
                    <a:lnTo>
                      <a:pt x="606" y="743"/>
                    </a:lnTo>
                    <a:lnTo>
                      <a:pt x="607" y="743"/>
                    </a:lnTo>
                    <a:lnTo>
                      <a:pt x="607" y="743"/>
                    </a:lnTo>
                    <a:lnTo>
                      <a:pt x="608" y="743"/>
                    </a:lnTo>
                    <a:lnTo>
                      <a:pt x="608" y="741"/>
                    </a:lnTo>
                    <a:lnTo>
                      <a:pt x="609" y="743"/>
                    </a:lnTo>
                    <a:lnTo>
                      <a:pt x="609" y="743"/>
                    </a:lnTo>
                    <a:lnTo>
                      <a:pt x="610" y="743"/>
                    </a:lnTo>
                    <a:lnTo>
                      <a:pt x="610" y="743"/>
                    </a:lnTo>
                    <a:lnTo>
                      <a:pt x="611" y="743"/>
                    </a:lnTo>
                    <a:lnTo>
                      <a:pt x="611" y="743"/>
                    </a:lnTo>
                    <a:lnTo>
                      <a:pt x="612" y="743"/>
                    </a:lnTo>
                    <a:lnTo>
                      <a:pt x="612" y="743"/>
                    </a:lnTo>
                    <a:lnTo>
                      <a:pt x="613" y="743"/>
                    </a:lnTo>
                    <a:lnTo>
                      <a:pt x="613" y="743"/>
                    </a:lnTo>
                    <a:lnTo>
                      <a:pt x="614" y="743"/>
                    </a:lnTo>
                    <a:lnTo>
                      <a:pt x="614" y="743"/>
                    </a:lnTo>
                    <a:lnTo>
                      <a:pt x="615" y="743"/>
                    </a:lnTo>
                    <a:lnTo>
                      <a:pt x="615" y="743"/>
                    </a:lnTo>
                    <a:lnTo>
                      <a:pt x="616" y="743"/>
                    </a:lnTo>
                    <a:lnTo>
                      <a:pt x="616" y="743"/>
                    </a:lnTo>
                    <a:lnTo>
                      <a:pt x="617" y="743"/>
                    </a:lnTo>
                    <a:lnTo>
                      <a:pt x="617" y="743"/>
                    </a:lnTo>
                    <a:lnTo>
                      <a:pt x="618" y="742"/>
                    </a:lnTo>
                    <a:lnTo>
                      <a:pt x="618" y="743"/>
                    </a:lnTo>
                    <a:lnTo>
                      <a:pt x="619" y="743"/>
                    </a:lnTo>
                    <a:lnTo>
                      <a:pt x="619" y="743"/>
                    </a:lnTo>
                    <a:lnTo>
                      <a:pt x="620" y="647"/>
                    </a:lnTo>
                    <a:lnTo>
                      <a:pt x="620" y="743"/>
                    </a:lnTo>
                    <a:lnTo>
                      <a:pt x="621" y="743"/>
                    </a:lnTo>
                    <a:lnTo>
                      <a:pt x="621" y="743"/>
                    </a:lnTo>
                    <a:lnTo>
                      <a:pt x="622" y="743"/>
                    </a:lnTo>
                    <a:lnTo>
                      <a:pt x="622" y="729"/>
                    </a:lnTo>
                    <a:lnTo>
                      <a:pt x="623" y="743"/>
                    </a:lnTo>
                    <a:lnTo>
                      <a:pt x="623" y="743"/>
                    </a:lnTo>
                    <a:lnTo>
                      <a:pt x="624" y="741"/>
                    </a:lnTo>
                    <a:lnTo>
                      <a:pt x="624" y="743"/>
                    </a:lnTo>
                    <a:lnTo>
                      <a:pt x="625" y="743"/>
                    </a:lnTo>
                    <a:lnTo>
                      <a:pt x="625" y="743"/>
                    </a:lnTo>
                    <a:lnTo>
                      <a:pt x="626" y="741"/>
                    </a:lnTo>
                    <a:lnTo>
                      <a:pt x="626" y="743"/>
                    </a:lnTo>
                    <a:lnTo>
                      <a:pt x="627" y="743"/>
                    </a:lnTo>
                    <a:lnTo>
                      <a:pt x="627" y="743"/>
                    </a:lnTo>
                    <a:lnTo>
                      <a:pt x="628" y="743"/>
                    </a:lnTo>
                    <a:lnTo>
                      <a:pt x="628" y="743"/>
                    </a:lnTo>
                    <a:lnTo>
                      <a:pt x="629" y="743"/>
                    </a:lnTo>
                    <a:lnTo>
                      <a:pt x="629" y="743"/>
                    </a:lnTo>
                    <a:lnTo>
                      <a:pt x="630" y="743"/>
                    </a:lnTo>
                    <a:lnTo>
                      <a:pt x="630" y="743"/>
                    </a:lnTo>
                    <a:lnTo>
                      <a:pt x="631" y="743"/>
                    </a:lnTo>
                    <a:lnTo>
                      <a:pt x="631" y="743"/>
                    </a:lnTo>
                    <a:lnTo>
                      <a:pt x="632" y="741"/>
                    </a:lnTo>
                    <a:lnTo>
                      <a:pt x="632" y="743"/>
                    </a:lnTo>
                    <a:lnTo>
                      <a:pt x="633" y="743"/>
                    </a:lnTo>
                    <a:lnTo>
                      <a:pt x="633" y="743"/>
                    </a:lnTo>
                    <a:lnTo>
                      <a:pt x="634" y="743"/>
                    </a:lnTo>
                    <a:lnTo>
                      <a:pt x="634" y="743"/>
                    </a:lnTo>
                    <a:lnTo>
                      <a:pt x="635" y="743"/>
                    </a:lnTo>
                    <a:lnTo>
                      <a:pt x="635" y="743"/>
                    </a:lnTo>
                    <a:lnTo>
                      <a:pt x="636" y="743"/>
                    </a:lnTo>
                    <a:lnTo>
                      <a:pt x="636" y="743"/>
                    </a:lnTo>
                    <a:lnTo>
                      <a:pt x="637" y="743"/>
                    </a:lnTo>
                    <a:lnTo>
                      <a:pt x="637" y="743"/>
                    </a:lnTo>
                    <a:lnTo>
                      <a:pt x="638" y="742"/>
                    </a:lnTo>
                    <a:lnTo>
                      <a:pt x="638" y="743"/>
                    </a:lnTo>
                    <a:lnTo>
                      <a:pt x="639" y="743"/>
                    </a:lnTo>
                    <a:lnTo>
                      <a:pt x="639" y="743"/>
                    </a:lnTo>
                    <a:lnTo>
                      <a:pt x="640" y="743"/>
                    </a:lnTo>
                    <a:lnTo>
                      <a:pt x="640" y="743"/>
                    </a:lnTo>
                    <a:lnTo>
                      <a:pt x="641" y="743"/>
                    </a:lnTo>
                    <a:lnTo>
                      <a:pt x="641" y="743"/>
                    </a:lnTo>
                    <a:lnTo>
                      <a:pt x="642" y="743"/>
                    </a:lnTo>
                    <a:lnTo>
                      <a:pt x="642" y="743"/>
                    </a:lnTo>
                    <a:lnTo>
                      <a:pt x="643" y="743"/>
                    </a:lnTo>
                    <a:lnTo>
                      <a:pt x="643" y="740"/>
                    </a:lnTo>
                    <a:lnTo>
                      <a:pt x="644" y="743"/>
                    </a:lnTo>
                    <a:lnTo>
                      <a:pt x="644" y="743"/>
                    </a:lnTo>
                    <a:lnTo>
                      <a:pt x="645" y="741"/>
                    </a:lnTo>
                    <a:lnTo>
                      <a:pt x="645" y="743"/>
                    </a:lnTo>
                    <a:lnTo>
                      <a:pt x="646" y="740"/>
                    </a:lnTo>
                    <a:lnTo>
                      <a:pt x="646" y="743"/>
                    </a:lnTo>
                    <a:lnTo>
                      <a:pt x="647" y="735"/>
                    </a:lnTo>
                    <a:lnTo>
                      <a:pt x="647" y="743"/>
                    </a:lnTo>
                    <a:lnTo>
                      <a:pt x="648" y="743"/>
                    </a:lnTo>
                    <a:lnTo>
                      <a:pt x="648" y="743"/>
                    </a:lnTo>
                    <a:lnTo>
                      <a:pt x="649" y="743"/>
                    </a:lnTo>
                    <a:lnTo>
                      <a:pt x="649" y="743"/>
                    </a:lnTo>
                    <a:lnTo>
                      <a:pt x="650" y="742"/>
                    </a:lnTo>
                    <a:lnTo>
                      <a:pt x="650" y="743"/>
                    </a:lnTo>
                    <a:lnTo>
                      <a:pt x="651" y="743"/>
                    </a:lnTo>
                    <a:lnTo>
                      <a:pt x="651" y="743"/>
                    </a:lnTo>
                    <a:lnTo>
                      <a:pt x="652" y="743"/>
                    </a:lnTo>
                    <a:lnTo>
                      <a:pt x="652" y="743"/>
                    </a:lnTo>
                    <a:lnTo>
                      <a:pt x="653" y="743"/>
                    </a:lnTo>
                    <a:lnTo>
                      <a:pt x="653" y="743"/>
                    </a:lnTo>
                    <a:lnTo>
                      <a:pt x="654" y="702"/>
                    </a:lnTo>
                    <a:lnTo>
                      <a:pt x="654" y="743"/>
                    </a:lnTo>
                    <a:lnTo>
                      <a:pt x="655" y="743"/>
                    </a:lnTo>
                    <a:lnTo>
                      <a:pt x="655" y="743"/>
                    </a:lnTo>
                    <a:lnTo>
                      <a:pt x="656" y="735"/>
                    </a:lnTo>
                    <a:lnTo>
                      <a:pt x="656" y="743"/>
                    </a:lnTo>
                    <a:lnTo>
                      <a:pt x="657" y="743"/>
                    </a:lnTo>
                    <a:lnTo>
                      <a:pt x="657" y="743"/>
                    </a:lnTo>
                    <a:lnTo>
                      <a:pt x="658" y="743"/>
                    </a:lnTo>
                    <a:lnTo>
                      <a:pt x="658" y="743"/>
                    </a:lnTo>
                    <a:lnTo>
                      <a:pt x="659" y="743"/>
                    </a:lnTo>
                    <a:lnTo>
                      <a:pt x="659" y="743"/>
                    </a:lnTo>
                    <a:lnTo>
                      <a:pt x="660" y="743"/>
                    </a:lnTo>
                    <a:lnTo>
                      <a:pt x="660" y="743"/>
                    </a:lnTo>
                    <a:lnTo>
                      <a:pt x="661" y="743"/>
                    </a:lnTo>
                    <a:lnTo>
                      <a:pt x="661" y="743"/>
                    </a:lnTo>
                    <a:lnTo>
                      <a:pt x="662" y="743"/>
                    </a:lnTo>
                    <a:lnTo>
                      <a:pt x="662" y="743"/>
                    </a:lnTo>
                    <a:lnTo>
                      <a:pt x="663" y="743"/>
                    </a:lnTo>
                    <a:lnTo>
                      <a:pt x="663" y="742"/>
                    </a:lnTo>
                    <a:lnTo>
                      <a:pt x="664" y="736"/>
                    </a:lnTo>
                    <a:lnTo>
                      <a:pt x="664" y="743"/>
                    </a:lnTo>
                    <a:lnTo>
                      <a:pt x="665" y="743"/>
                    </a:lnTo>
                    <a:lnTo>
                      <a:pt x="665" y="743"/>
                    </a:lnTo>
                    <a:lnTo>
                      <a:pt x="666" y="742"/>
                    </a:lnTo>
                    <a:lnTo>
                      <a:pt x="666" y="743"/>
                    </a:lnTo>
                    <a:lnTo>
                      <a:pt x="667" y="743"/>
                    </a:lnTo>
                    <a:lnTo>
                      <a:pt x="667" y="743"/>
                    </a:lnTo>
                    <a:lnTo>
                      <a:pt x="668" y="743"/>
                    </a:lnTo>
                    <a:lnTo>
                      <a:pt x="668" y="743"/>
                    </a:lnTo>
                    <a:lnTo>
                      <a:pt x="669" y="743"/>
                    </a:lnTo>
                    <a:lnTo>
                      <a:pt x="669" y="743"/>
                    </a:lnTo>
                    <a:lnTo>
                      <a:pt x="670" y="743"/>
                    </a:lnTo>
                    <a:lnTo>
                      <a:pt x="670" y="743"/>
                    </a:lnTo>
                    <a:lnTo>
                      <a:pt x="671" y="743"/>
                    </a:lnTo>
                    <a:lnTo>
                      <a:pt x="671" y="743"/>
                    </a:lnTo>
                    <a:lnTo>
                      <a:pt x="672" y="743"/>
                    </a:lnTo>
                    <a:lnTo>
                      <a:pt x="672" y="743"/>
                    </a:lnTo>
                    <a:lnTo>
                      <a:pt x="673" y="743"/>
                    </a:lnTo>
                    <a:lnTo>
                      <a:pt x="673" y="743"/>
                    </a:lnTo>
                    <a:lnTo>
                      <a:pt x="674" y="743"/>
                    </a:lnTo>
                    <a:lnTo>
                      <a:pt x="674" y="743"/>
                    </a:lnTo>
                    <a:lnTo>
                      <a:pt x="675" y="743"/>
                    </a:lnTo>
                    <a:lnTo>
                      <a:pt x="675" y="743"/>
                    </a:lnTo>
                    <a:lnTo>
                      <a:pt x="676" y="727"/>
                    </a:lnTo>
                    <a:lnTo>
                      <a:pt x="676" y="743"/>
                    </a:lnTo>
                    <a:lnTo>
                      <a:pt x="677" y="743"/>
                    </a:lnTo>
                    <a:lnTo>
                      <a:pt x="677" y="743"/>
                    </a:lnTo>
                    <a:lnTo>
                      <a:pt x="678" y="740"/>
                    </a:lnTo>
                    <a:lnTo>
                      <a:pt x="678" y="743"/>
                    </a:lnTo>
                    <a:lnTo>
                      <a:pt x="679" y="743"/>
                    </a:lnTo>
                    <a:lnTo>
                      <a:pt x="679" y="743"/>
                    </a:lnTo>
                    <a:lnTo>
                      <a:pt x="680" y="743"/>
                    </a:lnTo>
                    <a:lnTo>
                      <a:pt x="680" y="743"/>
                    </a:lnTo>
                    <a:lnTo>
                      <a:pt x="681" y="743"/>
                    </a:lnTo>
                    <a:lnTo>
                      <a:pt x="681" y="743"/>
                    </a:lnTo>
                    <a:lnTo>
                      <a:pt x="682" y="743"/>
                    </a:lnTo>
                    <a:lnTo>
                      <a:pt x="682" y="740"/>
                    </a:lnTo>
                    <a:lnTo>
                      <a:pt x="683" y="743"/>
                    </a:lnTo>
                    <a:lnTo>
                      <a:pt x="683" y="743"/>
                    </a:lnTo>
                    <a:lnTo>
                      <a:pt x="684" y="743"/>
                    </a:lnTo>
                    <a:lnTo>
                      <a:pt x="684" y="743"/>
                    </a:lnTo>
                    <a:lnTo>
                      <a:pt x="685" y="743"/>
                    </a:lnTo>
                    <a:lnTo>
                      <a:pt x="685" y="743"/>
                    </a:lnTo>
                    <a:lnTo>
                      <a:pt x="686" y="743"/>
                    </a:lnTo>
                    <a:lnTo>
                      <a:pt x="686" y="743"/>
                    </a:lnTo>
                    <a:lnTo>
                      <a:pt x="687" y="743"/>
                    </a:lnTo>
                    <a:lnTo>
                      <a:pt x="687" y="743"/>
                    </a:lnTo>
                    <a:lnTo>
                      <a:pt x="688" y="743"/>
                    </a:lnTo>
                    <a:lnTo>
                      <a:pt x="688" y="743"/>
                    </a:lnTo>
                    <a:lnTo>
                      <a:pt x="689" y="743"/>
                    </a:lnTo>
                    <a:lnTo>
                      <a:pt x="689" y="742"/>
                    </a:lnTo>
                    <a:lnTo>
                      <a:pt x="690" y="743"/>
                    </a:lnTo>
                    <a:lnTo>
                      <a:pt x="690" y="743"/>
                    </a:lnTo>
                    <a:lnTo>
                      <a:pt x="691" y="743"/>
                    </a:lnTo>
                    <a:lnTo>
                      <a:pt x="691" y="743"/>
                    </a:lnTo>
                    <a:lnTo>
                      <a:pt x="692" y="743"/>
                    </a:lnTo>
                    <a:lnTo>
                      <a:pt x="692" y="743"/>
                    </a:lnTo>
                    <a:lnTo>
                      <a:pt x="693" y="743"/>
                    </a:lnTo>
                    <a:lnTo>
                      <a:pt x="693" y="743"/>
                    </a:lnTo>
                    <a:lnTo>
                      <a:pt x="694" y="743"/>
                    </a:lnTo>
                    <a:lnTo>
                      <a:pt x="694" y="743"/>
                    </a:lnTo>
                    <a:lnTo>
                      <a:pt x="695" y="743"/>
                    </a:lnTo>
                    <a:lnTo>
                      <a:pt x="695" y="740"/>
                    </a:lnTo>
                    <a:lnTo>
                      <a:pt x="696" y="741"/>
                    </a:lnTo>
                    <a:lnTo>
                      <a:pt x="696" y="743"/>
                    </a:lnTo>
                    <a:lnTo>
                      <a:pt x="697" y="743"/>
                    </a:lnTo>
                    <a:lnTo>
                      <a:pt x="697" y="743"/>
                    </a:lnTo>
                    <a:lnTo>
                      <a:pt x="698" y="743"/>
                    </a:lnTo>
                    <a:lnTo>
                      <a:pt x="698" y="743"/>
                    </a:lnTo>
                    <a:lnTo>
                      <a:pt x="699" y="743"/>
                    </a:lnTo>
                    <a:lnTo>
                      <a:pt x="699" y="743"/>
                    </a:lnTo>
                    <a:lnTo>
                      <a:pt x="700" y="743"/>
                    </a:lnTo>
                    <a:lnTo>
                      <a:pt x="700" y="743"/>
                    </a:lnTo>
                    <a:lnTo>
                      <a:pt x="701" y="743"/>
                    </a:lnTo>
                    <a:lnTo>
                      <a:pt x="701" y="743"/>
                    </a:lnTo>
                    <a:lnTo>
                      <a:pt x="702" y="743"/>
                    </a:lnTo>
                    <a:lnTo>
                      <a:pt x="702" y="743"/>
                    </a:lnTo>
                    <a:lnTo>
                      <a:pt x="703" y="743"/>
                    </a:lnTo>
                    <a:lnTo>
                      <a:pt x="703" y="743"/>
                    </a:lnTo>
                    <a:lnTo>
                      <a:pt x="704" y="743"/>
                    </a:lnTo>
                    <a:lnTo>
                      <a:pt x="704" y="743"/>
                    </a:lnTo>
                    <a:lnTo>
                      <a:pt x="705" y="743"/>
                    </a:lnTo>
                    <a:lnTo>
                      <a:pt x="705" y="743"/>
                    </a:lnTo>
                    <a:lnTo>
                      <a:pt x="706" y="743"/>
                    </a:lnTo>
                    <a:lnTo>
                      <a:pt x="706" y="743"/>
                    </a:lnTo>
                    <a:lnTo>
                      <a:pt x="707" y="743"/>
                    </a:lnTo>
                    <a:lnTo>
                      <a:pt x="707" y="743"/>
                    </a:lnTo>
                    <a:lnTo>
                      <a:pt x="708" y="743"/>
                    </a:lnTo>
                    <a:lnTo>
                      <a:pt x="708" y="743"/>
                    </a:lnTo>
                    <a:lnTo>
                      <a:pt x="709" y="743"/>
                    </a:lnTo>
                    <a:lnTo>
                      <a:pt x="709" y="743"/>
                    </a:lnTo>
                    <a:lnTo>
                      <a:pt x="710" y="721"/>
                    </a:lnTo>
                    <a:lnTo>
                      <a:pt x="710" y="743"/>
                    </a:lnTo>
                    <a:lnTo>
                      <a:pt x="711" y="743"/>
                    </a:lnTo>
                    <a:lnTo>
                      <a:pt x="711" y="743"/>
                    </a:lnTo>
                    <a:lnTo>
                      <a:pt x="712" y="738"/>
                    </a:lnTo>
                    <a:lnTo>
                      <a:pt x="712" y="743"/>
                    </a:lnTo>
                    <a:lnTo>
                      <a:pt x="713" y="743"/>
                    </a:lnTo>
                    <a:lnTo>
                      <a:pt x="713" y="741"/>
                    </a:lnTo>
                    <a:lnTo>
                      <a:pt x="714" y="743"/>
                    </a:lnTo>
                    <a:lnTo>
                      <a:pt x="714" y="743"/>
                    </a:lnTo>
                    <a:lnTo>
                      <a:pt x="715" y="743"/>
                    </a:lnTo>
                    <a:lnTo>
                      <a:pt x="715" y="743"/>
                    </a:lnTo>
                    <a:lnTo>
                      <a:pt x="716" y="743"/>
                    </a:lnTo>
                    <a:lnTo>
                      <a:pt x="716" y="743"/>
                    </a:lnTo>
                    <a:lnTo>
                      <a:pt x="717" y="743"/>
                    </a:lnTo>
                    <a:lnTo>
                      <a:pt x="717" y="743"/>
                    </a:lnTo>
                    <a:lnTo>
                      <a:pt x="718" y="743"/>
                    </a:lnTo>
                    <a:lnTo>
                      <a:pt x="718" y="743"/>
                    </a:lnTo>
                    <a:lnTo>
                      <a:pt x="719" y="740"/>
                    </a:lnTo>
                    <a:lnTo>
                      <a:pt x="719" y="743"/>
                    </a:lnTo>
                    <a:lnTo>
                      <a:pt x="720" y="743"/>
                    </a:lnTo>
                    <a:lnTo>
                      <a:pt x="720" y="743"/>
                    </a:lnTo>
                    <a:lnTo>
                      <a:pt x="721" y="743"/>
                    </a:lnTo>
                    <a:lnTo>
                      <a:pt x="721" y="743"/>
                    </a:lnTo>
                    <a:lnTo>
                      <a:pt x="722" y="743"/>
                    </a:lnTo>
                    <a:lnTo>
                      <a:pt x="722" y="743"/>
                    </a:lnTo>
                    <a:lnTo>
                      <a:pt x="723" y="743"/>
                    </a:lnTo>
                    <a:lnTo>
                      <a:pt x="723" y="743"/>
                    </a:lnTo>
                    <a:lnTo>
                      <a:pt x="724" y="743"/>
                    </a:lnTo>
                    <a:lnTo>
                      <a:pt x="724" y="743"/>
                    </a:lnTo>
                    <a:lnTo>
                      <a:pt x="725" y="742"/>
                    </a:lnTo>
                    <a:lnTo>
                      <a:pt x="725" y="743"/>
                    </a:lnTo>
                    <a:lnTo>
                      <a:pt x="726" y="743"/>
                    </a:lnTo>
                    <a:lnTo>
                      <a:pt x="726" y="743"/>
                    </a:lnTo>
                    <a:lnTo>
                      <a:pt x="727" y="743"/>
                    </a:lnTo>
                    <a:lnTo>
                      <a:pt x="727" y="743"/>
                    </a:lnTo>
                    <a:lnTo>
                      <a:pt x="728" y="743"/>
                    </a:lnTo>
                    <a:lnTo>
                      <a:pt x="728" y="743"/>
                    </a:lnTo>
                    <a:lnTo>
                      <a:pt x="729" y="743"/>
                    </a:lnTo>
                    <a:lnTo>
                      <a:pt x="729" y="743"/>
                    </a:lnTo>
                    <a:lnTo>
                      <a:pt x="730" y="743"/>
                    </a:lnTo>
                    <a:lnTo>
                      <a:pt x="730" y="743"/>
                    </a:lnTo>
                    <a:lnTo>
                      <a:pt x="731" y="742"/>
                    </a:lnTo>
                    <a:lnTo>
                      <a:pt x="731" y="743"/>
                    </a:lnTo>
                    <a:lnTo>
                      <a:pt x="732" y="743"/>
                    </a:lnTo>
                    <a:lnTo>
                      <a:pt x="732" y="743"/>
                    </a:lnTo>
                    <a:lnTo>
                      <a:pt x="733" y="738"/>
                    </a:lnTo>
                    <a:lnTo>
                      <a:pt x="733" y="743"/>
                    </a:lnTo>
                    <a:lnTo>
                      <a:pt x="734" y="743"/>
                    </a:lnTo>
                    <a:lnTo>
                      <a:pt x="734" y="743"/>
                    </a:lnTo>
                    <a:lnTo>
                      <a:pt x="735" y="743"/>
                    </a:lnTo>
                    <a:lnTo>
                      <a:pt x="735" y="743"/>
                    </a:lnTo>
                    <a:lnTo>
                      <a:pt x="736" y="743"/>
                    </a:lnTo>
                    <a:lnTo>
                      <a:pt x="736" y="743"/>
                    </a:lnTo>
                    <a:lnTo>
                      <a:pt x="737" y="740"/>
                    </a:lnTo>
                    <a:lnTo>
                      <a:pt x="737" y="743"/>
                    </a:lnTo>
                    <a:lnTo>
                      <a:pt x="738" y="743"/>
                    </a:lnTo>
                    <a:lnTo>
                      <a:pt x="738" y="743"/>
                    </a:lnTo>
                    <a:lnTo>
                      <a:pt x="739" y="743"/>
                    </a:lnTo>
                    <a:lnTo>
                      <a:pt x="739" y="743"/>
                    </a:lnTo>
                    <a:lnTo>
                      <a:pt x="740" y="743"/>
                    </a:lnTo>
                    <a:lnTo>
                      <a:pt x="740" y="743"/>
                    </a:lnTo>
                    <a:lnTo>
                      <a:pt x="741" y="693"/>
                    </a:lnTo>
                    <a:lnTo>
                      <a:pt x="741" y="743"/>
                    </a:lnTo>
                    <a:lnTo>
                      <a:pt x="742" y="743"/>
                    </a:lnTo>
                    <a:lnTo>
                      <a:pt x="742" y="743"/>
                    </a:lnTo>
                    <a:lnTo>
                      <a:pt x="743" y="731"/>
                    </a:lnTo>
                    <a:lnTo>
                      <a:pt x="743" y="743"/>
                    </a:lnTo>
                    <a:lnTo>
                      <a:pt x="744" y="743"/>
                    </a:lnTo>
                    <a:lnTo>
                      <a:pt x="744" y="743"/>
                    </a:lnTo>
                    <a:lnTo>
                      <a:pt x="745" y="742"/>
                    </a:lnTo>
                    <a:lnTo>
                      <a:pt x="745" y="743"/>
                    </a:lnTo>
                    <a:lnTo>
                      <a:pt x="746" y="743"/>
                    </a:lnTo>
                    <a:lnTo>
                      <a:pt x="746" y="743"/>
                    </a:lnTo>
                    <a:lnTo>
                      <a:pt x="747" y="739"/>
                    </a:lnTo>
                    <a:lnTo>
                      <a:pt x="747" y="743"/>
                    </a:lnTo>
                    <a:lnTo>
                      <a:pt x="748" y="743"/>
                    </a:lnTo>
                    <a:lnTo>
                      <a:pt x="748" y="743"/>
                    </a:lnTo>
                    <a:lnTo>
                      <a:pt x="749" y="743"/>
                    </a:lnTo>
                    <a:lnTo>
                      <a:pt x="749" y="743"/>
                    </a:lnTo>
                    <a:lnTo>
                      <a:pt x="750" y="743"/>
                    </a:lnTo>
                    <a:lnTo>
                      <a:pt x="750" y="743"/>
                    </a:lnTo>
                    <a:lnTo>
                      <a:pt x="751" y="743"/>
                    </a:lnTo>
                    <a:lnTo>
                      <a:pt x="751" y="734"/>
                    </a:lnTo>
                    <a:lnTo>
                      <a:pt x="752" y="743"/>
                    </a:lnTo>
                    <a:lnTo>
                      <a:pt x="752" y="743"/>
                    </a:lnTo>
                    <a:lnTo>
                      <a:pt x="753" y="741"/>
                    </a:lnTo>
                    <a:lnTo>
                      <a:pt x="753" y="743"/>
                    </a:lnTo>
                    <a:lnTo>
                      <a:pt x="754" y="672"/>
                    </a:lnTo>
                    <a:lnTo>
                      <a:pt x="754" y="743"/>
                    </a:lnTo>
                    <a:lnTo>
                      <a:pt x="755" y="743"/>
                    </a:lnTo>
                    <a:lnTo>
                      <a:pt x="755" y="743"/>
                    </a:lnTo>
                    <a:lnTo>
                      <a:pt x="756" y="743"/>
                    </a:lnTo>
                    <a:lnTo>
                      <a:pt x="756" y="739"/>
                    </a:lnTo>
                    <a:lnTo>
                      <a:pt x="757" y="743"/>
                    </a:lnTo>
                    <a:lnTo>
                      <a:pt x="757" y="743"/>
                    </a:lnTo>
                    <a:lnTo>
                      <a:pt x="758" y="743"/>
                    </a:lnTo>
                    <a:lnTo>
                      <a:pt x="758" y="742"/>
                    </a:lnTo>
                    <a:lnTo>
                      <a:pt x="759" y="743"/>
                    </a:lnTo>
                    <a:lnTo>
                      <a:pt x="759" y="743"/>
                    </a:lnTo>
                    <a:lnTo>
                      <a:pt x="760" y="743"/>
                    </a:lnTo>
                    <a:lnTo>
                      <a:pt x="760" y="742"/>
                    </a:lnTo>
                    <a:lnTo>
                      <a:pt x="761" y="743"/>
                    </a:lnTo>
                    <a:lnTo>
                      <a:pt x="761" y="743"/>
                    </a:lnTo>
                    <a:lnTo>
                      <a:pt x="762" y="743"/>
                    </a:lnTo>
                    <a:lnTo>
                      <a:pt x="762" y="743"/>
                    </a:lnTo>
                    <a:lnTo>
                      <a:pt x="763" y="743"/>
                    </a:lnTo>
                    <a:lnTo>
                      <a:pt x="763" y="743"/>
                    </a:lnTo>
                    <a:lnTo>
                      <a:pt x="764" y="743"/>
                    </a:lnTo>
                    <a:lnTo>
                      <a:pt x="764" y="743"/>
                    </a:lnTo>
                    <a:lnTo>
                      <a:pt x="765" y="742"/>
                    </a:lnTo>
                    <a:lnTo>
                      <a:pt x="765" y="743"/>
                    </a:lnTo>
                    <a:lnTo>
                      <a:pt x="766" y="743"/>
                    </a:lnTo>
                    <a:lnTo>
                      <a:pt x="766" y="743"/>
                    </a:lnTo>
                    <a:lnTo>
                      <a:pt x="767" y="743"/>
                    </a:lnTo>
                    <a:lnTo>
                      <a:pt x="767" y="743"/>
                    </a:lnTo>
                    <a:lnTo>
                      <a:pt x="768" y="743"/>
                    </a:lnTo>
                    <a:lnTo>
                      <a:pt x="768" y="743"/>
                    </a:lnTo>
                    <a:lnTo>
                      <a:pt x="769" y="739"/>
                    </a:lnTo>
                    <a:lnTo>
                      <a:pt x="769" y="743"/>
                    </a:lnTo>
                    <a:lnTo>
                      <a:pt x="770" y="743"/>
                    </a:lnTo>
                    <a:lnTo>
                      <a:pt x="770" y="743"/>
                    </a:lnTo>
                    <a:lnTo>
                      <a:pt x="771" y="743"/>
                    </a:lnTo>
                    <a:lnTo>
                      <a:pt x="771" y="743"/>
                    </a:lnTo>
                    <a:lnTo>
                      <a:pt x="772" y="743"/>
                    </a:lnTo>
                    <a:lnTo>
                      <a:pt x="772" y="743"/>
                    </a:lnTo>
                    <a:lnTo>
                      <a:pt x="773" y="743"/>
                    </a:lnTo>
                    <a:lnTo>
                      <a:pt x="773" y="743"/>
                    </a:lnTo>
                    <a:lnTo>
                      <a:pt x="774" y="743"/>
                    </a:lnTo>
                    <a:lnTo>
                      <a:pt x="774" y="743"/>
                    </a:lnTo>
                    <a:lnTo>
                      <a:pt x="775" y="743"/>
                    </a:lnTo>
                    <a:lnTo>
                      <a:pt x="775" y="743"/>
                    </a:lnTo>
                    <a:lnTo>
                      <a:pt x="776" y="743"/>
                    </a:lnTo>
                    <a:lnTo>
                      <a:pt x="776" y="743"/>
                    </a:lnTo>
                    <a:lnTo>
                      <a:pt x="777" y="743"/>
                    </a:lnTo>
                    <a:lnTo>
                      <a:pt x="777" y="743"/>
                    </a:lnTo>
                    <a:lnTo>
                      <a:pt x="778" y="743"/>
                    </a:lnTo>
                    <a:lnTo>
                      <a:pt x="778" y="743"/>
                    </a:lnTo>
                    <a:lnTo>
                      <a:pt x="779" y="743"/>
                    </a:lnTo>
                    <a:lnTo>
                      <a:pt x="779" y="743"/>
                    </a:lnTo>
                    <a:lnTo>
                      <a:pt x="780" y="743"/>
                    </a:lnTo>
                    <a:lnTo>
                      <a:pt x="780" y="743"/>
                    </a:lnTo>
                    <a:lnTo>
                      <a:pt x="781" y="743"/>
                    </a:lnTo>
                    <a:lnTo>
                      <a:pt x="781" y="743"/>
                    </a:lnTo>
                    <a:lnTo>
                      <a:pt x="782" y="743"/>
                    </a:lnTo>
                    <a:lnTo>
                      <a:pt x="782" y="736"/>
                    </a:lnTo>
                    <a:lnTo>
                      <a:pt x="783" y="739"/>
                    </a:lnTo>
                    <a:lnTo>
                      <a:pt x="783" y="743"/>
                    </a:lnTo>
                    <a:lnTo>
                      <a:pt x="784" y="743"/>
                    </a:lnTo>
                    <a:lnTo>
                      <a:pt x="784" y="743"/>
                    </a:lnTo>
                    <a:lnTo>
                      <a:pt x="785" y="742"/>
                    </a:lnTo>
                    <a:lnTo>
                      <a:pt x="785" y="743"/>
                    </a:lnTo>
                    <a:lnTo>
                      <a:pt x="786" y="743"/>
                    </a:lnTo>
                    <a:lnTo>
                      <a:pt x="786" y="743"/>
                    </a:lnTo>
                    <a:lnTo>
                      <a:pt x="787" y="743"/>
                    </a:lnTo>
                    <a:lnTo>
                      <a:pt x="787" y="743"/>
                    </a:lnTo>
                    <a:lnTo>
                      <a:pt x="788" y="743"/>
                    </a:lnTo>
                    <a:lnTo>
                      <a:pt x="788" y="743"/>
                    </a:lnTo>
                    <a:lnTo>
                      <a:pt x="789" y="743"/>
                    </a:lnTo>
                    <a:lnTo>
                      <a:pt x="789" y="743"/>
                    </a:lnTo>
                    <a:lnTo>
                      <a:pt x="790" y="743"/>
                    </a:lnTo>
                    <a:lnTo>
                      <a:pt x="790" y="743"/>
                    </a:lnTo>
                    <a:lnTo>
                      <a:pt x="791" y="743"/>
                    </a:lnTo>
                    <a:lnTo>
                      <a:pt x="791" y="743"/>
                    </a:lnTo>
                    <a:lnTo>
                      <a:pt x="792" y="743"/>
                    </a:lnTo>
                    <a:lnTo>
                      <a:pt x="792" y="743"/>
                    </a:lnTo>
                    <a:lnTo>
                      <a:pt x="793" y="743"/>
                    </a:lnTo>
                    <a:lnTo>
                      <a:pt x="793" y="743"/>
                    </a:lnTo>
                    <a:lnTo>
                      <a:pt x="794" y="743"/>
                    </a:lnTo>
                    <a:lnTo>
                      <a:pt x="794" y="743"/>
                    </a:lnTo>
                    <a:lnTo>
                      <a:pt x="795" y="743"/>
                    </a:lnTo>
                    <a:lnTo>
                      <a:pt x="795" y="743"/>
                    </a:lnTo>
                    <a:lnTo>
                      <a:pt x="796" y="743"/>
                    </a:lnTo>
                    <a:lnTo>
                      <a:pt x="796" y="743"/>
                    </a:lnTo>
                    <a:lnTo>
                      <a:pt x="797" y="718"/>
                    </a:lnTo>
                    <a:lnTo>
                      <a:pt x="797" y="743"/>
                    </a:lnTo>
                    <a:lnTo>
                      <a:pt x="798" y="743"/>
                    </a:lnTo>
                    <a:lnTo>
                      <a:pt x="798" y="743"/>
                    </a:lnTo>
                    <a:lnTo>
                      <a:pt x="799" y="743"/>
                    </a:lnTo>
                    <a:lnTo>
                      <a:pt x="799" y="737"/>
                    </a:lnTo>
                    <a:lnTo>
                      <a:pt x="800" y="743"/>
                    </a:lnTo>
                    <a:lnTo>
                      <a:pt x="800" y="742"/>
                    </a:lnTo>
                    <a:lnTo>
                      <a:pt x="801" y="743"/>
                    </a:lnTo>
                    <a:lnTo>
                      <a:pt x="801" y="743"/>
                    </a:lnTo>
                    <a:lnTo>
                      <a:pt x="802" y="743"/>
                    </a:lnTo>
                    <a:lnTo>
                      <a:pt x="802" y="741"/>
                    </a:lnTo>
                    <a:lnTo>
                      <a:pt x="803" y="743"/>
                    </a:lnTo>
                    <a:lnTo>
                      <a:pt x="803" y="743"/>
                    </a:lnTo>
                    <a:lnTo>
                      <a:pt x="804" y="743"/>
                    </a:lnTo>
                    <a:lnTo>
                      <a:pt x="804" y="743"/>
                    </a:lnTo>
                    <a:lnTo>
                      <a:pt x="805" y="743"/>
                    </a:lnTo>
                    <a:lnTo>
                      <a:pt x="805" y="743"/>
                    </a:lnTo>
                    <a:lnTo>
                      <a:pt x="806" y="743"/>
                    </a:lnTo>
                    <a:lnTo>
                      <a:pt x="806" y="739"/>
                    </a:lnTo>
                    <a:lnTo>
                      <a:pt x="807" y="743"/>
                    </a:lnTo>
                    <a:lnTo>
                      <a:pt x="807" y="743"/>
                    </a:lnTo>
                    <a:lnTo>
                      <a:pt x="808" y="743"/>
                    </a:lnTo>
                    <a:lnTo>
                      <a:pt x="808" y="742"/>
                    </a:lnTo>
                    <a:lnTo>
                      <a:pt x="809" y="741"/>
                    </a:lnTo>
                    <a:lnTo>
                      <a:pt x="809" y="743"/>
                    </a:lnTo>
                    <a:lnTo>
                      <a:pt x="810" y="743"/>
                    </a:lnTo>
                    <a:lnTo>
                      <a:pt x="810" y="743"/>
                    </a:lnTo>
                    <a:lnTo>
                      <a:pt x="811" y="743"/>
                    </a:lnTo>
                    <a:lnTo>
                      <a:pt x="811" y="742"/>
                    </a:lnTo>
                    <a:lnTo>
                      <a:pt x="812" y="742"/>
                    </a:lnTo>
                    <a:lnTo>
                      <a:pt x="812" y="743"/>
                    </a:lnTo>
                    <a:lnTo>
                      <a:pt x="813" y="743"/>
                    </a:lnTo>
                    <a:lnTo>
                      <a:pt x="813" y="742"/>
                    </a:lnTo>
                    <a:lnTo>
                      <a:pt x="814" y="743"/>
                    </a:lnTo>
                    <a:lnTo>
                      <a:pt x="814" y="743"/>
                    </a:lnTo>
                    <a:lnTo>
                      <a:pt x="815" y="743"/>
                    </a:lnTo>
                    <a:lnTo>
                      <a:pt x="815" y="743"/>
                    </a:lnTo>
                    <a:lnTo>
                      <a:pt x="816" y="743"/>
                    </a:lnTo>
                    <a:lnTo>
                      <a:pt x="816" y="743"/>
                    </a:lnTo>
                    <a:lnTo>
                      <a:pt x="817" y="743"/>
                    </a:lnTo>
                    <a:lnTo>
                      <a:pt x="817" y="743"/>
                    </a:lnTo>
                    <a:lnTo>
                      <a:pt x="818" y="743"/>
                    </a:lnTo>
                    <a:lnTo>
                      <a:pt x="818" y="743"/>
                    </a:lnTo>
                    <a:lnTo>
                      <a:pt x="819" y="743"/>
                    </a:lnTo>
                    <a:lnTo>
                      <a:pt x="819" y="743"/>
                    </a:lnTo>
                    <a:lnTo>
                      <a:pt x="820" y="742"/>
                    </a:lnTo>
                    <a:lnTo>
                      <a:pt x="820" y="743"/>
                    </a:lnTo>
                    <a:lnTo>
                      <a:pt x="821" y="743"/>
                    </a:lnTo>
                    <a:lnTo>
                      <a:pt x="821" y="743"/>
                    </a:lnTo>
                    <a:lnTo>
                      <a:pt x="822" y="743"/>
                    </a:lnTo>
                    <a:lnTo>
                      <a:pt x="822" y="743"/>
                    </a:lnTo>
                    <a:lnTo>
                      <a:pt x="823" y="743"/>
                    </a:lnTo>
                    <a:lnTo>
                      <a:pt x="823" y="743"/>
                    </a:lnTo>
                    <a:lnTo>
                      <a:pt x="824" y="740"/>
                    </a:lnTo>
                    <a:lnTo>
                      <a:pt x="824" y="743"/>
                    </a:lnTo>
                    <a:lnTo>
                      <a:pt x="825" y="743"/>
                    </a:lnTo>
                    <a:lnTo>
                      <a:pt x="825" y="743"/>
                    </a:lnTo>
                    <a:lnTo>
                      <a:pt x="826" y="743"/>
                    </a:lnTo>
                    <a:lnTo>
                      <a:pt x="826" y="743"/>
                    </a:lnTo>
                    <a:lnTo>
                      <a:pt x="827" y="743"/>
                    </a:lnTo>
                    <a:lnTo>
                      <a:pt x="827" y="743"/>
                    </a:lnTo>
                    <a:lnTo>
                      <a:pt x="828" y="693"/>
                    </a:lnTo>
                    <a:lnTo>
                      <a:pt x="828" y="743"/>
                    </a:lnTo>
                    <a:lnTo>
                      <a:pt x="829" y="743"/>
                    </a:lnTo>
                    <a:lnTo>
                      <a:pt x="829" y="743"/>
                    </a:lnTo>
                    <a:lnTo>
                      <a:pt x="830" y="730"/>
                    </a:lnTo>
                    <a:lnTo>
                      <a:pt x="830" y="743"/>
                    </a:lnTo>
                    <a:lnTo>
                      <a:pt x="831" y="743"/>
                    </a:lnTo>
                    <a:lnTo>
                      <a:pt x="831" y="743"/>
                    </a:lnTo>
                    <a:lnTo>
                      <a:pt x="832" y="743"/>
                    </a:lnTo>
                    <a:lnTo>
                      <a:pt x="832" y="742"/>
                    </a:lnTo>
                    <a:lnTo>
                      <a:pt x="833" y="743"/>
                    </a:lnTo>
                    <a:lnTo>
                      <a:pt x="833" y="743"/>
                    </a:lnTo>
                    <a:lnTo>
                      <a:pt x="834" y="743"/>
                    </a:lnTo>
                    <a:lnTo>
                      <a:pt x="834" y="743"/>
                    </a:lnTo>
                    <a:lnTo>
                      <a:pt x="835" y="743"/>
                    </a:lnTo>
                    <a:lnTo>
                      <a:pt x="835" y="743"/>
                    </a:lnTo>
                    <a:lnTo>
                      <a:pt x="836" y="743"/>
                    </a:lnTo>
                    <a:lnTo>
                      <a:pt x="836" y="743"/>
                    </a:lnTo>
                    <a:lnTo>
                      <a:pt x="837" y="743"/>
                    </a:lnTo>
                    <a:lnTo>
                      <a:pt x="837" y="743"/>
                    </a:lnTo>
                    <a:lnTo>
                      <a:pt x="838" y="743"/>
                    </a:lnTo>
                    <a:lnTo>
                      <a:pt x="838" y="736"/>
                    </a:lnTo>
                    <a:lnTo>
                      <a:pt x="839" y="743"/>
                    </a:lnTo>
                    <a:lnTo>
                      <a:pt x="839" y="743"/>
                    </a:lnTo>
                    <a:lnTo>
                      <a:pt x="840" y="743"/>
                    </a:lnTo>
                    <a:lnTo>
                      <a:pt x="840" y="742"/>
                    </a:lnTo>
                    <a:lnTo>
                      <a:pt x="841" y="743"/>
                    </a:lnTo>
                    <a:lnTo>
                      <a:pt x="841" y="743"/>
                    </a:lnTo>
                    <a:lnTo>
                      <a:pt x="842" y="743"/>
                    </a:lnTo>
                    <a:lnTo>
                      <a:pt x="842" y="743"/>
                    </a:lnTo>
                    <a:lnTo>
                      <a:pt x="843" y="743"/>
                    </a:lnTo>
                    <a:lnTo>
                      <a:pt x="843" y="743"/>
                    </a:lnTo>
                    <a:lnTo>
                      <a:pt x="844" y="743"/>
                    </a:lnTo>
                    <a:lnTo>
                      <a:pt x="844" y="743"/>
                    </a:lnTo>
                    <a:lnTo>
                      <a:pt x="845" y="743"/>
                    </a:lnTo>
                    <a:lnTo>
                      <a:pt x="845" y="743"/>
                    </a:lnTo>
                    <a:lnTo>
                      <a:pt x="846" y="743"/>
                    </a:lnTo>
                    <a:lnTo>
                      <a:pt x="846" y="743"/>
                    </a:lnTo>
                    <a:lnTo>
                      <a:pt x="847" y="743"/>
                    </a:lnTo>
                    <a:lnTo>
                      <a:pt x="847" y="743"/>
                    </a:lnTo>
                    <a:lnTo>
                      <a:pt x="848" y="742"/>
                    </a:lnTo>
                    <a:lnTo>
                      <a:pt x="848" y="743"/>
                    </a:lnTo>
                    <a:lnTo>
                      <a:pt x="849" y="743"/>
                    </a:lnTo>
                    <a:lnTo>
                      <a:pt x="849" y="743"/>
                    </a:lnTo>
                    <a:lnTo>
                      <a:pt x="850" y="743"/>
                    </a:lnTo>
                    <a:lnTo>
                      <a:pt x="850" y="743"/>
                    </a:lnTo>
                    <a:lnTo>
                      <a:pt x="851" y="743"/>
                    </a:lnTo>
                    <a:lnTo>
                      <a:pt x="851" y="743"/>
                    </a:lnTo>
                    <a:lnTo>
                      <a:pt x="852" y="742"/>
                    </a:lnTo>
                    <a:lnTo>
                      <a:pt x="852" y="743"/>
                    </a:lnTo>
                    <a:lnTo>
                      <a:pt x="853" y="743"/>
                    </a:lnTo>
                    <a:lnTo>
                      <a:pt x="853" y="743"/>
                    </a:lnTo>
                    <a:lnTo>
                      <a:pt x="854" y="743"/>
                    </a:lnTo>
                    <a:lnTo>
                      <a:pt x="854" y="743"/>
                    </a:lnTo>
                    <a:lnTo>
                      <a:pt x="855" y="743"/>
                    </a:lnTo>
                    <a:lnTo>
                      <a:pt x="855" y="743"/>
                    </a:lnTo>
                    <a:lnTo>
                      <a:pt x="856" y="737"/>
                    </a:lnTo>
                    <a:lnTo>
                      <a:pt x="856" y="743"/>
                    </a:lnTo>
                    <a:lnTo>
                      <a:pt x="857" y="743"/>
                    </a:lnTo>
                    <a:lnTo>
                      <a:pt x="857" y="743"/>
                    </a:lnTo>
                    <a:lnTo>
                      <a:pt x="858" y="742"/>
                    </a:lnTo>
                    <a:lnTo>
                      <a:pt x="858" y="743"/>
                    </a:lnTo>
                    <a:lnTo>
                      <a:pt x="859" y="743"/>
                    </a:lnTo>
                    <a:lnTo>
                      <a:pt x="859" y="743"/>
                    </a:lnTo>
                    <a:lnTo>
                      <a:pt x="860" y="743"/>
                    </a:lnTo>
                    <a:lnTo>
                      <a:pt x="860" y="743"/>
                    </a:lnTo>
                    <a:lnTo>
                      <a:pt x="861" y="743"/>
                    </a:lnTo>
                    <a:lnTo>
                      <a:pt x="861" y="743"/>
                    </a:lnTo>
                    <a:lnTo>
                      <a:pt x="862" y="743"/>
                    </a:lnTo>
                    <a:lnTo>
                      <a:pt x="862" y="743"/>
                    </a:lnTo>
                    <a:lnTo>
                      <a:pt x="863" y="743"/>
                    </a:lnTo>
                    <a:lnTo>
                      <a:pt x="863" y="743"/>
                    </a:lnTo>
                    <a:lnTo>
                      <a:pt x="864" y="743"/>
                    </a:lnTo>
                    <a:lnTo>
                      <a:pt x="864" y="743"/>
                    </a:lnTo>
                    <a:lnTo>
                      <a:pt x="865" y="743"/>
                    </a:lnTo>
                    <a:lnTo>
                      <a:pt x="865" y="743"/>
                    </a:lnTo>
                    <a:lnTo>
                      <a:pt x="866" y="743"/>
                    </a:lnTo>
                    <a:lnTo>
                      <a:pt x="866" y="743"/>
                    </a:lnTo>
                    <a:lnTo>
                      <a:pt x="867" y="743"/>
                    </a:lnTo>
                    <a:lnTo>
                      <a:pt x="867" y="743"/>
                    </a:lnTo>
                    <a:lnTo>
                      <a:pt x="868" y="743"/>
                    </a:lnTo>
                    <a:lnTo>
                      <a:pt x="868" y="743"/>
                    </a:lnTo>
                    <a:lnTo>
                      <a:pt x="869" y="743"/>
                    </a:lnTo>
                    <a:lnTo>
                      <a:pt x="869" y="743"/>
                    </a:lnTo>
                    <a:lnTo>
                      <a:pt x="870" y="738"/>
                    </a:lnTo>
                    <a:lnTo>
                      <a:pt x="870" y="743"/>
                    </a:lnTo>
                    <a:lnTo>
                      <a:pt x="871" y="743"/>
                    </a:lnTo>
                    <a:lnTo>
                      <a:pt x="871" y="743"/>
                    </a:lnTo>
                    <a:lnTo>
                      <a:pt x="872" y="742"/>
                    </a:lnTo>
                    <a:lnTo>
                      <a:pt x="872" y="743"/>
                    </a:lnTo>
                    <a:lnTo>
                      <a:pt x="873" y="743"/>
                    </a:lnTo>
                    <a:lnTo>
                      <a:pt x="873" y="743"/>
                    </a:lnTo>
                    <a:lnTo>
                      <a:pt x="874" y="743"/>
                    </a:lnTo>
                    <a:lnTo>
                      <a:pt x="874" y="743"/>
                    </a:lnTo>
                    <a:lnTo>
                      <a:pt x="875" y="743"/>
                    </a:lnTo>
                    <a:lnTo>
                      <a:pt x="875" y="743"/>
                    </a:lnTo>
                    <a:lnTo>
                      <a:pt x="876" y="743"/>
                    </a:lnTo>
                    <a:lnTo>
                      <a:pt x="876" y="743"/>
                    </a:lnTo>
                    <a:lnTo>
                      <a:pt x="877" y="743"/>
                    </a:lnTo>
                    <a:lnTo>
                      <a:pt x="877" y="743"/>
                    </a:lnTo>
                    <a:lnTo>
                      <a:pt x="878" y="743"/>
                    </a:lnTo>
                    <a:lnTo>
                      <a:pt x="878" y="743"/>
                    </a:lnTo>
                    <a:lnTo>
                      <a:pt x="879" y="743"/>
                    </a:lnTo>
                    <a:lnTo>
                      <a:pt x="879" y="743"/>
                    </a:lnTo>
                    <a:lnTo>
                      <a:pt x="880" y="731"/>
                    </a:lnTo>
                    <a:lnTo>
                      <a:pt x="880" y="743"/>
                    </a:lnTo>
                    <a:lnTo>
                      <a:pt x="881" y="743"/>
                    </a:lnTo>
                    <a:lnTo>
                      <a:pt x="881" y="743"/>
                    </a:lnTo>
                    <a:lnTo>
                      <a:pt x="882" y="740"/>
                    </a:lnTo>
                    <a:lnTo>
                      <a:pt x="882" y="743"/>
                    </a:lnTo>
                    <a:lnTo>
                      <a:pt x="883" y="743"/>
                    </a:lnTo>
                    <a:lnTo>
                      <a:pt x="883" y="743"/>
                    </a:lnTo>
                    <a:lnTo>
                      <a:pt x="884" y="186"/>
                    </a:lnTo>
                    <a:lnTo>
                      <a:pt x="884" y="743"/>
                    </a:lnTo>
                    <a:lnTo>
                      <a:pt x="885" y="743"/>
                    </a:lnTo>
                    <a:lnTo>
                      <a:pt x="885" y="743"/>
                    </a:lnTo>
                    <a:lnTo>
                      <a:pt x="886" y="592"/>
                    </a:lnTo>
                    <a:lnTo>
                      <a:pt x="886" y="743"/>
                    </a:lnTo>
                    <a:lnTo>
                      <a:pt x="887" y="743"/>
                    </a:lnTo>
                    <a:lnTo>
                      <a:pt x="887" y="743"/>
                    </a:lnTo>
                    <a:lnTo>
                      <a:pt x="888" y="716"/>
                    </a:lnTo>
                    <a:lnTo>
                      <a:pt x="888" y="743"/>
                    </a:lnTo>
                    <a:lnTo>
                      <a:pt x="889" y="743"/>
                    </a:lnTo>
                    <a:lnTo>
                      <a:pt x="889" y="698"/>
                    </a:lnTo>
                    <a:lnTo>
                      <a:pt x="890" y="740"/>
                    </a:lnTo>
                    <a:lnTo>
                      <a:pt x="890" y="743"/>
                    </a:lnTo>
                    <a:lnTo>
                      <a:pt x="891" y="743"/>
                    </a:lnTo>
                    <a:lnTo>
                      <a:pt x="891" y="740"/>
                    </a:lnTo>
                    <a:lnTo>
                      <a:pt x="892" y="743"/>
                    </a:lnTo>
                    <a:lnTo>
                      <a:pt x="892" y="743"/>
                    </a:lnTo>
                    <a:lnTo>
                      <a:pt x="893" y="743"/>
                    </a:lnTo>
                    <a:lnTo>
                      <a:pt x="893" y="740"/>
                    </a:lnTo>
                    <a:lnTo>
                      <a:pt x="894" y="740"/>
                    </a:lnTo>
                    <a:lnTo>
                      <a:pt x="894" y="743"/>
                    </a:lnTo>
                    <a:lnTo>
                      <a:pt x="895" y="743"/>
                    </a:lnTo>
                    <a:lnTo>
                      <a:pt x="895" y="742"/>
                    </a:lnTo>
                    <a:lnTo>
                      <a:pt x="896" y="743"/>
                    </a:lnTo>
                    <a:lnTo>
                      <a:pt x="896" y="743"/>
                    </a:lnTo>
                    <a:lnTo>
                      <a:pt x="897" y="743"/>
                    </a:lnTo>
                    <a:lnTo>
                      <a:pt x="897" y="743"/>
                    </a:lnTo>
                    <a:lnTo>
                      <a:pt x="898" y="743"/>
                    </a:lnTo>
                    <a:lnTo>
                      <a:pt x="898" y="743"/>
                    </a:lnTo>
                    <a:lnTo>
                      <a:pt x="899" y="743"/>
                    </a:lnTo>
                    <a:lnTo>
                      <a:pt x="899" y="743"/>
                    </a:lnTo>
                    <a:lnTo>
                      <a:pt x="900" y="743"/>
                    </a:lnTo>
                    <a:lnTo>
                      <a:pt x="900" y="743"/>
                    </a:lnTo>
                    <a:lnTo>
                      <a:pt x="901" y="743"/>
                    </a:lnTo>
                    <a:lnTo>
                      <a:pt x="901" y="743"/>
                    </a:lnTo>
                    <a:lnTo>
                      <a:pt x="902" y="743"/>
                    </a:lnTo>
                    <a:lnTo>
                      <a:pt x="902" y="743"/>
                    </a:lnTo>
                    <a:lnTo>
                      <a:pt x="903" y="743"/>
                    </a:lnTo>
                    <a:lnTo>
                      <a:pt x="903" y="743"/>
                    </a:lnTo>
                    <a:lnTo>
                      <a:pt x="904" y="743"/>
                    </a:lnTo>
                    <a:lnTo>
                      <a:pt x="904" y="743"/>
                    </a:lnTo>
                    <a:lnTo>
                      <a:pt x="905" y="743"/>
                    </a:lnTo>
                    <a:lnTo>
                      <a:pt x="905" y="743"/>
                    </a:lnTo>
                    <a:lnTo>
                      <a:pt x="906" y="743"/>
                    </a:lnTo>
                    <a:lnTo>
                      <a:pt x="906" y="743"/>
                    </a:lnTo>
                    <a:lnTo>
                      <a:pt x="907" y="743"/>
                    </a:lnTo>
                    <a:lnTo>
                      <a:pt x="907" y="737"/>
                    </a:lnTo>
                    <a:lnTo>
                      <a:pt x="908" y="743"/>
                    </a:lnTo>
                    <a:lnTo>
                      <a:pt x="908" y="743"/>
                    </a:lnTo>
                    <a:lnTo>
                      <a:pt x="909" y="743"/>
                    </a:lnTo>
                    <a:lnTo>
                      <a:pt x="909" y="742"/>
                    </a:lnTo>
                    <a:lnTo>
                      <a:pt x="910" y="743"/>
                    </a:lnTo>
                    <a:lnTo>
                      <a:pt x="910" y="743"/>
                    </a:lnTo>
                    <a:lnTo>
                      <a:pt x="911" y="743"/>
                    </a:lnTo>
                    <a:lnTo>
                      <a:pt x="911" y="734"/>
                    </a:lnTo>
                    <a:lnTo>
                      <a:pt x="912" y="741"/>
                    </a:lnTo>
                    <a:lnTo>
                      <a:pt x="912" y="743"/>
                    </a:lnTo>
                    <a:lnTo>
                      <a:pt x="913" y="743"/>
                    </a:lnTo>
                    <a:lnTo>
                      <a:pt x="913" y="741"/>
                    </a:lnTo>
                    <a:lnTo>
                      <a:pt x="914" y="743"/>
                    </a:lnTo>
                    <a:lnTo>
                      <a:pt x="914" y="743"/>
                    </a:lnTo>
                    <a:lnTo>
                      <a:pt x="915" y="743"/>
                    </a:lnTo>
                    <a:lnTo>
                      <a:pt x="915" y="701"/>
                    </a:lnTo>
                    <a:lnTo>
                      <a:pt x="916" y="738"/>
                    </a:lnTo>
                    <a:lnTo>
                      <a:pt x="916" y="743"/>
                    </a:lnTo>
                    <a:lnTo>
                      <a:pt x="917" y="731"/>
                    </a:lnTo>
                    <a:lnTo>
                      <a:pt x="917" y="743"/>
                    </a:lnTo>
                    <a:lnTo>
                      <a:pt x="918" y="743"/>
                    </a:lnTo>
                    <a:lnTo>
                      <a:pt x="918" y="743"/>
                    </a:lnTo>
                    <a:lnTo>
                      <a:pt x="919" y="742"/>
                    </a:lnTo>
                    <a:lnTo>
                      <a:pt x="919" y="743"/>
                    </a:lnTo>
                    <a:lnTo>
                      <a:pt x="920" y="743"/>
                    </a:lnTo>
                    <a:lnTo>
                      <a:pt x="920" y="743"/>
                    </a:lnTo>
                    <a:lnTo>
                      <a:pt x="921" y="740"/>
                    </a:lnTo>
                    <a:lnTo>
                      <a:pt x="921" y="743"/>
                    </a:lnTo>
                    <a:lnTo>
                      <a:pt x="922" y="743"/>
                    </a:lnTo>
                    <a:lnTo>
                      <a:pt x="922" y="743"/>
                    </a:lnTo>
                    <a:lnTo>
                      <a:pt x="923" y="743"/>
                    </a:lnTo>
                    <a:lnTo>
                      <a:pt x="923" y="743"/>
                    </a:lnTo>
                    <a:lnTo>
                      <a:pt x="924" y="743"/>
                    </a:lnTo>
                    <a:lnTo>
                      <a:pt x="924" y="743"/>
                    </a:lnTo>
                    <a:lnTo>
                      <a:pt x="925" y="739"/>
                    </a:lnTo>
                    <a:lnTo>
                      <a:pt x="925" y="743"/>
                    </a:lnTo>
                    <a:lnTo>
                      <a:pt x="926" y="743"/>
                    </a:lnTo>
                    <a:lnTo>
                      <a:pt x="926" y="743"/>
                    </a:lnTo>
                    <a:lnTo>
                      <a:pt x="927" y="735"/>
                    </a:lnTo>
                    <a:lnTo>
                      <a:pt x="927" y="743"/>
                    </a:lnTo>
                    <a:lnTo>
                      <a:pt x="928" y="743"/>
                    </a:lnTo>
                    <a:lnTo>
                      <a:pt x="928" y="743"/>
                    </a:lnTo>
                    <a:lnTo>
                      <a:pt x="929" y="741"/>
                    </a:lnTo>
                    <a:lnTo>
                      <a:pt x="929" y="743"/>
                    </a:lnTo>
                    <a:lnTo>
                      <a:pt x="930" y="743"/>
                    </a:lnTo>
                    <a:lnTo>
                      <a:pt x="930" y="743"/>
                    </a:lnTo>
                    <a:lnTo>
                      <a:pt x="931" y="491"/>
                    </a:lnTo>
                    <a:lnTo>
                      <a:pt x="931" y="743"/>
                    </a:lnTo>
                    <a:lnTo>
                      <a:pt x="932" y="743"/>
                    </a:lnTo>
                    <a:lnTo>
                      <a:pt x="932" y="743"/>
                    </a:lnTo>
                    <a:lnTo>
                      <a:pt x="933" y="670"/>
                    </a:lnTo>
                    <a:lnTo>
                      <a:pt x="933" y="743"/>
                    </a:lnTo>
                    <a:lnTo>
                      <a:pt x="934" y="743"/>
                    </a:lnTo>
                    <a:lnTo>
                      <a:pt x="934" y="743"/>
                    </a:lnTo>
                    <a:lnTo>
                      <a:pt x="935" y="617"/>
                    </a:lnTo>
                    <a:lnTo>
                      <a:pt x="935" y="743"/>
                    </a:lnTo>
                    <a:lnTo>
                      <a:pt x="936" y="743"/>
                    </a:lnTo>
                    <a:lnTo>
                      <a:pt x="936" y="743"/>
                    </a:lnTo>
                    <a:lnTo>
                      <a:pt x="937" y="707"/>
                    </a:lnTo>
                    <a:lnTo>
                      <a:pt x="937" y="743"/>
                    </a:lnTo>
                    <a:lnTo>
                      <a:pt x="938" y="743"/>
                    </a:lnTo>
                    <a:lnTo>
                      <a:pt x="938" y="743"/>
                    </a:lnTo>
                    <a:lnTo>
                      <a:pt x="939" y="265"/>
                    </a:lnTo>
                    <a:lnTo>
                      <a:pt x="939" y="743"/>
                    </a:lnTo>
                    <a:lnTo>
                      <a:pt x="940" y="743"/>
                    </a:lnTo>
                    <a:lnTo>
                      <a:pt x="940" y="743"/>
                    </a:lnTo>
                    <a:lnTo>
                      <a:pt x="941" y="605"/>
                    </a:lnTo>
                    <a:lnTo>
                      <a:pt x="941" y="743"/>
                    </a:lnTo>
                    <a:lnTo>
                      <a:pt x="942" y="743"/>
                    </a:lnTo>
                    <a:lnTo>
                      <a:pt x="942" y="743"/>
                    </a:lnTo>
                    <a:lnTo>
                      <a:pt x="943" y="717"/>
                    </a:lnTo>
                    <a:lnTo>
                      <a:pt x="943" y="743"/>
                    </a:lnTo>
                    <a:lnTo>
                      <a:pt x="944" y="743"/>
                    </a:lnTo>
                    <a:lnTo>
                      <a:pt x="944" y="743"/>
                    </a:lnTo>
                    <a:lnTo>
                      <a:pt x="945" y="740"/>
                    </a:lnTo>
                    <a:lnTo>
                      <a:pt x="945" y="743"/>
                    </a:lnTo>
                    <a:lnTo>
                      <a:pt x="946" y="743"/>
                    </a:lnTo>
                    <a:lnTo>
                      <a:pt x="946" y="743"/>
                    </a:lnTo>
                    <a:lnTo>
                      <a:pt x="947" y="743"/>
                    </a:lnTo>
                    <a:lnTo>
                      <a:pt x="947" y="743"/>
                    </a:lnTo>
                    <a:lnTo>
                      <a:pt x="948" y="743"/>
                    </a:lnTo>
                    <a:lnTo>
                      <a:pt x="948" y="743"/>
                    </a:lnTo>
                    <a:lnTo>
                      <a:pt x="949" y="743"/>
                    </a:lnTo>
                    <a:lnTo>
                      <a:pt x="949" y="743"/>
                    </a:lnTo>
                    <a:lnTo>
                      <a:pt x="950" y="743"/>
                    </a:lnTo>
                    <a:lnTo>
                      <a:pt x="950" y="743"/>
                    </a:lnTo>
                    <a:lnTo>
                      <a:pt x="951" y="743"/>
                    </a:lnTo>
                    <a:lnTo>
                      <a:pt x="951" y="743"/>
                    </a:lnTo>
                    <a:lnTo>
                      <a:pt x="952" y="743"/>
                    </a:lnTo>
                    <a:lnTo>
                      <a:pt x="952" y="743"/>
                    </a:lnTo>
                    <a:lnTo>
                      <a:pt x="953" y="743"/>
                    </a:lnTo>
                    <a:lnTo>
                      <a:pt x="953" y="743"/>
                    </a:lnTo>
                    <a:lnTo>
                      <a:pt x="954" y="743"/>
                    </a:lnTo>
                    <a:lnTo>
                      <a:pt x="954" y="743"/>
                    </a:lnTo>
                    <a:lnTo>
                      <a:pt x="955" y="743"/>
                    </a:lnTo>
                    <a:lnTo>
                      <a:pt x="955" y="743"/>
                    </a:lnTo>
                    <a:lnTo>
                      <a:pt x="956" y="743"/>
                    </a:lnTo>
                    <a:lnTo>
                      <a:pt x="956" y="743"/>
                    </a:lnTo>
                    <a:lnTo>
                      <a:pt x="957" y="739"/>
                    </a:lnTo>
                    <a:lnTo>
                      <a:pt x="957" y="743"/>
                    </a:lnTo>
                    <a:lnTo>
                      <a:pt x="958" y="743"/>
                    </a:lnTo>
                    <a:lnTo>
                      <a:pt x="958" y="743"/>
                    </a:lnTo>
                    <a:lnTo>
                      <a:pt x="959" y="743"/>
                    </a:lnTo>
                    <a:lnTo>
                      <a:pt x="959" y="742"/>
                    </a:lnTo>
                    <a:lnTo>
                      <a:pt x="960" y="743"/>
                    </a:lnTo>
                    <a:lnTo>
                      <a:pt x="960" y="743"/>
                    </a:lnTo>
                    <a:lnTo>
                      <a:pt x="961" y="743"/>
                    </a:lnTo>
                    <a:lnTo>
                      <a:pt x="961" y="743"/>
                    </a:lnTo>
                    <a:lnTo>
                      <a:pt x="962" y="743"/>
                    </a:lnTo>
                    <a:lnTo>
                      <a:pt x="962" y="743"/>
                    </a:lnTo>
                    <a:lnTo>
                      <a:pt x="963" y="743"/>
                    </a:lnTo>
                    <a:lnTo>
                      <a:pt x="963" y="743"/>
                    </a:lnTo>
                    <a:lnTo>
                      <a:pt x="964" y="743"/>
                    </a:lnTo>
                    <a:lnTo>
                      <a:pt x="964" y="736"/>
                    </a:lnTo>
                    <a:lnTo>
                      <a:pt x="965" y="743"/>
                    </a:lnTo>
                    <a:lnTo>
                      <a:pt x="965" y="743"/>
                    </a:lnTo>
                    <a:lnTo>
                      <a:pt x="966" y="742"/>
                    </a:lnTo>
                    <a:lnTo>
                      <a:pt x="966" y="743"/>
                    </a:lnTo>
                    <a:lnTo>
                      <a:pt x="967" y="742"/>
                    </a:lnTo>
                    <a:lnTo>
                      <a:pt x="967" y="743"/>
                    </a:lnTo>
                    <a:lnTo>
                      <a:pt x="968" y="743"/>
                    </a:lnTo>
                    <a:lnTo>
                      <a:pt x="968" y="743"/>
                    </a:lnTo>
                    <a:lnTo>
                      <a:pt x="969" y="743"/>
                    </a:lnTo>
                    <a:lnTo>
                      <a:pt x="969" y="743"/>
                    </a:lnTo>
                    <a:lnTo>
                      <a:pt x="970" y="743"/>
                    </a:lnTo>
                    <a:lnTo>
                      <a:pt x="970" y="743"/>
                    </a:lnTo>
                    <a:lnTo>
                      <a:pt x="971" y="725"/>
                    </a:lnTo>
                    <a:lnTo>
                      <a:pt x="971" y="743"/>
                    </a:lnTo>
                    <a:lnTo>
                      <a:pt x="972" y="743"/>
                    </a:lnTo>
                    <a:lnTo>
                      <a:pt x="972" y="743"/>
                    </a:lnTo>
                    <a:lnTo>
                      <a:pt x="973" y="738"/>
                    </a:lnTo>
                    <a:lnTo>
                      <a:pt x="973" y="743"/>
                    </a:lnTo>
                    <a:lnTo>
                      <a:pt x="974" y="743"/>
                    </a:lnTo>
                    <a:lnTo>
                      <a:pt x="974" y="743"/>
                    </a:lnTo>
                    <a:lnTo>
                      <a:pt x="975" y="743"/>
                    </a:lnTo>
                    <a:lnTo>
                      <a:pt x="975" y="740"/>
                    </a:lnTo>
                    <a:lnTo>
                      <a:pt x="976" y="743"/>
                    </a:lnTo>
                    <a:lnTo>
                      <a:pt x="976" y="743"/>
                    </a:lnTo>
                    <a:lnTo>
                      <a:pt x="977" y="743"/>
                    </a:lnTo>
                    <a:lnTo>
                      <a:pt x="977" y="743"/>
                    </a:lnTo>
                    <a:lnTo>
                      <a:pt x="978" y="743"/>
                    </a:lnTo>
                    <a:lnTo>
                      <a:pt x="978" y="743"/>
                    </a:lnTo>
                    <a:lnTo>
                      <a:pt x="979" y="515"/>
                    </a:lnTo>
                    <a:lnTo>
                      <a:pt x="979" y="743"/>
                    </a:lnTo>
                    <a:lnTo>
                      <a:pt x="980" y="743"/>
                    </a:lnTo>
                    <a:lnTo>
                      <a:pt x="980" y="742"/>
                    </a:lnTo>
                    <a:lnTo>
                      <a:pt x="981" y="674"/>
                    </a:lnTo>
                    <a:lnTo>
                      <a:pt x="981" y="743"/>
                    </a:lnTo>
                    <a:lnTo>
                      <a:pt x="982" y="743"/>
                    </a:lnTo>
                    <a:lnTo>
                      <a:pt x="982" y="743"/>
                    </a:lnTo>
                    <a:lnTo>
                      <a:pt x="983" y="720"/>
                    </a:lnTo>
                    <a:lnTo>
                      <a:pt x="983" y="743"/>
                    </a:lnTo>
                    <a:lnTo>
                      <a:pt x="984" y="743"/>
                    </a:lnTo>
                    <a:lnTo>
                      <a:pt x="984" y="743"/>
                    </a:lnTo>
                    <a:lnTo>
                      <a:pt x="985" y="738"/>
                    </a:lnTo>
                    <a:lnTo>
                      <a:pt x="985" y="743"/>
                    </a:lnTo>
                    <a:lnTo>
                      <a:pt x="986" y="743"/>
                    </a:lnTo>
                    <a:lnTo>
                      <a:pt x="986" y="743"/>
                    </a:lnTo>
                    <a:lnTo>
                      <a:pt x="987" y="739"/>
                    </a:lnTo>
                    <a:lnTo>
                      <a:pt x="987" y="743"/>
                    </a:lnTo>
                    <a:lnTo>
                      <a:pt x="988" y="743"/>
                    </a:lnTo>
                    <a:lnTo>
                      <a:pt x="988" y="743"/>
                    </a:lnTo>
                    <a:lnTo>
                      <a:pt x="989" y="742"/>
                    </a:lnTo>
                    <a:lnTo>
                      <a:pt x="989" y="743"/>
                    </a:lnTo>
                    <a:lnTo>
                      <a:pt x="990" y="743"/>
                    </a:lnTo>
                    <a:lnTo>
                      <a:pt x="990" y="743"/>
                    </a:lnTo>
                    <a:lnTo>
                      <a:pt x="991" y="740"/>
                    </a:lnTo>
                    <a:lnTo>
                      <a:pt x="991" y="743"/>
                    </a:lnTo>
                    <a:lnTo>
                      <a:pt x="992" y="743"/>
                    </a:lnTo>
                    <a:lnTo>
                      <a:pt x="992" y="743"/>
                    </a:lnTo>
                    <a:lnTo>
                      <a:pt x="993" y="742"/>
                    </a:lnTo>
                    <a:lnTo>
                      <a:pt x="993" y="743"/>
                    </a:lnTo>
                    <a:lnTo>
                      <a:pt x="994" y="743"/>
                    </a:lnTo>
                    <a:lnTo>
                      <a:pt x="994" y="743"/>
                    </a:lnTo>
                    <a:lnTo>
                      <a:pt x="995" y="743"/>
                    </a:lnTo>
                    <a:lnTo>
                      <a:pt x="995" y="743"/>
                    </a:lnTo>
                    <a:lnTo>
                      <a:pt x="996" y="743"/>
                    </a:lnTo>
                    <a:lnTo>
                      <a:pt x="996" y="743"/>
                    </a:lnTo>
                    <a:lnTo>
                      <a:pt x="997" y="743"/>
                    </a:lnTo>
                    <a:lnTo>
                      <a:pt x="997" y="743"/>
                    </a:lnTo>
                    <a:lnTo>
                      <a:pt x="998" y="743"/>
                    </a:lnTo>
                    <a:lnTo>
                      <a:pt x="998" y="743"/>
                    </a:lnTo>
                    <a:lnTo>
                      <a:pt x="999" y="741"/>
                    </a:lnTo>
                    <a:lnTo>
                      <a:pt x="999" y="743"/>
                    </a:lnTo>
                    <a:lnTo>
                      <a:pt x="1000" y="743"/>
                    </a:lnTo>
                    <a:lnTo>
                      <a:pt x="1000" y="743"/>
                    </a:lnTo>
                    <a:lnTo>
                      <a:pt x="1001" y="743"/>
                    </a:lnTo>
                    <a:lnTo>
                      <a:pt x="1001" y="743"/>
                    </a:lnTo>
                    <a:lnTo>
                      <a:pt x="1002" y="743"/>
                    </a:lnTo>
                    <a:lnTo>
                      <a:pt x="1002" y="736"/>
                    </a:lnTo>
                    <a:lnTo>
                      <a:pt x="1003" y="715"/>
                    </a:lnTo>
                    <a:lnTo>
                      <a:pt x="1003" y="743"/>
                    </a:lnTo>
                    <a:lnTo>
                      <a:pt x="1004" y="743"/>
                    </a:lnTo>
                    <a:lnTo>
                      <a:pt x="1004" y="735"/>
                    </a:lnTo>
                    <a:lnTo>
                      <a:pt x="1005" y="735"/>
                    </a:lnTo>
                    <a:lnTo>
                      <a:pt x="1005" y="743"/>
                    </a:lnTo>
                    <a:lnTo>
                      <a:pt x="1006" y="743"/>
                    </a:lnTo>
                    <a:lnTo>
                      <a:pt x="1006" y="742"/>
                    </a:lnTo>
                    <a:lnTo>
                      <a:pt x="1007" y="743"/>
                    </a:lnTo>
                    <a:lnTo>
                      <a:pt x="1007" y="743"/>
                    </a:lnTo>
                    <a:lnTo>
                      <a:pt x="1008" y="743"/>
                    </a:lnTo>
                    <a:lnTo>
                      <a:pt x="1008" y="743"/>
                    </a:lnTo>
                    <a:lnTo>
                      <a:pt x="1009" y="743"/>
                    </a:lnTo>
                    <a:lnTo>
                      <a:pt x="1009" y="743"/>
                    </a:lnTo>
                    <a:lnTo>
                      <a:pt x="1010" y="737"/>
                    </a:lnTo>
                    <a:lnTo>
                      <a:pt x="1010" y="743"/>
                    </a:lnTo>
                    <a:lnTo>
                      <a:pt x="1011" y="743"/>
                    </a:lnTo>
                    <a:lnTo>
                      <a:pt x="1011" y="743"/>
                    </a:lnTo>
                    <a:lnTo>
                      <a:pt x="1012" y="741"/>
                    </a:lnTo>
                    <a:lnTo>
                      <a:pt x="1012" y="743"/>
                    </a:lnTo>
                    <a:lnTo>
                      <a:pt x="1013" y="743"/>
                    </a:lnTo>
                    <a:lnTo>
                      <a:pt x="1013" y="743"/>
                    </a:lnTo>
                    <a:lnTo>
                      <a:pt x="1014" y="743"/>
                    </a:lnTo>
                    <a:lnTo>
                      <a:pt x="1014" y="743"/>
                    </a:lnTo>
                    <a:lnTo>
                      <a:pt x="1015" y="743"/>
                    </a:lnTo>
                    <a:lnTo>
                      <a:pt x="1015" y="743"/>
                    </a:lnTo>
                    <a:lnTo>
                      <a:pt x="1016" y="743"/>
                    </a:lnTo>
                    <a:lnTo>
                      <a:pt x="1016" y="743"/>
                    </a:lnTo>
                    <a:lnTo>
                      <a:pt x="1017" y="743"/>
                    </a:lnTo>
                    <a:lnTo>
                      <a:pt x="1017" y="743"/>
                    </a:lnTo>
                    <a:lnTo>
                      <a:pt x="1018" y="743"/>
                    </a:lnTo>
                    <a:lnTo>
                      <a:pt x="1018" y="743"/>
                    </a:lnTo>
                    <a:lnTo>
                      <a:pt x="1019" y="743"/>
                    </a:lnTo>
                    <a:lnTo>
                      <a:pt x="1019" y="743"/>
                    </a:lnTo>
                    <a:lnTo>
                      <a:pt x="1020" y="743"/>
                    </a:lnTo>
                    <a:lnTo>
                      <a:pt x="1020" y="743"/>
                    </a:lnTo>
                    <a:lnTo>
                      <a:pt x="1021" y="743"/>
                    </a:lnTo>
                    <a:lnTo>
                      <a:pt x="1021" y="743"/>
                    </a:lnTo>
                    <a:lnTo>
                      <a:pt x="1022" y="741"/>
                    </a:lnTo>
                    <a:lnTo>
                      <a:pt x="1022" y="743"/>
                    </a:lnTo>
                    <a:lnTo>
                      <a:pt x="1023" y="743"/>
                    </a:lnTo>
                    <a:lnTo>
                      <a:pt x="1023" y="715"/>
                    </a:lnTo>
                    <a:lnTo>
                      <a:pt x="1024" y="743"/>
                    </a:lnTo>
                    <a:lnTo>
                      <a:pt x="1024" y="743"/>
                    </a:lnTo>
                    <a:lnTo>
                      <a:pt x="1025" y="741"/>
                    </a:lnTo>
                    <a:lnTo>
                      <a:pt x="1025" y="743"/>
                    </a:lnTo>
                    <a:lnTo>
                      <a:pt x="1026" y="743"/>
                    </a:lnTo>
                    <a:lnTo>
                      <a:pt x="1026" y="720"/>
                    </a:lnTo>
                    <a:lnTo>
                      <a:pt x="1027" y="743"/>
                    </a:lnTo>
                    <a:lnTo>
                      <a:pt x="1027" y="743"/>
                    </a:lnTo>
                    <a:lnTo>
                      <a:pt x="1028" y="736"/>
                    </a:lnTo>
                    <a:lnTo>
                      <a:pt x="1028" y="743"/>
                    </a:lnTo>
                    <a:lnTo>
                      <a:pt x="1029" y="743"/>
                    </a:lnTo>
                    <a:lnTo>
                      <a:pt x="1029" y="743"/>
                    </a:lnTo>
                    <a:lnTo>
                      <a:pt x="1030" y="736"/>
                    </a:lnTo>
                    <a:lnTo>
                      <a:pt x="1030" y="743"/>
                    </a:lnTo>
                    <a:lnTo>
                      <a:pt x="1031" y="743"/>
                    </a:lnTo>
                    <a:lnTo>
                      <a:pt x="1031" y="743"/>
                    </a:lnTo>
                    <a:lnTo>
                      <a:pt x="1032" y="741"/>
                    </a:lnTo>
                    <a:lnTo>
                      <a:pt x="1032" y="743"/>
                    </a:lnTo>
                    <a:lnTo>
                      <a:pt x="1033" y="743"/>
                    </a:lnTo>
                    <a:lnTo>
                      <a:pt x="1033" y="743"/>
                    </a:lnTo>
                    <a:lnTo>
                      <a:pt x="1034" y="742"/>
                    </a:lnTo>
                    <a:lnTo>
                      <a:pt x="1034" y="743"/>
                    </a:lnTo>
                    <a:lnTo>
                      <a:pt x="1035" y="743"/>
                    </a:lnTo>
                    <a:lnTo>
                      <a:pt x="1035" y="743"/>
                    </a:lnTo>
                    <a:lnTo>
                      <a:pt x="1036" y="743"/>
                    </a:lnTo>
                    <a:lnTo>
                      <a:pt x="1036" y="743"/>
                    </a:lnTo>
                    <a:lnTo>
                      <a:pt x="1037" y="743"/>
                    </a:lnTo>
                    <a:lnTo>
                      <a:pt x="1037" y="743"/>
                    </a:lnTo>
                    <a:lnTo>
                      <a:pt x="1038" y="743"/>
                    </a:lnTo>
                    <a:lnTo>
                      <a:pt x="1038" y="743"/>
                    </a:lnTo>
                    <a:lnTo>
                      <a:pt x="1039" y="743"/>
                    </a:lnTo>
                    <a:lnTo>
                      <a:pt x="1039" y="743"/>
                    </a:lnTo>
                    <a:lnTo>
                      <a:pt x="1040" y="743"/>
                    </a:lnTo>
                    <a:lnTo>
                      <a:pt x="1040" y="743"/>
                    </a:lnTo>
                    <a:lnTo>
                      <a:pt x="1041" y="743"/>
                    </a:lnTo>
                    <a:lnTo>
                      <a:pt x="1041" y="743"/>
                    </a:lnTo>
                    <a:lnTo>
                      <a:pt x="1042" y="743"/>
                    </a:lnTo>
                    <a:lnTo>
                      <a:pt x="1042" y="743"/>
                    </a:lnTo>
                    <a:lnTo>
                      <a:pt x="1043" y="743"/>
                    </a:lnTo>
                    <a:lnTo>
                      <a:pt x="1043" y="743"/>
                    </a:lnTo>
                    <a:lnTo>
                      <a:pt x="1044" y="740"/>
                    </a:lnTo>
                    <a:lnTo>
                      <a:pt x="1044" y="743"/>
                    </a:lnTo>
                    <a:lnTo>
                      <a:pt x="1045" y="743"/>
                    </a:lnTo>
                    <a:lnTo>
                      <a:pt x="1045" y="743"/>
                    </a:lnTo>
                    <a:lnTo>
                      <a:pt x="1046" y="743"/>
                    </a:lnTo>
                    <a:lnTo>
                      <a:pt x="1046" y="743"/>
                    </a:lnTo>
                    <a:lnTo>
                      <a:pt x="1047" y="743"/>
                    </a:lnTo>
                    <a:lnTo>
                      <a:pt x="1047" y="743"/>
                    </a:lnTo>
                    <a:lnTo>
                      <a:pt x="1048" y="743"/>
                    </a:lnTo>
                    <a:lnTo>
                      <a:pt x="1048" y="743"/>
                    </a:lnTo>
                    <a:lnTo>
                      <a:pt x="1049" y="743"/>
                    </a:lnTo>
                    <a:lnTo>
                      <a:pt x="1049" y="743"/>
                    </a:lnTo>
                    <a:lnTo>
                      <a:pt x="1050" y="743"/>
                    </a:lnTo>
                    <a:lnTo>
                      <a:pt x="1050" y="743"/>
                    </a:lnTo>
                    <a:lnTo>
                      <a:pt x="1051" y="739"/>
                    </a:lnTo>
                    <a:lnTo>
                      <a:pt x="1051" y="743"/>
                    </a:lnTo>
                    <a:lnTo>
                      <a:pt x="1052" y="743"/>
                    </a:lnTo>
                    <a:lnTo>
                      <a:pt x="1052" y="743"/>
                    </a:lnTo>
                    <a:lnTo>
                      <a:pt x="1053" y="743"/>
                    </a:lnTo>
                    <a:lnTo>
                      <a:pt x="1053" y="743"/>
                    </a:lnTo>
                    <a:lnTo>
                      <a:pt x="1054" y="743"/>
                    </a:lnTo>
                    <a:lnTo>
                      <a:pt x="1054" y="743"/>
                    </a:lnTo>
                    <a:lnTo>
                      <a:pt x="1055" y="743"/>
                    </a:lnTo>
                    <a:lnTo>
                      <a:pt x="1055" y="743"/>
                    </a:lnTo>
                    <a:lnTo>
                      <a:pt x="1056" y="743"/>
                    </a:lnTo>
                    <a:lnTo>
                      <a:pt x="1056" y="743"/>
                    </a:lnTo>
                    <a:lnTo>
                      <a:pt x="1057" y="743"/>
                    </a:lnTo>
                    <a:lnTo>
                      <a:pt x="1057" y="743"/>
                    </a:lnTo>
                    <a:lnTo>
                      <a:pt x="1058" y="729"/>
                    </a:lnTo>
                    <a:lnTo>
                      <a:pt x="1058" y="743"/>
                    </a:lnTo>
                    <a:lnTo>
                      <a:pt x="1059" y="743"/>
                    </a:lnTo>
                    <a:lnTo>
                      <a:pt x="1059" y="743"/>
                    </a:lnTo>
                    <a:lnTo>
                      <a:pt x="1060" y="743"/>
                    </a:lnTo>
                    <a:lnTo>
                      <a:pt x="1060" y="739"/>
                    </a:lnTo>
                    <a:lnTo>
                      <a:pt x="1061" y="743"/>
                    </a:lnTo>
                    <a:lnTo>
                      <a:pt x="1061" y="743"/>
                    </a:lnTo>
                    <a:lnTo>
                      <a:pt x="1062" y="743"/>
                    </a:lnTo>
                    <a:lnTo>
                      <a:pt x="1062" y="743"/>
                    </a:lnTo>
                    <a:lnTo>
                      <a:pt x="1063" y="743"/>
                    </a:lnTo>
                    <a:lnTo>
                      <a:pt x="1063" y="743"/>
                    </a:lnTo>
                    <a:lnTo>
                      <a:pt x="1064" y="743"/>
                    </a:lnTo>
                    <a:lnTo>
                      <a:pt x="1064" y="743"/>
                    </a:lnTo>
                    <a:lnTo>
                      <a:pt x="1065" y="743"/>
                    </a:lnTo>
                    <a:lnTo>
                      <a:pt x="1065" y="743"/>
                    </a:lnTo>
                    <a:lnTo>
                      <a:pt x="1066" y="743"/>
                    </a:lnTo>
                    <a:lnTo>
                      <a:pt x="1066" y="743"/>
                    </a:lnTo>
                    <a:lnTo>
                      <a:pt x="1067" y="743"/>
                    </a:lnTo>
                    <a:lnTo>
                      <a:pt x="1067" y="743"/>
                    </a:lnTo>
                    <a:lnTo>
                      <a:pt x="1068" y="742"/>
                    </a:lnTo>
                    <a:lnTo>
                      <a:pt x="1068" y="743"/>
                    </a:lnTo>
                    <a:lnTo>
                      <a:pt x="1069" y="743"/>
                    </a:lnTo>
                    <a:lnTo>
                      <a:pt x="1069" y="743"/>
                    </a:lnTo>
                    <a:lnTo>
                      <a:pt x="1070" y="743"/>
                    </a:lnTo>
                    <a:lnTo>
                      <a:pt x="1070" y="743"/>
                    </a:lnTo>
                    <a:lnTo>
                      <a:pt x="1071" y="743"/>
                    </a:lnTo>
                    <a:lnTo>
                      <a:pt x="1071" y="743"/>
                    </a:lnTo>
                    <a:lnTo>
                      <a:pt x="1072" y="743"/>
                    </a:lnTo>
                    <a:lnTo>
                      <a:pt x="1072" y="743"/>
                    </a:lnTo>
                    <a:lnTo>
                      <a:pt x="1073" y="743"/>
                    </a:lnTo>
                    <a:lnTo>
                      <a:pt x="1073" y="743"/>
                    </a:lnTo>
                    <a:lnTo>
                      <a:pt x="1074" y="743"/>
                    </a:lnTo>
                    <a:lnTo>
                      <a:pt x="1074" y="743"/>
                    </a:lnTo>
                    <a:lnTo>
                      <a:pt x="1075" y="743"/>
                    </a:lnTo>
                    <a:lnTo>
                      <a:pt x="1075" y="743"/>
                    </a:lnTo>
                    <a:lnTo>
                      <a:pt x="1076" y="743"/>
                    </a:lnTo>
                    <a:lnTo>
                      <a:pt x="1076" y="743"/>
                    </a:lnTo>
                    <a:lnTo>
                      <a:pt x="1077" y="743"/>
                    </a:lnTo>
                    <a:lnTo>
                      <a:pt x="1077" y="743"/>
                    </a:lnTo>
                    <a:lnTo>
                      <a:pt x="1078" y="743"/>
                    </a:lnTo>
                    <a:lnTo>
                      <a:pt x="1078" y="743"/>
                    </a:lnTo>
                    <a:lnTo>
                      <a:pt x="1079" y="743"/>
                    </a:lnTo>
                    <a:lnTo>
                      <a:pt x="1079" y="743"/>
                    </a:lnTo>
                    <a:lnTo>
                      <a:pt x="1080" y="743"/>
                    </a:lnTo>
                    <a:lnTo>
                      <a:pt x="1080" y="743"/>
                    </a:lnTo>
                    <a:lnTo>
                      <a:pt x="1081" y="743"/>
                    </a:lnTo>
                    <a:lnTo>
                      <a:pt x="1081" y="743"/>
                    </a:lnTo>
                    <a:lnTo>
                      <a:pt x="1082" y="743"/>
                    </a:lnTo>
                    <a:lnTo>
                      <a:pt x="1082" y="743"/>
                    </a:lnTo>
                    <a:lnTo>
                      <a:pt x="1083" y="743"/>
                    </a:lnTo>
                    <a:lnTo>
                      <a:pt x="1083" y="743"/>
                    </a:lnTo>
                    <a:lnTo>
                      <a:pt x="1084" y="743"/>
                    </a:lnTo>
                    <a:lnTo>
                      <a:pt x="1084" y="743"/>
                    </a:lnTo>
                    <a:lnTo>
                      <a:pt x="1085" y="743"/>
                    </a:lnTo>
                    <a:lnTo>
                      <a:pt x="1085" y="743"/>
                    </a:lnTo>
                    <a:lnTo>
                      <a:pt x="1086" y="742"/>
                    </a:lnTo>
                    <a:lnTo>
                      <a:pt x="1086" y="743"/>
                    </a:lnTo>
                    <a:lnTo>
                      <a:pt x="1087" y="743"/>
                    </a:lnTo>
                    <a:lnTo>
                      <a:pt x="1087" y="743"/>
                    </a:lnTo>
                    <a:lnTo>
                      <a:pt x="1088" y="743"/>
                    </a:lnTo>
                    <a:lnTo>
                      <a:pt x="1088" y="743"/>
                    </a:lnTo>
                    <a:lnTo>
                      <a:pt x="1089" y="743"/>
                    </a:lnTo>
                    <a:lnTo>
                      <a:pt x="1089" y="743"/>
                    </a:lnTo>
                    <a:lnTo>
                      <a:pt x="1090" y="743"/>
                    </a:lnTo>
                    <a:lnTo>
                      <a:pt x="1090" y="724"/>
                    </a:lnTo>
                    <a:lnTo>
                      <a:pt x="1091" y="743"/>
                    </a:lnTo>
                    <a:lnTo>
                      <a:pt x="1091" y="743"/>
                    </a:lnTo>
                    <a:lnTo>
                      <a:pt x="1092" y="737"/>
                    </a:lnTo>
                    <a:lnTo>
                      <a:pt x="1092" y="743"/>
                    </a:lnTo>
                    <a:lnTo>
                      <a:pt x="1093" y="743"/>
                    </a:lnTo>
                    <a:lnTo>
                      <a:pt x="1093" y="743"/>
                    </a:lnTo>
                    <a:lnTo>
                      <a:pt x="1094" y="743"/>
                    </a:lnTo>
                    <a:lnTo>
                      <a:pt x="1094" y="743"/>
                    </a:lnTo>
                    <a:lnTo>
                      <a:pt x="1095" y="743"/>
                    </a:lnTo>
                    <a:lnTo>
                      <a:pt x="1095" y="743"/>
                    </a:lnTo>
                    <a:lnTo>
                      <a:pt x="1096" y="743"/>
                    </a:lnTo>
                    <a:lnTo>
                      <a:pt x="1096" y="743"/>
                    </a:lnTo>
                    <a:lnTo>
                      <a:pt x="1097" y="743"/>
                    </a:lnTo>
                    <a:lnTo>
                      <a:pt x="1097" y="743"/>
                    </a:lnTo>
                    <a:lnTo>
                      <a:pt x="1098" y="743"/>
                    </a:lnTo>
                    <a:lnTo>
                      <a:pt x="1098" y="743"/>
                    </a:lnTo>
                    <a:lnTo>
                      <a:pt x="1099" y="743"/>
                    </a:lnTo>
                    <a:lnTo>
                      <a:pt x="1099" y="742"/>
                    </a:lnTo>
                    <a:lnTo>
                      <a:pt x="1100" y="743"/>
                    </a:lnTo>
                    <a:lnTo>
                      <a:pt x="1100" y="743"/>
                    </a:lnTo>
                    <a:lnTo>
                      <a:pt x="1101" y="743"/>
                    </a:lnTo>
                    <a:lnTo>
                      <a:pt x="1101" y="743"/>
                    </a:lnTo>
                    <a:lnTo>
                      <a:pt x="1102" y="743"/>
                    </a:lnTo>
                    <a:lnTo>
                      <a:pt x="1102" y="743"/>
                    </a:lnTo>
                    <a:lnTo>
                      <a:pt x="1103" y="743"/>
                    </a:lnTo>
                    <a:lnTo>
                      <a:pt x="1103" y="743"/>
                    </a:lnTo>
                    <a:lnTo>
                      <a:pt x="1104" y="743"/>
                    </a:lnTo>
                    <a:lnTo>
                      <a:pt x="1104" y="743"/>
                    </a:lnTo>
                    <a:lnTo>
                      <a:pt x="1105" y="743"/>
                    </a:lnTo>
                    <a:lnTo>
                      <a:pt x="1105" y="743"/>
                    </a:lnTo>
                    <a:lnTo>
                      <a:pt x="1106" y="743"/>
                    </a:lnTo>
                    <a:lnTo>
                      <a:pt x="1106" y="743"/>
                    </a:lnTo>
                    <a:lnTo>
                      <a:pt x="1107" y="743"/>
                    </a:lnTo>
                    <a:lnTo>
                      <a:pt x="1107" y="743"/>
                    </a:lnTo>
                    <a:lnTo>
                      <a:pt x="1108" y="743"/>
                    </a:lnTo>
                    <a:lnTo>
                      <a:pt x="1108" y="743"/>
                    </a:lnTo>
                    <a:lnTo>
                      <a:pt x="1109" y="743"/>
                    </a:lnTo>
                    <a:lnTo>
                      <a:pt x="1109" y="743"/>
                    </a:lnTo>
                    <a:lnTo>
                      <a:pt x="1110" y="743"/>
                    </a:lnTo>
                    <a:lnTo>
                      <a:pt x="1110" y="743"/>
                    </a:lnTo>
                    <a:lnTo>
                      <a:pt x="1111" y="743"/>
                    </a:lnTo>
                    <a:lnTo>
                      <a:pt x="1111" y="743"/>
                    </a:lnTo>
                    <a:lnTo>
                      <a:pt x="1112" y="743"/>
                    </a:lnTo>
                    <a:lnTo>
                      <a:pt x="1112" y="743"/>
                    </a:lnTo>
                    <a:lnTo>
                      <a:pt x="1113" y="743"/>
                    </a:lnTo>
                    <a:lnTo>
                      <a:pt x="1113" y="743"/>
                    </a:lnTo>
                    <a:lnTo>
                      <a:pt x="1114" y="743"/>
                    </a:lnTo>
                    <a:lnTo>
                      <a:pt x="1114" y="743"/>
                    </a:lnTo>
                    <a:lnTo>
                      <a:pt x="1115" y="743"/>
                    </a:lnTo>
                    <a:lnTo>
                      <a:pt x="1115" y="743"/>
                    </a:lnTo>
                    <a:lnTo>
                      <a:pt x="1116" y="743"/>
                    </a:lnTo>
                    <a:lnTo>
                      <a:pt x="1116" y="743"/>
                    </a:lnTo>
                    <a:lnTo>
                      <a:pt x="1117" y="743"/>
                    </a:lnTo>
                    <a:lnTo>
                      <a:pt x="1117" y="742"/>
                    </a:lnTo>
                    <a:lnTo>
                      <a:pt x="1118" y="743"/>
                    </a:lnTo>
                    <a:lnTo>
                      <a:pt x="1118" y="743"/>
                    </a:lnTo>
                    <a:lnTo>
                      <a:pt x="1119" y="743"/>
                    </a:lnTo>
                    <a:lnTo>
                      <a:pt x="1119" y="743"/>
                    </a:lnTo>
                    <a:lnTo>
                      <a:pt x="1120" y="743"/>
                    </a:lnTo>
                    <a:lnTo>
                      <a:pt x="1120" y="743"/>
                    </a:lnTo>
                    <a:lnTo>
                      <a:pt x="1121" y="743"/>
                    </a:lnTo>
                    <a:lnTo>
                      <a:pt x="1121" y="743"/>
                    </a:lnTo>
                    <a:lnTo>
                      <a:pt x="1122" y="743"/>
                    </a:lnTo>
                    <a:lnTo>
                      <a:pt x="1122" y="743"/>
                    </a:lnTo>
                    <a:lnTo>
                      <a:pt x="1123" y="743"/>
                    </a:lnTo>
                    <a:lnTo>
                      <a:pt x="1123" y="743"/>
                    </a:lnTo>
                    <a:lnTo>
                      <a:pt x="1125" y="743"/>
                    </a:lnTo>
                    <a:lnTo>
                      <a:pt x="1125" y="743"/>
                    </a:lnTo>
                    <a:lnTo>
                      <a:pt x="1125" y="743"/>
                    </a:lnTo>
                    <a:lnTo>
                      <a:pt x="1126" y="743"/>
                    </a:lnTo>
                    <a:lnTo>
                      <a:pt x="1126" y="743"/>
                    </a:lnTo>
                    <a:lnTo>
                      <a:pt x="1127" y="743"/>
                    </a:lnTo>
                    <a:lnTo>
                      <a:pt x="1127" y="743"/>
                    </a:lnTo>
                    <a:lnTo>
                      <a:pt x="1128" y="743"/>
                    </a:lnTo>
                    <a:lnTo>
                      <a:pt x="1128" y="743"/>
                    </a:lnTo>
                    <a:lnTo>
                      <a:pt x="1129" y="743"/>
                    </a:lnTo>
                    <a:lnTo>
                      <a:pt x="1129" y="743"/>
                    </a:lnTo>
                    <a:lnTo>
                      <a:pt x="1130" y="743"/>
                    </a:lnTo>
                    <a:lnTo>
                      <a:pt x="1130" y="743"/>
                    </a:lnTo>
                    <a:lnTo>
                      <a:pt x="1131" y="742"/>
                    </a:lnTo>
                    <a:lnTo>
                      <a:pt x="1131" y="743"/>
                    </a:lnTo>
                    <a:lnTo>
                      <a:pt x="1132" y="743"/>
                    </a:lnTo>
                    <a:lnTo>
                      <a:pt x="1132" y="743"/>
                    </a:lnTo>
                    <a:lnTo>
                      <a:pt x="1133" y="743"/>
                    </a:lnTo>
                    <a:lnTo>
                      <a:pt x="1133" y="743"/>
                    </a:lnTo>
                    <a:lnTo>
                      <a:pt x="1134" y="743"/>
                    </a:lnTo>
                    <a:lnTo>
                      <a:pt x="1134" y="743"/>
                    </a:lnTo>
                    <a:lnTo>
                      <a:pt x="1135" y="743"/>
                    </a:lnTo>
                    <a:lnTo>
                      <a:pt x="1135" y="743"/>
                    </a:lnTo>
                    <a:lnTo>
                      <a:pt x="1136" y="743"/>
                    </a:lnTo>
                    <a:lnTo>
                      <a:pt x="1136" y="743"/>
                    </a:lnTo>
                    <a:lnTo>
                      <a:pt x="1137" y="743"/>
                    </a:lnTo>
                    <a:lnTo>
                      <a:pt x="1137" y="743"/>
                    </a:lnTo>
                    <a:lnTo>
                      <a:pt x="1138" y="743"/>
                    </a:lnTo>
                    <a:lnTo>
                      <a:pt x="1138" y="743"/>
                    </a:lnTo>
                    <a:lnTo>
                      <a:pt x="1139" y="743"/>
                    </a:lnTo>
                    <a:lnTo>
                      <a:pt x="1139" y="743"/>
                    </a:lnTo>
                    <a:lnTo>
                      <a:pt x="1140" y="742"/>
                    </a:lnTo>
                    <a:lnTo>
                      <a:pt x="1140" y="743"/>
                    </a:lnTo>
                    <a:lnTo>
                      <a:pt x="1141" y="743"/>
                    </a:lnTo>
                    <a:lnTo>
                      <a:pt x="1141" y="743"/>
                    </a:lnTo>
                    <a:lnTo>
                      <a:pt x="1142" y="743"/>
                    </a:lnTo>
                    <a:lnTo>
                      <a:pt x="1142" y="743"/>
                    </a:lnTo>
                    <a:lnTo>
                      <a:pt x="1143" y="743"/>
                    </a:lnTo>
                    <a:lnTo>
                      <a:pt x="1143" y="743"/>
                    </a:lnTo>
                    <a:lnTo>
                      <a:pt x="1144" y="743"/>
                    </a:lnTo>
                    <a:lnTo>
                      <a:pt x="1144" y="743"/>
                    </a:lnTo>
                    <a:lnTo>
                      <a:pt x="1145" y="743"/>
                    </a:lnTo>
                    <a:lnTo>
                      <a:pt x="1145" y="734"/>
                    </a:lnTo>
                    <a:lnTo>
                      <a:pt x="1146" y="743"/>
                    </a:lnTo>
                    <a:lnTo>
                      <a:pt x="1146" y="743"/>
                    </a:lnTo>
                    <a:lnTo>
                      <a:pt x="1147" y="743"/>
                    </a:lnTo>
                    <a:lnTo>
                      <a:pt x="1147" y="741"/>
                    </a:lnTo>
                    <a:lnTo>
                      <a:pt x="1148" y="743"/>
                    </a:lnTo>
                    <a:lnTo>
                      <a:pt x="1148" y="743"/>
                    </a:lnTo>
                    <a:lnTo>
                      <a:pt x="1149" y="743"/>
                    </a:lnTo>
                    <a:lnTo>
                      <a:pt x="1149" y="743"/>
                    </a:lnTo>
                    <a:lnTo>
                      <a:pt x="1150" y="743"/>
                    </a:lnTo>
                    <a:lnTo>
                      <a:pt x="1150" y="743"/>
                    </a:lnTo>
                    <a:lnTo>
                      <a:pt x="1151" y="743"/>
                    </a:lnTo>
                    <a:lnTo>
                      <a:pt x="1151" y="743"/>
                    </a:lnTo>
                    <a:lnTo>
                      <a:pt x="1152" y="743"/>
                    </a:lnTo>
                    <a:lnTo>
                      <a:pt x="1152" y="743"/>
                    </a:lnTo>
                    <a:lnTo>
                      <a:pt x="1153" y="743"/>
                    </a:lnTo>
                    <a:lnTo>
                      <a:pt x="1153" y="743"/>
                    </a:lnTo>
                    <a:lnTo>
                      <a:pt x="1154" y="743"/>
                    </a:lnTo>
                    <a:lnTo>
                      <a:pt x="1154" y="743"/>
                    </a:lnTo>
                    <a:lnTo>
                      <a:pt x="1155" y="743"/>
                    </a:lnTo>
                    <a:lnTo>
                      <a:pt x="1155" y="743"/>
                    </a:lnTo>
                    <a:lnTo>
                      <a:pt x="1156" y="743"/>
                    </a:lnTo>
                    <a:lnTo>
                      <a:pt x="1156" y="743"/>
                    </a:lnTo>
                    <a:lnTo>
                      <a:pt x="1157" y="743"/>
                    </a:lnTo>
                    <a:lnTo>
                      <a:pt x="1157" y="743"/>
                    </a:lnTo>
                    <a:lnTo>
                      <a:pt x="1158" y="743"/>
                    </a:lnTo>
                    <a:lnTo>
                      <a:pt x="1158" y="724"/>
                    </a:lnTo>
                    <a:lnTo>
                      <a:pt x="1159" y="743"/>
                    </a:lnTo>
                    <a:lnTo>
                      <a:pt x="1159" y="743"/>
                    </a:lnTo>
                    <a:lnTo>
                      <a:pt x="1160" y="741"/>
                    </a:lnTo>
                    <a:lnTo>
                      <a:pt x="1160" y="743"/>
                    </a:lnTo>
                    <a:lnTo>
                      <a:pt x="1161" y="743"/>
                    </a:lnTo>
                    <a:lnTo>
                      <a:pt x="1161" y="743"/>
                    </a:lnTo>
                    <a:lnTo>
                      <a:pt x="1162" y="743"/>
                    </a:lnTo>
                    <a:lnTo>
                      <a:pt x="1162" y="743"/>
                    </a:lnTo>
                    <a:lnTo>
                      <a:pt x="1163" y="743"/>
                    </a:lnTo>
                    <a:lnTo>
                      <a:pt x="1163" y="743"/>
                    </a:lnTo>
                    <a:lnTo>
                      <a:pt x="1164" y="743"/>
                    </a:lnTo>
                    <a:lnTo>
                      <a:pt x="1164" y="743"/>
                    </a:lnTo>
                    <a:lnTo>
                      <a:pt x="1165" y="743"/>
                    </a:lnTo>
                    <a:lnTo>
                      <a:pt x="1165" y="743"/>
                    </a:lnTo>
                    <a:lnTo>
                      <a:pt x="1166" y="743"/>
                    </a:lnTo>
                    <a:lnTo>
                      <a:pt x="1166" y="743"/>
                    </a:lnTo>
                    <a:lnTo>
                      <a:pt x="1167" y="743"/>
                    </a:lnTo>
                    <a:lnTo>
                      <a:pt x="1167" y="743"/>
                    </a:lnTo>
                    <a:lnTo>
                      <a:pt x="1168" y="743"/>
                    </a:lnTo>
                    <a:lnTo>
                      <a:pt x="1168" y="743"/>
                    </a:lnTo>
                    <a:lnTo>
                      <a:pt x="1169" y="743"/>
                    </a:lnTo>
                    <a:lnTo>
                      <a:pt x="1169" y="743"/>
                    </a:lnTo>
                    <a:lnTo>
                      <a:pt x="1170" y="743"/>
                    </a:lnTo>
                    <a:lnTo>
                      <a:pt x="1170" y="743"/>
                    </a:lnTo>
                    <a:lnTo>
                      <a:pt x="1171" y="743"/>
                    </a:lnTo>
                    <a:lnTo>
                      <a:pt x="1171" y="743"/>
                    </a:lnTo>
                    <a:lnTo>
                      <a:pt x="1172" y="743"/>
                    </a:lnTo>
                    <a:lnTo>
                      <a:pt x="1172" y="743"/>
                    </a:lnTo>
                    <a:lnTo>
                      <a:pt x="1173" y="743"/>
                    </a:lnTo>
                    <a:lnTo>
                      <a:pt x="1173" y="743"/>
                    </a:lnTo>
                    <a:lnTo>
                      <a:pt x="1174" y="743"/>
                    </a:lnTo>
                    <a:lnTo>
                      <a:pt x="1174" y="743"/>
                    </a:lnTo>
                    <a:lnTo>
                      <a:pt x="1175" y="743"/>
                    </a:lnTo>
                    <a:lnTo>
                      <a:pt x="1175" y="743"/>
                    </a:lnTo>
                    <a:lnTo>
                      <a:pt x="1176" y="743"/>
                    </a:lnTo>
                    <a:lnTo>
                      <a:pt x="1176" y="743"/>
                    </a:lnTo>
                    <a:lnTo>
                      <a:pt x="1177" y="731"/>
                    </a:lnTo>
                    <a:lnTo>
                      <a:pt x="1177" y="743"/>
                    </a:lnTo>
                    <a:lnTo>
                      <a:pt x="1178" y="743"/>
                    </a:lnTo>
                    <a:lnTo>
                      <a:pt x="1178" y="743"/>
                    </a:lnTo>
                    <a:lnTo>
                      <a:pt x="1179" y="740"/>
                    </a:lnTo>
                    <a:lnTo>
                      <a:pt x="1179" y="743"/>
                    </a:lnTo>
                    <a:lnTo>
                      <a:pt x="1180" y="743"/>
                    </a:lnTo>
                    <a:lnTo>
                      <a:pt x="1180" y="743"/>
                    </a:lnTo>
                    <a:lnTo>
                      <a:pt x="1181" y="743"/>
                    </a:lnTo>
                    <a:lnTo>
                      <a:pt x="1181" y="743"/>
                    </a:lnTo>
                    <a:lnTo>
                      <a:pt x="1182" y="743"/>
                    </a:lnTo>
                    <a:lnTo>
                      <a:pt x="1182" y="743"/>
                    </a:lnTo>
                    <a:lnTo>
                      <a:pt x="1183" y="743"/>
                    </a:lnTo>
                    <a:lnTo>
                      <a:pt x="1183" y="743"/>
                    </a:lnTo>
                    <a:lnTo>
                      <a:pt x="1184" y="743"/>
                    </a:lnTo>
                    <a:lnTo>
                      <a:pt x="1184" y="743"/>
                    </a:lnTo>
                    <a:lnTo>
                      <a:pt x="1185" y="743"/>
                    </a:lnTo>
                    <a:lnTo>
                      <a:pt x="1185" y="741"/>
                    </a:lnTo>
                    <a:lnTo>
                      <a:pt x="1186" y="743"/>
                    </a:lnTo>
                    <a:lnTo>
                      <a:pt x="1186" y="743"/>
                    </a:lnTo>
                    <a:lnTo>
                      <a:pt x="1187" y="742"/>
                    </a:lnTo>
                    <a:lnTo>
                      <a:pt x="1187" y="743"/>
                    </a:lnTo>
                    <a:lnTo>
                      <a:pt x="1188" y="743"/>
                    </a:lnTo>
                    <a:lnTo>
                      <a:pt x="1188" y="743"/>
                    </a:lnTo>
                    <a:lnTo>
                      <a:pt x="1189" y="743"/>
                    </a:lnTo>
                    <a:lnTo>
                      <a:pt x="1189" y="743"/>
                    </a:lnTo>
                    <a:lnTo>
                      <a:pt x="1190" y="743"/>
                    </a:lnTo>
                    <a:lnTo>
                      <a:pt x="1190" y="743"/>
                    </a:lnTo>
                    <a:lnTo>
                      <a:pt x="1191" y="743"/>
                    </a:lnTo>
                    <a:lnTo>
                      <a:pt x="1191" y="743"/>
                    </a:lnTo>
                    <a:lnTo>
                      <a:pt x="1192" y="743"/>
                    </a:lnTo>
                    <a:lnTo>
                      <a:pt x="1192" y="743"/>
                    </a:lnTo>
                    <a:lnTo>
                      <a:pt x="1193" y="743"/>
                    </a:lnTo>
                    <a:lnTo>
                      <a:pt x="1193" y="743"/>
                    </a:lnTo>
                    <a:lnTo>
                      <a:pt x="1194" y="743"/>
                    </a:lnTo>
                    <a:lnTo>
                      <a:pt x="1194" y="743"/>
                    </a:lnTo>
                    <a:lnTo>
                      <a:pt x="1195" y="743"/>
                    </a:lnTo>
                    <a:lnTo>
                      <a:pt x="1195" y="743"/>
                    </a:lnTo>
                    <a:lnTo>
                      <a:pt x="1196" y="743"/>
                    </a:lnTo>
                    <a:lnTo>
                      <a:pt x="1196" y="743"/>
                    </a:lnTo>
                    <a:lnTo>
                      <a:pt x="1197" y="743"/>
                    </a:lnTo>
                    <a:lnTo>
                      <a:pt x="1197" y="743"/>
                    </a:lnTo>
                    <a:lnTo>
                      <a:pt x="1198" y="743"/>
                    </a:lnTo>
                    <a:lnTo>
                      <a:pt x="1198" y="743"/>
                    </a:lnTo>
                    <a:lnTo>
                      <a:pt x="1199" y="743"/>
                    </a:lnTo>
                    <a:lnTo>
                      <a:pt x="1199" y="743"/>
                    </a:lnTo>
                    <a:lnTo>
                      <a:pt x="1200" y="743"/>
                    </a:lnTo>
                    <a:lnTo>
                      <a:pt x="1200" y="743"/>
                    </a:lnTo>
                    <a:lnTo>
                      <a:pt x="1201" y="743"/>
                    </a:lnTo>
                    <a:lnTo>
                      <a:pt x="1201" y="743"/>
                    </a:lnTo>
                    <a:lnTo>
                      <a:pt x="1202" y="743"/>
                    </a:lnTo>
                    <a:lnTo>
                      <a:pt x="1202" y="743"/>
                    </a:lnTo>
                    <a:lnTo>
                      <a:pt x="1203" y="743"/>
                    </a:lnTo>
                    <a:lnTo>
                      <a:pt x="1203" y="743"/>
                    </a:lnTo>
                    <a:lnTo>
                      <a:pt x="1204" y="743"/>
                    </a:lnTo>
                    <a:lnTo>
                      <a:pt x="1204" y="743"/>
                    </a:lnTo>
                    <a:lnTo>
                      <a:pt x="1205" y="743"/>
                    </a:lnTo>
                    <a:lnTo>
                      <a:pt x="1205" y="743"/>
                    </a:lnTo>
                    <a:lnTo>
                      <a:pt x="1206" y="743"/>
                    </a:lnTo>
                    <a:lnTo>
                      <a:pt x="1206" y="743"/>
                    </a:lnTo>
                    <a:lnTo>
                      <a:pt x="1207" y="743"/>
                    </a:lnTo>
                    <a:lnTo>
                      <a:pt x="1207" y="743"/>
                    </a:lnTo>
                    <a:lnTo>
                      <a:pt x="1208" y="743"/>
                    </a:lnTo>
                    <a:lnTo>
                      <a:pt x="1208" y="743"/>
                    </a:lnTo>
                    <a:lnTo>
                      <a:pt x="1209" y="743"/>
                    </a:lnTo>
                    <a:lnTo>
                      <a:pt x="1209" y="743"/>
                    </a:lnTo>
                    <a:lnTo>
                      <a:pt x="1210" y="743"/>
                    </a:lnTo>
                    <a:lnTo>
                      <a:pt x="1210" y="743"/>
                    </a:lnTo>
                    <a:lnTo>
                      <a:pt x="1211" y="743"/>
                    </a:lnTo>
                    <a:lnTo>
                      <a:pt x="1211" y="743"/>
                    </a:lnTo>
                    <a:lnTo>
                      <a:pt x="1212" y="743"/>
                    </a:lnTo>
                    <a:lnTo>
                      <a:pt x="1212" y="743"/>
                    </a:lnTo>
                    <a:lnTo>
                      <a:pt x="1213" y="743"/>
                    </a:lnTo>
                    <a:lnTo>
                      <a:pt x="1213" y="743"/>
                    </a:lnTo>
                    <a:lnTo>
                      <a:pt x="1214" y="743"/>
                    </a:lnTo>
                    <a:lnTo>
                      <a:pt x="1214" y="743"/>
                    </a:lnTo>
                    <a:lnTo>
                      <a:pt x="1215" y="743"/>
                    </a:lnTo>
                    <a:lnTo>
                      <a:pt x="1215" y="743"/>
                    </a:lnTo>
                    <a:lnTo>
                      <a:pt x="1216" y="743"/>
                    </a:lnTo>
                    <a:lnTo>
                      <a:pt x="1216" y="743"/>
                    </a:lnTo>
                    <a:lnTo>
                      <a:pt x="1217" y="743"/>
                    </a:lnTo>
                    <a:lnTo>
                      <a:pt x="1217" y="743"/>
                    </a:lnTo>
                    <a:lnTo>
                      <a:pt x="1218" y="743"/>
                    </a:lnTo>
                    <a:lnTo>
                      <a:pt x="1218" y="742"/>
                    </a:lnTo>
                    <a:lnTo>
                      <a:pt x="1219" y="743"/>
                    </a:lnTo>
                    <a:lnTo>
                      <a:pt x="1219" y="743"/>
                    </a:lnTo>
                    <a:lnTo>
                      <a:pt x="1220" y="743"/>
                    </a:lnTo>
                    <a:lnTo>
                      <a:pt x="1220" y="743"/>
                    </a:lnTo>
                    <a:lnTo>
                      <a:pt x="1221" y="743"/>
                    </a:lnTo>
                    <a:lnTo>
                      <a:pt x="1221" y="743"/>
                    </a:lnTo>
                    <a:lnTo>
                      <a:pt x="1222" y="743"/>
                    </a:lnTo>
                    <a:lnTo>
                      <a:pt x="1222" y="743"/>
                    </a:lnTo>
                    <a:lnTo>
                      <a:pt x="1223" y="743"/>
                    </a:lnTo>
                    <a:lnTo>
                      <a:pt x="1223" y="743"/>
                    </a:lnTo>
                    <a:lnTo>
                      <a:pt x="1224" y="743"/>
                    </a:lnTo>
                    <a:lnTo>
                      <a:pt x="1224" y="743"/>
                    </a:lnTo>
                    <a:lnTo>
                      <a:pt x="1225" y="743"/>
                    </a:lnTo>
                    <a:lnTo>
                      <a:pt x="1225" y="743"/>
                    </a:lnTo>
                    <a:lnTo>
                      <a:pt x="1226" y="743"/>
                    </a:lnTo>
                    <a:lnTo>
                      <a:pt x="1226" y="743"/>
                    </a:lnTo>
                    <a:lnTo>
                      <a:pt x="1227" y="743"/>
                    </a:lnTo>
                    <a:lnTo>
                      <a:pt x="1227" y="743"/>
                    </a:lnTo>
                    <a:lnTo>
                      <a:pt x="1228" y="743"/>
                    </a:lnTo>
                    <a:lnTo>
                      <a:pt x="1228" y="743"/>
                    </a:lnTo>
                    <a:lnTo>
                      <a:pt x="1229" y="743"/>
                    </a:lnTo>
                    <a:lnTo>
                      <a:pt x="1229" y="743"/>
                    </a:lnTo>
                    <a:lnTo>
                      <a:pt x="1230" y="743"/>
                    </a:lnTo>
                    <a:lnTo>
                      <a:pt x="1230" y="743"/>
                    </a:lnTo>
                    <a:lnTo>
                      <a:pt x="1231" y="743"/>
                    </a:lnTo>
                    <a:lnTo>
                      <a:pt x="1231" y="743"/>
                    </a:lnTo>
                    <a:lnTo>
                      <a:pt x="1232" y="737"/>
                    </a:lnTo>
                    <a:lnTo>
                      <a:pt x="1232" y="743"/>
                    </a:lnTo>
                    <a:lnTo>
                      <a:pt x="1233" y="743"/>
                    </a:lnTo>
                    <a:lnTo>
                      <a:pt x="1233" y="743"/>
                    </a:lnTo>
                    <a:lnTo>
                      <a:pt x="1234" y="742"/>
                    </a:lnTo>
                    <a:lnTo>
                      <a:pt x="1234" y="743"/>
                    </a:lnTo>
                    <a:lnTo>
                      <a:pt x="1235" y="743"/>
                    </a:lnTo>
                    <a:lnTo>
                      <a:pt x="1235" y="743"/>
                    </a:lnTo>
                    <a:lnTo>
                      <a:pt x="1236" y="743"/>
                    </a:lnTo>
                    <a:lnTo>
                      <a:pt x="1236" y="743"/>
                    </a:lnTo>
                    <a:lnTo>
                      <a:pt x="1237" y="743"/>
                    </a:lnTo>
                    <a:lnTo>
                      <a:pt x="1237" y="743"/>
                    </a:lnTo>
                    <a:lnTo>
                      <a:pt x="1238" y="743"/>
                    </a:lnTo>
                    <a:lnTo>
                      <a:pt x="1238" y="743"/>
                    </a:lnTo>
                    <a:lnTo>
                      <a:pt x="1239" y="743"/>
                    </a:lnTo>
                    <a:lnTo>
                      <a:pt x="1239" y="743"/>
                    </a:lnTo>
                    <a:lnTo>
                      <a:pt x="1240" y="743"/>
                    </a:lnTo>
                    <a:lnTo>
                      <a:pt x="1240" y="743"/>
                    </a:lnTo>
                    <a:lnTo>
                      <a:pt x="1241" y="743"/>
                    </a:lnTo>
                    <a:lnTo>
                      <a:pt x="1241" y="743"/>
                    </a:lnTo>
                    <a:lnTo>
                      <a:pt x="1242" y="743"/>
                    </a:lnTo>
                    <a:lnTo>
                      <a:pt x="1242" y="743"/>
                    </a:lnTo>
                    <a:lnTo>
                      <a:pt x="1243" y="743"/>
                    </a:lnTo>
                    <a:lnTo>
                      <a:pt x="1243" y="743"/>
                    </a:lnTo>
                    <a:lnTo>
                      <a:pt x="1244" y="743"/>
                    </a:lnTo>
                    <a:lnTo>
                      <a:pt x="1244" y="743"/>
                    </a:lnTo>
                    <a:lnTo>
                      <a:pt x="1245" y="743"/>
                    </a:lnTo>
                    <a:lnTo>
                      <a:pt x="1245" y="743"/>
                    </a:lnTo>
                    <a:lnTo>
                      <a:pt x="1246" y="743"/>
                    </a:lnTo>
                    <a:lnTo>
                      <a:pt x="1246" y="743"/>
                    </a:lnTo>
                    <a:lnTo>
                      <a:pt x="1247" y="743"/>
                    </a:lnTo>
                    <a:lnTo>
                      <a:pt x="1247" y="743"/>
                    </a:lnTo>
                    <a:lnTo>
                      <a:pt x="1248" y="743"/>
                    </a:lnTo>
                    <a:lnTo>
                      <a:pt x="1248" y="743"/>
                    </a:lnTo>
                    <a:lnTo>
                      <a:pt x="1249" y="743"/>
                    </a:lnTo>
                    <a:lnTo>
                      <a:pt x="1249" y="743"/>
                    </a:lnTo>
                    <a:lnTo>
                      <a:pt x="1250" y="743"/>
                    </a:lnTo>
                    <a:lnTo>
                      <a:pt x="1250" y="743"/>
                    </a:lnTo>
                    <a:lnTo>
                      <a:pt x="1251" y="743"/>
                    </a:lnTo>
                    <a:lnTo>
                      <a:pt x="1251" y="743"/>
                    </a:lnTo>
                    <a:lnTo>
                      <a:pt x="1252" y="743"/>
                    </a:lnTo>
                    <a:lnTo>
                      <a:pt x="1252" y="743"/>
                    </a:lnTo>
                    <a:lnTo>
                      <a:pt x="1253" y="743"/>
                    </a:lnTo>
                    <a:lnTo>
                      <a:pt x="1253" y="743"/>
                    </a:lnTo>
                    <a:lnTo>
                      <a:pt x="1254" y="743"/>
                    </a:lnTo>
                    <a:lnTo>
                      <a:pt x="1254" y="743"/>
                    </a:lnTo>
                    <a:lnTo>
                      <a:pt x="1255" y="743"/>
                    </a:lnTo>
                    <a:lnTo>
                      <a:pt x="1255" y="743"/>
                    </a:lnTo>
                    <a:lnTo>
                      <a:pt x="1256" y="743"/>
                    </a:lnTo>
                    <a:lnTo>
                      <a:pt x="1256" y="743"/>
                    </a:lnTo>
                    <a:lnTo>
                      <a:pt x="1257" y="743"/>
                    </a:lnTo>
                    <a:lnTo>
                      <a:pt x="1257" y="743"/>
                    </a:lnTo>
                    <a:lnTo>
                      <a:pt x="1258" y="743"/>
                    </a:lnTo>
                    <a:lnTo>
                      <a:pt x="1258" y="743"/>
                    </a:lnTo>
                    <a:lnTo>
                      <a:pt x="1259" y="743"/>
                    </a:lnTo>
                    <a:lnTo>
                      <a:pt x="1259" y="743"/>
                    </a:lnTo>
                    <a:lnTo>
                      <a:pt x="1260" y="743"/>
                    </a:lnTo>
                    <a:lnTo>
                      <a:pt x="1260" y="743"/>
                    </a:lnTo>
                    <a:lnTo>
                      <a:pt x="1261" y="743"/>
                    </a:lnTo>
                    <a:lnTo>
                      <a:pt x="1261" y="743"/>
                    </a:lnTo>
                    <a:lnTo>
                      <a:pt x="1262" y="743"/>
                    </a:lnTo>
                    <a:lnTo>
                      <a:pt x="1262" y="743"/>
                    </a:lnTo>
                    <a:lnTo>
                      <a:pt x="1263" y="743"/>
                    </a:lnTo>
                    <a:lnTo>
                      <a:pt x="1263" y="743"/>
                    </a:lnTo>
                    <a:lnTo>
                      <a:pt x="1264" y="736"/>
                    </a:lnTo>
                    <a:lnTo>
                      <a:pt x="1264" y="743"/>
                    </a:lnTo>
                    <a:lnTo>
                      <a:pt x="1265" y="743"/>
                    </a:lnTo>
                    <a:lnTo>
                      <a:pt x="1265" y="743"/>
                    </a:lnTo>
                    <a:lnTo>
                      <a:pt x="1266" y="741"/>
                    </a:lnTo>
                    <a:lnTo>
                      <a:pt x="1266" y="743"/>
                    </a:lnTo>
                    <a:lnTo>
                      <a:pt x="1267" y="743"/>
                    </a:lnTo>
                    <a:lnTo>
                      <a:pt x="1267" y="743"/>
                    </a:lnTo>
                    <a:lnTo>
                      <a:pt x="1268" y="743"/>
                    </a:lnTo>
                    <a:lnTo>
                      <a:pt x="1268" y="743"/>
                    </a:lnTo>
                    <a:lnTo>
                      <a:pt x="1269" y="743"/>
                    </a:lnTo>
                    <a:lnTo>
                      <a:pt x="1269" y="743"/>
                    </a:lnTo>
                    <a:lnTo>
                      <a:pt x="1270" y="743"/>
                    </a:lnTo>
                    <a:lnTo>
                      <a:pt x="1270" y="743"/>
                    </a:lnTo>
                    <a:lnTo>
                      <a:pt x="1271" y="743"/>
                    </a:lnTo>
                    <a:lnTo>
                      <a:pt x="1271" y="743"/>
                    </a:lnTo>
                    <a:lnTo>
                      <a:pt x="1272" y="743"/>
                    </a:lnTo>
                    <a:lnTo>
                      <a:pt x="1272" y="743"/>
                    </a:lnTo>
                    <a:lnTo>
                      <a:pt x="1273" y="743"/>
                    </a:lnTo>
                    <a:lnTo>
                      <a:pt x="1273" y="743"/>
                    </a:lnTo>
                    <a:lnTo>
                      <a:pt x="1274" y="743"/>
                    </a:lnTo>
                    <a:lnTo>
                      <a:pt x="1274" y="743"/>
                    </a:lnTo>
                    <a:lnTo>
                      <a:pt x="1275" y="743"/>
                    </a:lnTo>
                    <a:lnTo>
                      <a:pt x="1275" y="743"/>
                    </a:lnTo>
                    <a:lnTo>
                      <a:pt x="1276" y="743"/>
                    </a:lnTo>
                    <a:lnTo>
                      <a:pt x="1276" y="743"/>
                    </a:lnTo>
                    <a:lnTo>
                      <a:pt x="1277" y="743"/>
                    </a:lnTo>
                    <a:lnTo>
                      <a:pt x="1277" y="743"/>
                    </a:lnTo>
                    <a:lnTo>
                      <a:pt x="1278" y="743"/>
                    </a:lnTo>
                    <a:lnTo>
                      <a:pt x="1278" y="743"/>
                    </a:lnTo>
                    <a:lnTo>
                      <a:pt x="1279" y="743"/>
                    </a:lnTo>
                    <a:lnTo>
                      <a:pt x="1279" y="743"/>
                    </a:lnTo>
                    <a:lnTo>
                      <a:pt x="1280" y="743"/>
                    </a:lnTo>
                    <a:lnTo>
                      <a:pt x="1280" y="743"/>
                    </a:lnTo>
                    <a:lnTo>
                      <a:pt x="1281" y="743"/>
                    </a:lnTo>
                    <a:lnTo>
                      <a:pt x="1281" y="743"/>
                    </a:lnTo>
                    <a:lnTo>
                      <a:pt x="1282" y="743"/>
                    </a:lnTo>
                    <a:lnTo>
                      <a:pt x="1282" y="743"/>
                    </a:lnTo>
                    <a:lnTo>
                      <a:pt x="1283" y="743"/>
                    </a:lnTo>
                    <a:lnTo>
                      <a:pt x="1283" y="743"/>
                    </a:lnTo>
                    <a:lnTo>
                      <a:pt x="1284" y="743"/>
                    </a:lnTo>
                    <a:lnTo>
                      <a:pt x="1284" y="743"/>
                    </a:lnTo>
                    <a:lnTo>
                      <a:pt x="1285" y="743"/>
                    </a:lnTo>
                    <a:lnTo>
                      <a:pt x="1285" y="743"/>
                    </a:lnTo>
                    <a:lnTo>
                      <a:pt x="1286" y="743"/>
                    </a:lnTo>
                    <a:lnTo>
                      <a:pt x="1286" y="743"/>
                    </a:lnTo>
                    <a:lnTo>
                      <a:pt x="1287" y="743"/>
                    </a:lnTo>
                    <a:lnTo>
                      <a:pt x="1287" y="743"/>
                    </a:lnTo>
                    <a:lnTo>
                      <a:pt x="1288" y="743"/>
                    </a:lnTo>
                    <a:lnTo>
                      <a:pt x="1288" y="743"/>
                    </a:lnTo>
                    <a:lnTo>
                      <a:pt x="1289" y="743"/>
                    </a:lnTo>
                    <a:lnTo>
                      <a:pt x="1289" y="743"/>
                    </a:lnTo>
                    <a:lnTo>
                      <a:pt x="1290" y="743"/>
                    </a:lnTo>
                    <a:lnTo>
                      <a:pt x="1290" y="741"/>
                    </a:lnTo>
                    <a:lnTo>
                      <a:pt x="1291" y="743"/>
                    </a:lnTo>
                    <a:lnTo>
                      <a:pt x="1291" y="743"/>
                    </a:lnTo>
                    <a:lnTo>
                      <a:pt x="1292" y="729"/>
                    </a:lnTo>
                    <a:lnTo>
                      <a:pt x="1292" y="743"/>
                    </a:lnTo>
                    <a:lnTo>
                      <a:pt x="1293" y="743"/>
                    </a:lnTo>
                    <a:lnTo>
                      <a:pt x="1293" y="743"/>
                    </a:lnTo>
                    <a:lnTo>
                      <a:pt x="1294" y="725"/>
                    </a:lnTo>
                    <a:lnTo>
                      <a:pt x="1294" y="743"/>
                    </a:lnTo>
                    <a:lnTo>
                      <a:pt x="1295" y="743"/>
                    </a:lnTo>
                    <a:lnTo>
                      <a:pt x="1295" y="743"/>
                    </a:lnTo>
                    <a:lnTo>
                      <a:pt x="1296" y="735"/>
                    </a:lnTo>
                    <a:lnTo>
                      <a:pt x="1296" y="743"/>
                    </a:lnTo>
                    <a:lnTo>
                      <a:pt x="1297" y="743"/>
                    </a:lnTo>
                    <a:lnTo>
                      <a:pt x="1297" y="743"/>
                    </a:lnTo>
                    <a:lnTo>
                      <a:pt x="1298" y="742"/>
                    </a:lnTo>
                    <a:lnTo>
                      <a:pt x="1298" y="743"/>
                    </a:lnTo>
                    <a:lnTo>
                      <a:pt x="1299" y="743"/>
                    </a:lnTo>
                    <a:lnTo>
                      <a:pt x="1299" y="743"/>
                    </a:lnTo>
                    <a:lnTo>
                      <a:pt x="1300" y="743"/>
                    </a:lnTo>
                    <a:lnTo>
                      <a:pt x="1300" y="743"/>
                    </a:lnTo>
                    <a:lnTo>
                      <a:pt x="1301" y="742"/>
                    </a:lnTo>
                    <a:lnTo>
                      <a:pt x="1301" y="743"/>
                    </a:lnTo>
                    <a:lnTo>
                      <a:pt x="1302" y="743"/>
                    </a:lnTo>
                    <a:lnTo>
                      <a:pt x="1302" y="743"/>
                    </a:lnTo>
                    <a:lnTo>
                      <a:pt x="1303" y="743"/>
                    </a:lnTo>
                    <a:lnTo>
                      <a:pt x="1303" y="743"/>
                    </a:lnTo>
                    <a:lnTo>
                      <a:pt x="1304" y="743"/>
                    </a:lnTo>
                    <a:lnTo>
                      <a:pt x="1304" y="739"/>
                    </a:lnTo>
                    <a:lnTo>
                      <a:pt x="1305" y="738"/>
                    </a:lnTo>
                    <a:lnTo>
                      <a:pt x="1305" y="743"/>
                    </a:lnTo>
                    <a:lnTo>
                      <a:pt x="1306" y="743"/>
                    </a:lnTo>
                    <a:lnTo>
                      <a:pt x="1306" y="743"/>
                    </a:lnTo>
                    <a:lnTo>
                      <a:pt x="1307" y="743"/>
                    </a:lnTo>
                    <a:lnTo>
                      <a:pt x="1307" y="743"/>
                    </a:lnTo>
                    <a:lnTo>
                      <a:pt x="1308" y="743"/>
                    </a:lnTo>
                    <a:lnTo>
                      <a:pt x="1308" y="732"/>
                    </a:lnTo>
                    <a:lnTo>
                      <a:pt x="1309" y="738"/>
                    </a:lnTo>
                    <a:lnTo>
                      <a:pt x="1309" y="743"/>
                    </a:lnTo>
                    <a:lnTo>
                      <a:pt x="1310" y="743"/>
                    </a:lnTo>
                    <a:lnTo>
                      <a:pt x="1310" y="743"/>
                    </a:lnTo>
                    <a:lnTo>
                      <a:pt x="1311" y="743"/>
                    </a:lnTo>
                    <a:lnTo>
                      <a:pt x="1311" y="743"/>
                    </a:lnTo>
                    <a:lnTo>
                      <a:pt x="1312" y="743"/>
                    </a:lnTo>
                    <a:lnTo>
                      <a:pt x="1312" y="730"/>
                    </a:lnTo>
                    <a:lnTo>
                      <a:pt x="1313" y="743"/>
                    </a:lnTo>
                    <a:lnTo>
                      <a:pt x="1313" y="743"/>
                    </a:lnTo>
                    <a:lnTo>
                      <a:pt x="1314" y="743"/>
                    </a:lnTo>
                    <a:lnTo>
                      <a:pt x="1314" y="743"/>
                    </a:lnTo>
                    <a:lnTo>
                      <a:pt x="1315" y="743"/>
                    </a:lnTo>
                    <a:lnTo>
                      <a:pt x="1315" y="743"/>
                    </a:lnTo>
                    <a:lnTo>
                      <a:pt x="1316" y="743"/>
                    </a:lnTo>
                    <a:lnTo>
                      <a:pt x="1316" y="733"/>
                    </a:lnTo>
                    <a:lnTo>
                      <a:pt x="1317" y="743"/>
                    </a:lnTo>
                    <a:lnTo>
                      <a:pt x="1317" y="743"/>
                    </a:lnTo>
                    <a:lnTo>
                      <a:pt x="1318" y="743"/>
                    </a:lnTo>
                    <a:lnTo>
                      <a:pt x="1318" y="743"/>
                    </a:lnTo>
                    <a:lnTo>
                      <a:pt x="1319" y="740"/>
                    </a:lnTo>
                    <a:lnTo>
                      <a:pt x="1319" y="743"/>
                    </a:lnTo>
                    <a:lnTo>
                      <a:pt x="1320" y="743"/>
                    </a:lnTo>
                    <a:lnTo>
                      <a:pt x="1320" y="737"/>
                    </a:lnTo>
                    <a:lnTo>
                      <a:pt x="1321" y="743"/>
                    </a:lnTo>
                    <a:lnTo>
                      <a:pt x="1321" y="743"/>
                    </a:lnTo>
                    <a:lnTo>
                      <a:pt x="1322" y="743"/>
                    </a:lnTo>
                    <a:lnTo>
                      <a:pt x="1322" y="743"/>
                    </a:lnTo>
                    <a:lnTo>
                      <a:pt x="1323" y="743"/>
                    </a:lnTo>
                    <a:lnTo>
                      <a:pt x="1323" y="743"/>
                    </a:lnTo>
                    <a:lnTo>
                      <a:pt x="1324" y="741"/>
                    </a:lnTo>
                    <a:lnTo>
                      <a:pt x="1324" y="743"/>
                    </a:lnTo>
                    <a:lnTo>
                      <a:pt x="1325" y="743"/>
                    </a:lnTo>
                    <a:lnTo>
                      <a:pt x="1325" y="743"/>
                    </a:lnTo>
                    <a:lnTo>
                      <a:pt x="1326" y="743"/>
                    </a:lnTo>
                    <a:lnTo>
                      <a:pt x="1326" y="743"/>
                    </a:lnTo>
                    <a:lnTo>
                      <a:pt x="1327" y="743"/>
                    </a:lnTo>
                    <a:lnTo>
                      <a:pt x="1327" y="743"/>
                    </a:lnTo>
                    <a:lnTo>
                      <a:pt x="1328" y="743"/>
                    </a:lnTo>
                    <a:lnTo>
                      <a:pt x="1328" y="743"/>
                    </a:lnTo>
                    <a:lnTo>
                      <a:pt x="1329" y="743"/>
                    </a:lnTo>
                    <a:lnTo>
                      <a:pt x="1329" y="743"/>
                    </a:lnTo>
                    <a:lnTo>
                      <a:pt x="1330" y="743"/>
                    </a:lnTo>
                    <a:lnTo>
                      <a:pt x="1330" y="743"/>
                    </a:lnTo>
                    <a:lnTo>
                      <a:pt x="1331" y="743"/>
                    </a:lnTo>
                    <a:lnTo>
                      <a:pt x="1331" y="743"/>
                    </a:lnTo>
                    <a:lnTo>
                      <a:pt x="1332" y="743"/>
                    </a:lnTo>
                    <a:lnTo>
                      <a:pt x="1332" y="743"/>
                    </a:lnTo>
                    <a:lnTo>
                      <a:pt x="1333" y="743"/>
                    </a:lnTo>
                    <a:lnTo>
                      <a:pt x="1333" y="743"/>
                    </a:lnTo>
                    <a:lnTo>
                      <a:pt x="1334" y="743"/>
                    </a:lnTo>
                    <a:lnTo>
                      <a:pt x="1334" y="743"/>
                    </a:lnTo>
                    <a:lnTo>
                      <a:pt x="1335" y="743"/>
                    </a:lnTo>
                    <a:lnTo>
                      <a:pt x="1335" y="743"/>
                    </a:lnTo>
                    <a:lnTo>
                      <a:pt x="1336" y="743"/>
                    </a:lnTo>
                    <a:lnTo>
                      <a:pt x="1336" y="743"/>
                    </a:lnTo>
                    <a:lnTo>
                      <a:pt x="1337" y="743"/>
                    </a:lnTo>
                    <a:lnTo>
                      <a:pt x="1337" y="743"/>
                    </a:lnTo>
                    <a:lnTo>
                      <a:pt x="1338" y="743"/>
                    </a:lnTo>
                    <a:lnTo>
                      <a:pt x="1338" y="743"/>
                    </a:lnTo>
                    <a:lnTo>
                      <a:pt x="1339" y="743"/>
                    </a:lnTo>
                    <a:lnTo>
                      <a:pt x="1339" y="743"/>
                    </a:lnTo>
                    <a:lnTo>
                      <a:pt x="1340" y="743"/>
                    </a:lnTo>
                    <a:lnTo>
                      <a:pt x="1340" y="743"/>
                    </a:lnTo>
                    <a:lnTo>
                      <a:pt x="1341" y="743"/>
                    </a:lnTo>
                    <a:lnTo>
                      <a:pt x="1341" y="743"/>
                    </a:lnTo>
                    <a:lnTo>
                      <a:pt x="1342" y="743"/>
                    </a:lnTo>
                    <a:lnTo>
                      <a:pt x="1342" y="743"/>
                    </a:lnTo>
                    <a:lnTo>
                      <a:pt x="1343" y="743"/>
                    </a:lnTo>
                    <a:lnTo>
                      <a:pt x="1343" y="743"/>
                    </a:lnTo>
                    <a:lnTo>
                      <a:pt x="1344" y="743"/>
                    </a:lnTo>
                    <a:lnTo>
                      <a:pt x="1344" y="743"/>
                    </a:lnTo>
                    <a:lnTo>
                      <a:pt x="1345" y="743"/>
                    </a:lnTo>
                    <a:lnTo>
                      <a:pt x="1345" y="743"/>
                    </a:lnTo>
                    <a:lnTo>
                      <a:pt x="1346" y="743"/>
                    </a:lnTo>
                    <a:lnTo>
                      <a:pt x="1346" y="743"/>
                    </a:lnTo>
                    <a:lnTo>
                      <a:pt x="1347" y="743"/>
                    </a:lnTo>
                    <a:lnTo>
                      <a:pt x="1347" y="743"/>
                    </a:lnTo>
                    <a:lnTo>
                      <a:pt x="1348" y="743"/>
                    </a:lnTo>
                    <a:lnTo>
                      <a:pt x="1348" y="743"/>
                    </a:lnTo>
                    <a:lnTo>
                      <a:pt x="1349" y="743"/>
                    </a:lnTo>
                    <a:lnTo>
                      <a:pt x="1349" y="743"/>
                    </a:lnTo>
                    <a:lnTo>
                      <a:pt x="1350" y="743"/>
                    </a:lnTo>
                    <a:lnTo>
                      <a:pt x="1350" y="743"/>
                    </a:lnTo>
                    <a:lnTo>
                      <a:pt x="1351" y="743"/>
                    </a:lnTo>
                    <a:lnTo>
                      <a:pt x="1351" y="740"/>
                    </a:lnTo>
                    <a:lnTo>
                      <a:pt x="1352" y="743"/>
                    </a:lnTo>
                    <a:lnTo>
                      <a:pt x="1352" y="743"/>
                    </a:lnTo>
                    <a:lnTo>
                      <a:pt x="1353" y="743"/>
                    </a:lnTo>
                    <a:lnTo>
                      <a:pt x="1353" y="742"/>
                    </a:lnTo>
                    <a:lnTo>
                      <a:pt x="1354" y="743"/>
                    </a:lnTo>
                    <a:lnTo>
                      <a:pt x="1354" y="743"/>
                    </a:lnTo>
                    <a:lnTo>
                      <a:pt x="1355" y="743"/>
                    </a:lnTo>
                    <a:lnTo>
                      <a:pt x="1355" y="743"/>
                    </a:lnTo>
                    <a:lnTo>
                      <a:pt x="1356" y="743"/>
                    </a:lnTo>
                    <a:lnTo>
                      <a:pt x="1356" y="743"/>
                    </a:lnTo>
                    <a:lnTo>
                      <a:pt x="1357" y="743"/>
                    </a:lnTo>
                    <a:lnTo>
                      <a:pt x="1357" y="743"/>
                    </a:lnTo>
                    <a:lnTo>
                      <a:pt x="1358" y="743"/>
                    </a:lnTo>
                    <a:lnTo>
                      <a:pt x="1358" y="743"/>
                    </a:lnTo>
                    <a:lnTo>
                      <a:pt x="1359" y="743"/>
                    </a:lnTo>
                    <a:lnTo>
                      <a:pt x="1359" y="742"/>
                    </a:lnTo>
                    <a:lnTo>
                      <a:pt x="1360" y="742"/>
                    </a:lnTo>
                    <a:lnTo>
                      <a:pt x="1360" y="743"/>
                    </a:lnTo>
                    <a:lnTo>
                      <a:pt x="1361" y="743"/>
                    </a:lnTo>
                    <a:lnTo>
                      <a:pt x="1361" y="743"/>
                    </a:lnTo>
                    <a:lnTo>
                      <a:pt x="1362" y="743"/>
                    </a:lnTo>
                    <a:lnTo>
                      <a:pt x="1362" y="743"/>
                    </a:lnTo>
                    <a:lnTo>
                      <a:pt x="1363" y="743"/>
                    </a:lnTo>
                    <a:lnTo>
                      <a:pt x="1363" y="743"/>
                    </a:lnTo>
                    <a:lnTo>
                      <a:pt x="1364" y="743"/>
                    </a:lnTo>
                    <a:lnTo>
                      <a:pt x="1364" y="743"/>
                    </a:lnTo>
                    <a:lnTo>
                      <a:pt x="1365" y="743"/>
                    </a:lnTo>
                    <a:lnTo>
                      <a:pt x="1365" y="743"/>
                    </a:lnTo>
                    <a:lnTo>
                      <a:pt x="1366" y="743"/>
                    </a:lnTo>
                    <a:lnTo>
                      <a:pt x="1366" y="743"/>
                    </a:lnTo>
                    <a:lnTo>
                      <a:pt x="1367" y="743"/>
                    </a:lnTo>
                    <a:lnTo>
                      <a:pt x="1367" y="743"/>
                    </a:lnTo>
                    <a:lnTo>
                      <a:pt x="1368" y="743"/>
                    </a:lnTo>
                    <a:lnTo>
                      <a:pt x="1368" y="743"/>
                    </a:lnTo>
                    <a:lnTo>
                      <a:pt x="1369" y="743"/>
                    </a:lnTo>
                    <a:lnTo>
                      <a:pt x="1369" y="743"/>
                    </a:lnTo>
                    <a:lnTo>
                      <a:pt x="1370" y="743"/>
                    </a:lnTo>
                    <a:lnTo>
                      <a:pt x="1370" y="743"/>
                    </a:lnTo>
                    <a:lnTo>
                      <a:pt x="1371" y="743"/>
                    </a:lnTo>
                    <a:lnTo>
                      <a:pt x="1371" y="743"/>
                    </a:lnTo>
                    <a:lnTo>
                      <a:pt x="1372" y="743"/>
                    </a:lnTo>
                    <a:lnTo>
                      <a:pt x="1372" y="743"/>
                    </a:lnTo>
                    <a:lnTo>
                      <a:pt x="1373" y="743"/>
                    </a:lnTo>
                    <a:lnTo>
                      <a:pt x="1373" y="743"/>
                    </a:lnTo>
                    <a:lnTo>
                      <a:pt x="1374" y="743"/>
                    </a:lnTo>
                    <a:lnTo>
                      <a:pt x="1374" y="743"/>
                    </a:lnTo>
                    <a:lnTo>
                      <a:pt x="1375" y="743"/>
                    </a:lnTo>
                    <a:lnTo>
                      <a:pt x="1375" y="743"/>
                    </a:lnTo>
                    <a:lnTo>
                      <a:pt x="1376" y="743"/>
                    </a:lnTo>
                    <a:lnTo>
                      <a:pt x="1376" y="743"/>
                    </a:lnTo>
                    <a:lnTo>
                      <a:pt x="1377" y="743"/>
                    </a:lnTo>
                    <a:lnTo>
                      <a:pt x="1377" y="743"/>
                    </a:lnTo>
                    <a:lnTo>
                      <a:pt x="1378" y="743"/>
                    </a:lnTo>
                    <a:lnTo>
                      <a:pt x="1378" y="743"/>
                    </a:lnTo>
                    <a:lnTo>
                      <a:pt x="1379" y="743"/>
                    </a:lnTo>
                    <a:lnTo>
                      <a:pt x="1379" y="743"/>
                    </a:lnTo>
                    <a:lnTo>
                      <a:pt x="1380" y="743"/>
                    </a:lnTo>
                    <a:lnTo>
                      <a:pt x="1380" y="743"/>
                    </a:lnTo>
                    <a:lnTo>
                      <a:pt x="1381" y="743"/>
                    </a:lnTo>
                    <a:lnTo>
                      <a:pt x="1381" y="743"/>
                    </a:lnTo>
                    <a:lnTo>
                      <a:pt x="1382" y="743"/>
                    </a:lnTo>
                    <a:lnTo>
                      <a:pt x="1382" y="743"/>
                    </a:lnTo>
                    <a:lnTo>
                      <a:pt x="1383" y="743"/>
                    </a:lnTo>
                    <a:lnTo>
                      <a:pt x="1383" y="743"/>
                    </a:lnTo>
                    <a:lnTo>
                      <a:pt x="1384" y="743"/>
                    </a:lnTo>
                    <a:lnTo>
                      <a:pt x="1384" y="743"/>
                    </a:lnTo>
                    <a:lnTo>
                      <a:pt x="1385" y="743"/>
                    </a:lnTo>
                    <a:lnTo>
                      <a:pt x="1385" y="743"/>
                    </a:lnTo>
                    <a:lnTo>
                      <a:pt x="1386" y="743"/>
                    </a:lnTo>
                    <a:lnTo>
                      <a:pt x="1386" y="743"/>
                    </a:lnTo>
                    <a:lnTo>
                      <a:pt x="1400" y="743"/>
                    </a:lnTo>
                    <a:lnTo>
                      <a:pt x="1400" y="743"/>
                    </a:lnTo>
                    <a:lnTo>
                      <a:pt x="1400" y="743"/>
                    </a:lnTo>
                    <a:lnTo>
                      <a:pt x="1401" y="743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32" name="Rectangle 535">
                <a:extLst>
                  <a:ext uri="{FF2B5EF4-FFF2-40B4-BE49-F238E27FC236}">
                    <a16:creationId xmlns:a16="http://schemas.microsoft.com/office/drawing/2014/main" xmlns="" id="{61F7574A-E0D2-4064-A628-DABE52A434D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04" y="1983"/>
                <a:ext cx="174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18.09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33" name="Rectangle 536">
                <a:extLst>
                  <a:ext uri="{FF2B5EF4-FFF2-40B4-BE49-F238E27FC236}">
                    <a16:creationId xmlns:a16="http://schemas.microsoft.com/office/drawing/2014/main" xmlns="" id="{02B4465A-513F-4C18-AE60-4AAF3B97210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89" y="2230"/>
                <a:ext cx="174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62.11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34" name="Rectangle 537">
                <a:extLst>
                  <a:ext uri="{FF2B5EF4-FFF2-40B4-BE49-F238E27FC236}">
                    <a16:creationId xmlns:a16="http://schemas.microsoft.com/office/drawing/2014/main" xmlns="" id="{F877B539-B207-4CE9-9E91-6215C6A5EC3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03" y="2247"/>
                <a:ext cx="174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96.34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35" name="Rectangle 538">
                <a:extLst>
                  <a:ext uri="{FF2B5EF4-FFF2-40B4-BE49-F238E27FC236}">
                    <a16:creationId xmlns:a16="http://schemas.microsoft.com/office/drawing/2014/main" xmlns="" id="{E16D0AFF-E909-40CB-9D34-C3ABC27041B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21" y="2359"/>
                <a:ext cx="174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24.37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36" name="Rectangle 539">
                <a:extLst>
                  <a:ext uri="{FF2B5EF4-FFF2-40B4-BE49-F238E27FC236}">
                    <a16:creationId xmlns:a16="http://schemas.microsoft.com/office/drawing/2014/main" xmlns="" id="{B3D9914B-9EBE-48A7-8B8D-8998BA6C4CB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65" y="2520"/>
                <a:ext cx="174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26.9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37" name="Rectangle 540">
                <a:extLst>
                  <a:ext uri="{FF2B5EF4-FFF2-40B4-BE49-F238E27FC236}">
                    <a16:creationId xmlns:a16="http://schemas.microsoft.com/office/drawing/2014/main" xmlns="" id="{D8F67561-B5F0-49C8-9802-F222F37B510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00" y="2554"/>
                <a:ext cx="146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4.02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38" name="Line 541">
                <a:extLst>
                  <a:ext uri="{FF2B5EF4-FFF2-40B4-BE49-F238E27FC236}">
                    <a16:creationId xmlns:a16="http://schemas.microsoft.com/office/drawing/2014/main" xmlns="" id="{B80CCA51-66FC-430D-A774-D7D71E369A2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362" y="2581"/>
                <a:ext cx="11" cy="5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39" name="Rectangle 542">
                <a:extLst>
                  <a:ext uri="{FF2B5EF4-FFF2-40B4-BE49-F238E27FC236}">
                    <a16:creationId xmlns:a16="http://schemas.microsoft.com/office/drawing/2014/main" xmlns="" id="{C2AB94F5-031E-4998-8481-5F25475856F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06" y="2714"/>
                <a:ext cx="174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44.34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40" name="Rectangle 543">
                <a:extLst>
                  <a:ext uri="{FF2B5EF4-FFF2-40B4-BE49-F238E27FC236}">
                    <a16:creationId xmlns:a16="http://schemas.microsoft.com/office/drawing/2014/main" xmlns="" id="{FFE25508-3C0F-4D23-ADF3-7C458A222B4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91" y="2739"/>
                <a:ext cx="174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26.02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41" name="Line 544">
                <a:extLst>
                  <a:ext uri="{FF2B5EF4-FFF2-40B4-BE49-F238E27FC236}">
                    <a16:creationId xmlns:a16="http://schemas.microsoft.com/office/drawing/2014/main" xmlns="" id="{17A2DC8C-F020-4041-A863-06F84006F57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625" y="2766"/>
                <a:ext cx="53" cy="4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2" name="Rectangle 545">
                <a:extLst>
                  <a:ext uri="{FF2B5EF4-FFF2-40B4-BE49-F238E27FC236}">
                    <a16:creationId xmlns:a16="http://schemas.microsoft.com/office/drawing/2014/main" xmlns="" id="{3BDD6C7C-BE29-4267-B50D-F392C33979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04" y="2773"/>
                <a:ext cx="146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90.98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43" name="Rectangle 546">
                <a:extLst>
                  <a:ext uri="{FF2B5EF4-FFF2-40B4-BE49-F238E27FC236}">
                    <a16:creationId xmlns:a16="http://schemas.microsoft.com/office/drawing/2014/main" xmlns="" id="{E6C30CA7-2546-4425-82D2-DC843B4E6B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95" y="2831"/>
                <a:ext cx="174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58.11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44" name="Rectangle 547">
                <a:extLst>
                  <a:ext uri="{FF2B5EF4-FFF2-40B4-BE49-F238E27FC236}">
                    <a16:creationId xmlns:a16="http://schemas.microsoft.com/office/drawing/2014/main" xmlns="" id="{17C0A118-11EE-478B-BF51-DA6210EABBF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20" y="2601"/>
                <a:ext cx="174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16.07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45" name="Line 548">
                <a:extLst>
                  <a:ext uri="{FF2B5EF4-FFF2-40B4-BE49-F238E27FC236}">
                    <a16:creationId xmlns:a16="http://schemas.microsoft.com/office/drawing/2014/main" xmlns="" id="{516580A2-530A-4C7D-8607-6337517B61B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1507" y="2628"/>
                <a:ext cx="75" cy="289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6" name="Rectangle 549">
                <a:extLst>
                  <a:ext uri="{FF2B5EF4-FFF2-40B4-BE49-F238E27FC236}">
                    <a16:creationId xmlns:a16="http://schemas.microsoft.com/office/drawing/2014/main" xmlns="" id="{5996BDAF-4BE1-473B-9942-945B9A2F09D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39" y="2902"/>
                <a:ext cx="174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62.93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47" name="Rectangle 550">
                <a:extLst>
                  <a:ext uri="{FF2B5EF4-FFF2-40B4-BE49-F238E27FC236}">
                    <a16:creationId xmlns:a16="http://schemas.microsoft.com/office/drawing/2014/main" xmlns="" id="{7713BF56-9329-4243-97DC-CC26E60AB5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51" y="2902"/>
                <a:ext cx="174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94.94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48" name="Rectangle 551">
                <a:extLst>
                  <a:ext uri="{FF2B5EF4-FFF2-40B4-BE49-F238E27FC236}">
                    <a16:creationId xmlns:a16="http://schemas.microsoft.com/office/drawing/2014/main" xmlns="" id="{9CC7BF9F-A535-49F4-9965-233ABC06BD3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26" y="2937"/>
                <a:ext cx="174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30.91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49" name="Rectangle 552">
                <a:extLst>
                  <a:ext uri="{FF2B5EF4-FFF2-40B4-BE49-F238E27FC236}">
                    <a16:creationId xmlns:a16="http://schemas.microsoft.com/office/drawing/2014/main" xmlns="" id="{47CBABE6-D093-4DEB-B817-27CAB3FC211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85" y="2940"/>
                <a:ext cx="174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45.34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50" name="Line 553">
                <a:extLst>
                  <a:ext uri="{FF2B5EF4-FFF2-40B4-BE49-F238E27FC236}">
                    <a16:creationId xmlns:a16="http://schemas.microsoft.com/office/drawing/2014/main" xmlns="" id="{68B5005C-33C7-45AA-B41E-A761E202C5D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97" y="2968"/>
                <a:ext cx="75" cy="4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1" name="Rectangle 554">
                <a:extLst>
                  <a:ext uri="{FF2B5EF4-FFF2-40B4-BE49-F238E27FC236}">
                    <a16:creationId xmlns:a16="http://schemas.microsoft.com/office/drawing/2014/main" xmlns="" id="{DB15003E-E425-476A-A1CC-146466EC7C4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44" y="2643"/>
                <a:ext cx="174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28.1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52" name="Line 555">
                <a:extLst>
                  <a:ext uri="{FF2B5EF4-FFF2-40B4-BE49-F238E27FC236}">
                    <a16:creationId xmlns:a16="http://schemas.microsoft.com/office/drawing/2014/main" xmlns="" id="{353E5706-D45E-4335-AFBB-19CC7F6378F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056" y="2671"/>
                <a:ext cx="75" cy="318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3" name="Rectangle 556">
                <a:extLst>
                  <a:ext uri="{FF2B5EF4-FFF2-40B4-BE49-F238E27FC236}">
                    <a16:creationId xmlns:a16="http://schemas.microsoft.com/office/drawing/2014/main" xmlns="" id="{2877573F-5017-4625-8B06-F59E3E2D352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84" y="2967"/>
                <a:ext cx="174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68.39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54" name="Rectangle 557">
                <a:extLst>
                  <a:ext uri="{FF2B5EF4-FFF2-40B4-BE49-F238E27FC236}">
                    <a16:creationId xmlns:a16="http://schemas.microsoft.com/office/drawing/2014/main" xmlns="" id="{8FF9FDAA-F074-4B2E-A695-2EAAC316CC8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71" y="2972"/>
                <a:ext cx="174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66.09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55" name="Line 558">
                <a:extLst>
                  <a:ext uri="{FF2B5EF4-FFF2-40B4-BE49-F238E27FC236}">
                    <a16:creationId xmlns:a16="http://schemas.microsoft.com/office/drawing/2014/main" xmlns="" id="{618CDC25-1181-42AD-A9AC-C7D68C76BE5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793" y="2999"/>
                <a:ext cx="65" cy="4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6" name="Rectangle 559">
                <a:extLst>
                  <a:ext uri="{FF2B5EF4-FFF2-40B4-BE49-F238E27FC236}">
                    <a16:creationId xmlns:a16="http://schemas.microsoft.com/office/drawing/2014/main" xmlns="" id="{F8C5F00D-2C85-432F-9F3D-97CF709C4CE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23" y="2980"/>
                <a:ext cx="174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80.34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57" name="Line 560">
                <a:extLst>
                  <a:ext uri="{FF2B5EF4-FFF2-40B4-BE49-F238E27FC236}">
                    <a16:creationId xmlns:a16="http://schemas.microsoft.com/office/drawing/2014/main" xmlns="" id="{2F58FD90-6BDF-407C-BFBC-C77EB7F862B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699" y="3007"/>
                <a:ext cx="11" cy="5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8" name="Rectangle 561">
                <a:extLst>
                  <a:ext uri="{FF2B5EF4-FFF2-40B4-BE49-F238E27FC236}">
                    <a16:creationId xmlns:a16="http://schemas.microsoft.com/office/drawing/2014/main" xmlns="" id="{45859778-CEE8-4DEE-B356-7BEBD8EBC00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71" y="2925"/>
                <a:ext cx="174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05.1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59" name="Line 562">
                <a:extLst>
                  <a:ext uri="{FF2B5EF4-FFF2-40B4-BE49-F238E27FC236}">
                    <a16:creationId xmlns:a16="http://schemas.microsoft.com/office/drawing/2014/main" xmlns="" id="{681775C6-47A4-4F42-B2AA-B176BBA3AE4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958" y="2952"/>
                <a:ext cx="0" cy="67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60" name="Rectangle 563">
                <a:extLst>
                  <a:ext uri="{FF2B5EF4-FFF2-40B4-BE49-F238E27FC236}">
                    <a16:creationId xmlns:a16="http://schemas.microsoft.com/office/drawing/2014/main" xmlns="" id="{A33A98CD-B28B-4DD4-A937-9CD78AC5298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00" y="2998"/>
                <a:ext cx="174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66.89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61" name="Rectangle 564">
                <a:extLst>
                  <a:ext uri="{FF2B5EF4-FFF2-40B4-BE49-F238E27FC236}">
                    <a16:creationId xmlns:a16="http://schemas.microsoft.com/office/drawing/2014/main" xmlns="" id="{932A8AD2-D748-44AC-96F3-9F43A8BAF97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26" y="3004"/>
                <a:ext cx="174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36.31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62" name="Rectangle 565">
                <a:extLst>
                  <a:ext uri="{FF2B5EF4-FFF2-40B4-BE49-F238E27FC236}">
                    <a16:creationId xmlns:a16="http://schemas.microsoft.com/office/drawing/2014/main" xmlns="" id="{2C1C231C-C12E-4AB6-B20F-D356DB683EC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88" y="3011"/>
                <a:ext cx="174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34.88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63" name="Rectangle 566">
                <a:extLst>
                  <a:ext uri="{FF2B5EF4-FFF2-40B4-BE49-F238E27FC236}">
                    <a16:creationId xmlns:a16="http://schemas.microsoft.com/office/drawing/2014/main" xmlns="" id="{11BB1B5F-5521-4ACF-98C8-3ACB915351C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79" y="3013"/>
                <a:ext cx="174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703.57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64" name="Rectangle 567">
                <a:extLst>
                  <a:ext uri="{FF2B5EF4-FFF2-40B4-BE49-F238E27FC236}">
                    <a16:creationId xmlns:a16="http://schemas.microsoft.com/office/drawing/2014/main" xmlns="" id="{954507E7-04BF-4A1B-89F2-A6C2DCE2BA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32" y="2967"/>
                <a:ext cx="174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08.9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65" name="Line 568">
                <a:extLst>
                  <a:ext uri="{FF2B5EF4-FFF2-40B4-BE49-F238E27FC236}">
                    <a16:creationId xmlns:a16="http://schemas.microsoft.com/office/drawing/2014/main" xmlns="" id="{6BEBC7B8-7240-48D6-BF75-81FFD0DFCD3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398" y="2995"/>
                <a:ext cx="21" cy="66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66" name="Rectangle 569">
                <a:extLst>
                  <a:ext uri="{FF2B5EF4-FFF2-40B4-BE49-F238E27FC236}">
                    <a16:creationId xmlns:a16="http://schemas.microsoft.com/office/drawing/2014/main" xmlns="" id="{63429EDB-019A-40E9-AC3B-D0A68461A7F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43" y="3034"/>
                <a:ext cx="174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732.5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67" name="Line 570">
                <a:extLst>
                  <a:ext uri="{FF2B5EF4-FFF2-40B4-BE49-F238E27FC236}">
                    <a16:creationId xmlns:a16="http://schemas.microsoft.com/office/drawing/2014/main" xmlns="" id="{1EE7FC6C-A484-4D50-9245-60CF600F467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434" y="808"/>
                <a:ext cx="20" cy="3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</p:grpSp>
      <p:sp>
        <p:nvSpPr>
          <p:cNvPr id="558" name="TextBox 557">
            <a:extLst>
              <a:ext uri="{FF2B5EF4-FFF2-40B4-BE49-F238E27FC236}">
                <a16:creationId xmlns:a16="http://schemas.microsoft.com/office/drawing/2014/main" xmlns="" id="{29F68325-DF84-4814-95C2-2BB6BA5FC56B}"/>
              </a:ext>
            </a:extLst>
          </p:cNvPr>
          <p:cNvSpPr txBox="1"/>
          <p:nvPr/>
        </p:nvSpPr>
        <p:spPr>
          <a:xfrm>
            <a:off x="1773906" y="5763717"/>
            <a:ext cx="735323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upplemental Fig 1. A) Representative chromatogram from a Fisher 344 liver metabolite extract in positive ion mode acquired on a </a:t>
            </a:r>
            <a:r>
              <a:rPr lang="en-US" sz="1200" dirty="0" err="1"/>
              <a:t>Q-ToF</a:t>
            </a:r>
            <a:r>
              <a:rPr lang="en-US" sz="1200" dirty="0"/>
              <a:t> mass spectrometer. B) Total ion current spectra from the chromatographic run in A).</a:t>
            </a:r>
          </a:p>
        </p:txBody>
      </p:sp>
      <p:sp>
        <p:nvSpPr>
          <p:cNvPr id="559" name="TextBox 558">
            <a:extLst>
              <a:ext uri="{FF2B5EF4-FFF2-40B4-BE49-F238E27FC236}">
                <a16:creationId xmlns:a16="http://schemas.microsoft.com/office/drawing/2014/main" xmlns="" id="{51DEE996-9746-4C51-AE8E-A2BBC3991AD1}"/>
              </a:ext>
            </a:extLst>
          </p:cNvPr>
          <p:cNvSpPr txBox="1"/>
          <p:nvPr/>
        </p:nvSpPr>
        <p:spPr>
          <a:xfrm>
            <a:off x="2047871" y="419299"/>
            <a:ext cx="91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560" name="TextBox 559">
            <a:extLst>
              <a:ext uri="{FF2B5EF4-FFF2-40B4-BE49-F238E27FC236}">
                <a16:creationId xmlns:a16="http://schemas.microsoft.com/office/drawing/2014/main" xmlns="" id="{8F1725E4-4C6D-4D62-9BC3-91563F98E054}"/>
              </a:ext>
            </a:extLst>
          </p:cNvPr>
          <p:cNvSpPr txBox="1"/>
          <p:nvPr/>
        </p:nvSpPr>
        <p:spPr>
          <a:xfrm>
            <a:off x="2078524" y="3392607"/>
            <a:ext cx="91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231094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98</Words>
  <Application>Microsoft Office PowerPoint</Application>
  <PresentationFormat>Custom</PresentationFormat>
  <Paragraphs>15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oyce, Gregory (CDC/NIOSH/HELD/ACIB)</dc:creator>
  <cp:lastModifiedBy>Baranieswaran</cp:lastModifiedBy>
  <cp:revision>2</cp:revision>
  <dcterms:created xsi:type="dcterms:W3CDTF">2020-04-30T12:01:48Z</dcterms:created>
  <dcterms:modified xsi:type="dcterms:W3CDTF">2020-06-24T05:13:14Z</dcterms:modified>
</cp:coreProperties>
</file>